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drawings/drawing8.xml" ContentType="application/vnd.openxmlformats-officedocument.drawingml.chartshapes+xml"/>
  <Override PartName="/ppt/notesSlides/notesSlide3.xml" ContentType="application/vnd.openxmlformats-officedocument.presentationml.notesSlide+xml"/>
  <Override PartName="/ppt/charts/chart9.xml" ContentType="application/vnd.openxmlformats-officedocument.drawingml.chart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drawings/drawing10.xml" ContentType="application/vnd.openxmlformats-officedocument.drawingml.chartshapes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1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1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1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1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1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1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1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82" r:id="rId2"/>
    <p:sldId id="275" r:id="rId3"/>
    <p:sldId id="272" r:id="rId4"/>
    <p:sldId id="283" r:id="rId5"/>
    <p:sldId id="284" r:id="rId6"/>
  </p:sldIdLst>
  <p:sldSz cx="6858000" cy="9144000" type="screen4x3"/>
  <p:notesSz cx="6808788" cy="99409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52"/>
    <p:restoredTop sz="88016" autoAdjust="0"/>
  </p:normalViewPr>
  <p:slideViewPr>
    <p:cSldViewPr>
      <p:cViewPr varScale="1">
        <p:scale>
          <a:sx n="43" d="100"/>
          <a:sy n="43" d="100"/>
        </p:scale>
        <p:origin x="2460" y="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5" d="100"/>
        <a:sy n="15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F:\LED%20Iluminaci&#243;n\Ensayo%202\Biometria.xlsx" TargetMode="Externa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oleObject" Target="file:///F:\LED%20Iluminaci&#243;n\Ensayo%201\LED%20Probatina%201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ortatil\Dropbox\2021_D&#237;az-Rueda_LED\Revision%20en%20Plants\09-2021.%20Modificaciones\Spectral%20data\Spectral%20data%20manualment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ortatil\Dropbox\2021_D&#237;az-Rueda_LED\Revision%20en%20Plants\09-2021.%20Modificaciones\Spectral%20data\Spectral%20data%20manualment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ortatil\Dropbox\2021_D&#237;az-Rueda_LED\Revision%20en%20Plants\09-2021.%20Modificaciones\Spectral%20data\Spectral%20data%20manualment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ortatil\Dropbox\2021_D&#237;az-Rueda_LED\Revision%20en%20Plants\09-2021.%20Modificaciones\Spectral%20data\Spectral%20data%20manualment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ortatil\Dropbox\2021_D&#237;az-Rueda_LED\Revision%20en%20Plants\09-2021.%20Modificaciones\Spectral%20data\Spectral%20data%20manualmente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ortatil\Dropbox\2021_D&#237;az-Rueda_LED\Revision%20en%20Plants\09-2021.%20Modificaciones\Spectral%20data\Spectral%20data%20manualmente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ortatil\Dropbox\2021_D&#237;az-Rueda_LED\Revision%20en%20Plants\09-2021.%20Modificaciones\Spectral%20data\Spectral%20data%20manualmente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ortatil\Dropbox\2021_D&#237;az-Rueda_LED\Revision%20en%20Plants\09-2021.%20Modificaciones\Spectral%20data\Spectral%20data%20manualmente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F:\LED%20Iluminaci&#243;n\Ensayo%202\Biometria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F:\LED%20Iluminaci&#243;n\Ensayo%202\Biometria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F:\LED%20Iluminaci&#243;n\Ensayo%202\Biometria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F:\LED%20Iluminaci&#243;n\Ensayo%202\Biometria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F:\LED%20Iluminaci&#243;n\Ensayo%202\Biometria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F:\LED%20Iluminaci&#243;n\Ensayo%202\Biometria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F:\LED%20Iluminaci&#243;n\Ensayo%202\Biometria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F:\LED%20Iluminaci&#243;n\Ensayo%201\LED%20Probatina%20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160868055555556"/>
          <c:y val="7.7611111111111117E-2"/>
          <c:w val="0.74988437499999983"/>
          <c:h val="0.520779444444444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MK34 FINAL'!$P$1</c:f>
              <c:strCache>
                <c:ptCount val="1"/>
                <c:pt idx="0">
                  <c:v>Long tallo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0B8-4554-87C6-8B8AF42B792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20B8-4554-87C6-8B8AF42B792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20B8-4554-87C6-8B8AF42B792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20B8-4554-87C6-8B8AF42B792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20B8-4554-87C6-8B8AF42B7927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20B8-4554-87C6-8B8AF42B7927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20B8-4554-87C6-8B8AF42B7927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20B8-4554-87C6-8B8AF42B7927}"/>
              </c:ext>
            </c:extLst>
          </c:dPt>
          <c:errBars>
            <c:errBarType val="both"/>
            <c:errValType val="cust"/>
            <c:noEndCap val="0"/>
            <c:plus>
              <c:numRef>
                <c:f>'AMK34 FINAL'!$O$11:$O$1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8.3333333333333232E-2</c:v>
                  </c:pt>
                  <c:pt idx="3">
                    <c:v>0.12309149097933274</c:v>
                  </c:pt>
                  <c:pt idx="4">
                    <c:v>0.1123666437438736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'AMK34 FINAL'!$O$11:$O$1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8.3333333333333232E-2</c:v>
                  </c:pt>
                  <c:pt idx="3">
                    <c:v>0.12309149097933274</c:v>
                  </c:pt>
                  <c:pt idx="4">
                    <c:v>0.1123666437438736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</c:errBars>
          <c:cat>
            <c:strRef>
              <c:f>'AMK34 FINAL'!$N$2:$N$9</c:f>
              <c:strCache>
                <c:ptCount val="8"/>
                <c:pt idx="0">
                  <c:v>R9B1-56</c:v>
                </c:pt>
                <c:pt idx="1">
                  <c:v>R8B2-30</c:v>
                </c:pt>
                <c:pt idx="2">
                  <c:v>R7B3-34</c:v>
                </c:pt>
                <c:pt idx="3">
                  <c:v>R7B3-52</c:v>
                </c:pt>
                <c:pt idx="4">
                  <c:v>R6B4-40</c:v>
                </c:pt>
                <c:pt idx="5">
                  <c:v>R7B3W-84</c:v>
                </c:pt>
                <c:pt idx="6">
                  <c:v>R6B4W-98</c:v>
                </c:pt>
                <c:pt idx="7">
                  <c:v>TFL-137</c:v>
                </c:pt>
              </c:strCache>
            </c:strRef>
          </c:cat>
          <c:val>
            <c:numRef>
              <c:f>'AMK34 FINAL'!$O$2:$O$9</c:f>
              <c:numCache>
                <c:formatCode>General</c:formatCode>
                <c:ptCount val="8"/>
                <c:pt idx="0">
                  <c:v>2</c:v>
                </c:pt>
                <c:pt idx="1">
                  <c:v>2</c:v>
                </c:pt>
                <c:pt idx="2">
                  <c:v>1.9166666666666667</c:v>
                </c:pt>
                <c:pt idx="3">
                  <c:v>2</c:v>
                </c:pt>
                <c:pt idx="4">
                  <c:v>1.8333333333333333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0B8-4554-87C6-8B8AF42B79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7609472"/>
        <c:axId val="108082304"/>
      </c:barChart>
      <c:catAx>
        <c:axId val="1076094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100" b="1"/>
            </a:pPr>
            <a:endParaRPr lang="es-ES"/>
          </a:p>
        </c:txPr>
        <c:crossAx val="108082304"/>
        <c:crosses val="autoZero"/>
        <c:auto val="1"/>
        <c:lblAlgn val="ctr"/>
        <c:lblOffset val="100"/>
        <c:noMultiLvlLbl val="0"/>
      </c:catAx>
      <c:valAx>
        <c:axId val="108082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s-ES" sz="1100" baseline="0" dirty="0" err="1"/>
                  <a:t>Number</a:t>
                </a:r>
                <a:r>
                  <a:rPr lang="es-ES" sz="1100" baseline="0" dirty="0"/>
                  <a:t> of </a:t>
                </a:r>
                <a:r>
                  <a:rPr lang="es-ES" sz="1100" baseline="0" dirty="0" err="1"/>
                  <a:t>shoots</a:t>
                </a:r>
                <a:endParaRPr lang="es-ES" sz="11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900" b="1"/>
            </a:pPr>
            <a:endParaRPr lang="es-ES"/>
          </a:p>
        </c:txPr>
        <c:crossAx val="107609472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77395061728395"/>
          <c:y val="7.1428608064338303E-2"/>
          <c:w val="0.82133827160493822"/>
          <c:h val="0.718487763470696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ato Biométricos Cosecha 1'!$S$3</c:f>
              <c:strCache>
                <c:ptCount val="1"/>
                <c:pt idx="0">
                  <c:v>R7B3-34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Dato Biométricos Cosecha 1'!$Y$11;'Dato Biométricos Cosecha 1'!$Y$13;'Dato Biométricos Cosecha 1'!$Y$15;'Dato Biométricos Cosecha 1'!$Y$17)</c:f>
                <c:numCache>
                  <c:formatCode>General</c:formatCode>
                  <c:ptCount val="4"/>
                  <c:pt idx="0">
                    <c:v>0.23614043418165703</c:v>
                  </c:pt>
                  <c:pt idx="1">
                    <c:v>0.4198928934013294</c:v>
                  </c:pt>
                  <c:pt idx="2">
                    <c:v>0.25994965024940109</c:v>
                  </c:pt>
                  <c:pt idx="3">
                    <c:v>0.51280144751186318</c:v>
                  </c:pt>
                </c:numCache>
              </c:numRef>
            </c:plus>
            <c:minus>
              <c:numRef>
                <c:f>('Dato Biométricos Cosecha 1'!$Y$11;'Dato Biométricos Cosecha 1'!$Y$13;'Dato Biométricos Cosecha 1'!$Y$15;'Dato Biométricos Cosecha 1'!$Y$17)</c:f>
                <c:numCache>
                  <c:formatCode>General</c:formatCode>
                  <c:ptCount val="4"/>
                  <c:pt idx="0">
                    <c:v>0.23614043418165703</c:v>
                  </c:pt>
                  <c:pt idx="1">
                    <c:v>0.4198928934013294</c:v>
                  </c:pt>
                  <c:pt idx="2">
                    <c:v>0.25994965024940109</c:v>
                  </c:pt>
                  <c:pt idx="3">
                    <c:v>0.51280144751186318</c:v>
                  </c:pt>
                </c:numCache>
              </c:numRef>
            </c:minus>
          </c:errBars>
          <c:cat>
            <c:strRef>
              <c:f>'Dato Biométricos Cosecha 1'!$R$3:$R$6</c:f>
              <c:strCache>
                <c:ptCount val="4"/>
                <c:pt idx="0">
                  <c:v>ACZ1</c:v>
                </c:pt>
                <c:pt idx="1">
                  <c:v>ACZ4</c:v>
                </c:pt>
                <c:pt idx="2">
                  <c:v>AJA4</c:v>
                </c:pt>
                <c:pt idx="3">
                  <c:v>AJA6</c:v>
                </c:pt>
              </c:strCache>
            </c:strRef>
          </c:cat>
          <c:val>
            <c:numRef>
              <c:f>('Dato Biométricos Cosecha 1'!$Y$3;'Dato Biométricos Cosecha 1'!$Y$5;'Dato Biométricos Cosecha 1'!$Y$7;'Dato Biométricos Cosecha 1'!$Y$9)</c:f>
              <c:numCache>
                <c:formatCode>0.0000</c:formatCode>
                <c:ptCount val="4"/>
                <c:pt idx="0" formatCode="General">
                  <c:v>5.105672438672439</c:v>
                </c:pt>
                <c:pt idx="1">
                  <c:v>8.3504634254634258</c:v>
                </c:pt>
                <c:pt idx="2">
                  <c:v>8.3548174048174069</c:v>
                </c:pt>
                <c:pt idx="3">
                  <c:v>11.0822751322751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B6-49A5-BB6E-6A774DE74D80}"/>
            </c:ext>
          </c:extLst>
        </c:ser>
        <c:ser>
          <c:idx val="1"/>
          <c:order val="1"/>
          <c:tx>
            <c:strRef>
              <c:f>'Dato Biométricos Cosecha 1'!$S$4</c:f>
              <c:strCache>
                <c:ptCount val="1"/>
                <c:pt idx="0">
                  <c:v>TFL-137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Dato Biométricos Cosecha 1'!$Y$12;'Dato Biométricos Cosecha 1'!$Y$14;'Dato Biométricos Cosecha 1'!$Y$16;'Dato Biométricos Cosecha 1'!$Y$18)</c:f>
                <c:numCache>
                  <c:formatCode>General</c:formatCode>
                  <c:ptCount val="4"/>
                  <c:pt idx="0">
                    <c:v>0.11320344956457577</c:v>
                  </c:pt>
                  <c:pt idx="1">
                    <c:v>0.14895832124242134</c:v>
                  </c:pt>
                  <c:pt idx="2">
                    <c:v>0.17014671469282372</c:v>
                  </c:pt>
                  <c:pt idx="3">
                    <c:v>0.14111989019861834</c:v>
                  </c:pt>
                </c:numCache>
              </c:numRef>
            </c:plus>
            <c:minus>
              <c:numRef>
                <c:f>('Dato Biométricos Cosecha 1'!$Y$12;'Dato Biométricos Cosecha 1'!$Y$14;'Dato Biométricos Cosecha 1'!$Y$16;'Dato Biométricos Cosecha 1'!$Y$18)</c:f>
                <c:numCache>
                  <c:formatCode>General</c:formatCode>
                  <c:ptCount val="4"/>
                  <c:pt idx="0">
                    <c:v>0.11320344956457577</c:v>
                  </c:pt>
                  <c:pt idx="1">
                    <c:v>0.14895832124242134</c:v>
                  </c:pt>
                  <c:pt idx="2">
                    <c:v>0.17014671469282372</c:v>
                  </c:pt>
                  <c:pt idx="3">
                    <c:v>0.14111989019861834</c:v>
                  </c:pt>
                </c:numCache>
              </c:numRef>
            </c:minus>
          </c:errBars>
          <c:cat>
            <c:strRef>
              <c:f>'Dato Biométricos Cosecha 1'!$R$3:$R$6</c:f>
              <c:strCache>
                <c:ptCount val="4"/>
                <c:pt idx="0">
                  <c:v>ACZ1</c:v>
                </c:pt>
                <c:pt idx="1">
                  <c:v>ACZ4</c:v>
                </c:pt>
                <c:pt idx="2">
                  <c:v>AJA4</c:v>
                </c:pt>
                <c:pt idx="3">
                  <c:v>AJA6</c:v>
                </c:pt>
              </c:strCache>
            </c:strRef>
          </c:cat>
          <c:val>
            <c:numRef>
              <c:f>('Dato Biométricos Cosecha 1'!$Y$4;'Dato Biométricos Cosecha 1'!$Y$6;'Dato Biométricos Cosecha 1'!$Y$8;'Dato Biométricos Cosecha 1'!$Y$10)</c:f>
              <c:numCache>
                <c:formatCode>0.0000</c:formatCode>
                <c:ptCount val="4"/>
                <c:pt idx="0" formatCode="General">
                  <c:v>2.9240115995115996</c:v>
                </c:pt>
                <c:pt idx="1">
                  <c:v>3.7676987456987456</c:v>
                </c:pt>
                <c:pt idx="2">
                  <c:v>3.0792277167277153</c:v>
                </c:pt>
                <c:pt idx="3">
                  <c:v>5.23847068569290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BB6-49A5-BB6E-6A774DE74D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564288"/>
        <c:axId val="45565824"/>
      </c:barChart>
      <c:catAx>
        <c:axId val="45564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s-ES" sz="1200" b="1"/>
            </a:pPr>
            <a:endParaRPr lang="es-ES"/>
          </a:p>
        </c:txPr>
        <c:crossAx val="45565824"/>
        <c:crosses val="autoZero"/>
        <c:auto val="1"/>
        <c:lblAlgn val="ctr"/>
        <c:lblOffset val="100"/>
        <c:noMultiLvlLbl val="0"/>
      </c:catAx>
      <c:valAx>
        <c:axId val="455658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s-ES" sz="1200" baseline="0" dirty="0" err="1"/>
                  <a:t>Internodal</a:t>
                </a:r>
                <a:r>
                  <a:rPr lang="es-ES" sz="1200" baseline="0" dirty="0"/>
                  <a:t> (mm)</a:t>
                </a:r>
                <a:endParaRPr lang="es-ES" sz="12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s-ES" sz="1200" b="1"/>
            </a:pPr>
            <a:endParaRPr lang="es-ES"/>
          </a:p>
        </c:txPr>
        <c:crossAx val="455642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externalData r:id="rId1">
    <c:autoUpdate val="0"/>
  </c:externalData>
  <c:userShapes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 b="0">
                <a:solidFill>
                  <a:schemeClr val="tx1"/>
                </a:solidFill>
              </a:rPr>
              <a:t>R9B1-56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Hoja2!$A$7:$A$407</c:f>
              <c:numCache>
                <c:formatCode>General</c:formatCode>
                <c:ptCount val="401"/>
                <c:pt idx="0">
                  <c:v>380</c:v>
                </c:pt>
                <c:pt idx="1">
                  <c:v>381</c:v>
                </c:pt>
                <c:pt idx="2">
                  <c:v>382</c:v>
                </c:pt>
                <c:pt idx="3">
                  <c:v>383</c:v>
                </c:pt>
                <c:pt idx="4">
                  <c:v>384</c:v>
                </c:pt>
                <c:pt idx="5">
                  <c:v>385</c:v>
                </c:pt>
                <c:pt idx="6">
                  <c:v>386</c:v>
                </c:pt>
                <c:pt idx="7">
                  <c:v>387</c:v>
                </c:pt>
                <c:pt idx="8">
                  <c:v>388</c:v>
                </c:pt>
                <c:pt idx="9">
                  <c:v>389</c:v>
                </c:pt>
                <c:pt idx="10">
                  <c:v>390</c:v>
                </c:pt>
                <c:pt idx="11">
                  <c:v>391</c:v>
                </c:pt>
                <c:pt idx="12">
                  <c:v>392</c:v>
                </c:pt>
                <c:pt idx="13">
                  <c:v>393</c:v>
                </c:pt>
                <c:pt idx="14">
                  <c:v>394</c:v>
                </c:pt>
                <c:pt idx="15">
                  <c:v>395</c:v>
                </c:pt>
                <c:pt idx="16">
                  <c:v>396</c:v>
                </c:pt>
                <c:pt idx="17">
                  <c:v>397</c:v>
                </c:pt>
                <c:pt idx="18">
                  <c:v>398</c:v>
                </c:pt>
                <c:pt idx="19">
                  <c:v>399</c:v>
                </c:pt>
                <c:pt idx="20">
                  <c:v>400</c:v>
                </c:pt>
                <c:pt idx="21">
                  <c:v>401</c:v>
                </c:pt>
                <c:pt idx="22">
                  <c:v>402</c:v>
                </c:pt>
                <c:pt idx="23">
                  <c:v>403</c:v>
                </c:pt>
                <c:pt idx="24">
                  <c:v>404</c:v>
                </c:pt>
                <c:pt idx="25">
                  <c:v>405</c:v>
                </c:pt>
                <c:pt idx="26">
                  <c:v>406</c:v>
                </c:pt>
                <c:pt idx="27">
                  <c:v>407</c:v>
                </c:pt>
                <c:pt idx="28">
                  <c:v>408</c:v>
                </c:pt>
                <c:pt idx="29">
                  <c:v>409</c:v>
                </c:pt>
                <c:pt idx="30">
                  <c:v>410</c:v>
                </c:pt>
                <c:pt idx="31">
                  <c:v>411</c:v>
                </c:pt>
                <c:pt idx="32">
                  <c:v>412</c:v>
                </c:pt>
                <c:pt idx="33">
                  <c:v>413</c:v>
                </c:pt>
                <c:pt idx="34">
                  <c:v>414</c:v>
                </c:pt>
                <c:pt idx="35">
                  <c:v>415</c:v>
                </c:pt>
                <c:pt idx="36">
                  <c:v>416</c:v>
                </c:pt>
                <c:pt idx="37">
                  <c:v>417</c:v>
                </c:pt>
                <c:pt idx="38">
                  <c:v>418</c:v>
                </c:pt>
                <c:pt idx="39">
                  <c:v>419</c:v>
                </c:pt>
                <c:pt idx="40">
                  <c:v>420</c:v>
                </c:pt>
                <c:pt idx="41">
                  <c:v>421</c:v>
                </c:pt>
                <c:pt idx="42">
                  <c:v>422</c:v>
                </c:pt>
                <c:pt idx="43">
                  <c:v>423</c:v>
                </c:pt>
                <c:pt idx="44">
                  <c:v>424</c:v>
                </c:pt>
                <c:pt idx="45">
                  <c:v>425</c:v>
                </c:pt>
                <c:pt idx="46">
                  <c:v>426</c:v>
                </c:pt>
                <c:pt idx="47">
                  <c:v>427</c:v>
                </c:pt>
                <c:pt idx="48">
                  <c:v>428</c:v>
                </c:pt>
                <c:pt idx="49">
                  <c:v>429</c:v>
                </c:pt>
                <c:pt idx="50">
                  <c:v>430</c:v>
                </c:pt>
                <c:pt idx="51">
                  <c:v>431</c:v>
                </c:pt>
                <c:pt idx="52">
                  <c:v>432</c:v>
                </c:pt>
                <c:pt idx="53">
                  <c:v>433</c:v>
                </c:pt>
                <c:pt idx="54">
                  <c:v>434</c:v>
                </c:pt>
                <c:pt idx="55">
                  <c:v>435</c:v>
                </c:pt>
                <c:pt idx="56">
                  <c:v>436</c:v>
                </c:pt>
                <c:pt idx="57">
                  <c:v>437</c:v>
                </c:pt>
                <c:pt idx="58">
                  <c:v>438</c:v>
                </c:pt>
                <c:pt idx="59">
                  <c:v>439</c:v>
                </c:pt>
                <c:pt idx="60">
                  <c:v>440</c:v>
                </c:pt>
                <c:pt idx="61">
                  <c:v>441</c:v>
                </c:pt>
                <c:pt idx="62">
                  <c:v>442</c:v>
                </c:pt>
                <c:pt idx="63">
                  <c:v>443</c:v>
                </c:pt>
                <c:pt idx="64">
                  <c:v>444</c:v>
                </c:pt>
                <c:pt idx="65">
                  <c:v>445</c:v>
                </c:pt>
                <c:pt idx="66">
                  <c:v>446</c:v>
                </c:pt>
                <c:pt idx="67">
                  <c:v>447</c:v>
                </c:pt>
                <c:pt idx="68">
                  <c:v>448</c:v>
                </c:pt>
                <c:pt idx="69">
                  <c:v>449</c:v>
                </c:pt>
                <c:pt idx="70">
                  <c:v>450</c:v>
                </c:pt>
                <c:pt idx="71">
                  <c:v>451</c:v>
                </c:pt>
                <c:pt idx="72">
                  <c:v>452</c:v>
                </c:pt>
                <c:pt idx="73">
                  <c:v>453</c:v>
                </c:pt>
                <c:pt idx="74">
                  <c:v>454</c:v>
                </c:pt>
                <c:pt idx="75">
                  <c:v>455</c:v>
                </c:pt>
                <c:pt idx="76">
                  <c:v>456</c:v>
                </c:pt>
                <c:pt idx="77">
                  <c:v>457</c:v>
                </c:pt>
                <c:pt idx="78">
                  <c:v>458</c:v>
                </c:pt>
                <c:pt idx="79">
                  <c:v>459</c:v>
                </c:pt>
                <c:pt idx="80">
                  <c:v>460</c:v>
                </c:pt>
                <c:pt idx="81">
                  <c:v>461</c:v>
                </c:pt>
                <c:pt idx="82">
                  <c:v>462</c:v>
                </c:pt>
                <c:pt idx="83">
                  <c:v>463</c:v>
                </c:pt>
                <c:pt idx="84">
                  <c:v>464</c:v>
                </c:pt>
                <c:pt idx="85">
                  <c:v>465</c:v>
                </c:pt>
                <c:pt idx="86">
                  <c:v>466</c:v>
                </c:pt>
                <c:pt idx="87">
                  <c:v>467</c:v>
                </c:pt>
                <c:pt idx="88">
                  <c:v>468</c:v>
                </c:pt>
                <c:pt idx="89">
                  <c:v>469</c:v>
                </c:pt>
                <c:pt idx="90">
                  <c:v>470</c:v>
                </c:pt>
                <c:pt idx="91">
                  <c:v>471</c:v>
                </c:pt>
                <c:pt idx="92">
                  <c:v>472</c:v>
                </c:pt>
                <c:pt idx="93">
                  <c:v>473</c:v>
                </c:pt>
                <c:pt idx="94">
                  <c:v>474</c:v>
                </c:pt>
                <c:pt idx="95">
                  <c:v>475</c:v>
                </c:pt>
                <c:pt idx="96">
                  <c:v>476</c:v>
                </c:pt>
                <c:pt idx="97">
                  <c:v>477</c:v>
                </c:pt>
                <c:pt idx="98">
                  <c:v>478</c:v>
                </c:pt>
                <c:pt idx="99">
                  <c:v>479</c:v>
                </c:pt>
                <c:pt idx="100">
                  <c:v>480</c:v>
                </c:pt>
                <c:pt idx="101">
                  <c:v>481</c:v>
                </c:pt>
                <c:pt idx="102">
                  <c:v>482</c:v>
                </c:pt>
                <c:pt idx="103">
                  <c:v>483</c:v>
                </c:pt>
                <c:pt idx="104">
                  <c:v>484</c:v>
                </c:pt>
                <c:pt idx="105">
                  <c:v>485</c:v>
                </c:pt>
                <c:pt idx="106">
                  <c:v>486</c:v>
                </c:pt>
                <c:pt idx="107">
                  <c:v>487</c:v>
                </c:pt>
                <c:pt idx="108">
                  <c:v>488</c:v>
                </c:pt>
                <c:pt idx="109">
                  <c:v>489</c:v>
                </c:pt>
                <c:pt idx="110">
                  <c:v>490</c:v>
                </c:pt>
                <c:pt idx="111">
                  <c:v>491</c:v>
                </c:pt>
                <c:pt idx="112">
                  <c:v>492</c:v>
                </c:pt>
                <c:pt idx="113">
                  <c:v>493</c:v>
                </c:pt>
                <c:pt idx="114">
                  <c:v>494</c:v>
                </c:pt>
                <c:pt idx="115">
                  <c:v>495</c:v>
                </c:pt>
                <c:pt idx="116">
                  <c:v>496</c:v>
                </c:pt>
                <c:pt idx="117">
                  <c:v>497</c:v>
                </c:pt>
                <c:pt idx="118">
                  <c:v>498</c:v>
                </c:pt>
                <c:pt idx="119">
                  <c:v>499</c:v>
                </c:pt>
                <c:pt idx="120">
                  <c:v>500</c:v>
                </c:pt>
                <c:pt idx="121">
                  <c:v>501</c:v>
                </c:pt>
                <c:pt idx="122">
                  <c:v>502</c:v>
                </c:pt>
                <c:pt idx="123">
                  <c:v>503</c:v>
                </c:pt>
                <c:pt idx="124">
                  <c:v>504</c:v>
                </c:pt>
                <c:pt idx="125">
                  <c:v>505</c:v>
                </c:pt>
                <c:pt idx="126">
                  <c:v>506</c:v>
                </c:pt>
                <c:pt idx="127">
                  <c:v>507</c:v>
                </c:pt>
                <c:pt idx="128">
                  <c:v>508</c:v>
                </c:pt>
                <c:pt idx="129">
                  <c:v>509</c:v>
                </c:pt>
                <c:pt idx="130">
                  <c:v>510</c:v>
                </c:pt>
                <c:pt idx="131">
                  <c:v>511</c:v>
                </c:pt>
                <c:pt idx="132">
                  <c:v>512</c:v>
                </c:pt>
                <c:pt idx="133">
                  <c:v>513</c:v>
                </c:pt>
                <c:pt idx="134">
                  <c:v>514</c:v>
                </c:pt>
                <c:pt idx="135">
                  <c:v>515</c:v>
                </c:pt>
                <c:pt idx="136">
                  <c:v>516</c:v>
                </c:pt>
                <c:pt idx="137">
                  <c:v>517</c:v>
                </c:pt>
                <c:pt idx="138">
                  <c:v>518</c:v>
                </c:pt>
                <c:pt idx="139">
                  <c:v>519</c:v>
                </c:pt>
                <c:pt idx="140">
                  <c:v>520</c:v>
                </c:pt>
                <c:pt idx="141">
                  <c:v>521</c:v>
                </c:pt>
                <c:pt idx="142">
                  <c:v>522</c:v>
                </c:pt>
                <c:pt idx="143">
                  <c:v>523</c:v>
                </c:pt>
                <c:pt idx="144">
                  <c:v>524</c:v>
                </c:pt>
                <c:pt idx="145">
                  <c:v>525</c:v>
                </c:pt>
                <c:pt idx="146">
                  <c:v>526</c:v>
                </c:pt>
                <c:pt idx="147">
                  <c:v>527</c:v>
                </c:pt>
                <c:pt idx="148">
                  <c:v>528</c:v>
                </c:pt>
                <c:pt idx="149">
                  <c:v>529</c:v>
                </c:pt>
                <c:pt idx="150">
                  <c:v>530</c:v>
                </c:pt>
                <c:pt idx="151">
                  <c:v>531</c:v>
                </c:pt>
                <c:pt idx="152">
                  <c:v>532</c:v>
                </c:pt>
                <c:pt idx="153">
                  <c:v>533</c:v>
                </c:pt>
                <c:pt idx="154">
                  <c:v>534</c:v>
                </c:pt>
                <c:pt idx="155">
                  <c:v>535</c:v>
                </c:pt>
                <c:pt idx="156">
                  <c:v>536</c:v>
                </c:pt>
                <c:pt idx="157">
                  <c:v>537</c:v>
                </c:pt>
                <c:pt idx="158">
                  <c:v>538</c:v>
                </c:pt>
                <c:pt idx="159">
                  <c:v>539</c:v>
                </c:pt>
                <c:pt idx="160">
                  <c:v>540</c:v>
                </c:pt>
                <c:pt idx="161">
                  <c:v>541</c:v>
                </c:pt>
                <c:pt idx="162">
                  <c:v>542</c:v>
                </c:pt>
                <c:pt idx="163">
                  <c:v>543</c:v>
                </c:pt>
                <c:pt idx="164">
                  <c:v>544</c:v>
                </c:pt>
                <c:pt idx="165">
                  <c:v>545</c:v>
                </c:pt>
                <c:pt idx="166">
                  <c:v>546</c:v>
                </c:pt>
                <c:pt idx="167">
                  <c:v>547</c:v>
                </c:pt>
                <c:pt idx="168">
                  <c:v>548</c:v>
                </c:pt>
                <c:pt idx="169">
                  <c:v>549</c:v>
                </c:pt>
                <c:pt idx="170">
                  <c:v>550</c:v>
                </c:pt>
                <c:pt idx="171">
                  <c:v>551</c:v>
                </c:pt>
                <c:pt idx="172">
                  <c:v>552</c:v>
                </c:pt>
                <c:pt idx="173">
                  <c:v>553</c:v>
                </c:pt>
                <c:pt idx="174">
                  <c:v>554</c:v>
                </c:pt>
                <c:pt idx="175">
                  <c:v>555</c:v>
                </c:pt>
                <c:pt idx="176">
                  <c:v>556</c:v>
                </c:pt>
                <c:pt idx="177">
                  <c:v>557</c:v>
                </c:pt>
                <c:pt idx="178">
                  <c:v>558</c:v>
                </c:pt>
                <c:pt idx="179">
                  <c:v>559</c:v>
                </c:pt>
                <c:pt idx="180">
                  <c:v>560</c:v>
                </c:pt>
                <c:pt idx="181">
                  <c:v>561</c:v>
                </c:pt>
                <c:pt idx="182">
                  <c:v>562</c:v>
                </c:pt>
                <c:pt idx="183">
                  <c:v>563</c:v>
                </c:pt>
                <c:pt idx="184">
                  <c:v>564</c:v>
                </c:pt>
                <c:pt idx="185">
                  <c:v>565</c:v>
                </c:pt>
                <c:pt idx="186">
                  <c:v>566</c:v>
                </c:pt>
                <c:pt idx="187">
                  <c:v>567</c:v>
                </c:pt>
                <c:pt idx="188">
                  <c:v>568</c:v>
                </c:pt>
                <c:pt idx="189">
                  <c:v>569</c:v>
                </c:pt>
                <c:pt idx="190">
                  <c:v>570</c:v>
                </c:pt>
                <c:pt idx="191">
                  <c:v>571</c:v>
                </c:pt>
                <c:pt idx="192">
                  <c:v>572</c:v>
                </c:pt>
                <c:pt idx="193">
                  <c:v>573</c:v>
                </c:pt>
                <c:pt idx="194">
                  <c:v>574</c:v>
                </c:pt>
                <c:pt idx="195">
                  <c:v>575</c:v>
                </c:pt>
                <c:pt idx="196">
                  <c:v>576</c:v>
                </c:pt>
                <c:pt idx="197">
                  <c:v>577</c:v>
                </c:pt>
                <c:pt idx="198">
                  <c:v>578</c:v>
                </c:pt>
                <c:pt idx="199">
                  <c:v>579</c:v>
                </c:pt>
                <c:pt idx="200">
                  <c:v>580</c:v>
                </c:pt>
                <c:pt idx="201">
                  <c:v>581</c:v>
                </c:pt>
                <c:pt idx="202">
                  <c:v>582</c:v>
                </c:pt>
                <c:pt idx="203">
                  <c:v>583</c:v>
                </c:pt>
                <c:pt idx="204">
                  <c:v>584</c:v>
                </c:pt>
                <c:pt idx="205">
                  <c:v>585</c:v>
                </c:pt>
                <c:pt idx="206">
                  <c:v>586</c:v>
                </c:pt>
                <c:pt idx="207">
                  <c:v>587</c:v>
                </c:pt>
                <c:pt idx="208">
                  <c:v>588</c:v>
                </c:pt>
                <c:pt idx="209">
                  <c:v>589</c:v>
                </c:pt>
                <c:pt idx="210">
                  <c:v>590</c:v>
                </c:pt>
                <c:pt idx="211">
                  <c:v>591</c:v>
                </c:pt>
                <c:pt idx="212">
                  <c:v>592</c:v>
                </c:pt>
                <c:pt idx="213">
                  <c:v>593</c:v>
                </c:pt>
                <c:pt idx="214">
                  <c:v>594</c:v>
                </c:pt>
                <c:pt idx="215">
                  <c:v>595</c:v>
                </c:pt>
                <c:pt idx="216">
                  <c:v>596</c:v>
                </c:pt>
                <c:pt idx="217">
                  <c:v>597</c:v>
                </c:pt>
                <c:pt idx="218">
                  <c:v>598</c:v>
                </c:pt>
                <c:pt idx="219">
                  <c:v>599</c:v>
                </c:pt>
                <c:pt idx="220">
                  <c:v>600</c:v>
                </c:pt>
                <c:pt idx="221">
                  <c:v>601</c:v>
                </c:pt>
                <c:pt idx="222">
                  <c:v>602</c:v>
                </c:pt>
                <c:pt idx="223">
                  <c:v>603</c:v>
                </c:pt>
                <c:pt idx="224">
                  <c:v>604</c:v>
                </c:pt>
                <c:pt idx="225">
                  <c:v>605</c:v>
                </c:pt>
                <c:pt idx="226">
                  <c:v>606</c:v>
                </c:pt>
                <c:pt idx="227">
                  <c:v>607</c:v>
                </c:pt>
                <c:pt idx="228">
                  <c:v>608</c:v>
                </c:pt>
                <c:pt idx="229">
                  <c:v>609</c:v>
                </c:pt>
                <c:pt idx="230">
                  <c:v>610</c:v>
                </c:pt>
                <c:pt idx="231">
                  <c:v>611</c:v>
                </c:pt>
                <c:pt idx="232">
                  <c:v>612</c:v>
                </c:pt>
                <c:pt idx="233">
                  <c:v>613</c:v>
                </c:pt>
                <c:pt idx="234">
                  <c:v>614</c:v>
                </c:pt>
                <c:pt idx="235">
                  <c:v>615</c:v>
                </c:pt>
                <c:pt idx="236">
                  <c:v>616</c:v>
                </c:pt>
                <c:pt idx="237">
                  <c:v>617</c:v>
                </c:pt>
                <c:pt idx="238">
                  <c:v>618</c:v>
                </c:pt>
                <c:pt idx="239">
                  <c:v>619</c:v>
                </c:pt>
                <c:pt idx="240">
                  <c:v>620</c:v>
                </c:pt>
                <c:pt idx="241">
                  <c:v>621</c:v>
                </c:pt>
                <c:pt idx="242">
                  <c:v>622</c:v>
                </c:pt>
                <c:pt idx="243">
                  <c:v>623</c:v>
                </c:pt>
                <c:pt idx="244">
                  <c:v>624</c:v>
                </c:pt>
                <c:pt idx="245">
                  <c:v>625</c:v>
                </c:pt>
                <c:pt idx="246">
                  <c:v>626</c:v>
                </c:pt>
                <c:pt idx="247">
                  <c:v>627</c:v>
                </c:pt>
                <c:pt idx="248">
                  <c:v>628</c:v>
                </c:pt>
                <c:pt idx="249">
                  <c:v>629</c:v>
                </c:pt>
                <c:pt idx="250">
                  <c:v>630</c:v>
                </c:pt>
                <c:pt idx="251">
                  <c:v>631</c:v>
                </c:pt>
                <c:pt idx="252">
                  <c:v>632</c:v>
                </c:pt>
                <c:pt idx="253">
                  <c:v>633</c:v>
                </c:pt>
                <c:pt idx="254">
                  <c:v>634</c:v>
                </c:pt>
                <c:pt idx="255">
                  <c:v>635</c:v>
                </c:pt>
                <c:pt idx="256">
                  <c:v>636</c:v>
                </c:pt>
                <c:pt idx="257">
                  <c:v>637</c:v>
                </c:pt>
                <c:pt idx="258">
                  <c:v>638</c:v>
                </c:pt>
                <c:pt idx="259">
                  <c:v>639</c:v>
                </c:pt>
                <c:pt idx="260">
                  <c:v>640</c:v>
                </c:pt>
                <c:pt idx="261">
                  <c:v>641</c:v>
                </c:pt>
                <c:pt idx="262">
                  <c:v>642</c:v>
                </c:pt>
                <c:pt idx="263">
                  <c:v>643</c:v>
                </c:pt>
                <c:pt idx="264">
                  <c:v>644</c:v>
                </c:pt>
                <c:pt idx="265">
                  <c:v>645</c:v>
                </c:pt>
                <c:pt idx="266">
                  <c:v>646</c:v>
                </c:pt>
                <c:pt idx="267">
                  <c:v>647</c:v>
                </c:pt>
                <c:pt idx="268">
                  <c:v>648</c:v>
                </c:pt>
                <c:pt idx="269">
                  <c:v>649</c:v>
                </c:pt>
                <c:pt idx="270">
                  <c:v>650</c:v>
                </c:pt>
                <c:pt idx="271">
                  <c:v>651</c:v>
                </c:pt>
                <c:pt idx="272">
                  <c:v>652</c:v>
                </c:pt>
                <c:pt idx="273">
                  <c:v>653</c:v>
                </c:pt>
                <c:pt idx="274">
                  <c:v>654</c:v>
                </c:pt>
                <c:pt idx="275">
                  <c:v>655</c:v>
                </c:pt>
                <c:pt idx="276">
                  <c:v>656</c:v>
                </c:pt>
                <c:pt idx="277">
                  <c:v>657</c:v>
                </c:pt>
                <c:pt idx="278">
                  <c:v>658</c:v>
                </c:pt>
                <c:pt idx="279">
                  <c:v>659</c:v>
                </c:pt>
                <c:pt idx="280">
                  <c:v>660</c:v>
                </c:pt>
                <c:pt idx="281">
                  <c:v>661</c:v>
                </c:pt>
                <c:pt idx="282">
                  <c:v>662</c:v>
                </c:pt>
                <c:pt idx="283">
                  <c:v>663</c:v>
                </c:pt>
                <c:pt idx="284">
                  <c:v>664</c:v>
                </c:pt>
                <c:pt idx="285">
                  <c:v>665</c:v>
                </c:pt>
                <c:pt idx="286">
                  <c:v>666</c:v>
                </c:pt>
                <c:pt idx="287">
                  <c:v>667</c:v>
                </c:pt>
                <c:pt idx="288">
                  <c:v>668</c:v>
                </c:pt>
                <c:pt idx="289">
                  <c:v>669</c:v>
                </c:pt>
                <c:pt idx="290">
                  <c:v>670</c:v>
                </c:pt>
                <c:pt idx="291">
                  <c:v>671</c:v>
                </c:pt>
                <c:pt idx="292">
                  <c:v>672</c:v>
                </c:pt>
                <c:pt idx="293">
                  <c:v>673</c:v>
                </c:pt>
                <c:pt idx="294">
                  <c:v>674</c:v>
                </c:pt>
                <c:pt idx="295">
                  <c:v>675</c:v>
                </c:pt>
                <c:pt idx="296">
                  <c:v>676</c:v>
                </c:pt>
                <c:pt idx="297">
                  <c:v>677</c:v>
                </c:pt>
                <c:pt idx="298">
                  <c:v>678</c:v>
                </c:pt>
                <c:pt idx="299">
                  <c:v>679</c:v>
                </c:pt>
                <c:pt idx="300">
                  <c:v>680</c:v>
                </c:pt>
                <c:pt idx="301">
                  <c:v>681</c:v>
                </c:pt>
                <c:pt idx="302">
                  <c:v>682</c:v>
                </c:pt>
                <c:pt idx="303">
                  <c:v>683</c:v>
                </c:pt>
                <c:pt idx="304">
                  <c:v>684</c:v>
                </c:pt>
                <c:pt idx="305">
                  <c:v>685</c:v>
                </c:pt>
                <c:pt idx="306">
                  <c:v>686</c:v>
                </c:pt>
                <c:pt idx="307">
                  <c:v>687</c:v>
                </c:pt>
                <c:pt idx="308">
                  <c:v>688</c:v>
                </c:pt>
                <c:pt idx="309">
                  <c:v>689</c:v>
                </c:pt>
                <c:pt idx="310">
                  <c:v>690</c:v>
                </c:pt>
                <c:pt idx="311">
                  <c:v>691</c:v>
                </c:pt>
                <c:pt idx="312">
                  <c:v>692</c:v>
                </c:pt>
                <c:pt idx="313">
                  <c:v>693</c:v>
                </c:pt>
                <c:pt idx="314">
                  <c:v>694</c:v>
                </c:pt>
                <c:pt idx="315">
                  <c:v>695</c:v>
                </c:pt>
                <c:pt idx="316">
                  <c:v>696</c:v>
                </c:pt>
                <c:pt idx="317">
                  <c:v>697</c:v>
                </c:pt>
                <c:pt idx="318">
                  <c:v>698</c:v>
                </c:pt>
                <c:pt idx="319">
                  <c:v>699</c:v>
                </c:pt>
                <c:pt idx="320">
                  <c:v>700</c:v>
                </c:pt>
                <c:pt idx="321">
                  <c:v>701</c:v>
                </c:pt>
                <c:pt idx="322">
                  <c:v>702</c:v>
                </c:pt>
                <c:pt idx="323">
                  <c:v>703</c:v>
                </c:pt>
                <c:pt idx="324">
                  <c:v>704</c:v>
                </c:pt>
                <c:pt idx="325">
                  <c:v>705</c:v>
                </c:pt>
                <c:pt idx="326">
                  <c:v>706</c:v>
                </c:pt>
                <c:pt idx="327">
                  <c:v>707</c:v>
                </c:pt>
                <c:pt idx="328">
                  <c:v>708</c:v>
                </c:pt>
                <c:pt idx="329">
                  <c:v>709</c:v>
                </c:pt>
                <c:pt idx="330">
                  <c:v>710</c:v>
                </c:pt>
                <c:pt idx="331">
                  <c:v>711</c:v>
                </c:pt>
                <c:pt idx="332">
                  <c:v>712</c:v>
                </c:pt>
                <c:pt idx="333">
                  <c:v>713</c:v>
                </c:pt>
                <c:pt idx="334">
                  <c:v>714</c:v>
                </c:pt>
                <c:pt idx="335">
                  <c:v>715</c:v>
                </c:pt>
                <c:pt idx="336">
                  <c:v>716</c:v>
                </c:pt>
                <c:pt idx="337">
                  <c:v>717</c:v>
                </c:pt>
                <c:pt idx="338">
                  <c:v>718</c:v>
                </c:pt>
                <c:pt idx="339">
                  <c:v>719</c:v>
                </c:pt>
                <c:pt idx="340">
                  <c:v>720</c:v>
                </c:pt>
                <c:pt idx="341">
                  <c:v>721</c:v>
                </c:pt>
                <c:pt idx="342">
                  <c:v>722</c:v>
                </c:pt>
                <c:pt idx="343">
                  <c:v>723</c:v>
                </c:pt>
                <c:pt idx="344">
                  <c:v>724</c:v>
                </c:pt>
                <c:pt idx="345">
                  <c:v>725</c:v>
                </c:pt>
                <c:pt idx="346">
                  <c:v>726</c:v>
                </c:pt>
                <c:pt idx="347">
                  <c:v>727</c:v>
                </c:pt>
                <c:pt idx="348">
                  <c:v>728</c:v>
                </c:pt>
                <c:pt idx="349">
                  <c:v>729</c:v>
                </c:pt>
                <c:pt idx="350">
                  <c:v>730</c:v>
                </c:pt>
                <c:pt idx="351">
                  <c:v>731</c:v>
                </c:pt>
                <c:pt idx="352">
                  <c:v>732</c:v>
                </c:pt>
                <c:pt idx="353">
                  <c:v>733</c:v>
                </c:pt>
                <c:pt idx="354">
                  <c:v>734</c:v>
                </c:pt>
                <c:pt idx="355">
                  <c:v>735</c:v>
                </c:pt>
                <c:pt idx="356">
                  <c:v>736</c:v>
                </c:pt>
                <c:pt idx="357">
                  <c:v>737</c:v>
                </c:pt>
                <c:pt idx="358">
                  <c:v>738</c:v>
                </c:pt>
                <c:pt idx="359">
                  <c:v>739</c:v>
                </c:pt>
                <c:pt idx="360">
                  <c:v>740</c:v>
                </c:pt>
                <c:pt idx="361">
                  <c:v>741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6</c:v>
                </c:pt>
                <c:pt idx="367">
                  <c:v>747</c:v>
                </c:pt>
                <c:pt idx="368">
                  <c:v>748</c:v>
                </c:pt>
                <c:pt idx="369">
                  <c:v>749</c:v>
                </c:pt>
                <c:pt idx="370">
                  <c:v>750</c:v>
                </c:pt>
                <c:pt idx="371">
                  <c:v>751</c:v>
                </c:pt>
                <c:pt idx="372">
                  <c:v>752</c:v>
                </c:pt>
                <c:pt idx="373">
                  <c:v>753</c:v>
                </c:pt>
                <c:pt idx="374">
                  <c:v>754</c:v>
                </c:pt>
                <c:pt idx="375">
                  <c:v>755</c:v>
                </c:pt>
                <c:pt idx="376">
                  <c:v>756</c:v>
                </c:pt>
                <c:pt idx="377">
                  <c:v>757</c:v>
                </c:pt>
                <c:pt idx="378">
                  <c:v>758</c:v>
                </c:pt>
                <c:pt idx="379">
                  <c:v>759</c:v>
                </c:pt>
                <c:pt idx="380">
                  <c:v>760</c:v>
                </c:pt>
                <c:pt idx="381">
                  <c:v>761</c:v>
                </c:pt>
                <c:pt idx="382">
                  <c:v>762</c:v>
                </c:pt>
                <c:pt idx="383">
                  <c:v>763</c:v>
                </c:pt>
                <c:pt idx="384">
                  <c:v>764</c:v>
                </c:pt>
                <c:pt idx="385">
                  <c:v>765</c:v>
                </c:pt>
                <c:pt idx="386">
                  <c:v>766</c:v>
                </c:pt>
                <c:pt idx="387">
                  <c:v>767</c:v>
                </c:pt>
                <c:pt idx="388">
                  <c:v>768</c:v>
                </c:pt>
                <c:pt idx="389">
                  <c:v>769</c:v>
                </c:pt>
                <c:pt idx="390">
                  <c:v>770</c:v>
                </c:pt>
                <c:pt idx="391">
                  <c:v>771</c:v>
                </c:pt>
                <c:pt idx="392">
                  <c:v>772</c:v>
                </c:pt>
                <c:pt idx="393">
                  <c:v>773</c:v>
                </c:pt>
                <c:pt idx="394">
                  <c:v>774</c:v>
                </c:pt>
                <c:pt idx="395">
                  <c:v>775</c:v>
                </c:pt>
                <c:pt idx="396">
                  <c:v>776</c:v>
                </c:pt>
                <c:pt idx="397">
                  <c:v>777</c:v>
                </c:pt>
                <c:pt idx="398">
                  <c:v>778</c:v>
                </c:pt>
                <c:pt idx="399">
                  <c:v>779</c:v>
                </c:pt>
                <c:pt idx="400">
                  <c:v>780</c:v>
                </c:pt>
              </c:numCache>
            </c:numRef>
          </c:xVal>
          <c:yVal>
            <c:numRef>
              <c:f>Hoja2!$B$7:$B$407</c:f>
              <c:numCache>
                <c:formatCode>General</c:formatCode>
                <c:ptCount val="401"/>
                <c:pt idx="0">
                  <c:v>5.9500000000000004E-3</c:v>
                </c:pt>
                <c:pt idx="1">
                  <c:v>5.7419999999999997E-3</c:v>
                </c:pt>
                <c:pt idx="2">
                  <c:v>5.4809999999999998E-3</c:v>
                </c:pt>
                <c:pt idx="3">
                  <c:v>5.006E-3</c:v>
                </c:pt>
                <c:pt idx="4">
                  <c:v>4.4270000000000004E-3</c:v>
                </c:pt>
                <c:pt idx="5">
                  <c:v>4.4929999999999996E-3</c:v>
                </c:pt>
                <c:pt idx="6">
                  <c:v>4.7140000000000003E-3</c:v>
                </c:pt>
                <c:pt idx="7">
                  <c:v>4.4549999999999998E-3</c:v>
                </c:pt>
                <c:pt idx="8">
                  <c:v>4.1980000000000003E-3</c:v>
                </c:pt>
                <c:pt idx="9">
                  <c:v>4.3410000000000002E-3</c:v>
                </c:pt>
                <c:pt idx="10">
                  <c:v>4.4349999999999997E-3</c:v>
                </c:pt>
                <c:pt idx="11">
                  <c:v>4.3410000000000002E-3</c:v>
                </c:pt>
                <c:pt idx="12">
                  <c:v>4.261E-3</c:v>
                </c:pt>
                <c:pt idx="13">
                  <c:v>4.2079999999999999E-3</c:v>
                </c:pt>
                <c:pt idx="14">
                  <c:v>4.241E-3</c:v>
                </c:pt>
                <c:pt idx="15">
                  <c:v>4.3680000000000004E-3</c:v>
                </c:pt>
                <c:pt idx="16">
                  <c:v>4.2110000000000003E-3</c:v>
                </c:pt>
                <c:pt idx="17">
                  <c:v>3.8739999999999998E-3</c:v>
                </c:pt>
                <c:pt idx="18">
                  <c:v>3.7959999999999999E-3</c:v>
                </c:pt>
                <c:pt idx="19">
                  <c:v>3.8070000000000001E-3</c:v>
                </c:pt>
                <c:pt idx="20">
                  <c:v>3.9459999999999999E-3</c:v>
                </c:pt>
                <c:pt idx="21">
                  <c:v>4.1019999999999997E-3</c:v>
                </c:pt>
                <c:pt idx="22">
                  <c:v>4.2469999999999999E-3</c:v>
                </c:pt>
                <c:pt idx="23">
                  <c:v>4.3660000000000001E-3</c:v>
                </c:pt>
                <c:pt idx="24">
                  <c:v>4.3400000000000001E-3</c:v>
                </c:pt>
                <c:pt idx="25">
                  <c:v>4.3340000000000002E-3</c:v>
                </c:pt>
                <c:pt idx="26">
                  <c:v>4.3759999999999997E-3</c:v>
                </c:pt>
                <c:pt idx="27">
                  <c:v>4.3550000000000004E-3</c:v>
                </c:pt>
                <c:pt idx="28">
                  <c:v>4.2490000000000002E-3</c:v>
                </c:pt>
                <c:pt idx="29">
                  <c:v>4.0549999999999996E-3</c:v>
                </c:pt>
                <c:pt idx="30">
                  <c:v>3.7919999999999998E-3</c:v>
                </c:pt>
                <c:pt idx="31">
                  <c:v>3.6489999999999999E-3</c:v>
                </c:pt>
                <c:pt idx="32">
                  <c:v>3.5569999999999998E-3</c:v>
                </c:pt>
                <c:pt idx="33">
                  <c:v>3.5040000000000002E-3</c:v>
                </c:pt>
                <c:pt idx="34">
                  <c:v>3.4580000000000001E-3</c:v>
                </c:pt>
                <c:pt idx="35">
                  <c:v>3.699E-3</c:v>
                </c:pt>
                <c:pt idx="36">
                  <c:v>3.9259999999999998E-3</c:v>
                </c:pt>
                <c:pt idx="37">
                  <c:v>3.993E-3</c:v>
                </c:pt>
                <c:pt idx="38">
                  <c:v>4.0489999999999996E-3</c:v>
                </c:pt>
                <c:pt idx="39">
                  <c:v>4.0769999999999999E-3</c:v>
                </c:pt>
                <c:pt idx="40">
                  <c:v>4.2199999999999998E-3</c:v>
                </c:pt>
                <c:pt idx="41">
                  <c:v>4.5380000000000004E-3</c:v>
                </c:pt>
                <c:pt idx="42">
                  <c:v>4.633E-3</c:v>
                </c:pt>
                <c:pt idx="43">
                  <c:v>4.5319999999999996E-3</c:v>
                </c:pt>
                <c:pt idx="44">
                  <c:v>4.7019999999999996E-3</c:v>
                </c:pt>
                <c:pt idx="45">
                  <c:v>5.0029999999999996E-3</c:v>
                </c:pt>
                <c:pt idx="46">
                  <c:v>5.437E-3</c:v>
                </c:pt>
                <c:pt idx="47">
                  <c:v>5.8989999999999997E-3</c:v>
                </c:pt>
                <c:pt idx="48">
                  <c:v>6.4349999999999997E-3</c:v>
                </c:pt>
                <c:pt idx="49">
                  <c:v>6.999E-3</c:v>
                </c:pt>
                <c:pt idx="50">
                  <c:v>7.7929999999999996E-3</c:v>
                </c:pt>
                <c:pt idx="51">
                  <c:v>8.5830000000000004E-3</c:v>
                </c:pt>
                <c:pt idx="52">
                  <c:v>9.3640000000000008E-3</c:v>
                </c:pt>
                <c:pt idx="53">
                  <c:v>1.0394E-2</c:v>
                </c:pt>
                <c:pt idx="54">
                  <c:v>1.1819E-2</c:v>
                </c:pt>
                <c:pt idx="55">
                  <c:v>1.3084999999999999E-2</c:v>
                </c:pt>
                <c:pt idx="56">
                  <c:v>1.4212000000000001E-2</c:v>
                </c:pt>
                <c:pt idx="57">
                  <c:v>1.5848999999999999E-2</c:v>
                </c:pt>
                <c:pt idx="58">
                  <c:v>1.7729000000000002E-2</c:v>
                </c:pt>
                <c:pt idx="59">
                  <c:v>1.9977000000000002E-2</c:v>
                </c:pt>
                <c:pt idx="60">
                  <c:v>2.2304999999999998E-2</c:v>
                </c:pt>
                <c:pt idx="61">
                  <c:v>2.5312999999999999E-2</c:v>
                </c:pt>
                <c:pt idx="62">
                  <c:v>2.8414999999999999E-2</c:v>
                </c:pt>
                <c:pt idx="63">
                  <c:v>3.2059999999999998E-2</c:v>
                </c:pt>
                <c:pt idx="64">
                  <c:v>3.5895999999999997E-2</c:v>
                </c:pt>
                <c:pt idx="65">
                  <c:v>4.0259000000000003E-2</c:v>
                </c:pt>
                <c:pt idx="66">
                  <c:v>4.5043E-2</c:v>
                </c:pt>
                <c:pt idx="67">
                  <c:v>5.0416000000000002E-2</c:v>
                </c:pt>
                <c:pt idx="68">
                  <c:v>5.6069000000000001E-2</c:v>
                </c:pt>
                <c:pt idx="69">
                  <c:v>6.1935999999999998E-2</c:v>
                </c:pt>
                <c:pt idx="70">
                  <c:v>6.8403000000000005E-2</c:v>
                </c:pt>
                <c:pt idx="71">
                  <c:v>7.5108999999999995E-2</c:v>
                </c:pt>
                <c:pt idx="72">
                  <c:v>8.1997E-2</c:v>
                </c:pt>
                <c:pt idx="73">
                  <c:v>8.8910000000000003E-2</c:v>
                </c:pt>
                <c:pt idx="74">
                  <c:v>9.5672999999999994E-2</c:v>
                </c:pt>
                <c:pt idx="75">
                  <c:v>0.102296</c:v>
                </c:pt>
                <c:pt idx="76">
                  <c:v>0.108227</c:v>
                </c:pt>
                <c:pt idx="77">
                  <c:v>0.113608</c:v>
                </c:pt>
                <c:pt idx="78">
                  <c:v>0.117816</c:v>
                </c:pt>
                <c:pt idx="79">
                  <c:v>0.12117700000000001</c:v>
                </c:pt>
                <c:pt idx="80">
                  <c:v>0.12359199999999999</c:v>
                </c:pt>
                <c:pt idx="81">
                  <c:v>0.124474</c:v>
                </c:pt>
                <c:pt idx="82">
                  <c:v>0.124445</c:v>
                </c:pt>
                <c:pt idx="83">
                  <c:v>0.122819</c:v>
                </c:pt>
                <c:pt idx="84">
                  <c:v>0.12074699999999999</c:v>
                </c:pt>
                <c:pt idx="85">
                  <c:v>0.11681800000000001</c:v>
                </c:pt>
                <c:pt idx="86">
                  <c:v>0.112667</c:v>
                </c:pt>
                <c:pt idx="87">
                  <c:v>0.10758</c:v>
                </c:pt>
                <c:pt idx="88">
                  <c:v>0.102343</c:v>
                </c:pt>
                <c:pt idx="89">
                  <c:v>9.6664E-2</c:v>
                </c:pt>
                <c:pt idx="90">
                  <c:v>9.0912000000000007E-2</c:v>
                </c:pt>
                <c:pt idx="91">
                  <c:v>8.5057999999999995E-2</c:v>
                </c:pt>
                <c:pt idx="92">
                  <c:v>7.9418000000000002E-2</c:v>
                </c:pt>
                <c:pt idx="93">
                  <c:v>7.3937000000000003E-2</c:v>
                </c:pt>
                <c:pt idx="94">
                  <c:v>6.8689E-2</c:v>
                </c:pt>
                <c:pt idx="95">
                  <c:v>6.3523999999999997E-2</c:v>
                </c:pt>
                <c:pt idx="96">
                  <c:v>5.8993999999999998E-2</c:v>
                </c:pt>
                <c:pt idx="97">
                  <c:v>5.4574999999999999E-2</c:v>
                </c:pt>
                <c:pt idx="98">
                  <c:v>5.0734000000000001E-2</c:v>
                </c:pt>
                <c:pt idx="99">
                  <c:v>4.7008000000000001E-2</c:v>
                </c:pt>
                <c:pt idx="100">
                  <c:v>4.3671000000000001E-2</c:v>
                </c:pt>
                <c:pt idx="101">
                  <c:v>4.0460999999999997E-2</c:v>
                </c:pt>
                <c:pt idx="102">
                  <c:v>3.7449000000000003E-2</c:v>
                </c:pt>
                <c:pt idx="103">
                  <c:v>3.465E-2</c:v>
                </c:pt>
                <c:pt idx="104">
                  <c:v>3.2017999999999998E-2</c:v>
                </c:pt>
                <c:pt idx="105">
                  <c:v>2.9728000000000001E-2</c:v>
                </c:pt>
                <c:pt idx="106">
                  <c:v>2.7564999999999999E-2</c:v>
                </c:pt>
                <c:pt idx="107">
                  <c:v>2.5249000000000001E-2</c:v>
                </c:pt>
                <c:pt idx="108">
                  <c:v>2.2959E-2</c:v>
                </c:pt>
                <c:pt idx="109">
                  <c:v>2.1229000000000001E-2</c:v>
                </c:pt>
                <c:pt idx="110">
                  <c:v>1.9574999999999999E-2</c:v>
                </c:pt>
                <c:pt idx="111">
                  <c:v>1.8154E-2</c:v>
                </c:pt>
                <c:pt idx="112">
                  <c:v>1.6884E-2</c:v>
                </c:pt>
                <c:pt idx="113">
                  <c:v>1.5824999999999999E-2</c:v>
                </c:pt>
                <c:pt idx="114">
                  <c:v>1.4814000000000001E-2</c:v>
                </c:pt>
                <c:pt idx="115">
                  <c:v>1.3835999999999999E-2</c:v>
                </c:pt>
                <c:pt idx="116">
                  <c:v>1.3006E-2</c:v>
                </c:pt>
                <c:pt idx="117">
                  <c:v>1.222E-2</c:v>
                </c:pt>
                <c:pt idx="118">
                  <c:v>1.1553000000000001E-2</c:v>
                </c:pt>
                <c:pt idx="119">
                  <c:v>1.0874E-2</c:v>
                </c:pt>
                <c:pt idx="120">
                  <c:v>1.0052E-2</c:v>
                </c:pt>
                <c:pt idx="121">
                  <c:v>9.2860000000000009E-3</c:v>
                </c:pt>
                <c:pt idx="122">
                  <c:v>8.6490000000000004E-3</c:v>
                </c:pt>
                <c:pt idx="123">
                  <c:v>8.1030000000000008E-3</c:v>
                </c:pt>
                <c:pt idx="124">
                  <c:v>7.6530000000000001E-3</c:v>
                </c:pt>
                <c:pt idx="125">
                  <c:v>7.3249999999999999E-3</c:v>
                </c:pt>
                <c:pt idx="126">
                  <c:v>7.058E-3</c:v>
                </c:pt>
                <c:pt idx="127">
                  <c:v>6.6839999999999998E-3</c:v>
                </c:pt>
                <c:pt idx="128">
                  <c:v>6.2989999999999999E-3</c:v>
                </c:pt>
                <c:pt idx="129">
                  <c:v>6.1000000000000004E-3</c:v>
                </c:pt>
                <c:pt idx="130">
                  <c:v>5.8979999999999996E-3</c:v>
                </c:pt>
                <c:pt idx="131">
                  <c:v>5.6839999999999998E-3</c:v>
                </c:pt>
                <c:pt idx="132">
                  <c:v>5.4050000000000001E-3</c:v>
                </c:pt>
                <c:pt idx="133">
                  <c:v>5.0369999999999998E-3</c:v>
                </c:pt>
                <c:pt idx="134">
                  <c:v>4.6940000000000003E-3</c:v>
                </c:pt>
                <c:pt idx="135">
                  <c:v>4.3670000000000002E-3</c:v>
                </c:pt>
                <c:pt idx="136">
                  <c:v>4.2529999999999998E-3</c:v>
                </c:pt>
                <c:pt idx="137">
                  <c:v>4.1949999999999999E-3</c:v>
                </c:pt>
                <c:pt idx="138">
                  <c:v>4.2339999999999999E-3</c:v>
                </c:pt>
                <c:pt idx="139">
                  <c:v>4.2519999999999997E-3</c:v>
                </c:pt>
                <c:pt idx="140">
                  <c:v>4.1710000000000002E-3</c:v>
                </c:pt>
                <c:pt idx="141">
                  <c:v>4.0920000000000002E-3</c:v>
                </c:pt>
                <c:pt idx="142">
                  <c:v>4.0150000000000003E-3</c:v>
                </c:pt>
                <c:pt idx="143">
                  <c:v>3.9069999999999999E-3</c:v>
                </c:pt>
                <c:pt idx="144">
                  <c:v>3.7750000000000001E-3</c:v>
                </c:pt>
                <c:pt idx="145">
                  <c:v>3.6280000000000001E-3</c:v>
                </c:pt>
                <c:pt idx="146">
                  <c:v>3.4770000000000001E-3</c:v>
                </c:pt>
                <c:pt idx="147">
                  <c:v>3.4580000000000001E-3</c:v>
                </c:pt>
                <c:pt idx="148">
                  <c:v>3.4459999999999998E-3</c:v>
                </c:pt>
                <c:pt idx="149">
                  <c:v>3.4020000000000001E-3</c:v>
                </c:pt>
                <c:pt idx="150">
                  <c:v>3.388E-3</c:v>
                </c:pt>
                <c:pt idx="151">
                  <c:v>3.447E-3</c:v>
                </c:pt>
                <c:pt idx="152">
                  <c:v>3.4659999999999999E-3</c:v>
                </c:pt>
                <c:pt idx="153">
                  <c:v>3.441E-3</c:v>
                </c:pt>
                <c:pt idx="154">
                  <c:v>3.454E-3</c:v>
                </c:pt>
                <c:pt idx="155">
                  <c:v>3.4859999999999999E-3</c:v>
                </c:pt>
                <c:pt idx="156">
                  <c:v>3.506E-3</c:v>
                </c:pt>
                <c:pt idx="157">
                  <c:v>3.519E-3</c:v>
                </c:pt>
                <c:pt idx="158">
                  <c:v>3.447E-3</c:v>
                </c:pt>
                <c:pt idx="159">
                  <c:v>3.3270000000000001E-3</c:v>
                </c:pt>
                <c:pt idx="160">
                  <c:v>3.0509999999999999E-3</c:v>
                </c:pt>
                <c:pt idx="161">
                  <c:v>2.9060000000000002E-3</c:v>
                </c:pt>
                <c:pt idx="162">
                  <c:v>2.9399999999999999E-3</c:v>
                </c:pt>
                <c:pt idx="163">
                  <c:v>3.0739999999999999E-3</c:v>
                </c:pt>
                <c:pt idx="164">
                  <c:v>3.2699999999999999E-3</c:v>
                </c:pt>
                <c:pt idx="165">
                  <c:v>3.2989999999999998E-3</c:v>
                </c:pt>
                <c:pt idx="166">
                  <c:v>3.2889999999999998E-3</c:v>
                </c:pt>
                <c:pt idx="167">
                  <c:v>3.228E-3</c:v>
                </c:pt>
                <c:pt idx="168">
                  <c:v>3.235E-3</c:v>
                </c:pt>
                <c:pt idx="169">
                  <c:v>3.5019999999999999E-3</c:v>
                </c:pt>
                <c:pt idx="170">
                  <c:v>3.5720000000000001E-3</c:v>
                </c:pt>
                <c:pt idx="171">
                  <c:v>3.3570000000000002E-3</c:v>
                </c:pt>
                <c:pt idx="172">
                  <c:v>3.313E-3</c:v>
                </c:pt>
                <c:pt idx="173">
                  <c:v>3.3779999999999999E-3</c:v>
                </c:pt>
                <c:pt idx="174">
                  <c:v>3.3739999999999998E-3</c:v>
                </c:pt>
                <c:pt idx="175">
                  <c:v>3.359E-3</c:v>
                </c:pt>
                <c:pt idx="176">
                  <c:v>3.5370000000000002E-3</c:v>
                </c:pt>
                <c:pt idx="177">
                  <c:v>3.7069999999999998E-3</c:v>
                </c:pt>
                <c:pt idx="178">
                  <c:v>3.8500000000000001E-3</c:v>
                </c:pt>
                <c:pt idx="179">
                  <c:v>3.9779999999999998E-3</c:v>
                </c:pt>
                <c:pt idx="180">
                  <c:v>4.0870000000000004E-3</c:v>
                </c:pt>
                <c:pt idx="181">
                  <c:v>4.1799999999999997E-3</c:v>
                </c:pt>
                <c:pt idx="182">
                  <c:v>4.2640000000000004E-3</c:v>
                </c:pt>
                <c:pt idx="183">
                  <c:v>4.3909999999999999E-3</c:v>
                </c:pt>
                <c:pt idx="184">
                  <c:v>4.5279999999999999E-3</c:v>
                </c:pt>
                <c:pt idx="185">
                  <c:v>4.6839999999999998E-3</c:v>
                </c:pt>
                <c:pt idx="186">
                  <c:v>4.8820000000000001E-3</c:v>
                </c:pt>
                <c:pt idx="187">
                  <c:v>5.1830000000000001E-3</c:v>
                </c:pt>
                <c:pt idx="188">
                  <c:v>5.4920000000000004E-3</c:v>
                </c:pt>
                <c:pt idx="189">
                  <c:v>5.8089999999999999E-3</c:v>
                </c:pt>
                <c:pt idx="190">
                  <c:v>6.2639999999999996E-3</c:v>
                </c:pt>
                <c:pt idx="191">
                  <c:v>6.7710000000000001E-3</c:v>
                </c:pt>
                <c:pt idx="192">
                  <c:v>7.2150000000000001E-3</c:v>
                </c:pt>
                <c:pt idx="193">
                  <c:v>7.6810000000000003E-3</c:v>
                </c:pt>
                <c:pt idx="194">
                  <c:v>8.2780000000000006E-3</c:v>
                </c:pt>
                <c:pt idx="195">
                  <c:v>8.8920000000000006E-3</c:v>
                </c:pt>
                <c:pt idx="196">
                  <c:v>9.5350000000000001E-3</c:v>
                </c:pt>
                <c:pt idx="197">
                  <c:v>1.0278000000000001E-2</c:v>
                </c:pt>
                <c:pt idx="198">
                  <c:v>1.1084E-2</c:v>
                </c:pt>
                <c:pt idx="199">
                  <c:v>1.2114E-2</c:v>
                </c:pt>
                <c:pt idx="200">
                  <c:v>1.3200999999999999E-2</c:v>
                </c:pt>
                <c:pt idx="201">
                  <c:v>1.4472E-2</c:v>
                </c:pt>
                <c:pt idx="202">
                  <c:v>1.5872000000000001E-2</c:v>
                </c:pt>
                <c:pt idx="203">
                  <c:v>1.7561E-2</c:v>
                </c:pt>
                <c:pt idx="204">
                  <c:v>1.9321999999999999E-2</c:v>
                </c:pt>
                <c:pt idx="205">
                  <c:v>2.1144E-2</c:v>
                </c:pt>
                <c:pt idx="206">
                  <c:v>2.3317999999999998E-2</c:v>
                </c:pt>
                <c:pt idx="207">
                  <c:v>2.5597999999999999E-2</c:v>
                </c:pt>
                <c:pt idx="208">
                  <c:v>2.8164999999999999E-2</c:v>
                </c:pt>
                <c:pt idx="209">
                  <c:v>3.0890000000000001E-2</c:v>
                </c:pt>
                <c:pt idx="210">
                  <c:v>3.4081E-2</c:v>
                </c:pt>
                <c:pt idx="211">
                  <c:v>3.7623999999999998E-2</c:v>
                </c:pt>
                <c:pt idx="212">
                  <c:v>4.1530999999999998E-2</c:v>
                </c:pt>
                <c:pt idx="213">
                  <c:v>4.6030000000000001E-2</c:v>
                </c:pt>
                <c:pt idx="214">
                  <c:v>5.0743000000000003E-2</c:v>
                </c:pt>
                <c:pt idx="215">
                  <c:v>5.6191999999999999E-2</c:v>
                </c:pt>
                <c:pt idx="216">
                  <c:v>6.1894999999999999E-2</c:v>
                </c:pt>
                <c:pt idx="217">
                  <c:v>6.8413000000000002E-2</c:v>
                </c:pt>
                <c:pt idx="218">
                  <c:v>7.5573000000000001E-2</c:v>
                </c:pt>
                <c:pt idx="219">
                  <c:v>8.3445000000000005E-2</c:v>
                </c:pt>
                <c:pt idx="220">
                  <c:v>9.2082999999999998E-2</c:v>
                </c:pt>
                <c:pt idx="221">
                  <c:v>0.101012</c:v>
                </c:pt>
                <c:pt idx="222">
                  <c:v>0.112278</c:v>
                </c:pt>
                <c:pt idx="223">
                  <c:v>0.124095</c:v>
                </c:pt>
                <c:pt idx="224">
                  <c:v>0.13756599999999999</c:v>
                </c:pt>
                <c:pt idx="225">
                  <c:v>0.152228</c:v>
                </c:pt>
                <c:pt idx="226">
                  <c:v>0.168154</c:v>
                </c:pt>
                <c:pt idx="227">
                  <c:v>0.186746</c:v>
                </c:pt>
                <c:pt idx="228">
                  <c:v>0.20626900000000001</c:v>
                </c:pt>
                <c:pt idx="229">
                  <c:v>0.22947200000000001</c:v>
                </c:pt>
                <c:pt idx="230">
                  <c:v>0.25376599999999999</c:v>
                </c:pt>
                <c:pt idx="231">
                  <c:v>0.28109400000000001</c:v>
                </c:pt>
                <c:pt idx="232">
                  <c:v>0.31093100000000001</c:v>
                </c:pt>
                <c:pt idx="233">
                  <c:v>0.34301399999999999</c:v>
                </c:pt>
                <c:pt idx="234">
                  <c:v>0.37981100000000001</c:v>
                </c:pt>
                <c:pt idx="235">
                  <c:v>0.41820800000000002</c:v>
                </c:pt>
                <c:pt idx="236">
                  <c:v>0.46234799999999998</c:v>
                </c:pt>
                <c:pt idx="237">
                  <c:v>0.50873800000000002</c:v>
                </c:pt>
                <c:pt idx="238">
                  <c:v>0.55968700000000005</c:v>
                </c:pt>
                <c:pt idx="239">
                  <c:v>0.61496499999999998</c:v>
                </c:pt>
                <c:pt idx="240">
                  <c:v>0.67310800000000004</c:v>
                </c:pt>
                <c:pt idx="241">
                  <c:v>0.73792199999999997</c:v>
                </c:pt>
                <c:pt idx="242">
                  <c:v>0.80470299999999995</c:v>
                </c:pt>
                <c:pt idx="243">
                  <c:v>0.87721400000000005</c:v>
                </c:pt>
                <c:pt idx="244">
                  <c:v>0.92589699999999997</c:v>
                </c:pt>
                <c:pt idx="245">
                  <c:v>0.94274000000000002</c:v>
                </c:pt>
                <c:pt idx="246">
                  <c:v>0.94924699999999995</c:v>
                </c:pt>
                <c:pt idx="247">
                  <c:v>0.95147999999999999</c:v>
                </c:pt>
                <c:pt idx="248">
                  <c:v>0.95285900000000001</c:v>
                </c:pt>
                <c:pt idx="249">
                  <c:v>0.95445500000000005</c:v>
                </c:pt>
                <c:pt idx="250">
                  <c:v>0.95662000000000003</c:v>
                </c:pt>
                <c:pt idx="251">
                  <c:v>0.95938199999999996</c:v>
                </c:pt>
                <c:pt idx="252">
                  <c:v>0.96255800000000002</c:v>
                </c:pt>
                <c:pt idx="253">
                  <c:v>0.96561200000000003</c:v>
                </c:pt>
                <c:pt idx="254">
                  <c:v>0.96874300000000002</c:v>
                </c:pt>
                <c:pt idx="255">
                  <c:v>0.97220899999999999</c:v>
                </c:pt>
                <c:pt idx="256">
                  <c:v>0.97583399999999998</c:v>
                </c:pt>
                <c:pt idx="257">
                  <c:v>0.97960199999999997</c:v>
                </c:pt>
                <c:pt idx="258">
                  <c:v>0.98298600000000003</c:v>
                </c:pt>
                <c:pt idx="259">
                  <c:v>0.98652099999999998</c:v>
                </c:pt>
                <c:pt idx="260">
                  <c:v>0.99129</c:v>
                </c:pt>
                <c:pt idx="261">
                  <c:v>0.99579300000000004</c:v>
                </c:pt>
                <c:pt idx="262">
                  <c:v>1</c:v>
                </c:pt>
                <c:pt idx="263">
                  <c:v>0.98804599999999998</c:v>
                </c:pt>
                <c:pt idx="264">
                  <c:v>0.96000099999999999</c:v>
                </c:pt>
                <c:pt idx="265">
                  <c:v>0.84254300000000004</c:v>
                </c:pt>
                <c:pt idx="266">
                  <c:v>0.73106700000000002</c:v>
                </c:pt>
                <c:pt idx="267">
                  <c:v>0.62711799999999995</c:v>
                </c:pt>
                <c:pt idx="268">
                  <c:v>0.53756599999999999</c:v>
                </c:pt>
                <c:pt idx="269">
                  <c:v>0.454152</c:v>
                </c:pt>
                <c:pt idx="270">
                  <c:v>0.38740400000000003</c:v>
                </c:pt>
                <c:pt idx="271">
                  <c:v>0.32728299999999999</c:v>
                </c:pt>
                <c:pt idx="272">
                  <c:v>0.27591399999999999</c:v>
                </c:pt>
                <c:pt idx="273">
                  <c:v>0.23409199999999999</c:v>
                </c:pt>
                <c:pt idx="274">
                  <c:v>0.19616700000000001</c:v>
                </c:pt>
                <c:pt idx="275">
                  <c:v>0.166821</c:v>
                </c:pt>
                <c:pt idx="276">
                  <c:v>0.14071</c:v>
                </c:pt>
                <c:pt idx="277">
                  <c:v>0.11874899999999999</c:v>
                </c:pt>
                <c:pt idx="278">
                  <c:v>0.101034</c:v>
                </c:pt>
                <c:pt idx="279">
                  <c:v>8.4960999999999995E-2</c:v>
                </c:pt>
                <c:pt idx="280">
                  <c:v>7.2048000000000001E-2</c:v>
                </c:pt>
                <c:pt idx="281">
                  <c:v>6.0962000000000002E-2</c:v>
                </c:pt>
                <c:pt idx="282">
                  <c:v>5.1979999999999998E-2</c:v>
                </c:pt>
                <c:pt idx="283">
                  <c:v>4.4808000000000001E-2</c:v>
                </c:pt>
                <c:pt idx="284">
                  <c:v>3.8355E-2</c:v>
                </c:pt>
                <c:pt idx="285">
                  <c:v>3.3459000000000003E-2</c:v>
                </c:pt>
                <c:pt idx="286">
                  <c:v>2.9284000000000001E-2</c:v>
                </c:pt>
                <c:pt idx="287">
                  <c:v>2.5801999999999999E-2</c:v>
                </c:pt>
                <c:pt idx="288">
                  <c:v>2.2872E-2</c:v>
                </c:pt>
                <c:pt idx="289">
                  <c:v>2.0209000000000001E-2</c:v>
                </c:pt>
                <c:pt idx="290">
                  <c:v>1.8186000000000001E-2</c:v>
                </c:pt>
                <c:pt idx="291">
                  <c:v>1.6188000000000001E-2</c:v>
                </c:pt>
                <c:pt idx="292">
                  <c:v>1.4208999999999999E-2</c:v>
                </c:pt>
                <c:pt idx="293">
                  <c:v>1.3022000000000001E-2</c:v>
                </c:pt>
                <c:pt idx="294">
                  <c:v>1.1891000000000001E-2</c:v>
                </c:pt>
                <c:pt idx="295">
                  <c:v>1.0762000000000001E-2</c:v>
                </c:pt>
                <c:pt idx="296">
                  <c:v>9.9640000000000006E-3</c:v>
                </c:pt>
                <c:pt idx="297">
                  <c:v>9.3390000000000001E-3</c:v>
                </c:pt>
                <c:pt idx="298">
                  <c:v>8.8649999999999996E-3</c:v>
                </c:pt>
                <c:pt idx="299">
                  <c:v>8.2799999999999992E-3</c:v>
                </c:pt>
                <c:pt idx="300">
                  <c:v>7.5259999999999997E-3</c:v>
                </c:pt>
                <c:pt idx="301">
                  <c:v>7.1630000000000001E-3</c:v>
                </c:pt>
                <c:pt idx="302">
                  <c:v>6.875E-3</c:v>
                </c:pt>
                <c:pt idx="303">
                  <c:v>6.3200000000000001E-3</c:v>
                </c:pt>
                <c:pt idx="304">
                  <c:v>5.9179999999999996E-3</c:v>
                </c:pt>
                <c:pt idx="305">
                  <c:v>5.6600000000000001E-3</c:v>
                </c:pt>
                <c:pt idx="306">
                  <c:v>5.5820000000000002E-3</c:v>
                </c:pt>
                <c:pt idx="307">
                  <c:v>5.4349999999999997E-3</c:v>
                </c:pt>
                <c:pt idx="308">
                  <c:v>5.0499999999999998E-3</c:v>
                </c:pt>
                <c:pt idx="309">
                  <c:v>4.9950000000000003E-3</c:v>
                </c:pt>
                <c:pt idx="310">
                  <c:v>5.104E-3</c:v>
                </c:pt>
                <c:pt idx="311">
                  <c:v>5.0239999999999998E-3</c:v>
                </c:pt>
                <c:pt idx="312">
                  <c:v>4.9100000000000003E-3</c:v>
                </c:pt>
                <c:pt idx="313">
                  <c:v>4.7489999999999997E-3</c:v>
                </c:pt>
                <c:pt idx="314">
                  <c:v>4.5599999999999998E-3</c:v>
                </c:pt>
                <c:pt idx="315">
                  <c:v>4.3680000000000004E-3</c:v>
                </c:pt>
                <c:pt idx="316">
                  <c:v>4.1869999999999997E-3</c:v>
                </c:pt>
                <c:pt idx="317">
                  <c:v>4.1669999999999997E-3</c:v>
                </c:pt>
                <c:pt idx="318">
                  <c:v>4.2519999999999997E-3</c:v>
                </c:pt>
                <c:pt idx="319">
                  <c:v>4.2900000000000004E-3</c:v>
                </c:pt>
                <c:pt idx="320">
                  <c:v>4.3889999999999997E-3</c:v>
                </c:pt>
                <c:pt idx="321">
                  <c:v>4.5760000000000002E-3</c:v>
                </c:pt>
                <c:pt idx="322">
                  <c:v>4.5539999999999999E-3</c:v>
                </c:pt>
                <c:pt idx="323">
                  <c:v>4.5050000000000003E-3</c:v>
                </c:pt>
                <c:pt idx="324">
                  <c:v>4.5469999999999998E-3</c:v>
                </c:pt>
                <c:pt idx="325">
                  <c:v>4.385E-3</c:v>
                </c:pt>
                <c:pt idx="326">
                  <c:v>4.1019999999999997E-3</c:v>
                </c:pt>
                <c:pt idx="327">
                  <c:v>4.1440000000000001E-3</c:v>
                </c:pt>
                <c:pt idx="328">
                  <c:v>4.1110000000000001E-3</c:v>
                </c:pt>
                <c:pt idx="329">
                  <c:v>3.9810000000000002E-3</c:v>
                </c:pt>
                <c:pt idx="330">
                  <c:v>4.248E-3</c:v>
                </c:pt>
                <c:pt idx="331">
                  <c:v>4.463E-3</c:v>
                </c:pt>
                <c:pt idx="332">
                  <c:v>4.3309999999999998E-3</c:v>
                </c:pt>
                <c:pt idx="333">
                  <c:v>4.4050000000000001E-3</c:v>
                </c:pt>
                <c:pt idx="334">
                  <c:v>4.5399999999999998E-3</c:v>
                </c:pt>
                <c:pt idx="335">
                  <c:v>4.3889999999999997E-3</c:v>
                </c:pt>
                <c:pt idx="336">
                  <c:v>4.215E-3</c:v>
                </c:pt>
                <c:pt idx="337">
                  <c:v>4.0210000000000003E-3</c:v>
                </c:pt>
                <c:pt idx="338">
                  <c:v>4.1549999999999998E-3</c:v>
                </c:pt>
                <c:pt idx="339">
                  <c:v>4.2290000000000001E-3</c:v>
                </c:pt>
                <c:pt idx="340">
                  <c:v>4.182E-3</c:v>
                </c:pt>
                <c:pt idx="341">
                  <c:v>4.4390000000000002E-3</c:v>
                </c:pt>
                <c:pt idx="342">
                  <c:v>4.6410000000000002E-3</c:v>
                </c:pt>
                <c:pt idx="343">
                  <c:v>4.463E-3</c:v>
                </c:pt>
                <c:pt idx="344">
                  <c:v>4.4149999999999997E-3</c:v>
                </c:pt>
                <c:pt idx="345">
                  <c:v>4.457E-3</c:v>
                </c:pt>
                <c:pt idx="346">
                  <c:v>4.7200000000000002E-3</c:v>
                </c:pt>
                <c:pt idx="347">
                  <c:v>4.6750000000000003E-3</c:v>
                </c:pt>
                <c:pt idx="348">
                  <c:v>4.398E-3</c:v>
                </c:pt>
                <c:pt idx="349">
                  <c:v>4.4879999999999998E-3</c:v>
                </c:pt>
                <c:pt idx="350">
                  <c:v>4.5149999999999999E-3</c:v>
                </c:pt>
                <c:pt idx="351">
                  <c:v>4.4660000000000004E-3</c:v>
                </c:pt>
                <c:pt idx="352">
                  <c:v>4.6769999999999997E-3</c:v>
                </c:pt>
                <c:pt idx="353">
                  <c:v>4.8799999999999998E-3</c:v>
                </c:pt>
                <c:pt idx="354">
                  <c:v>5.0239999999999998E-3</c:v>
                </c:pt>
                <c:pt idx="355">
                  <c:v>5.0509999999999999E-3</c:v>
                </c:pt>
                <c:pt idx="356">
                  <c:v>5.0809999999999996E-3</c:v>
                </c:pt>
                <c:pt idx="357">
                  <c:v>5.1910000000000003E-3</c:v>
                </c:pt>
                <c:pt idx="358">
                  <c:v>5.032E-3</c:v>
                </c:pt>
                <c:pt idx="359">
                  <c:v>4.8910000000000004E-3</c:v>
                </c:pt>
                <c:pt idx="360">
                  <c:v>5.2230000000000002E-3</c:v>
                </c:pt>
                <c:pt idx="361">
                  <c:v>5.2810000000000001E-3</c:v>
                </c:pt>
                <c:pt idx="362">
                  <c:v>5.2440000000000004E-3</c:v>
                </c:pt>
                <c:pt idx="363">
                  <c:v>5.4999999999999997E-3</c:v>
                </c:pt>
                <c:pt idx="364">
                  <c:v>5.8989999999999997E-3</c:v>
                </c:pt>
                <c:pt idx="365">
                  <c:v>6.3509999999999999E-3</c:v>
                </c:pt>
                <c:pt idx="366">
                  <c:v>6.2960000000000004E-3</c:v>
                </c:pt>
                <c:pt idx="367">
                  <c:v>6.5329999999999997E-3</c:v>
                </c:pt>
                <c:pt idx="368">
                  <c:v>6.9750000000000003E-3</c:v>
                </c:pt>
                <c:pt idx="369">
                  <c:v>6.6559999999999996E-3</c:v>
                </c:pt>
                <c:pt idx="370">
                  <c:v>6.4229999999999999E-3</c:v>
                </c:pt>
                <c:pt idx="371">
                  <c:v>6.2709999999999997E-3</c:v>
                </c:pt>
                <c:pt idx="372">
                  <c:v>6.5900000000000004E-3</c:v>
                </c:pt>
                <c:pt idx="373">
                  <c:v>6.862E-3</c:v>
                </c:pt>
                <c:pt idx="374">
                  <c:v>7.0850000000000002E-3</c:v>
                </c:pt>
                <c:pt idx="375">
                  <c:v>7.8340000000000007E-3</c:v>
                </c:pt>
                <c:pt idx="376">
                  <c:v>8.1399999999999997E-3</c:v>
                </c:pt>
                <c:pt idx="377">
                  <c:v>7.9559999999999995E-3</c:v>
                </c:pt>
                <c:pt idx="378">
                  <c:v>8.1349999999999999E-3</c:v>
                </c:pt>
                <c:pt idx="379">
                  <c:v>8.0110000000000008E-3</c:v>
                </c:pt>
                <c:pt idx="380">
                  <c:v>7.5449999999999996E-3</c:v>
                </c:pt>
                <c:pt idx="381">
                  <c:v>7.6099999999999996E-3</c:v>
                </c:pt>
                <c:pt idx="382">
                  <c:v>7.7299999999999999E-3</c:v>
                </c:pt>
                <c:pt idx="383">
                  <c:v>7.8980000000000005E-3</c:v>
                </c:pt>
                <c:pt idx="384">
                  <c:v>8.4209999999999997E-3</c:v>
                </c:pt>
                <c:pt idx="385">
                  <c:v>8.4419999999999999E-3</c:v>
                </c:pt>
                <c:pt idx="386">
                  <c:v>7.9950000000000004E-3</c:v>
                </c:pt>
                <c:pt idx="387">
                  <c:v>8.2909999999999998E-3</c:v>
                </c:pt>
                <c:pt idx="388">
                  <c:v>8.574E-3</c:v>
                </c:pt>
                <c:pt idx="389">
                  <c:v>8.7930000000000005E-3</c:v>
                </c:pt>
                <c:pt idx="390">
                  <c:v>8.2319999999999997E-3</c:v>
                </c:pt>
                <c:pt idx="391">
                  <c:v>7.9769999999999997E-3</c:v>
                </c:pt>
                <c:pt idx="392">
                  <c:v>7.9380000000000006E-3</c:v>
                </c:pt>
                <c:pt idx="393">
                  <c:v>7.927E-3</c:v>
                </c:pt>
                <c:pt idx="394">
                  <c:v>8.4499999999999992E-3</c:v>
                </c:pt>
                <c:pt idx="395">
                  <c:v>9.1249999999999994E-3</c:v>
                </c:pt>
                <c:pt idx="396">
                  <c:v>9.1900000000000003E-3</c:v>
                </c:pt>
                <c:pt idx="397">
                  <c:v>9.1120000000000003E-3</c:v>
                </c:pt>
                <c:pt idx="398">
                  <c:v>9.0939999999999997E-3</c:v>
                </c:pt>
                <c:pt idx="399">
                  <c:v>9.4039999999999992E-3</c:v>
                </c:pt>
                <c:pt idx="400">
                  <c:v>8.8090000000000009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E14-4089-A3F3-FC5BE9FA31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9757391"/>
        <c:axId val="849754895"/>
      </c:scatterChart>
      <c:valAx>
        <c:axId val="849757391"/>
        <c:scaling>
          <c:orientation val="minMax"/>
          <c:max val="780"/>
          <c:min val="3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Wavelength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4895"/>
        <c:crosses val="autoZero"/>
        <c:crossBetween val="midCat"/>
      </c:valAx>
      <c:valAx>
        <c:axId val="849754895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dirty="0" err="1"/>
                  <a:t>Relative</a:t>
                </a:r>
                <a:r>
                  <a:rPr lang="es-ES" dirty="0"/>
                  <a:t> </a:t>
                </a:r>
                <a:r>
                  <a:rPr lang="es-ES" dirty="0" err="1"/>
                  <a:t>spectral</a:t>
                </a:r>
                <a:r>
                  <a:rPr lang="es-ES" dirty="0"/>
                  <a:t> </a:t>
                </a:r>
                <a:r>
                  <a:rPr lang="es-ES" dirty="0" err="1"/>
                  <a:t>irradiance</a:t>
                </a:r>
                <a:r>
                  <a:rPr lang="es-ES" dirty="0"/>
                  <a:t> </a:t>
                </a:r>
                <a:r>
                  <a:rPr lang="es-ES" dirty="0" err="1"/>
                  <a:t>composition</a:t>
                </a:r>
                <a:endParaRPr lang="es-E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7391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>
                <a:solidFill>
                  <a:schemeClr val="tx1"/>
                </a:solidFill>
              </a:rPr>
              <a:t>R8B2-30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Hoja2!$A$7:$A$407</c:f>
              <c:numCache>
                <c:formatCode>General</c:formatCode>
                <c:ptCount val="401"/>
                <c:pt idx="0">
                  <c:v>380</c:v>
                </c:pt>
                <c:pt idx="1">
                  <c:v>381</c:v>
                </c:pt>
                <c:pt idx="2">
                  <c:v>382</c:v>
                </c:pt>
                <c:pt idx="3">
                  <c:v>383</c:v>
                </c:pt>
                <c:pt idx="4">
                  <c:v>384</c:v>
                </c:pt>
                <c:pt idx="5">
                  <c:v>385</c:v>
                </c:pt>
                <c:pt idx="6">
                  <c:v>386</c:v>
                </c:pt>
                <c:pt idx="7">
                  <c:v>387</c:v>
                </c:pt>
                <c:pt idx="8">
                  <c:v>388</c:v>
                </c:pt>
                <c:pt idx="9">
                  <c:v>389</c:v>
                </c:pt>
                <c:pt idx="10">
                  <c:v>390</c:v>
                </c:pt>
                <c:pt idx="11">
                  <c:v>391</c:v>
                </c:pt>
                <c:pt idx="12">
                  <c:v>392</c:v>
                </c:pt>
                <c:pt idx="13">
                  <c:v>393</c:v>
                </c:pt>
                <c:pt idx="14">
                  <c:v>394</c:v>
                </c:pt>
                <c:pt idx="15">
                  <c:v>395</c:v>
                </c:pt>
                <c:pt idx="16">
                  <c:v>396</c:v>
                </c:pt>
                <c:pt idx="17">
                  <c:v>397</c:v>
                </c:pt>
                <c:pt idx="18">
                  <c:v>398</c:v>
                </c:pt>
                <c:pt idx="19">
                  <c:v>399</c:v>
                </c:pt>
                <c:pt idx="20">
                  <c:v>400</c:v>
                </c:pt>
                <c:pt idx="21">
                  <c:v>401</c:v>
                </c:pt>
                <c:pt idx="22">
                  <c:v>402</c:v>
                </c:pt>
                <c:pt idx="23">
                  <c:v>403</c:v>
                </c:pt>
                <c:pt idx="24">
                  <c:v>404</c:v>
                </c:pt>
                <c:pt idx="25">
                  <c:v>405</c:v>
                </c:pt>
                <c:pt idx="26">
                  <c:v>406</c:v>
                </c:pt>
                <c:pt idx="27">
                  <c:v>407</c:v>
                </c:pt>
                <c:pt idx="28">
                  <c:v>408</c:v>
                </c:pt>
                <c:pt idx="29">
                  <c:v>409</c:v>
                </c:pt>
                <c:pt idx="30">
                  <c:v>410</c:v>
                </c:pt>
                <c:pt idx="31">
                  <c:v>411</c:v>
                </c:pt>
                <c:pt idx="32">
                  <c:v>412</c:v>
                </c:pt>
                <c:pt idx="33">
                  <c:v>413</c:v>
                </c:pt>
                <c:pt idx="34">
                  <c:v>414</c:v>
                </c:pt>
                <c:pt idx="35">
                  <c:v>415</c:v>
                </c:pt>
                <c:pt idx="36">
                  <c:v>416</c:v>
                </c:pt>
                <c:pt idx="37">
                  <c:v>417</c:v>
                </c:pt>
                <c:pt idx="38">
                  <c:v>418</c:v>
                </c:pt>
                <c:pt idx="39">
                  <c:v>419</c:v>
                </c:pt>
                <c:pt idx="40">
                  <c:v>420</c:v>
                </c:pt>
                <c:pt idx="41">
                  <c:v>421</c:v>
                </c:pt>
                <c:pt idx="42">
                  <c:v>422</c:v>
                </c:pt>
                <c:pt idx="43">
                  <c:v>423</c:v>
                </c:pt>
                <c:pt idx="44">
                  <c:v>424</c:v>
                </c:pt>
                <c:pt idx="45">
                  <c:v>425</c:v>
                </c:pt>
                <c:pt idx="46">
                  <c:v>426</c:v>
                </c:pt>
                <c:pt idx="47">
                  <c:v>427</c:v>
                </c:pt>
                <c:pt idx="48">
                  <c:v>428</c:v>
                </c:pt>
                <c:pt idx="49">
                  <c:v>429</c:v>
                </c:pt>
                <c:pt idx="50">
                  <c:v>430</c:v>
                </c:pt>
                <c:pt idx="51">
                  <c:v>431</c:v>
                </c:pt>
                <c:pt idx="52">
                  <c:v>432</c:v>
                </c:pt>
                <c:pt idx="53">
                  <c:v>433</c:v>
                </c:pt>
                <c:pt idx="54">
                  <c:v>434</c:v>
                </c:pt>
                <c:pt idx="55">
                  <c:v>435</c:v>
                </c:pt>
                <c:pt idx="56">
                  <c:v>436</c:v>
                </c:pt>
                <c:pt idx="57">
                  <c:v>437</c:v>
                </c:pt>
                <c:pt idx="58">
                  <c:v>438</c:v>
                </c:pt>
                <c:pt idx="59">
                  <c:v>439</c:v>
                </c:pt>
                <c:pt idx="60">
                  <c:v>440</c:v>
                </c:pt>
                <c:pt idx="61">
                  <c:v>441</c:v>
                </c:pt>
                <c:pt idx="62">
                  <c:v>442</c:v>
                </c:pt>
                <c:pt idx="63">
                  <c:v>443</c:v>
                </c:pt>
                <c:pt idx="64">
                  <c:v>444</c:v>
                </c:pt>
                <c:pt idx="65">
                  <c:v>445</c:v>
                </c:pt>
                <c:pt idx="66">
                  <c:v>446</c:v>
                </c:pt>
                <c:pt idx="67">
                  <c:v>447</c:v>
                </c:pt>
                <c:pt idx="68">
                  <c:v>448</c:v>
                </c:pt>
                <c:pt idx="69">
                  <c:v>449</c:v>
                </c:pt>
                <c:pt idx="70">
                  <c:v>450</c:v>
                </c:pt>
                <c:pt idx="71">
                  <c:v>451</c:v>
                </c:pt>
                <c:pt idx="72">
                  <c:v>452</c:v>
                </c:pt>
                <c:pt idx="73">
                  <c:v>453</c:v>
                </c:pt>
                <c:pt idx="74">
                  <c:v>454</c:v>
                </c:pt>
                <c:pt idx="75">
                  <c:v>455</c:v>
                </c:pt>
                <c:pt idx="76">
                  <c:v>456</c:v>
                </c:pt>
                <c:pt idx="77">
                  <c:v>457</c:v>
                </c:pt>
                <c:pt idx="78">
                  <c:v>458</c:v>
                </c:pt>
                <c:pt idx="79">
                  <c:v>459</c:v>
                </c:pt>
                <c:pt idx="80">
                  <c:v>460</c:v>
                </c:pt>
                <c:pt idx="81">
                  <c:v>461</c:v>
                </c:pt>
                <c:pt idx="82">
                  <c:v>462</c:v>
                </c:pt>
                <c:pt idx="83">
                  <c:v>463</c:v>
                </c:pt>
                <c:pt idx="84">
                  <c:v>464</c:v>
                </c:pt>
                <c:pt idx="85">
                  <c:v>465</c:v>
                </c:pt>
                <c:pt idx="86">
                  <c:v>466</c:v>
                </c:pt>
                <c:pt idx="87">
                  <c:v>467</c:v>
                </c:pt>
                <c:pt idx="88">
                  <c:v>468</c:v>
                </c:pt>
                <c:pt idx="89">
                  <c:v>469</c:v>
                </c:pt>
                <c:pt idx="90">
                  <c:v>470</c:v>
                </c:pt>
                <c:pt idx="91">
                  <c:v>471</c:v>
                </c:pt>
                <c:pt idx="92">
                  <c:v>472</c:v>
                </c:pt>
                <c:pt idx="93">
                  <c:v>473</c:v>
                </c:pt>
                <c:pt idx="94">
                  <c:v>474</c:v>
                </c:pt>
                <c:pt idx="95">
                  <c:v>475</c:v>
                </c:pt>
                <c:pt idx="96">
                  <c:v>476</c:v>
                </c:pt>
                <c:pt idx="97">
                  <c:v>477</c:v>
                </c:pt>
                <c:pt idx="98">
                  <c:v>478</c:v>
                </c:pt>
                <c:pt idx="99">
                  <c:v>479</c:v>
                </c:pt>
                <c:pt idx="100">
                  <c:v>480</c:v>
                </c:pt>
                <c:pt idx="101">
                  <c:v>481</c:v>
                </c:pt>
                <c:pt idx="102">
                  <c:v>482</c:v>
                </c:pt>
                <c:pt idx="103">
                  <c:v>483</c:v>
                </c:pt>
                <c:pt idx="104">
                  <c:v>484</c:v>
                </c:pt>
                <c:pt idx="105">
                  <c:v>485</c:v>
                </c:pt>
                <c:pt idx="106">
                  <c:v>486</c:v>
                </c:pt>
                <c:pt idx="107">
                  <c:v>487</c:v>
                </c:pt>
                <c:pt idx="108">
                  <c:v>488</c:v>
                </c:pt>
                <c:pt idx="109">
                  <c:v>489</c:v>
                </c:pt>
                <c:pt idx="110">
                  <c:v>490</c:v>
                </c:pt>
                <c:pt idx="111">
                  <c:v>491</c:v>
                </c:pt>
                <c:pt idx="112">
                  <c:v>492</c:v>
                </c:pt>
                <c:pt idx="113">
                  <c:v>493</c:v>
                </c:pt>
                <c:pt idx="114">
                  <c:v>494</c:v>
                </c:pt>
                <c:pt idx="115">
                  <c:v>495</c:v>
                </c:pt>
                <c:pt idx="116">
                  <c:v>496</c:v>
                </c:pt>
                <c:pt idx="117">
                  <c:v>497</c:v>
                </c:pt>
                <c:pt idx="118">
                  <c:v>498</c:v>
                </c:pt>
                <c:pt idx="119">
                  <c:v>499</c:v>
                </c:pt>
                <c:pt idx="120">
                  <c:v>500</c:v>
                </c:pt>
                <c:pt idx="121">
                  <c:v>501</c:v>
                </c:pt>
                <c:pt idx="122">
                  <c:v>502</c:v>
                </c:pt>
                <c:pt idx="123">
                  <c:v>503</c:v>
                </c:pt>
                <c:pt idx="124">
                  <c:v>504</c:v>
                </c:pt>
                <c:pt idx="125">
                  <c:v>505</c:v>
                </c:pt>
                <c:pt idx="126">
                  <c:v>506</c:v>
                </c:pt>
                <c:pt idx="127">
                  <c:v>507</c:v>
                </c:pt>
                <c:pt idx="128">
                  <c:v>508</c:v>
                </c:pt>
                <c:pt idx="129">
                  <c:v>509</c:v>
                </c:pt>
                <c:pt idx="130">
                  <c:v>510</c:v>
                </c:pt>
                <c:pt idx="131">
                  <c:v>511</c:v>
                </c:pt>
                <c:pt idx="132">
                  <c:v>512</c:v>
                </c:pt>
                <c:pt idx="133">
                  <c:v>513</c:v>
                </c:pt>
                <c:pt idx="134">
                  <c:v>514</c:v>
                </c:pt>
                <c:pt idx="135">
                  <c:v>515</c:v>
                </c:pt>
                <c:pt idx="136">
                  <c:v>516</c:v>
                </c:pt>
                <c:pt idx="137">
                  <c:v>517</c:v>
                </c:pt>
                <c:pt idx="138">
                  <c:v>518</c:v>
                </c:pt>
                <c:pt idx="139">
                  <c:v>519</c:v>
                </c:pt>
                <c:pt idx="140">
                  <c:v>520</c:v>
                </c:pt>
                <c:pt idx="141">
                  <c:v>521</c:v>
                </c:pt>
                <c:pt idx="142">
                  <c:v>522</c:v>
                </c:pt>
                <c:pt idx="143">
                  <c:v>523</c:v>
                </c:pt>
                <c:pt idx="144">
                  <c:v>524</c:v>
                </c:pt>
                <c:pt idx="145">
                  <c:v>525</c:v>
                </c:pt>
                <c:pt idx="146">
                  <c:v>526</c:v>
                </c:pt>
                <c:pt idx="147">
                  <c:v>527</c:v>
                </c:pt>
                <c:pt idx="148">
                  <c:v>528</c:v>
                </c:pt>
                <c:pt idx="149">
                  <c:v>529</c:v>
                </c:pt>
                <c:pt idx="150">
                  <c:v>530</c:v>
                </c:pt>
                <c:pt idx="151">
                  <c:v>531</c:v>
                </c:pt>
                <c:pt idx="152">
                  <c:v>532</c:v>
                </c:pt>
                <c:pt idx="153">
                  <c:v>533</c:v>
                </c:pt>
                <c:pt idx="154">
                  <c:v>534</c:v>
                </c:pt>
                <c:pt idx="155">
                  <c:v>535</c:v>
                </c:pt>
                <c:pt idx="156">
                  <c:v>536</c:v>
                </c:pt>
                <c:pt idx="157">
                  <c:v>537</c:v>
                </c:pt>
                <c:pt idx="158">
                  <c:v>538</c:v>
                </c:pt>
                <c:pt idx="159">
                  <c:v>539</c:v>
                </c:pt>
                <c:pt idx="160">
                  <c:v>540</c:v>
                </c:pt>
                <c:pt idx="161">
                  <c:v>541</c:v>
                </c:pt>
                <c:pt idx="162">
                  <c:v>542</c:v>
                </c:pt>
                <c:pt idx="163">
                  <c:v>543</c:v>
                </c:pt>
                <c:pt idx="164">
                  <c:v>544</c:v>
                </c:pt>
                <c:pt idx="165">
                  <c:v>545</c:v>
                </c:pt>
                <c:pt idx="166">
                  <c:v>546</c:v>
                </c:pt>
                <c:pt idx="167">
                  <c:v>547</c:v>
                </c:pt>
                <c:pt idx="168">
                  <c:v>548</c:v>
                </c:pt>
                <c:pt idx="169">
                  <c:v>549</c:v>
                </c:pt>
                <c:pt idx="170">
                  <c:v>550</c:v>
                </c:pt>
                <c:pt idx="171">
                  <c:v>551</c:v>
                </c:pt>
                <c:pt idx="172">
                  <c:v>552</c:v>
                </c:pt>
                <c:pt idx="173">
                  <c:v>553</c:v>
                </c:pt>
                <c:pt idx="174">
                  <c:v>554</c:v>
                </c:pt>
                <c:pt idx="175">
                  <c:v>555</c:v>
                </c:pt>
                <c:pt idx="176">
                  <c:v>556</c:v>
                </c:pt>
                <c:pt idx="177">
                  <c:v>557</c:v>
                </c:pt>
                <c:pt idx="178">
                  <c:v>558</c:v>
                </c:pt>
                <c:pt idx="179">
                  <c:v>559</c:v>
                </c:pt>
                <c:pt idx="180">
                  <c:v>560</c:v>
                </c:pt>
                <c:pt idx="181">
                  <c:v>561</c:v>
                </c:pt>
                <c:pt idx="182">
                  <c:v>562</c:v>
                </c:pt>
                <c:pt idx="183">
                  <c:v>563</c:v>
                </c:pt>
                <c:pt idx="184">
                  <c:v>564</c:v>
                </c:pt>
                <c:pt idx="185">
                  <c:v>565</c:v>
                </c:pt>
                <c:pt idx="186">
                  <c:v>566</c:v>
                </c:pt>
                <c:pt idx="187">
                  <c:v>567</c:v>
                </c:pt>
                <c:pt idx="188">
                  <c:v>568</c:v>
                </c:pt>
                <c:pt idx="189">
                  <c:v>569</c:v>
                </c:pt>
                <c:pt idx="190">
                  <c:v>570</c:v>
                </c:pt>
                <c:pt idx="191">
                  <c:v>571</c:v>
                </c:pt>
                <c:pt idx="192">
                  <c:v>572</c:v>
                </c:pt>
                <c:pt idx="193">
                  <c:v>573</c:v>
                </c:pt>
                <c:pt idx="194">
                  <c:v>574</c:v>
                </c:pt>
                <c:pt idx="195">
                  <c:v>575</c:v>
                </c:pt>
                <c:pt idx="196">
                  <c:v>576</c:v>
                </c:pt>
                <c:pt idx="197">
                  <c:v>577</c:v>
                </c:pt>
                <c:pt idx="198">
                  <c:v>578</c:v>
                </c:pt>
                <c:pt idx="199">
                  <c:v>579</c:v>
                </c:pt>
                <c:pt idx="200">
                  <c:v>580</c:v>
                </c:pt>
                <c:pt idx="201">
                  <c:v>581</c:v>
                </c:pt>
                <c:pt idx="202">
                  <c:v>582</c:v>
                </c:pt>
                <c:pt idx="203">
                  <c:v>583</c:v>
                </c:pt>
                <c:pt idx="204">
                  <c:v>584</c:v>
                </c:pt>
                <c:pt idx="205">
                  <c:v>585</c:v>
                </c:pt>
                <c:pt idx="206">
                  <c:v>586</c:v>
                </c:pt>
                <c:pt idx="207">
                  <c:v>587</c:v>
                </c:pt>
                <c:pt idx="208">
                  <c:v>588</c:v>
                </c:pt>
                <c:pt idx="209">
                  <c:v>589</c:v>
                </c:pt>
                <c:pt idx="210">
                  <c:v>590</c:v>
                </c:pt>
                <c:pt idx="211">
                  <c:v>591</c:v>
                </c:pt>
                <c:pt idx="212">
                  <c:v>592</c:v>
                </c:pt>
                <c:pt idx="213">
                  <c:v>593</c:v>
                </c:pt>
                <c:pt idx="214">
                  <c:v>594</c:v>
                </c:pt>
                <c:pt idx="215">
                  <c:v>595</c:v>
                </c:pt>
                <c:pt idx="216">
                  <c:v>596</c:v>
                </c:pt>
                <c:pt idx="217">
                  <c:v>597</c:v>
                </c:pt>
                <c:pt idx="218">
                  <c:v>598</c:v>
                </c:pt>
                <c:pt idx="219">
                  <c:v>599</c:v>
                </c:pt>
                <c:pt idx="220">
                  <c:v>600</c:v>
                </c:pt>
                <c:pt idx="221">
                  <c:v>601</c:v>
                </c:pt>
                <c:pt idx="222">
                  <c:v>602</c:v>
                </c:pt>
                <c:pt idx="223">
                  <c:v>603</c:v>
                </c:pt>
                <c:pt idx="224">
                  <c:v>604</c:v>
                </c:pt>
                <c:pt idx="225">
                  <c:v>605</c:v>
                </c:pt>
                <c:pt idx="226">
                  <c:v>606</c:v>
                </c:pt>
                <c:pt idx="227">
                  <c:v>607</c:v>
                </c:pt>
                <c:pt idx="228">
                  <c:v>608</c:v>
                </c:pt>
                <c:pt idx="229">
                  <c:v>609</c:v>
                </c:pt>
                <c:pt idx="230">
                  <c:v>610</c:v>
                </c:pt>
                <c:pt idx="231">
                  <c:v>611</c:v>
                </c:pt>
                <c:pt idx="232">
                  <c:v>612</c:v>
                </c:pt>
                <c:pt idx="233">
                  <c:v>613</c:v>
                </c:pt>
                <c:pt idx="234">
                  <c:v>614</c:v>
                </c:pt>
                <c:pt idx="235">
                  <c:v>615</c:v>
                </c:pt>
                <c:pt idx="236">
                  <c:v>616</c:v>
                </c:pt>
                <c:pt idx="237">
                  <c:v>617</c:v>
                </c:pt>
                <c:pt idx="238">
                  <c:v>618</c:v>
                </c:pt>
                <c:pt idx="239">
                  <c:v>619</c:v>
                </c:pt>
                <c:pt idx="240">
                  <c:v>620</c:v>
                </c:pt>
                <c:pt idx="241">
                  <c:v>621</c:v>
                </c:pt>
                <c:pt idx="242">
                  <c:v>622</c:v>
                </c:pt>
                <c:pt idx="243">
                  <c:v>623</c:v>
                </c:pt>
                <c:pt idx="244">
                  <c:v>624</c:v>
                </c:pt>
                <c:pt idx="245">
                  <c:v>625</c:v>
                </c:pt>
                <c:pt idx="246">
                  <c:v>626</c:v>
                </c:pt>
                <c:pt idx="247">
                  <c:v>627</c:v>
                </c:pt>
                <c:pt idx="248">
                  <c:v>628</c:v>
                </c:pt>
                <c:pt idx="249">
                  <c:v>629</c:v>
                </c:pt>
                <c:pt idx="250">
                  <c:v>630</c:v>
                </c:pt>
                <c:pt idx="251">
                  <c:v>631</c:v>
                </c:pt>
                <c:pt idx="252">
                  <c:v>632</c:v>
                </c:pt>
                <c:pt idx="253">
                  <c:v>633</c:v>
                </c:pt>
                <c:pt idx="254">
                  <c:v>634</c:v>
                </c:pt>
                <c:pt idx="255">
                  <c:v>635</c:v>
                </c:pt>
                <c:pt idx="256">
                  <c:v>636</c:v>
                </c:pt>
                <c:pt idx="257">
                  <c:v>637</c:v>
                </c:pt>
                <c:pt idx="258">
                  <c:v>638</c:v>
                </c:pt>
                <c:pt idx="259">
                  <c:v>639</c:v>
                </c:pt>
                <c:pt idx="260">
                  <c:v>640</c:v>
                </c:pt>
                <c:pt idx="261">
                  <c:v>641</c:v>
                </c:pt>
                <c:pt idx="262">
                  <c:v>642</c:v>
                </c:pt>
                <c:pt idx="263">
                  <c:v>643</c:v>
                </c:pt>
                <c:pt idx="264">
                  <c:v>644</c:v>
                </c:pt>
                <c:pt idx="265">
                  <c:v>645</c:v>
                </c:pt>
                <c:pt idx="266">
                  <c:v>646</c:v>
                </c:pt>
                <c:pt idx="267">
                  <c:v>647</c:v>
                </c:pt>
                <c:pt idx="268">
                  <c:v>648</c:v>
                </c:pt>
                <c:pt idx="269">
                  <c:v>649</c:v>
                </c:pt>
                <c:pt idx="270">
                  <c:v>650</c:v>
                </c:pt>
                <c:pt idx="271">
                  <c:v>651</c:v>
                </c:pt>
                <c:pt idx="272">
                  <c:v>652</c:v>
                </c:pt>
                <c:pt idx="273">
                  <c:v>653</c:v>
                </c:pt>
                <c:pt idx="274">
                  <c:v>654</c:v>
                </c:pt>
                <c:pt idx="275">
                  <c:v>655</c:v>
                </c:pt>
                <c:pt idx="276">
                  <c:v>656</c:v>
                </c:pt>
                <c:pt idx="277">
                  <c:v>657</c:v>
                </c:pt>
                <c:pt idx="278">
                  <c:v>658</c:v>
                </c:pt>
                <c:pt idx="279">
                  <c:v>659</c:v>
                </c:pt>
                <c:pt idx="280">
                  <c:v>660</c:v>
                </c:pt>
                <c:pt idx="281">
                  <c:v>661</c:v>
                </c:pt>
                <c:pt idx="282">
                  <c:v>662</c:v>
                </c:pt>
                <c:pt idx="283">
                  <c:v>663</c:v>
                </c:pt>
                <c:pt idx="284">
                  <c:v>664</c:v>
                </c:pt>
                <c:pt idx="285">
                  <c:v>665</c:v>
                </c:pt>
                <c:pt idx="286">
                  <c:v>666</c:v>
                </c:pt>
                <c:pt idx="287">
                  <c:v>667</c:v>
                </c:pt>
                <c:pt idx="288">
                  <c:v>668</c:v>
                </c:pt>
                <c:pt idx="289">
                  <c:v>669</c:v>
                </c:pt>
                <c:pt idx="290">
                  <c:v>670</c:v>
                </c:pt>
                <c:pt idx="291">
                  <c:v>671</c:v>
                </c:pt>
                <c:pt idx="292">
                  <c:v>672</c:v>
                </c:pt>
                <c:pt idx="293">
                  <c:v>673</c:v>
                </c:pt>
                <c:pt idx="294">
                  <c:v>674</c:v>
                </c:pt>
                <c:pt idx="295">
                  <c:v>675</c:v>
                </c:pt>
                <c:pt idx="296">
                  <c:v>676</c:v>
                </c:pt>
                <c:pt idx="297">
                  <c:v>677</c:v>
                </c:pt>
                <c:pt idx="298">
                  <c:v>678</c:v>
                </c:pt>
                <c:pt idx="299">
                  <c:v>679</c:v>
                </c:pt>
                <c:pt idx="300">
                  <c:v>680</c:v>
                </c:pt>
                <c:pt idx="301">
                  <c:v>681</c:v>
                </c:pt>
                <c:pt idx="302">
                  <c:v>682</c:v>
                </c:pt>
                <c:pt idx="303">
                  <c:v>683</c:v>
                </c:pt>
                <c:pt idx="304">
                  <c:v>684</c:v>
                </c:pt>
                <c:pt idx="305">
                  <c:v>685</c:v>
                </c:pt>
                <c:pt idx="306">
                  <c:v>686</c:v>
                </c:pt>
                <c:pt idx="307">
                  <c:v>687</c:v>
                </c:pt>
                <c:pt idx="308">
                  <c:v>688</c:v>
                </c:pt>
                <c:pt idx="309">
                  <c:v>689</c:v>
                </c:pt>
                <c:pt idx="310">
                  <c:v>690</c:v>
                </c:pt>
                <c:pt idx="311">
                  <c:v>691</c:v>
                </c:pt>
                <c:pt idx="312">
                  <c:v>692</c:v>
                </c:pt>
                <c:pt idx="313">
                  <c:v>693</c:v>
                </c:pt>
                <c:pt idx="314">
                  <c:v>694</c:v>
                </c:pt>
                <c:pt idx="315">
                  <c:v>695</c:v>
                </c:pt>
                <c:pt idx="316">
                  <c:v>696</c:v>
                </c:pt>
                <c:pt idx="317">
                  <c:v>697</c:v>
                </c:pt>
                <c:pt idx="318">
                  <c:v>698</c:v>
                </c:pt>
                <c:pt idx="319">
                  <c:v>699</c:v>
                </c:pt>
                <c:pt idx="320">
                  <c:v>700</c:v>
                </c:pt>
                <c:pt idx="321">
                  <c:v>701</c:v>
                </c:pt>
                <c:pt idx="322">
                  <c:v>702</c:v>
                </c:pt>
                <c:pt idx="323">
                  <c:v>703</c:v>
                </c:pt>
                <c:pt idx="324">
                  <c:v>704</c:v>
                </c:pt>
                <c:pt idx="325">
                  <c:v>705</c:v>
                </c:pt>
                <c:pt idx="326">
                  <c:v>706</c:v>
                </c:pt>
                <c:pt idx="327">
                  <c:v>707</c:v>
                </c:pt>
                <c:pt idx="328">
                  <c:v>708</c:v>
                </c:pt>
                <c:pt idx="329">
                  <c:v>709</c:v>
                </c:pt>
                <c:pt idx="330">
                  <c:v>710</c:v>
                </c:pt>
                <c:pt idx="331">
                  <c:v>711</c:v>
                </c:pt>
                <c:pt idx="332">
                  <c:v>712</c:v>
                </c:pt>
                <c:pt idx="333">
                  <c:v>713</c:v>
                </c:pt>
                <c:pt idx="334">
                  <c:v>714</c:v>
                </c:pt>
                <c:pt idx="335">
                  <c:v>715</c:v>
                </c:pt>
                <c:pt idx="336">
                  <c:v>716</c:v>
                </c:pt>
                <c:pt idx="337">
                  <c:v>717</c:v>
                </c:pt>
                <c:pt idx="338">
                  <c:v>718</c:v>
                </c:pt>
                <c:pt idx="339">
                  <c:v>719</c:v>
                </c:pt>
                <c:pt idx="340">
                  <c:v>720</c:v>
                </c:pt>
                <c:pt idx="341">
                  <c:v>721</c:v>
                </c:pt>
                <c:pt idx="342">
                  <c:v>722</c:v>
                </c:pt>
                <c:pt idx="343">
                  <c:v>723</c:v>
                </c:pt>
                <c:pt idx="344">
                  <c:v>724</c:v>
                </c:pt>
                <c:pt idx="345">
                  <c:v>725</c:v>
                </c:pt>
                <c:pt idx="346">
                  <c:v>726</c:v>
                </c:pt>
                <c:pt idx="347">
                  <c:v>727</c:v>
                </c:pt>
                <c:pt idx="348">
                  <c:v>728</c:v>
                </c:pt>
                <c:pt idx="349">
                  <c:v>729</c:v>
                </c:pt>
                <c:pt idx="350">
                  <c:v>730</c:v>
                </c:pt>
                <c:pt idx="351">
                  <c:v>731</c:v>
                </c:pt>
                <c:pt idx="352">
                  <c:v>732</c:v>
                </c:pt>
                <c:pt idx="353">
                  <c:v>733</c:v>
                </c:pt>
                <c:pt idx="354">
                  <c:v>734</c:v>
                </c:pt>
                <c:pt idx="355">
                  <c:v>735</c:v>
                </c:pt>
                <c:pt idx="356">
                  <c:v>736</c:v>
                </c:pt>
                <c:pt idx="357">
                  <c:v>737</c:v>
                </c:pt>
                <c:pt idx="358">
                  <c:v>738</c:v>
                </c:pt>
                <c:pt idx="359">
                  <c:v>739</c:v>
                </c:pt>
                <c:pt idx="360">
                  <c:v>740</c:v>
                </c:pt>
                <c:pt idx="361">
                  <c:v>741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6</c:v>
                </c:pt>
                <c:pt idx="367">
                  <c:v>747</c:v>
                </c:pt>
                <c:pt idx="368">
                  <c:v>748</c:v>
                </c:pt>
                <c:pt idx="369">
                  <c:v>749</c:v>
                </c:pt>
                <c:pt idx="370">
                  <c:v>750</c:v>
                </c:pt>
                <c:pt idx="371">
                  <c:v>751</c:v>
                </c:pt>
                <c:pt idx="372">
                  <c:v>752</c:v>
                </c:pt>
                <c:pt idx="373">
                  <c:v>753</c:v>
                </c:pt>
                <c:pt idx="374">
                  <c:v>754</c:v>
                </c:pt>
                <c:pt idx="375">
                  <c:v>755</c:v>
                </c:pt>
                <c:pt idx="376">
                  <c:v>756</c:v>
                </c:pt>
                <c:pt idx="377">
                  <c:v>757</c:v>
                </c:pt>
                <c:pt idx="378">
                  <c:v>758</c:v>
                </c:pt>
                <c:pt idx="379">
                  <c:v>759</c:v>
                </c:pt>
                <c:pt idx="380">
                  <c:v>760</c:v>
                </c:pt>
                <c:pt idx="381">
                  <c:v>761</c:v>
                </c:pt>
                <c:pt idx="382">
                  <c:v>762</c:v>
                </c:pt>
                <c:pt idx="383">
                  <c:v>763</c:v>
                </c:pt>
                <c:pt idx="384">
                  <c:v>764</c:v>
                </c:pt>
                <c:pt idx="385">
                  <c:v>765</c:v>
                </c:pt>
                <c:pt idx="386">
                  <c:v>766</c:v>
                </c:pt>
                <c:pt idx="387">
                  <c:v>767</c:v>
                </c:pt>
                <c:pt idx="388">
                  <c:v>768</c:v>
                </c:pt>
                <c:pt idx="389">
                  <c:v>769</c:v>
                </c:pt>
                <c:pt idx="390">
                  <c:v>770</c:v>
                </c:pt>
                <c:pt idx="391">
                  <c:v>771</c:v>
                </c:pt>
                <c:pt idx="392">
                  <c:v>772</c:v>
                </c:pt>
                <c:pt idx="393">
                  <c:v>773</c:v>
                </c:pt>
                <c:pt idx="394">
                  <c:v>774</c:v>
                </c:pt>
                <c:pt idx="395">
                  <c:v>775</c:v>
                </c:pt>
                <c:pt idx="396">
                  <c:v>776</c:v>
                </c:pt>
                <c:pt idx="397">
                  <c:v>777</c:v>
                </c:pt>
                <c:pt idx="398">
                  <c:v>778</c:v>
                </c:pt>
                <c:pt idx="399">
                  <c:v>779</c:v>
                </c:pt>
                <c:pt idx="400">
                  <c:v>780</c:v>
                </c:pt>
              </c:numCache>
            </c:numRef>
          </c:xVal>
          <c:yVal>
            <c:numRef>
              <c:f>Hoja2!$C$7:$C$407</c:f>
              <c:numCache>
                <c:formatCode>General</c:formatCode>
                <c:ptCount val="401"/>
                <c:pt idx="0">
                  <c:v>5.3379999999999999E-3</c:v>
                </c:pt>
                <c:pt idx="1">
                  <c:v>5.2469999999999999E-3</c:v>
                </c:pt>
                <c:pt idx="2">
                  <c:v>5.1330000000000004E-3</c:v>
                </c:pt>
                <c:pt idx="3">
                  <c:v>4.6820000000000004E-3</c:v>
                </c:pt>
                <c:pt idx="4">
                  <c:v>4.0679999999999996E-3</c:v>
                </c:pt>
                <c:pt idx="5">
                  <c:v>3.9940000000000002E-3</c:v>
                </c:pt>
                <c:pt idx="6">
                  <c:v>4.0499999999999998E-3</c:v>
                </c:pt>
                <c:pt idx="7">
                  <c:v>3.9280000000000001E-3</c:v>
                </c:pt>
                <c:pt idx="8">
                  <c:v>3.8E-3</c:v>
                </c:pt>
                <c:pt idx="9">
                  <c:v>3.7269999999999998E-3</c:v>
                </c:pt>
                <c:pt idx="10">
                  <c:v>3.6909999999999998E-3</c:v>
                </c:pt>
                <c:pt idx="11">
                  <c:v>3.7959999999999999E-3</c:v>
                </c:pt>
                <c:pt idx="12">
                  <c:v>3.8739999999999998E-3</c:v>
                </c:pt>
                <c:pt idx="13">
                  <c:v>3.8990000000000001E-3</c:v>
                </c:pt>
                <c:pt idx="14">
                  <c:v>3.8939999999999999E-3</c:v>
                </c:pt>
                <c:pt idx="15">
                  <c:v>3.8570000000000002E-3</c:v>
                </c:pt>
                <c:pt idx="16">
                  <c:v>3.637E-3</c:v>
                </c:pt>
                <c:pt idx="17">
                  <c:v>3.3010000000000001E-3</c:v>
                </c:pt>
                <c:pt idx="18">
                  <c:v>3.2620000000000001E-3</c:v>
                </c:pt>
                <c:pt idx="19">
                  <c:v>3.3240000000000001E-3</c:v>
                </c:pt>
                <c:pt idx="20">
                  <c:v>3.3519999999999999E-3</c:v>
                </c:pt>
                <c:pt idx="21">
                  <c:v>3.3760000000000001E-3</c:v>
                </c:pt>
                <c:pt idx="22">
                  <c:v>3.434E-3</c:v>
                </c:pt>
                <c:pt idx="23">
                  <c:v>3.4889999999999999E-3</c:v>
                </c:pt>
                <c:pt idx="24">
                  <c:v>3.5249999999999999E-3</c:v>
                </c:pt>
                <c:pt idx="25">
                  <c:v>3.6029999999999999E-3</c:v>
                </c:pt>
                <c:pt idx="26">
                  <c:v>3.784E-3</c:v>
                </c:pt>
                <c:pt idx="27">
                  <c:v>3.8830000000000002E-3</c:v>
                </c:pt>
                <c:pt idx="28">
                  <c:v>3.8709999999999999E-3</c:v>
                </c:pt>
                <c:pt idx="29">
                  <c:v>3.594E-3</c:v>
                </c:pt>
                <c:pt idx="30">
                  <c:v>3.1120000000000002E-3</c:v>
                </c:pt>
                <c:pt idx="31">
                  <c:v>3.0140000000000002E-3</c:v>
                </c:pt>
                <c:pt idx="32">
                  <c:v>3.0820000000000001E-3</c:v>
                </c:pt>
                <c:pt idx="33">
                  <c:v>3.1610000000000002E-3</c:v>
                </c:pt>
                <c:pt idx="34">
                  <c:v>3.2429999999999998E-3</c:v>
                </c:pt>
                <c:pt idx="35">
                  <c:v>3.5130000000000001E-3</c:v>
                </c:pt>
                <c:pt idx="36">
                  <c:v>3.7650000000000001E-3</c:v>
                </c:pt>
                <c:pt idx="37">
                  <c:v>3.8440000000000002E-3</c:v>
                </c:pt>
                <c:pt idx="38">
                  <c:v>3.9719999999999998E-3</c:v>
                </c:pt>
                <c:pt idx="39">
                  <c:v>4.2469999999999999E-3</c:v>
                </c:pt>
                <c:pt idx="40">
                  <c:v>4.5830000000000003E-3</c:v>
                </c:pt>
                <c:pt idx="41">
                  <c:v>5.0109999999999998E-3</c:v>
                </c:pt>
                <c:pt idx="42">
                  <c:v>5.2830000000000004E-3</c:v>
                </c:pt>
                <c:pt idx="43">
                  <c:v>5.4180000000000001E-3</c:v>
                </c:pt>
                <c:pt idx="44">
                  <c:v>5.9059999999999998E-3</c:v>
                </c:pt>
                <c:pt idx="45">
                  <c:v>6.5659999999999998E-3</c:v>
                </c:pt>
                <c:pt idx="46">
                  <c:v>7.3920000000000001E-3</c:v>
                </c:pt>
                <c:pt idx="47">
                  <c:v>8.2550000000000002E-3</c:v>
                </c:pt>
                <c:pt idx="48">
                  <c:v>9.2379999999999997E-3</c:v>
                </c:pt>
                <c:pt idx="49">
                  <c:v>1.0293999999999999E-2</c:v>
                </c:pt>
                <c:pt idx="50">
                  <c:v>1.1960999999999999E-2</c:v>
                </c:pt>
                <c:pt idx="51">
                  <c:v>1.363E-2</c:v>
                </c:pt>
                <c:pt idx="52">
                  <c:v>1.5310000000000001E-2</c:v>
                </c:pt>
                <c:pt idx="53">
                  <c:v>1.7284999999999998E-2</c:v>
                </c:pt>
                <c:pt idx="54">
                  <c:v>1.9727999999999999E-2</c:v>
                </c:pt>
                <c:pt idx="55">
                  <c:v>2.2242999999999999E-2</c:v>
                </c:pt>
                <c:pt idx="56">
                  <c:v>2.4822E-2</c:v>
                </c:pt>
                <c:pt idx="57">
                  <c:v>2.8129000000000001E-2</c:v>
                </c:pt>
                <c:pt idx="58">
                  <c:v>3.1782999999999999E-2</c:v>
                </c:pt>
                <c:pt idx="59">
                  <c:v>3.5999999999999997E-2</c:v>
                </c:pt>
                <c:pt idx="60">
                  <c:v>4.0336999999999998E-2</c:v>
                </c:pt>
                <c:pt idx="61">
                  <c:v>4.5726000000000003E-2</c:v>
                </c:pt>
                <c:pt idx="62">
                  <c:v>5.1270999999999997E-2</c:v>
                </c:pt>
                <c:pt idx="63">
                  <c:v>5.7738999999999999E-2</c:v>
                </c:pt>
                <c:pt idx="64">
                  <c:v>6.4611000000000002E-2</c:v>
                </c:pt>
                <c:pt idx="65">
                  <c:v>7.2592000000000004E-2</c:v>
                </c:pt>
                <c:pt idx="66">
                  <c:v>8.1101999999999994E-2</c:v>
                </c:pt>
                <c:pt idx="67">
                  <c:v>9.0355000000000005E-2</c:v>
                </c:pt>
                <c:pt idx="68">
                  <c:v>0.10004300000000001</c:v>
                </c:pt>
                <c:pt idx="69">
                  <c:v>0.110066</c:v>
                </c:pt>
                <c:pt idx="70">
                  <c:v>0.120892</c:v>
                </c:pt>
                <c:pt idx="71">
                  <c:v>0.13203899999999999</c:v>
                </c:pt>
                <c:pt idx="72">
                  <c:v>0.143317</c:v>
                </c:pt>
                <c:pt idx="73">
                  <c:v>0.15459800000000001</c:v>
                </c:pt>
                <c:pt idx="74">
                  <c:v>0.164853</c:v>
                </c:pt>
                <c:pt idx="75">
                  <c:v>0.17480200000000001</c:v>
                </c:pt>
                <c:pt idx="76">
                  <c:v>0.183229</c:v>
                </c:pt>
                <c:pt idx="77">
                  <c:v>0.190663</c:v>
                </c:pt>
                <c:pt idx="78">
                  <c:v>0.19598199999999999</c:v>
                </c:pt>
                <c:pt idx="79">
                  <c:v>0.199795</c:v>
                </c:pt>
                <c:pt idx="80">
                  <c:v>0.201929</c:v>
                </c:pt>
                <c:pt idx="81">
                  <c:v>0.20164099999999999</c:v>
                </c:pt>
                <c:pt idx="82">
                  <c:v>0.19991200000000001</c:v>
                </c:pt>
                <c:pt idx="83">
                  <c:v>0.19550400000000001</c:v>
                </c:pt>
                <c:pt idx="84">
                  <c:v>0.19034999999999999</c:v>
                </c:pt>
                <c:pt idx="85">
                  <c:v>0.182751</c:v>
                </c:pt>
                <c:pt idx="86">
                  <c:v>0.17485899999999999</c:v>
                </c:pt>
                <c:pt idx="87">
                  <c:v>0.165711</c:v>
                </c:pt>
                <c:pt idx="88">
                  <c:v>0.15651100000000001</c:v>
                </c:pt>
                <c:pt idx="89">
                  <c:v>0.14716000000000001</c:v>
                </c:pt>
                <c:pt idx="90">
                  <c:v>0.137849</c:v>
                </c:pt>
                <c:pt idx="91">
                  <c:v>0.12859599999999999</c:v>
                </c:pt>
                <c:pt idx="92">
                  <c:v>0.11981600000000001</c:v>
                </c:pt>
                <c:pt idx="93">
                  <c:v>0.111385</c:v>
                </c:pt>
                <c:pt idx="94">
                  <c:v>0.103355</c:v>
                </c:pt>
                <c:pt idx="95">
                  <c:v>9.5467999999999997E-2</c:v>
                </c:pt>
                <c:pt idx="96">
                  <c:v>8.8715000000000002E-2</c:v>
                </c:pt>
                <c:pt idx="97">
                  <c:v>8.2137000000000002E-2</c:v>
                </c:pt>
                <c:pt idx="98">
                  <c:v>7.6269000000000003E-2</c:v>
                </c:pt>
                <c:pt idx="99">
                  <c:v>7.0552000000000004E-2</c:v>
                </c:pt>
                <c:pt idx="100">
                  <c:v>6.5347000000000002E-2</c:v>
                </c:pt>
                <c:pt idx="101">
                  <c:v>6.0359999999999997E-2</c:v>
                </c:pt>
                <c:pt idx="102">
                  <c:v>5.5710999999999997E-2</c:v>
                </c:pt>
                <c:pt idx="103">
                  <c:v>5.1353000000000003E-2</c:v>
                </c:pt>
                <c:pt idx="104">
                  <c:v>4.7222E-2</c:v>
                </c:pt>
                <c:pt idx="105">
                  <c:v>4.3512000000000002E-2</c:v>
                </c:pt>
                <c:pt idx="106">
                  <c:v>3.9958E-2</c:v>
                </c:pt>
                <c:pt idx="107">
                  <c:v>3.6624999999999998E-2</c:v>
                </c:pt>
                <c:pt idx="108">
                  <c:v>3.3359E-2</c:v>
                </c:pt>
                <c:pt idx="109">
                  <c:v>3.0651000000000001E-2</c:v>
                </c:pt>
                <c:pt idx="110">
                  <c:v>2.8088999999999999E-2</c:v>
                </c:pt>
                <c:pt idx="111">
                  <c:v>2.5982999999999999E-2</c:v>
                </c:pt>
                <c:pt idx="112">
                  <c:v>2.4063000000000001E-2</c:v>
                </c:pt>
                <c:pt idx="113">
                  <c:v>2.2402999999999999E-2</c:v>
                </c:pt>
                <c:pt idx="114">
                  <c:v>2.0823000000000001E-2</c:v>
                </c:pt>
                <c:pt idx="115">
                  <c:v>1.9297999999999999E-2</c:v>
                </c:pt>
                <c:pt idx="116">
                  <c:v>1.7826999999999999E-2</c:v>
                </c:pt>
                <c:pt idx="117">
                  <c:v>1.6371E-2</c:v>
                </c:pt>
                <c:pt idx="118">
                  <c:v>1.5398999999999999E-2</c:v>
                </c:pt>
                <c:pt idx="119">
                  <c:v>1.4423E-2</c:v>
                </c:pt>
                <c:pt idx="120">
                  <c:v>1.3214E-2</c:v>
                </c:pt>
                <c:pt idx="121">
                  <c:v>1.2122000000000001E-2</c:v>
                </c:pt>
                <c:pt idx="122">
                  <c:v>1.1294999999999999E-2</c:v>
                </c:pt>
                <c:pt idx="123">
                  <c:v>1.0465E-2</c:v>
                </c:pt>
                <c:pt idx="124">
                  <c:v>9.6299999999999997E-3</c:v>
                </c:pt>
                <c:pt idx="125">
                  <c:v>9.0109999999999999E-3</c:v>
                </c:pt>
                <c:pt idx="126">
                  <c:v>8.5000000000000006E-3</c:v>
                </c:pt>
                <c:pt idx="127">
                  <c:v>8.0459999999999993E-3</c:v>
                </c:pt>
                <c:pt idx="128">
                  <c:v>7.6049999999999998E-3</c:v>
                </c:pt>
                <c:pt idx="129">
                  <c:v>7.241E-3</c:v>
                </c:pt>
                <c:pt idx="130">
                  <c:v>6.8599999999999998E-3</c:v>
                </c:pt>
                <c:pt idx="131">
                  <c:v>6.4159999999999998E-3</c:v>
                </c:pt>
                <c:pt idx="132">
                  <c:v>6.0219999999999996E-3</c:v>
                </c:pt>
                <c:pt idx="133">
                  <c:v>5.6969999999999998E-3</c:v>
                </c:pt>
                <c:pt idx="134">
                  <c:v>5.3930000000000002E-3</c:v>
                </c:pt>
                <c:pt idx="135">
                  <c:v>5.1019999999999998E-3</c:v>
                </c:pt>
                <c:pt idx="136">
                  <c:v>4.7990000000000003E-3</c:v>
                </c:pt>
                <c:pt idx="137">
                  <c:v>4.4920000000000003E-3</c:v>
                </c:pt>
                <c:pt idx="138">
                  <c:v>4.3359999999999996E-3</c:v>
                </c:pt>
                <c:pt idx="139">
                  <c:v>4.2079999999999999E-3</c:v>
                </c:pt>
                <c:pt idx="140">
                  <c:v>4.2069999999999998E-3</c:v>
                </c:pt>
                <c:pt idx="141">
                  <c:v>4.1510000000000002E-3</c:v>
                </c:pt>
                <c:pt idx="142">
                  <c:v>4.0010000000000002E-3</c:v>
                </c:pt>
                <c:pt idx="143">
                  <c:v>3.8779999999999999E-3</c:v>
                </c:pt>
                <c:pt idx="144">
                  <c:v>3.777E-3</c:v>
                </c:pt>
                <c:pt idx="145">
                  <c:v>3.5409999999999999E-3</c:v>
                </c:pt>
                <c:pt idx="146">
                  <c:v>3.261E-3</c:v>
                </c:pt>
                <c:pt idx="147">
                  <c:v>3.1819999999999999E-3</c:v>
                </c:pt>
                <c:pt idx="148">
                  <c:v>3.1280000000000001E-3</c:v>
                </c:pt>
                <c:pt idx="149">
                  <c:v>3.1549999999999998E-3</c:v>
                </c:pt>
                <c:pt idx="150">
                  <c:v>3.1679999999999998E-3</c:v>
                </c:pt>
                <c:pt idx="151">
                  <c:v>3.1470000000000001E-3</c:v>
                </c:pt>
                <c:pt idx="152">
                  <c:v>3.1470000000000001E-3</c:v>
                </c:pt>
                <c:pt idx="153">
                  <c:v>3.1689999999999999E-3</c:v>
                </c:pt>
                <c:pt idx="154">
                  <c:v>3.1549999999999998E-3</c:v>
                </c:pt>
                <c:pt idx="155">
                  <c:v>3.1220000000000002E-3</c:v>
                </c:pt>
                <c:pt idx="156">
                  <c:v>3.0899999999999999E-3</c:v>
                </c:pt>
                <c:pt idx="157">
                  <c:v>3.0530000000000002E-3</c:v>
                </c:pt>
                <c:pt idx="158">
                  <c:v>2.9139999999999999E-3</c:v>
                </c:pt>
                <c:pt idx="159">
                  <c:v>2.7929999999999999E-3</c:v>
                </c:pt>
                <c:pt idx="160">
                  <c:v>2.7339999999999999E-3</c:v>
                </c:pt>
                <c:pt idx="161">
                  <c:v>2.6649999999999998E-3</c:v>
                </c:pt>
                <c:pt idx="162">
                  <c:v>2.5820000000000001E-3</c:v>
                </c:pt>
                <c:pt idx="163">
                  <c:v>2.6359999999999999E-3</c:v>
                </c:pt>
                <c:pt idx="164">
                  <c:v>2.7750000000000001E-3</c:v>
                </c:pt>
                <c:pt idx="165">
                  <c:v>2.9009999999999999E-3</c:v>
                </c:pt>
                <c:pt idx="166">
                  <c:v>3.0209999999999998E-3</c:v>
                </c:pt>
                <c:pt idx="167">
                  <c:v>2.8419999999999999E-3</c:v>
                </c:pt>
                <c:pt idx="168">
                  <c:v>2.738E-3</c:v>
                </c:pt>
                <c:pt idx="169">
                  <c:v>2.9239999999999999E-3</c:v>
                </c:pt>
                <c:pt idx="170">
                  <c:v>2.9589999999999998E-3</c:v>
                </c:pt>
                <c:pt idx="171">
                  <c:v>2.7750000000000001E-3</c:v>
                </c:pt>
                <c:pt idx="172">
                  <c:v>2.6979999999999999E-3</c:v>
                </c:pt>
                <c:pt idx="173">
                  <c:v>2.6879999999999999E-3</c:v>
                </c:pt>
                <c:pt idx="174">
                  <c:v>2.6840000000000002E-3</c:v>
                </c:pt>
                <c:pt idx="175">
                  <c:v>2.6849999999999999E-3</c:v>
                </c:pt>
                <c:pt idx="176">
                  <c:v>2.8579999999999999E-3</c:v>
                </c:pt>
                <c:pt idx="177">
                  <c:v>3.0200000000000001E-3</c:v>
                </c:pt>
                <c:pt idx="178">
                  <c:v>3.1489999999999999E-3</c:v>
                </c:pt>
                <c:pt idx="179">
                  <c:v>3.2629999999999998E-3</c:v>
                </c:pt>
                <c:pt idx="180">
                  <c:v>3.3579999999999999E-3</c:v>
                </c:pt>
                <c:pt idx="181">
                  <c:v>3.447E-3</c:v>
                </c:pt>
                <c:pt idx="182">
                  <c:v>3.5330000000000001E-3</c:v>
                </c:pt>
                <c:pt idx="183">
                  <c:v>3.5349999999999999E-3</c:v>
                </c:pt>
                <c:pt idx="184">
                  <c:v>3.5379999999999999E-3</c:v>
                </c:pt>
                <c:pt idx="185">
                  <c:v>3.7439999999999999E-3</c:v>
                </c:pt>
                <c:pt idx="186">
                  <c:v>3.9439999999999996E-3</c:v>
                </c:pt>
                <c:pt idx="187">
                  <c:v>4.1279999999999997E-3</c:v>
                </c:pt>
                <c:pt idx="188">
                  <c:v>4.3680000000000004E-3</c:v>
                </c:pt>
                <c:pt idx="189">
                  <c:v>4.6610000000000002E-3</c:v>
                </c:pt>
                <c:pt idx="190">
                  <c:v>5.006E-3</c:v>
                </c:pt>
                <c:pt idx="191">
                  <c:v>5.3699999999999998E-3</c:v>
                </c:pt>
                <c:pt idx="192">
                  <c:v>5.8149999999999999E-3</c:v>
                </c:pt>
                <c:pt idx="193">
                  <c:v>6.2440000000000004E-3</c:v>
                </c:pt>
                <c:pt idx="194">
                  <c:v>6.5750000000000001E-3</c:v>
                </c:pt>
                <c:pt idx="195">
                  <c:v>6.9779999999999998E-3</c:v>
                </c:pt>
                <c:pt idx="196">
                  <c:v>7.4910000000000003E-3</c:v>
                </c:pt>
                <c:pt idx="197">
                  <c:v>8.0879999999999997E-3</c:v>
                </c:pt>
                <c:pt idx="198">
                  <c:v>8.737E-3</c:v>
                </c:pt>
                <c:pt idx="199">
                  <c:v>9.5359999999999993E-3</c:v>
                </c:pt>
                <c:pt idx="200">
                  <c:v>1.0378E-2</c:v>
                </c:pt>
                <c:pt idx="201">
                  <c:v>1.14E-2</c:v>
                </c:pt>
                <c:pt idx="202">
                  <c:v>1.2524E-2</c:v>
                </c:pt>
                <c:pt idx="203">
                  <c:v>1.3875999999999999E-2</c:v>
                </c:pt>
                <c:pt idx="204">
                  <c:v>1.5257E-2</c:v>
                </c:pt>
                <c:pt idx="205">
                  <c:v>1.6662E-2</c:v>
                </c:pt>
                <c:pt idx="206">
                  <c:v>1.8346000000000001E-2</c:v>
                </c:pt>
                <c:pt idx="207">
                  <c:v>2.0112999999999999E-2</c:v>
                </c:pt>
                <c:pt idx="208">
                  <c:v>2.2024999999999999E-2</c:v>
                </c:pt>
                <c:pt idx="209">
                  <c:v>2.4105999999999999E-2</c:v>
                </c:pt>
                <c:pt idx="210">
                  <c:v>2.6686999999999999E-2</c:v>
                </c:pt>
                <c:pt idx="211">
                  <c:v>2.9493999999999999E-2</c:v>
                </c:pt>
                <c:pt idx="212">
                  <c:v>3.2536000000000002E-2</c:v>
                </c:pt>
                <c:pt idx="213">
                  <c:v>3.6094000000000001E-2</c:v>
                </c:pt>
                <c:pt idx="214">
                  <c:v>3.9837999999999998E-2</c:v>
                </c:pt>
                <c:pt idx="215">
                  <c:v>4.4059000000000001E-2</c:v>
                </c:pt>
                <c:pt idx="216">
                  <c:v>4.8486000000000001E-2</c:v>
                </c:pt>
                <c:pt idx="217">
                  <c:v>5.3588999999999998E-2</c:v>
                </c:pt>
                <c:pt idx="218">
                  <c:v>5.9241000000000002E-2</c:v>
                </c:pt>
                <c:pt idx="219">
                  <c:v>6.5502000000000005E-2</c:v>
                </c:pt>
                <c:pt idx="220">
                  <c:v>7.2356000000000004E-2</c:v>
                </c:pt>
                <c:pt idx="221">
                  <c:v>7.9436999999999994E-2</c:v>
                </c:pt>
                <c:pt idx="222">
                  <c:v>8.7998999999999994E-2</c:v>
                </c:pt>
                <c:pt idx="223">
                  <c:v>9.7055000000000002E-2</c:v>
                </c:pt>
                <c:pt idx="224">
                  <c:v>0.10764799999999999</c:v>
                </c:pt>
                <c:pt idx="225">
                  <c:v>0.119312</c:v>
                </c:pt>
                <c:pt idx="226">
                  <c:v>0.13211000000000001</c:v>
                </c:pt>
                <c:pt idx="227">
                  <c:v>0.14679300000000001</c:v>
                </c:pt>
                <c:pt idx="228">
                  <c:v>0.162134</c:v>
                </c:pt>
                <c:pt idx="229">
                  <c:v>0.180446</c:v>
                </c:pt>
                <c:pt idx="230">
                  <c:v>0.19973399999999999</c:v>
                </c:pt>
                <c:pt idx="231">
                  <c:v>0.22173899999999999</c:v>
                </c:pt>
                <c:pt idx="232">
                  <c:v>0.24554999999999999</c:v>
                </c:pt>
                <c:pt idx="233">
                  <c:v>0.27097700000000002</c:v>
                </c:pt>
                <c:pt idx="234">
                  <c:v>0.30050500000000002</c:v>
                </c:pt>
                <c:pt idx="235">
                  <c:v>0.33141199999999998</c:v>
                </c:pt>
                <c:pt idx="236">
                  <c:v>0.36711899999999997</c:v>
                </c:pt>
                <c:pt idx="237">
                  <c:v>0.40446700000000002</c:v>
                </c:pt>
                <c:pt idx="238">
                  <c:v>0.44514100000000001</c:v>
                </c:pt>
                <c:pt idx="239">
                  <c:v>0.48940099999999997</c:v>
                </c:pt>
                <c:pt idx="240">
                  <c:v>0.53603400000000001</c:v>
                </c:pt>
                <c:pt idx="241">
                  <c:v>0.58832200000000001</c:v>
                </c:pt>
                <c:pt idx="242">
                  <c:v>0.64231000000000005</c:v>
                </c:pt>
                <c:pt idx="243">
                  <c:v>0.70133900000000005</c:v>
                </c:pt>
                <c:pt idx="244">
                  <c:v>0.762741</c:v>
                </c:pt>
                <c:pt idx="245">
                  <c:v>0.82731299999999997</c:v>
                </c:pt>
                <c:pt idx="246">
                  <c:v>0.89199899999999999</c:v>
                </c:pt>
                <c:pt idx="247">
                  <c:v>0.95673299999999994</c:v>
                </c:pt>
                <c:pt idx="248">
                  <c:v>0.96072999999999997</c:v>
                </c:pt>
                <c:pt idx="249">
                  <c:v>0.96376600000000001</c:v>
                </c:pt>
                <c:pt idx="250">
                  <c:v>0.96607799999999999</c:v>
                </c:pt>
                <c:pt idx="251">
                  <c:v>0.96894999999999998</c:v>
                </c:pt>
                <c:pt idx="252">
                  <c:v>0.97221000000000002</c:v>
                </c:pt>
                <c:pt idx="253">
                  <c:v>0.97525300000000004</c:v>
                </c:pt>
                <c:pt idx="254">
                  <c:v>0.97839500000000001</c:v>
                </c:pt>
                <c:pt idx="255">
                  <c:v>0.98200299999999996</c:v>
                </c:pt>
                <c:pt idx="256">
                  <c:v>0.98574899999999999</c:v>
                </c:pt>
                <c:pt idx="257">
                  <c:v>0.98962000000000006</c:v>
                </c:pt>
                <c:pt idx="258">
                  <c:v>0.99301300000000003</c:v>
                </c:pt>
                <c:pt idx="259">
                  <c:v>0.99636400000000003</c:v>
                </c:pt>
                <c:pt idx="260">
                  <c:v>1</c:v>
                </c:pt>
                <c:pt idx="261">
                  <c:v>0.96099100000000004</c:v>
                </c:pt>
                <c:pt idx="262">
                  <c:v>0.87456699999999998</c:v>
                </c:pt>
                <c:pt idx="263">
                  <c:v>0.77871800000000002</c:v>
                </c:pt>
                <c:pt idx="264">
                  <c:v>0.68129799999999996</c:v>
                </c:pt>
                <c:pt idx="265">
                  <c:v>0.59037799999999996</c:v>
                </c:pt>
                <c:pt idx="266">
                  <c:v>0.50565000000000004</c:v>
                </c:pt>
                <c:pt idx="267">
                  <c:v>0.42871399999999998</c:v>
                </c:pt>
                <c:pt idx="268">
                  <c:v>0.36387199999999997</c:v>
                </c:pt>
                <c:pt idx="269">
                  <c:v>0.304093</c:v>
                </c:pt>
                <c:pt idx="270">
                  <c:v>0.25747900000000001</c:v>
                </c:pt>
                <c:pt idx="271">
                  <c:v>0.215805</c:v>
                </c:pt>
                <c:pt idx="272">
                  <c:v>0.18065600000000001</c:v>
                </c:pt>
                <c:pt idx="273">
                  <c:v>0.152776</c:v>
                </c:pt>
                <c:pt idx="274">
                  <c:v>0.127752</c:v>
                </c:pt>
                <c:pt idx="275">
                  <c:v>0.108263</c:v>
                </c:pt>
                <c:pt idx="276">
                  <c:v>9.1067999999999996E-2</c:v>
                </c:pt>
                <c:pt idx="277">
                  <c:v>7.6813000000000006E-2</c:v>
                </c:pt>
                <c:pt idx="278">
                  <c:v>6.5370999999999999E-2</c:v>
                </c:pt>
                <c:pt idx="279">
                  <c:v>5.5017000000000003E-2</c:v>
                </c:pt>
                <c:pt idx="280">
                  <c:v>4.6744000000000001E-2</c:v>
                </c:pt>
                <c:pt idx="281">
                  <c:v>3.9694E-2</c:v>
                </c:pt>
                <c:pt idx="282">
                  <c:v>3.4054000000000001E-2</c:v>
                </c:pt>
                <c:pt idx="283">
                  <c:v>2.9618999999999999E-2</c:v>
                </c:pt>
                <c:pt idx="284">
                  <c:v>2.5606E-2</c:v>
                </c:pt>
                <c:pt idx="285">
                  <c:v>2.2328000000000001E-2</c:v>
                </c:pt>
                <c:pt idx="286">
                  <c:v>1.9503E-2</c:v>
                </c:pt>
                <c:pt idx="287">
                  <c:v>1.7113E-2</c:v>
                </c:pt>
                <c:pt idx="288">
                  <c:v>1.5395000000000001E-2</c:v>
                </c:pt>
                <c:pt idx="289">
                  <c:v>1.3849999999999999E-2</c:v>
                </c:pt>
                <c:pt idx="290">
                  <c:v>1.2541999999999999E-2</c:v>
                </c:pt>
                <c:pt idx="291">
                  <c:v>1.1106E-2</c:v>
                </c:pt>
                <c:pt idx="292">
                  <c:v>9.5759999999999994E-3</c:v>
                </c:pt>
                <c:pt idx="293">
                  <c:v>8.7770000000000001E-3</c:v>
                </c:pt>
                <c:pt idx="294">
                  <c:v>8.064E-3</c:v>
                </c:pt>
                <c:pt idx="295">
                  <c:v>7.4380000000000002E-3</c:v>
                </c:pt>
                <c:pt idx="296">
                  <c:v>6.8659999999999997E-3</c:v>
                </c:pt>
                <c:pt idx="297">
                  <c:v>6.332E-3</c:v>
                </c:pt>
                <c:pt idx="298">
                  <c:v>6.1320000000000003E-3</c:v>
                </c:pt>
                <c:pt idx="299">
                  <c:v>5.9119999999999997E-3</c:v>
                </c:pt>
                <c:pt idx="300">
                  <c:v>5.6629999999999996E-3</c:v>
                </c:pt>
                <c:pt idx="301">
                  <c:v>5.3410000000000003E-3</c:v>
                </c:pt>
                <c:pt idx="302">
                  <c:v>4.9870000000000001E-3</c:v>
                </c:pt>
                <c:pt idx="303">
                  <c:v>4.5770000000000003E-3</c:v>
                </c:pt>
                <c:pt idx="304">
                  <c:v>4.2680000000000001E-3</c:v>
                </c:pt>
                <c:pt idx="305">
                  <c:v>4.0559999999999997E-3</c:v>
                </c:pt>
                <c:pt idx="306">
                  <c:v>4.0280000000000003E-3</c:v>
                </c:pt>
                <c:pt idx="307">
                  <c:v>4.0220000000000004E-3</c:v>
                </c:pt>
                <c:pt idx="308">
                  <c:v>4.0169999999999997E-3</c:v>
                </c:pt>
                <c:pt idx="309">
                  <c:v>4.1190000000000003E-3</c:v>
                </c:pt>
                <c:pt idx="310">
                  <c:v>4.2640000000000004E-3</c:v>
                </c:pt>
                <c:pt idx="311">
                  <c:v>4.1019999999999997E-3</c:v>
                </c:pt>
                <c:pt idx="312">
                  <c:v>3.9309999999999996E-3</c:v>
                </c:pt>
                <c:pt idx="313">
                  <c:v>3.748E-3</c:v>
                </c:pt>
                <c:pt idx="314">
                  <c:v>3.4459999999999998E-3</c:v>
                </c:pt>
                <c:pt idx="315">
                  <c:v>3.1979999999999999E-3</c:v>
                </c:pt>
                <c:pt idx="316">
                  <c:v>3.2460000000000002E-3</c:v>
                </c:pt>
                <c:pt idx="317">
                  <c:v>3.2950000000000002E-3</c:v>
                </c:pt>
                <c:pt idx="318">
                  <c:v>3.3440000000000002E-3</c:v>
                </c:pt>
                <c:pt idx="319">
                  <c:v>3.3939999999999999E-3</c:v>
                </c:pt>
                <c:pt idx="320">
                  <c:v>3.4450000000000001E-3</c:v>
                </c:pt>
                <c:pt idx="321">
                  <c:v>3.4979999999999998E-3</c:v>
                </c:pt>
                <c:pt idx="322">
                  <c:v>3.617E-3</c:v>
                </c:pt>
                <c:pt idx="323">
                  <c:v>3.7460000000000002E-3</c:v>
                </c:pt>
                <c:pt idx="324">
                  <c:v>3.8509999999999998E-3</c:v>
                </c:pt>
                <c:pt idx="325">
                  <c:v>3.6259999999999999E-3</c:v>
                </c:pt>
                <c:pt idx="326">
                  <c:v>3.2000000000000002E-3</c:v>
                </c:pt>
                <c:pt idx="327">
                  <c:v>3.117E-3</c:v>
                </c:pt>
                <c:pt idx="328">
                  <c:v>3.0999999999999999E-3</c:v>
                </c:pt>
                <c:pt idx="329">
                  <c:v>3.1700000000000001E-3</c:v>
                </c:pt>
                <c:pt idx="330">
                  <c:v>3.3470000000000001E-3</c:v>
                </c:pt>
                <c:pt idx="331">
                  <c:v>3.5149999999999999E-3</c:v>
                </c:pt>
                <c:pt idx="332">
                  <c:v>3.6059999999999998E-3</c:v>
                </c:pt>
                <c:pt idx="333">
                  <c:v>3.6510000000000002E-3</c:v>
                </c:pt>
                <c:pt idx="334">
                  <c:v>3.6749999999999999E-3</c:v>
                </c:pt>
                <c:pt idx="335">
                  <c:v>3.7160000000000001E-3</c:v>
                </c:pt>
                <c:pt idx="336">
                  <c:v>3.63E-3</c:v>
                </c:pt>
                <c:pt idx="337">
                  <c:v>3.4299999999999999E-3</c:v>
                </c:pt>
                <c:pt idx="338">
                  <c:v>3.3159999999999999E-3</c:v>
                </c:pt>
                <c:pt idx="339">
                  <c:v>3.1700000000000001E-3</c:v>
                </c:pt>
                <c:pt idx="340">
                  <c:v>2.9659999999999999E-3</c:v>
                </c:pt>
                <c:pt idx="341">
                  <c:v>3.2820000000000002E-3</c:v>
                </c:pt>
                <c:pt idx="342">
                  <c:v>3.6670000000000001E-3</c:v>
                </c:pt>
                <c:pt idx="343">
                  <c:v>3.901E-3</c:v>
                </c:pt>
                <c:pt idx="344">
                  <c:v>3.8479999999999999E-3</c:v>
                </c:pt>
                <c:pt idx="345">
                  <c:v>3.7100000000000002E-3</c:v>
                </c:pt>
                <c:pt idx="346">
                  <c:v>3.9110000000000004E-3</c:v>
                </c:pt>
                <c:pt idx="347">
                  <c:v>3.8010000000000001E-3</c:v>
                </c:pt>
                <c:pt idx="348">
                  <c:v>3.4550000000000002E-3</c:v>
                </c:pt>
                <c:pt idx="349">
                  <c:v>3.46E-3</c:v>
                </c:pt>
                <c:pt idx="350">
                  <c:v>3.4169999999999999E-3</c:v>
                </c:pt>
                <c:pt idx="351">
                  <c:v>3.3189999999999999E-3</c:v>
                </c:pt>
                <c:pt idx="352">
                  <c:v>3.4069999999999999E-3</c:v>
                </c:pt>
                <c:pt idx="353">
                  <c:v>3.5760000000000002E-3</c:v>
                </c:pt>
                <c:pt idx="354">
                  <c:v>3.8560000000000001E-3</c:v>
                </c:pt>
                <c:pt idx="355">
                  <c:v>3.9690000000000003E-3</c:v>
                </c:pt>
                <c:pt idx="356">
                  <c:v>4.0870000000000004E-3</c:v>
                </c:pt>
                <c:pt idx="357">
                  <c:v>4.3169999999999997E-3</c:v>
                </c:pt>
                <c:pt idx="358">
                  <c:v>4.1660000000000004E-3</c:v>
                </c:pt>
                <c:pt idx="359">
                  <c:v>3.9329999999999999E-3</c:v>
                </c:pt>
                <c:pt idx="360">
                  <c:v>3.9259999999999998E-3</c:v>
                </c:pt>
                <c:pt idx="361">
                  <c:v>4.0090000000000004E-3</c:v>
                </c:pt>
                <c:pt idx="362">
                  <c:v>4.1479999999999998E-3</c:v>
                </c:pt>
                <c:pt idx="363">
                  <c:v>4.3489999999999996E-3</c:v>
                </c:pt>
                <c:pt idx="364">
                  <c:v>4.6239999999999996E-3</c:v>
                </c:pt>
                <c:pt idx="365">
                  <c:v>4.9280000000000001E-3</c:v>
                </c:pt>
                <c:pt idx="366">
                  <c:v>5.0010000000000002E-3</c:v>
                </c:pt>
                <c:pt idx="367">
                  <c:v>5.3169999999999997E-3</c:v>
                </c:pt>
                <c:pt idx="368">
                  <c:v>5.7879999999999997E-3</c:v>
                </c:pt>
                <c:pt idx="369">
                  <c:v>5.2069999999999998E-3</c:v>
                </c:pt>
                <c:pt idx="370">
                  <c:v>4.7990000000000003E-3</c:v>
                </c:pt>
                <c:pt idx="371">
                  <c:v>4.5539999999999999E-3</c:v>
                </c:pt>
                <c:pt idx="372">
                  <c:v>5.0610000000000004E-3</c:v>
                </c:pt>
                <c:pt idx="373">
                  <c:v>5.5120000000000004E-3</c:v>
                </c:pt>
                <c:pt idx="374">
                  <c:v>5.9040000000000004E-3</c:v>
                </c:pt>
                <c:pt idx="375">
                  <c:v>6.1029999999999999E-3</c:v>
                </c:pt>
                <c:pt idx="376">
                  <c:v>6.1320000000000003E-3</c:v>
                </c:pt>
                <c:pt idx="377">
                  <c:v>5.9789999999999999E-3</c:v>
                </c:pt>
                <c:pt idx="378">
                  <c:v>6.4070000000000004E-3</c:v>
                </c:pt>
                <c:pt idx="379">
                  <c:v>6.4460000000000003E-3</c:v>
                </c:pt>
                <c:pt idx="380">
                  <c:v>6.0410000000000004E-3</c:v>
                </c:pt>
                <c:pt idx="381">
                  <c:v>5.8149999999999999E-3</c:v>
                </c:pt>
                <c:pt idx="382">
                  <c:v>5.7029999999999997E-3</c:v>
                </c:pt>
                <c:pt idx="383">
                  <c:v>5.7070000000000003E-3</c:v>
                </c:pt>
                <c:pt idx="384">
                  <c:v>6.2969999999999996E-3</c:v>
                </c:pt>
                <c:pt idx="385">
                  <c:v>6.6400000000000001E-3</c:v>
                </c:pt>
                <c:pt idx="386">
                  <c:v>6.7419999999999997E-3</c:v>
                </c:pt>
                <c:pt idx="387">
                  <c:v>6.783E-3</c:v>
                </c:pt>
                <c:pt idx="388">
                  <c:v>7.0759999999999998E-3</c:v>
                </c:pt>
                <c:pt idx="389">
                  <c:v>7.4929999999999997E-3</c:v>
                </c:pt>
                <c:pt idx="390">
                  <c:v>6.6280000000000002E-3</c:v>
                </c:pt>
                <c:pt idx="391">
                  <c:v>6.123E-3</c:v>
                </c:pt>
                <c:pt idx="392">
                  <c:v>5.9329999999999999E-3</c:v>
                </c:pt>
                <c:pt idx="393">
                  <c:v>6.2249999999999996E-3</c:v>
                </c:pt>
                <c:pt idx="394">
                  <c:v>6.6969999999999998E-3</c:v>
                </c:pt>
                <c:pt idx="395">
                  <c:v>7.2880000000000002E-3</c:v>
                </c:pt>
                <c:pt idx="396">
                  <c:v>7.9740000000000002E-3</c:v>
                </c:pt>
                <c:pt idx="397">
                  <c:v>7.6610000000000003E-3</c:v>
                </c:pt>
                <c:pt idx="398">
                  <c:v>7.2119999999999997E-3</c:v>
                </c:pt>
                <c:pt idx="399">
                  <c:v>7.4679999999999998E-3</c:v>
                </c:pt>
                <c:pt idx="400">
                  <c:v>6.8079999999999998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659-4348-B8C5-E84EBE5261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9757391"/>
        <c:axId val="849754895"/>
      </c:scatterChart>
      <c:valAx>
        <c:axId val="849757391"/>
        <c:scaling>
          <c:orientation val="minMax"/>
          <c:max val="780"/>
          <c:min val="3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Wavelength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4895"/>
        <c:crosses val="autoZero"/>
        <c:crossBetween val="midCat"/>
      </c:valAx>
      <c:valAx>
        <c:axId val="849754895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0" i="0" baseline="0" dirty="0" err="1">
                    <a:effectLst/>
                  </a:rPr>
                  <a:t>Relativ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spectral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irradianc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composition</a:t>
                </a:r>
                <a:endParaRPr lang="es-ES" sz="10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7391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>
                <a:solidFill>
                  <a:schemeClr val="tx1"/>
                </a:solidFill>
              </a:rPr>
              <a:t>R7B3-34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Hoja2!$A$7:$A$407</c:f>
              <c:numCache>
                <c:formatCode>General</c:formatCode>
                <c:ptCount val="401"/>
                <c:pt idx="0">
                  <c:v>380</c:v>
                </c:pt>
                <c:pt idx="1">
                  <c:v>381</c:v>
                </c:pt>
                <c:pt idx="2">
                  <c:v>382</c:v>
                </c:pt>
                <c:pt idx="3">
                  <c:v>383</c:v>
                </c:pt>
                <c:pt idx="4">
                  <c:v>384</c:v>
                </c:pt>
                <c:pt idx="5">
                  <c:v>385</c:v>
                </c:pt>
                <c:pt idx="6">
                  <c:v>386</c:v>
                </c:pt>
                <c:pt idx="7">
                  <c:v>387</c:v>
                </c:pt>
                <c:pt idx="8">
                  <c:v>388</c:v>
                </c:pt>
                <c:pt idx="9">
                  <c:v>389</c:v>
                </c:pt>
                <c:pt idx="10">
                  <c:v>390</c:v>
                </c:pt>
                <c:pt idx="11">
                  <c:v>391</c:v>
                </c:pt>
                <c:pt idx="12">
                  <c:v>392</c:v>
                </c:pt>
                <c:pt idx="13">
                  <c:v>393</c:v>
                </c:pt>
                <c:pt idx="14">
                  <c:v>394</c:v>
                </c:pt>
                <c:pt idx="15">
                  <c:v>395</c:v>
                </c:pt>
                <c:pt idx="16">
                  <c:v>396</c:v>
                </c:pt>
                <c:pt idx="17">
                  <c:v>397</c:v>
                </c:pt>
                <c:pt idx="18">
                  <c:v>398</c:v>
                </c:pt>
                <c:pt idx="19">
                  <c:v>399</c:v>
                </c:pt>
                <c:pt idx="20">
                  <c:v>400</c:v>
                </c:pt>
                <c:pt idx="21">
                  <c:v>401</c:v>
                </c:pt>
                <c:pt idx="22">
                  <c:v>402</c:v>
                </c:pt>
                <c:pt idx="23">
                  <c:v>403</c:v>
                </c:pt>
                <c:pt idx="24">
                  <c:v>404</c:v>
                </c:pt>
                <c:pt idx="25">
                  <c:v>405</c:v>
                </c:pt>
                <c:pt idx="26">
                  <c:v>406</c:v>
                </c:pt>
                <c:pt idx="27">
                  <c:v>407</c:v>
                </c:pt>
                <c:pt idx="28">
                  <c:v>408</c:v>
                </c:pt>
                <c:pt idx="29">
                  <c:v>409</c:v>
                </c:pt>
                <c:pt idx="30">
                  <c:v>410</c:v>
                </c:pt>
                <c:pt idx="31">
                  <c:v>411</c:v>
                </c:pt>
                <c:pt idx="32">
                  <c:v>412</c:v>
                </c:pt>
                <c:pt idx="33">
                  <c:v>413</c:v>
                </c:pt>
                <c:pt idx="34">
                  <c:v>414</c:v>
                </c:pt>
                <c:pt idx="35">
                  <c:v>415</c:v>
                </c:pt>
                <c:pt idx="36">
                  <c:v>416</c:v>
                </c:pt>
                <c:pt idx="37">
                  <c:v>417</c:v>
                </c:pt>
                <c:pt idx="38">
                  <c:v>418</c:v>
                </c:pt>
                <c:pt idx="39">
                  <c:v>419</c:v>
                </c:pt>
                <c:pt idx="40">
                  <c:v>420</c:v>
                </c:pt>
                <c:pt idx="41">
                  <c:v>421</c:v>
                </c:pt>
                <c:pt idx="42">
                  <c:v>422</c:v>
                </c:pt>
                <c:pt idx="43">
                  <c:v>423</c:v>
                </c:pt>
                <c:pt idx="44">
                  <c:v>424</c:v>
                </c:pt>
                <c:pt idx="45">
                  <c:v>425</c:v>
                </c:pt>
                <c:pt idx="46">
                  <c:v>426</c:v>
                </c:pt>
                <c:pt idx="47">
                  <c:v>427</c:v>
                </c:pt>
                <c:pt idx="48">
                  <c:v>428</c:v>
                </c:pt>
                <c:pt idx="49">
                  <c:v>429</c:v>
                </c:pt>
                <c:pt idx="50">
                  <c:v>430</c:v>
                </c:pt>
                <c:pt idx="51">
                  <c:v>431</c:v>
                </c:pt>
                <c:pt idx="52">
                  <c:v>432</c:v>
                </c:pt>
                <c:pt idx="53">
                  <c:v>433</c:v>
                </c:pt>
                <c:pt idx="54">
                  <c:v>434</c:v>
                </c:pt>
                <c:pt idx="55">
                  <c:v>435</c:v>
                </c:pt>
                <c:pt idx="56">
                  <c:v>436</c:v>
                </c:pt>
                <c:pt idx="57">
                  <c:v>437</c:v>
                </c:pt>
                <c:pt idx="58">
                  <c:v>438</c:v>
                </c:pt>
                <c:pt idx="59">
                  <c:v>439</c:v>
                </c:pt>
                <c:pt idx="60">
                  <c:v>440</c:v>
                </c:pt>
                <c:pt idx="61">
                  <c:v>441</c:v>
                </c:pt>
                <c:pt idx="62">
                  <c:v>442</c:v>
                </c:pt>
                <c:pt idx="63">
                  <c:v>443</c:v>
                </c:pt>
                <c:pt idx="64">
                  <c:v>444</c:v>
                </c:pt>
                <c:pt idx="65">
                  <c:v>445</c:v>
                </c:pt>
                <c:pt idx="66">
                  <c:v>446</c:v>
                </c:pt>
                <c:pt idx="67">
                  <c:v>447</c:v>
                </c:pt>
                <c:pt idx="68">
                  <c:v>448</c:v>
                </c:pt>
                <c:pt idx="69">
                  <c:v>449</c:v>
                </c:pt>
                <c:pt idx="70">
                  <c:v>450</c:v>
                </c:pt>
                <c:pt idx="71">
                  <c:v>451</c:v>
                </c:pt>
                <c:pt idx="72">
                  <c:v>452</c:v>
                </c:pt>
                <c:pt idx="73">
                  <c:v>453</c:v>
                </c:pt>
                <c:pt idx="74">
                  <c:v>454</c:v>
                </c:pt>
                <c:pt idx="75">
                  <c:v>455</c:v>
                </c:pt>
                <c:pt idx="76">
                  <c:v>456</c:v>
                </c:pt>
                <c:pt idx="77">
                  <c:v>457</c:v>
                </c:pt>
                <c:pt idx="78">
                  <c:v>458</c:v>
                </c:pt>
                <c:pt idx="79">
                  <c:v>459</c:v>
                </c:pt>
                <c:pt idx="80">
                  <c:v>460</c:v>
                </c:pt>
                <c:pt idx="81">
                  <c:v>461</c:v>
                </c:pt>
                <c:pt idx="82">
                  <c:v>462</c:v>
                </c:pt>
                <c:pt idx="83">
                  <c:v>463</c:v>
                </c:pt>
                <c:pt idx="84">
                  <c:v>464</c:v>
                </c:pt>
                <c:pt idx="85">
                  <c:v>465</c:v>
                </c:pt>
                <c:pt idx="86">
                  <c:v>466</c:v>
                </c:pt>
                <c:pt idx="87">
                  <c:v>467</c:v>
                </c:pt>
                <c:pt idx="88">
                  <c:v>468</c:v>
                </c:pt>
                <c:pt idx="89">
                  <c:v>469</c:v>
                </c:pt>
                <c:pt idx="90">
                  <c:v>470</c:v>
                </c:pt>
                <c:pt idx="91">
                  <c:v>471</c:v>
                </c:pt>
                <c:pt idx="92">
                  <c:v>472</c:v>
                </c:pt>
                <c:pt idx="93">
                  <c:v>473</c:v>
                </c:pt>
                <c:pt idx="94">
                  <c:v>474</c:v>
                </c:pt>
                <c:pt idx="95">
                  <c:v>475</c:v>
                </c:pt>
                <c:pt idx="96">
                  <c:v>476</c:v>
                </c:pt>
                <c:pt idx="97">
                  <c:v>477</c:v>
                </c:pt>
                <c:pt idx="98">
                  <c:v>478</c:v>
                </c:pt>
                <c:pt idx="99">
                  <c:v>479</c:v>
                </c:pt>
                <c:pt idx="100">
                  <c:v>480</c:v>
                </c:pt>
                <c:pt idx="101">
                  <c:v>481</c:v>
                </c:pt>
                <c:pt idx="102">
                  <c:v>482</c:v>
                </c:pt>
                <c:pt idx="103">
                  <c:v>483</c:v>
                </c:pt>
                <c:pt idx="104">
                  <c:v>484</c:v>
                </c:pt>
                <c:pt idx="105">
                  <c:v>485</c:v>
                </c:pt>
                <c:pt idx="106">
                  <c:v>486</c:v>
                </c:pt>
                <c:pt idx="107">
                  <c:v>487</c:v>
                </c:pt>
                <c:pt idx="108">
                  <c:v>488</c:v>
                </c:pt>
                <c:pt idx="109">
                  <c:v>489</c:v>
                </c:pt>
                <c:pt idx="110">
                  <c:v>490</c:v>
                </c:pt>
                <c:pt idx="111">
                  <c:v>491</c:v>
                </c:pt>
                <c:pt idx="112">
                  <c:v>492</c:v>
                </c:pt>
                <c:pt idx="113">
                  <c:v>493</c:v>
                </c:pt>
                <c:pt idx="114">
                  <c:v>494</c:v>
                </c:pt>
                <c:pt idx="115">
                  <c:v>495</c:v>
                </c:pt>
                <c:pt idx="116">
                  <c:v>496</c:v>
                </c:pt>
                <c:pt idx="117">
                  <c:v>497</c:v>
                </c:pt>
                <c:pt idx="118">
                  <c:v>498</c:v>
                </c:pt>
                <c:pt idx="119">
                  <c:v>499</c:v>
                </c:pt>
                <c:pt idx="120">
                  <c:v>500</c:v>
                </c:pt>
                <c:pt idx="121">
                  <c:v>501</c:v>
                </c:pt>
                <c:pt idx="122">
                  <c:v>502</c:v>
                </c:pt>
                <c:pt idx="123">
                  <c:v>503</c:v>
                </c:pt>
                <c:pt idx="124">
                  <c:v>504</c:v>
                </c:pt>
                <c:pt idx="125">
                  <c:v>505</c:v>
                </c:pt>
                <c:pt idx="126">
                  <c:v>506</c:v>
                </c:pt>
                <c:pt idx="127">
                  <c:v>507</c:v>
                </c:pt>
                <c:pt idx="128">
                  <c:v>508</c:v>
                </c:pt>
                <c:pt idx="129">
                  <c:v>509</c:v>
                </c:pt>
                <c:pt idx="130">
                  <c:v>510</c:v>
                </c:pt>
                <c:pt idx="131">
                  <c:v>511</c:v>
                </c:pt>
                <c:pt idx="132">
                  <c:v>512</c:v>
                </c:pt>
                <c:pt idx="133">
                  <c:v>513</c:v>
                </c:pt>
                <c:pt idx="134">
                  <c:v>514</c:v>
                </c:pt>
                <c:pt idx="135">
                  <c:v>515</c:v>
                </c:pt>
                <c:pt idx="136">
                  <c:v>516</c:v>
                </c:pt>
                <c:pt idx="137">
                  <c:v>517</c:v>
                </c:pt>
                <c:pt idx="138">
                  <c:v>518</c:v>
                </c:pt>
                <c:pt idx="139">
                  <c:v>519</c:v>
                </c:pt>
                <c:pt idx="140">
                  <c:v>520</c:v>
                </c:pt>
                <c:pt idx="141">
                  <c:v>521</c:v>
                </c:pt>
                <c:pt idx="142">
                  <c:v>522</c:v>
                </c:pt>
                <c:pt idx="143">
                  <c:v>523</c:v>
                </c:pt>
                <c:pt idx="144">
                  <c:v>524</c:v>
                </c:pt>
                <c:pt idx="145">
                  <c:v>525</c:v>
                </c:pt>
                <c:pt idx="146">
                  <c:v>526</c:v>
                </c:pt>
                <c:pt idx="147">
                  <c:v>527</c:v>
                </c:pt>
                <c:pt idx="148">
                  <c:v>528</c:v>
                </c:pt>
                <c:pt idx="149">
                  <c:v>529</c:v>
                </c:pt>
                <c:pt idx="150">
                  <c:v>530</c:v>
                </c:pt>
                <c:pt idx="151">
                  <c:v>531</c:v>
                </c:pt>
                <c:pt idx="152">
                  <c:v>532</c:v>
                </c:pt>
                <c:pt idx="153">
                  <c:v>533</c:v>
                </c:pt>
                <c:pt idx="154">
                  <c:v>534</c:v>
                </c:pt>
                <c:pt idx="155">
                  <c:v>535</c:v>
                </c:pt>
                <c:pt idx="156">
                  <c:v>536</c:v>
                </c:pt>
                <c:pt idx="157">
                  <c:v>537</c:v>
                </c:pt>
                <c:pt idx="158">
                  <c:v>538</c:v>
                </c:pt>
                <c:pt idx="159">
                  <c:v>539</c:v>
                </c:pt>
                <c:pt idx="160">
                  <c:v>540</c:v>
                </c:pt>
                <c:pt idx="161">
                  <c:v>541</c:v>
                </c:pt>
                <c:pt idx="162">
                  <c:v>542</c:v>
                </c:pt>
                <c:pt idx="163">
                  <c:v>543</c:v>
                </c:pt>
                <c:pt idx="164">
                  <c:v>544</c:v>
                </c:pt>
                <c:pt idx="165">
                  <c:v>545</c:v>
                </c:pt>
                <c:pt idx="166">
                  <c:v>546</c:v>
                </c:pt>
                <c:pt idx="167">
                  <c:v>547</c:v>
                </c:pt>
                <c:pt idx="168">
                  <c:v>548</c:v>
                </c:pt>
                <c:pt idx="169">
                  <c:v>549</c:v>
                </c:pt>
                <c:pt idx="170">
                  <c:v>550</c:v>
                </c:pt>
                <c:pt idx="171">
                  <c:v>551</c:v>
                </c:pt>
                <c:pt idx="172">
                  <c:v>552</c:v>
                </c:pt>
                <c:pt idx="173">
                  <c:v>553</c:v>
                </c:pt>
                <c:pt idx="174">
                  <c:v>554</c:v>
                </c:pt>
                <c:pt idx="175">
                  <c:v>555</c:v>
                </c:pt>
                <c:pt idx="176">
                  <c:v>556</c:v>
                </c:pt>
                <c:pt idx="177">
                  <c:v>557</c:v>
                </c:pt>
                <c:pt idx="178">
                  <c:v>558</c:v>
                </c:pt>
                <c:pt idx="179">
                  <c:v>559</c:v>
                </c:pt>
                <c:pt idx="180">
                  <c:v>560</c:v>
                </c:pt>
                <c:pt idx="181">
                  <c:v>561</c:v>
                </c:pt>
                <c:pt idx="182">
                  <c:v>562</c:v>
                </c:pt>
                <c:pt idx="183">
                  <c:v>563</c:v>
                </c:pt>
                <c:pt idx="184">
                  <c:v>564</c:v>
                </c:pt>
                <c:pt idx="185">
                  <c:v>565</c:v>
                </c:pt>
                <c:pt idx="186">
                  <c:v>566</c:v>
                </c:pt>
                <c:pt idx="187">
                  <c:v>567</c:v>
                </c:pt>
                <c:pt idx="188">
                  <c:v>568</c:v>
                </c:pt>
                <c:pt idx="189">
                  <c:v>569</c:v>
                </c:pt>
                <c:pt idx="190">
                  <c:v>570</c:v>
                </c:pt>
                <c:pt idx="191">
                  <c:v>571</c:v>
                </c:pt>
                <c:pt idx="192">
                  <c:v>572</c:v>
                </c:pt>
                <c:pt idx="193">
                  <c:v>573</c:v>
                </c:pt>
                <c:pt idx="194">
                  <c:v>574</c:v>
                </c:pt>
                <c:pt idx="195">
                  <c:v>575</c:v>
                </c:pt>
                <c:pt idx="196">
                  <c:v>576</c:v>
                </c:pt>
                <c:pt idx="197">
                  <c:v>577</c:v>
                </c:pt>
                <c:pt idx="198">
                  <c:v>578</c:v>
                </c:pt>
                <c:pt idx="199">
                  <c:v>579</c:v>
                </c:pt>
                <c:pt idx="200">
                  <c:v>580</c:v>
                </c:pt>
                <c:pt idx="201">
                  <c:v>581</c:v>
                </c:pt>
                <c:pt idx="202">
                  <c:v>582</c:v>
                </c:pt>
                <c:pt idx="203">
                  <c:v>583</c:v>
                </c:pt>
                <c:pt idx="204">
                  <c:v>584</c:v>
                </c:pt>
                <c:pt idx="205">
                  <c:v>585</c:v>
                </c:pt>
                <c:pt idx="206">
                  <c:v>586</c:v>
                </c:pt>
                <c:pt idx="207">
                  <c:v>587</c:v>
                </c:pt>
                <c:pt idx="208">
                  <c:v>588</c:v>
                </c:pt>
                <c:pt idx="209">
                  <c:v>589</c:v>
                </c:pt>
                <c:pt idx="210">
                  <c:v>590</c:v>
                </c:pt>
                <c:pt idx="211">
                  <c:v>591</c:v>
                </c:pt>
                <c:pt idx="212">
                  <c:v>592</c:v>
                </c:pt>
                <c:pt idx="213">
                  <c:v>593</c:v>
                </c:pt>
                <c:pt idx="214">
                  <c:v>594</c:v>
                </c:pt>
                <c:pt idx="215">
                  <c:v>595</c:v>
                </c:pt>
                <c:pt idx="216">
                  <c:v>596</c:v>
                </c:pt>
                <c:pt idx="217">
                  <c:v>597</c:v>
                </c:pt>
                <c:pt idx="218">
                  <c:v>598</c:v>
                </c:pt>
                <c:pt idx="219">
                  <c:v>599</c:v>
                </c:pt>
                <c:pt idx="220">
                  <c:v>600</c:v>
                </c:pt>
                <c:pt idx="221">
                  <c:v>601</c:v>
                </c:pt>
                <c:pt idx="222">
                  <c:v>602</c:v>
                </c:pt>
                <c:pt idx="223">
                  <c:v>603</c:v>
                </c:pt>
                <c:pt idx="224">
                  <c:v>604</c:v>
                </c:pt>
                <c:pt idx="225">
                  <c:v>605</c:v>
                </c:pt>
                <c:pt idx="226">
                  <c:v>606</c:v>
                </c:pt>
                <c:pt idx="227">
                  <c:v>607</c:v>
                </c:pt>
                <c:pt idx="228">
                  <c:v>608</c:v>
                </c:pt>
                <c:pt idx="229">
                  <c:v>609</c:v>
                </c:pt>
                <c:pt idx="230">
                  <c:v>610</c:v>
                </c:pt>
                <c:pt idx="231">
                  <c:v>611</c:v>
                </c:pt>
                <c:pt idx="232">
                  <c:v>612</c:v>
                </c:pt>
                <c:pt idx="233">
                  <c:v>613</c:v>
                </c:pt>
                <c:pt idx="234">
                  <c:v>614</c:v>
                </c:pt>
                <c:pt idx="235">
                  <c:v>615</c:v>
                </c:pt>
                <c:pt idx="236">
                  <c:v>616</c:v>
                </c:pt>
                <c:pt idx="237">
                  <c:v>617</c:v>
                </c:pt>
                <c:pt idx="238">
                  <c:v>618</c:v>
                </c:pt>
                <c:pt idx="239">
                  <c:v>619</c:v>
                </c:pt>
                <c:pt idx="240">
                  <c:v>620</c:v>
                </c:pt>
                <c:pt idx="241">
                  <c:v>621</c:v>
                </c:pt>
                <c:pt idx="242">
                  <c:v>622</c:v>
                </c:pt>
                <c:pt idx="243">
                  <c:v>623</c:v>
                </c:pt>
                <c:pt idx="244">
                  <c:v>624</c:v>
                </c:pt>
                <c:pt idx="245">
                  <c:v>625</c:v>
                </c:pt>
                <c:pt idx="246">
                  <c:v>626</c:v>
                </c:pt>
                <c:pt idx="247">
                  <c:v>627</c:v>
                </c:pt>
                <c:pt idx="248">
                  <c:v>628</c:v>
                </c:pt>
                <c:pt idx="249">
                  <c:v>629</c:v>
                </c:pt>
                <c:pt idx="250">
                  <c:v>630</c:v>
                </c:pt>
                <c:pt idx="251">
                  <c:v>631</c:v>
                </c:pt>
                <c:pt idx="252">
                  <c:v>632</c:v>
                </c:pt>
                <c:pt idx="253">
                  <c:v>633</c:v>
                </c:pt>
                <c:pt idx="254">
                  <c:v>634</c:v>
                </c:pt>
                <c:pt idx="255">
                  <c:v>635</c:v>
                </c:pt>
                <c:pt idx="256">
                  <c:v>636</c:v>
                </c:pt>
                <c:pt idx="257">
                  <c:v>637</c:v>
                </c:pt>
                <c:pt idx="258">
                  <c:v>638</c:v>
                </c:pt>
                <c:pt idx="259">
                  <c:v>639</c:v>
                </c:pt>
                <c:pt idx="260">
                  <c:v>640</c:v>
                </c:pt>
                <c:pt idx="261">
                  <c:v>641</c:v>
                </c:pt>
                <c:pt idx="262">
                  <c:v>642</c:v>
                </c:pt>
                <c:pt idx="263">
                  <c:v>643</c:v>
                </c:pt>
                <c:pt idx="264">
                  <c:v>644</c:v>
                </c:pt>
                <c:pt idx="265">
                  <c:v>645</c:v>
                </c:pt>
                <c:pt idx="266">
                  <c:v>646</c:v>
                </c:pt>
                <c:pt idx="267">
                  <c:v>647</c:v>
                </c:pt>
                <c:pt idx="268">
                  <c:v>648</c:v>
                </c:pt>
                <c:pt idx="269">
                  <c:v>649</c:v>
                </c:pt>
                <c:pt idx="270">
                  <c:v>650</c:v>
                </c:pt>
                <c:pt idx="271">
                  <c:v>651</c:v>
                </c:pt>
                <c:pt idx="272">
                  <c:v>652</c:v>
                </c:pt>
                <c:pt idx="273">
                  <c:v>653</c:v>
                </c:pt>
                <c:pt idx="274">
                  <c:v>654</c:v>
                </c:pt>
                <c:pt idx="275">
                  <c:v>655</c:v>
                </c:pt>
                <c:pt idx="276">
                  <c:v>656</c:v>
                </c:pt>
                <c:pt idx="277">
                  <c:v>657</c:v>
                </c:pt>
                <c:pt idx="278">
                  <c:v>658</c:v>
                </c:pt>
                <c:pt idx="279">
                  <c:v>659</c:v>
                </c:pt>
                <c:pt idx="280">
                  <c:v>660</c:v>
                </c:pt>
                <c:pt idx="281">
                  <c:v>661</c:v>
                </c:pt>
                <c:pt idx="282">
                  <c:v>662</c:v>
                </c:pt>
                <c:pt idx="283">
                  <c:v>663</c:v>
                </c:pt>
                <c:pt idx="284">
                  <c:v>664</c:v>
                </c:pt>
                <c:pt idx="285">
                  <c:v>665</c:v>
                </c:pt>
                <c:pt idx="286">
                  <c:v>666</c:v>
                </c:pt>
                <c:pt idx="287">
                  <c:v>667</c:v>
                </c:pt>
                <c:pt idx="288">
                  <c:v>668</c:v>
                </c:pt>
                <c:pt idx="289">
                  <c:v>669</c:v>
                </c:pt>
                <c:pt idx="290">
                  <c:v>670</c:v>
                </c:pt>
                <c:pt idx="291">
                  <c:v>671</c:v>
                </c:pt>
                <c:pt idx="292">
                  <c:v>672</c:v>
                </c:pt>
                <c:pt idx="293">
                  <c:v>673</c:v>
                </c:pt>
                <c:pt idx="294">
                  <c:v>674</c:v>
                </c:pt>
                <c:pt idx="295">
                  <c:v>675</c:v>
                </c:pt>
                <c:pt idx="296">
                  <c:v>676</c:v>
                </c:pt>
                <c:pt idx="297">
                  <c:v>677</c:v>
                </c:pt>
                <c:pt idx="298">
                  <c:v>678</c:v>
                </c:pt>
                <c:pt idx="299">
                  <c:v>679</c:v>
                </c:pt>
                <c:pt idx="300">
                  <c:v>680</c:v>
                </c:pt>
                <c:pt idx="301">
                  <c:v>681</c:v>
                </c:pt>
                <c:pt idx="302">
                  <c:v>682</c:v>
                </c:pt>
                <c:pt idx="303">
                  <c:v>683</c:v>
                </c:pt>
                <c:pt idx="304">
                  <c:v>684</c:v>
                </c:pt>
                <c:pt idx="305">
                  <c:v>685</c:v>
                </c:pt>
                <c:pt idx="306">
                  <c:v>686</c:v>
                </c:pt>
                <c:pt idx="307">
                  <c:v>687</c:v>
                </c:pt>
                <c:pt idx="308">
                  <c:v>688</c:v>
                </c:pt>
                <c:pt idx="309">
                  <c:v>689</c:v>
                </c:pt>
                <c:pt idx="310">
                  <c:v>690</c:v>
                </c:pt>
                <c:pt idx="311">
                  <c:v>691</c:v>
                </c:pt>
                <c:pt idx="312">
                  <c:v>692</c:v>
                </c:pt>
                <c:pt idx="313">
                  <c:v>693</c:v>
                </c:pt>
                <c:pt idx="314">
                  <c:v>694</c:v>
                </c:pt>
                <c:pt idx="315">
                  <c:v>695</c:v>
                </c:pt>
                <c:pt idx="316">
                  <c:v>696</c:v>
                </c:pt>
                <c:pt idx="317">
                  <c:v>697</c:v>
                </c:pt>
                <c:pt idx="318">
                  <c:v>698</c:v>
                </c:pt>
                <c:pt idx="319">
                  <c:v>699</c:v>
                </c:pt>
                <c:pt idx="320">
                  <c:v>700</c:v>
                </c:pt>
                <c:pt idx="321">
                  <c:v>701</c:v>
                </c:pt>
                <c:pt idx="322">
                  <c:v>702</c:v>
                </c:pt>
                <c:pt idx="323">
                  <c:v>703</c:v>
                </c:pt>
                <c:pt idx="324">
                  <c:v>704</c:v>
                </c:pt>
                <c:pt idx="325">
                  <c:v>705</c:v>
                </c:pt>
                <c:pt idx="326">
                  <c:v>706</c:v>
                </c:pt>
                <c:pt idx="327">
                  <c:v>707</c:v>
                </c:pt>
                <c:pt idx="328">
                  <c:v>708</c:v>
                </c:pt>
                <c:pt idx="329">
                  <c:v>709</c:v>
                </c:pt>
                <c:pt idx="330">
                  <c:v>710</c:v>
                </c:pt>
                <c:pt idx="331">
                  <c:v>711</c:v>
                </c:pt>
                <c:pt idx="332">
                  <c:v>712</c:v>
                </c:pt>
                <c:pt idx="333">
                  <c:v>713</c:v>
                </c:pt>
                <c:pt idx="334">
                  <c:v>714</c:v>
                </c:pt>
                <c:pt idx="335">
                  <c:v>715</c:v>
                </c:pt>
                <c:pt idx="336">
                  <c:v>716</c:v>
                </c:pt>
                <c:pt idx="337">
                  <c:v>717</c:v>
                </c:pt>
                <c:pt idx="338">
                  <c:v>718</c:v>
                </c:pt>
                <c:pt idx="339">
                  <c:v>719</c:v>
                </c:pt>
                <c:pt idx="340">
                  <c:v>720</c:v>
                </c:pt>
                <c:pt idx="341">
                  <c:v>721</c:v>
                </c:pt>
                <c:pt idx="342">
                  <c:v>722</c:v>
                </c:pt>
                <c:pt idx="343">
                  <c:v>723</c:v>
                </c:pt>
                <c:pt idx="344">
                  <c:v>724</c:v>
                </c:pt>
                <c:pt idx="345">
                  <c:v>725</c:v>
                </c:pt>
                <c:pt idx="346">
                  <c:v>726</c:v>
                </c:pt>
                <c:pt idx="347">
                  <c:v>727</c:v>
                </c:pt>
                <c:pt idx="348">
                  <c:v>728</c:v>
                </c:pt>
                <c:pt idx="349">
                  <c:v>729</c:v>
                </c:pt>
                <c:pt idx="350">
                  <c:v>730</c:v>
                </c:pt>
                <c:pt idx="351">
                  <c:v>731</c:v>
                </c:pt>
                <c:pt idx="352">
                  <c:v>732</c:v>
                </c:pt>
                <c:pt idx="353">
                  <c:v>733</c:v>
                </c:pt>
                <c:pt idx="354">
                  <c:v>734</c:v>
                </c:pt>
                <c:pt idx="355">
                  <c:v>735</c:v>
                </c:pt>
                <c:pt idx="356">
                  <c:v>736</c:v>
                </c:pt>
                <c:pt idx="357">
                  <c:v>737</c:v>
                </c:pt>
                <c:pt idx="358">
                  <c:v>738</c:v>
                </c:pt>
                <c:pt idx="359">
                  <c:v>739</c:v>
                </c:pt>
                <c:pt idx="360">
                  <c:v>740</c:v>
                </c:pt>
                <c:pt idx="361">
                  <c:v>741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6</c:v>
                </c:pt>
                <c:pt idx="367">
                  <c:v>747</c:v>
                </c:pt>
                <c:pt idx="368">
                  <c:v>748</c:v>
                </c:pt>
                <c:pt idx="369">
                  <c:v>749</c:v>
                </c:pt>
                <c:pt idx="370">
                  <c:v>750</c:v>
                </c:pt>
                <c:pt idx="371">
                  <c:v>751</c:v>
                </c:pt>
                <c:pt idx="372">
                  <c:v>752</c:v>
                </c:pt>
                <c:pt idx="373">
                  <c:v>753</c:v>
                </c:pt>
                <c:pt idx="374">
                  <c:v>754</c:v>
                </c:pt>
                <c:pt idx="375">
                  <c:v>755</c:v>
                </c:pt>
                <c:pt idx="376">
                  <c:v>756</c:v>
                </c:pt>
                <c:pt idx="377">
                  <c:v>757</c:v>
                </c:pt>
                <c:pt idx="378">
                  <c:v>758</c:v>
                </c:pt>
                <c:pt idx="379">
                  <c:v>759</c:v>
                </c:pt>
                <c:pt idx="380">
                  <c:v>760</c:v>
                </c:pt>
                <c:pt idx="381">
                  <c:v>761</c:v>
                </c:pt>
                <c:pt idx="382">
                  <c:v>762</c:v>
                </c:pt>
                <c:pt idx="383">
                  <c:v>763</c:v>
                </c:pt>
                <c:pt idx="384">
                  <c:v>764</c:v>
                </c:pt>
                <c:pt idx="385">
                  <c:v>765</c:v>
                </c:pt>
                <c:pt idx="386">
                  <c:v>766</c:v>
                </c:pt>
                <c:pt idx="387">
                  <c:v>767</c:v>
                </c:pt>
                <c:pt idx="388">
                  <c:v>768</c:v>
                </c:pt>
                <c:pt idx="389">
                  <c:v>769</c:v>
                </c:pt>
                <c:pt idx="390">
                  <c:v>770</c:v>
                </c:pt>
                <c:pt idx="391">
                  <c:v>771</c:v>
                </c:pt>
                <c:pt idx="392">
                  <c:v>772</c:v>
                </c:pt>
                <c:pt idx="393">
                  <c:v>773</c:v>
                </c:pt>
                <c:pt idx="394">
                  <c:v>774</c:v>
                </c:pt>
                <c:pt idx="395">
                  <c:v>775</c:v>
                </c:pt>
                <c:pt idx="396">
                  <c:v>776</c:v>
                </c:pt>
                <c:pt idx="397">
                  <c:v>777</c:v>
                </c:pt>
                <c:pt idx="398">
                  <c:v>778</c:v>
                </c:pt>
                <c:pt idx="399">
                  <c:v>779</c:v>
                </c:pt>
                <c:pt idx="400">
                  <c:v>780</c:v>
                </c:pt>
              </c:numCache>
            </c:numRef>
          </c:xVal>
          <c:yVal>
            <c:numRef>
              <c:f>Hoja2!$D$7:$D$407</c:f>
              <c:numCache>
                <c:formatCode>General</c:formatCode>
                <c:ptCount val="401"/>
                <c:pt idx="0">
                  <c:v>4.6950000000000004E-3</c:v>
                </c:pt>
                <c:pt idx="1">
                  <c:v>4.5700000000000003E-3</c:v>
                </c:pt>
                <c:pt idx="2">
                  <c:v>4.4029999999999998E-3</c:v>
                </c:pt>
                <c:pt idx="3">
                  <c:v>4.0070000000000001E-3</c:v>
                </c:pt>
                <c:pt idx="4">
                  <c:v>3.5000000000000001E-3</c:v>
                </c:pt>
                <c:pt idx="5">
                  <c:v>3.5530000000000002E-3</c:v>
                </c:pt>
                <c:pt idx="6">
                  <c:v>3.741E-3</c:v>
                </c:pt>
                <c:pt idx="7">
                  <c:v>3.5330000000000001E-3</c:v>
                </c:pt>
                <c:pt idx="8">
                  <c:v>3.3270000000000001E-3</c:v>
                </c:pt>
                <c:pt idx="9">
                  <c:v>3.457E-3</c:v>
                </c:pt>
                <c:pt idx="10">
                  <c:v>3.5149999999999999E-3</c:v>
                </c:pt>
                <c:pt idx="11">
                  <c:v>3.3E-3</c:v>
                </c:pt>
                <c:pt idx="12">
                  <c:v>3.2330000000000002E-3</c:v>
                </c:pt>
                <c:pt idx="13">
                  <c:v>3.4510000000000001E-3</c:v>
                </c:pt>
                <c:pt idx="14">
                  <c:v>3.552E-3</c:v>
                </c:pt>
                <c:pt idx="15">
                  <c:v>3.5260000000000001E-3</c:v>
                </c:pt>
                <c:pt idx="16">
                  <c:v>3.3470000000000001E-3</c:v>
                </c:pt>
                <c:pt idx="17">
                  <c:v>3.0709999999999999E-3</c:v>
                </c:pt>
                <c:pt idx="18">
                  <c:v>2.8960000000000001E-3</c:v>
                </c:pt>
                <c:pt idx="19">
                  <c:v>2.7539999999999999E-3</c:v>
                </c:pt>
                <c:pt idx="20">
                  <c:v>2.807E-3</c:v>
                </c:pt>
                <c:pt idx="21">
                  <c:v>2.8909999999999999E-3</c:v>
                </c:pt>
                <c:pt idx="22">
                  <c:v>3.2490000000000002E-3</c:v>
                </c:pt>
                <c:pt idx="23">
                  <c:v>3.516E-3</c:v>
                </c:pt>
                <c:pt idx="24">
                  <c:v>3.277E-3</c:v>
                </c:pt>
                <c:pt idx="25">
                  <c:v>3.1110000000000001E-3</c:v>
                </c:pt>
                <c:pt idx="26">
                  <c:v>3.124E-3</c:v>
                </c:pt>
                <c:pt idx="27">
                  <c:v>3.1700000000000001E-3</c:v>
                </c:pt>
                <c:pt idx="28">
                  <c:v>3.2590000000000002E-3</c:v>
                </c:pt>
                <c:pt idx="29">
                  <c:v>3.2439999999999999E-3</c:v>
                </c:pt>
                <c:pt idx="30">
                  <c:v>3.1489999999999999E-3</c:v>
                </c:pt>
                <c:pt idx="31">
                  <c:v>3.0530000000000002E-3</c:v>
                </c:pt>
                <c:pt idx="32">
                  <c:v>2.9589999999999998E-3</c:v>
                </c:pt>
                <c:pt idx="33">
                  <c:v>2.9870000000000001E-3</c:v>
                </c:pt>
                <c:pt idx="34">
                  <c:v>3.039E-3</c:v>
                </c:pt>
                <c:pt idx="35">
                  <c:v>3.1949999999999999E-3</c:v>
                </c:pt>
                <c:pt idx="36">
                  <c:v>3.3609999999999998E-3</c:v>
                </c:pt>
                <c:pt idx="37">
                  <c:v>3.5869999999999999E-3</c:v>
                </c:pt>
                <c:pt idx="38">
                  <c:v>3.813E-3</c:v>
                </c:pt>
                <c:pt idx="39">
                  <c:v>4.0379999999999999E-3</c:v>
                </c:pt>
                <c:pt idx="40">
                  <c:v>4.3709999999999999E-3</c:v>
                </c:pt>
                <c:pt idx="41">
                  <c:v>4.8700000000000002E-3</c:v>
                </c:pt>
                <c:pt idx="42">
                  <c:v>5.28E-3</c:v>
                </c:pt>
                <c:pt idx="43">
                  <c:v>5.6129999999999999E-3</c:v>
                </c:pt>
                <c:pt idx="44">
                  <c:v>6.1349999999999998E-3</c:v>
                </c:pt>
                <c:pt idx="45">
                  <c:v>6.7479999999999997E-3</c:v>
                </c:pt>
                <c:pt idx="46">
                  <c:v>7.7330000000000003E-3</c:v>
                </c:pt>
                <c:pt idx="47">
                  <c:v>8.8030000000000001E-3</c:v>
                </c:pt>
                <c:pt idx="48">
                  <c:v>1.0199E-2</c:v>
                </c:pt>
                <c:pt idx="49">
                  <c:v>1.1650000000000001E-2</c:v>
                </c:pt>
                <c:pt idx="50">
                  <c:v>1.3459E-2</c:v>
                </c:pt>
                <c:pt idx="51">
                  <c:v>1.5355000000000001E-2</c:v>
                </c:pt>
                <c:pt idx="52">
                  <c:v>1.7519E-2</c:v>
                </c:pt>
                <c:pt idx="53">
                  <c:v>2.0102999999999999E-2</c:v>
                </c:pt>
                <c:pt idx="54">
                  <c:v>2.3351E-2</c:v>
                </c:pt>
                <c:pt idx="55">
                  <c:v>2.6808999999999999E-2</c:v>
                </c:pt>
                <c:pt idx="56">
                  <c:v>3.0450999999999999E-2</c:v>
                </c:pt>
                <c:pt idx="57">
                  <c:v>3.4911999999999999E-2</c:v>
                </c:pt>
                <c:pt idx="58">
                  <c:v>3.9760999999999998E-2</c:v>
                </c:pt>
                <c:pt idx="59">
                  <c:v>4.5516000000000001E-2</c:v>
                </c:pt>
                <c:pt idx="60">
                  <c:v>5.1464999999999997E-2</c:v>
                </c:pt>
                <c:pt idx="61">
                  <c:v>5.9072E-2</c:v>
                </c:pt>
                <c:pt idx="62">
                  <c:v>6.6911999999999999E-2</c:v>
                </c:pt>
                <c:pt idx="63">
                  <c:v>7.6118000000000005E-2</c:v>
                </c:pt>
                <c:pt idx="64">
                  <c:v>8.5819999999999994E-2</c:v>
                </c:pt>
                <c:pt idx="65">
                  <c:v>9.6879000000000007E-2</c:v>
                </c:pt>
                <c:pt idx="66">
                  <c:v>0.108944</c:v>
                </c:pt>
                <c:pt idx="67">
                  <c:v>0.122414</c:v>
                </c:pt>
                <c:pt idx="68">
                  <c:v>0.13687299999999999</c:v>
                </c:pt>
                <c:pt idx="69">
                  <c:v>0.152086</c:v>
                </c:pt>
                <c:pt idx="70">
                  <c:v>0.168269</c:v>
                </c:pt>
                <c:pt idx="71">
                  <c:v>0.184838</c:v>
                </c:pt>
                <c:pt idx="72">
                  <c:v>0.202018</c:v>
                </c:pt>
                <c:pt idx="73">
                  <c:v>0.219282</c:v>
                </c:pt>
                <c:pt idx="74">
                  <c:v>0.23579900000000001</c:v>
                </c:pt>
                <c:pt idx="75">
                  <c:v>0.25190800000000002</c:v>
                </c:pt>
                <c:pt idx="76">
                  <c:v>0.26598300000000002</c:v>
                </c:pt>
                <c:pt idx="77">
                  <c:v>0.27873900000000001</c:v>
                </c:pt>
                <c:pt idx="78">
                  <c:v>0.28868100000000002</c:v>
                </c:pt>
                <c:pt idx="79">
                  <c:v>0.29630400000000001</c:v>
                </c:pt>
                <c:pt idx="80">
                  <c:v>0.30134</c:v>
                </c:pt>
                <c:pt idx="81">
                  <c:v>0.30308499999999999</c:v>
                </c:pt>
                <c:pt idx="82">
                  <c:v>0.30287199999999997</c:v>
                </c:pt>
                <c:pt idx="83">
                  <c:v>0.29811199999999999</c:v>
                </c:pt>
                <c:pt idx="84">
                  <c:v>0.29208600000000001</c:v>
                </c:pt>
                <c:pt idx="85">
                  <c:v>0.28173199999999998</c:v>
                </c:pt>
                <c:pt idx="86">
                  <c:v>0.27085500000000001</c:v>
                </c:pt>
                <c:pt idx="87">
                  <c:v>0.25772600000000001</c:v>
                </c:pt>
                <c:pt idx="88">
                  <c:v>0.24430299999999999</c:v>
                </c:pt>
                <c:pt idx="89">
                  <c:v>0.23002</c:v>
                </c:pt>
                <c:pt idx="90">
                  <c:v>0.21568100000000001</c:v>
                </c:pt>
                <c:pt idx="91">
                  <c:v>0.201261</c:v>
                </c:pt>
                <c:pt idx="92">
                  <c:v>0.187365</c:v>
                </c:pt>
                <c:pt idx="93">
                  <c:v>0.17385900000000001</c:v>
                </c:pt>
                <c:pt idx="94">
                  <c:v>0.161273</c:v>
                </c:pt>
                <c:pt idx="95">
                  <c:v>0.14901900000000001</c:v>
                </c:pt>
                <c:pt idx="96">
                  <c:v>0.138321</c:v>
                </c:pt>
                <c:pt idx="97">
                  <c:v>0.12787399999999999</c:v>
                </c:pt>
                <c:pt idx="98">
                  <c:v>0.11855400000000001</c:v>
                </c:pt>
                <c:pt idx="99">
                  <c:v>0.109497</c:v>
                </c:pt>
                <c:pt idx="100">
                  <c:v>0.10133499999999999</c:v>
                </c:pt>
                <c:pt idx="101">
                  <c:v>9.3614000000000003E-2</c:v>
                </c:pt>
                <c:pt idx="102">
                  <c:v>8.6573999999999998E-2</c:v>
                </c:pt>
                <c:pt idx="103">
                  <c:v>7.979E-2</c:v>
                </c:pt>
                <c:pt idx="104">
                  <c:v>7.3206999999999994E-2</c:v>
                </c:pt>
                <c:pt idx="105">
                  <c:v>6.7479999999999998E-2</c:v>
                </c:pt>
                <c:pt idx="106">
                  <c:v>6.2068999999999999E-2</c:v>
                </c:pt>
                <c:pt idx="107">
                  <c:v>5.6868000000000002E-2</c:v>
                </c:pt>
                <c:pt idx="108">
                  <c:v>5.1764999999999999E-2</c:v>
                </c:pt>
                <c:pt idx="109">
                  <c:v>4.7632000000000001E-2</c:v>
                </c:pt>
                <c:pt idx="110">
                  <c:v>4.3633999999999999E-2</c:v>
                </c:pt>
                <c:pt idx="111">
                  <c:v>4.0058000000000003E-2</c:v>
                </c:pt>
                <c:pt idx="112">
                  <c:v>3.6804000000000003E-2</c:v>
                </c:pt>
                <c:pt idx="113">
                  <c:v>3.4001000000000003E-2</c:v>
                </c:pt>
                <c:pt idx="114">
                  <c:v>3.1467000000000002E-2</c:v>
                </c:pt>
                <c:pt idx="115">
                  <c:v>2.9118999999999999E-2</c:v>
                </c:pt>
                <c:pt idx="116">
                  <c:v>2.6877000000000002E-2</c:v>
                </c:pt>
                <c:pt idx="117">
                  <c:v>2.4667999999999999E-2</c:v>
                </c:pt>
                <c:pt idx="118">
                  <c:v>2.2884000000000002E-2</c:v>
                </c:pt>
                <c:pt idx="119">
                  <c:v>2.1114999999999998E-2</c:v>
                </c:pt>
                <c:pt idx="120">
                  <c:v>1.9278E-2</c:v>
                </c:pt>
                <c:pt idx="121">
                  <c:v>1.7593000000000001E-2</c:v>
                </c:pt>
                <c:pt idx="122">
                  <c:v>1.6258000000000002E-2</c:v>
                </c:pt>
                <c:pt idx="123">
                  <c:v>1.4964E-2</c:v>
                </c:pt>
                <c:pt idx="124">
                  <c:v>1.3712999999999999E-2</c:v>
                </c:pt>
                <c:pt idx="125">
                  <c:v>1.2743000000000001E-2</c:v>
                </c:pt>
                <c:pt idx="126">
                  <c:v>1.1915E-2</c:v>
                </c:pt>
                <c:pt idx="127">
                  <c:v>1.1074000000000001E-2</c:v>
                </c:pt>
                <c:pt idx="128">
                  <c:v>1.0237E-2</c:v>
                </c:pt>
                <c:pt idx="129">
                  <c:v>9.5809999999999992E-3</c:v>
                </c:pt>
                <c:pt idx="130">
                  <c:v>8.9490000000000004E-3</c:v>
                </c:pt>
                <c:pt idx="131">
                  <c:v>8.4019999999999997E-3</c:v>
                </c:pt>
                <c:pt idx="132">
                  <c:v>7.8050000000000003E-3</c:v>
                </c:pt>
                <c:pt idx="133">
                  <c:v>7.1370000000000001E-3</c:v>
                </c:pt>
                <c:pt idx="134">
                  <c:v>6.6059999999999999E-3</c:v>
                </c:pt>
                <c:pt idx="135">
                  <c:v>6.1659999999999996E-3</c:v>
                </c:pt>
                <c:pt idx="136">
                  <c:v>5.8589999999999996E-3</c:v>
                </c:pt>
                <c:pt idx="137">
                  <c:v>5.5859999999999998E-3</c:v>
                </c:pt>
                <c:pt idx="138">
                  <c:v>5.2389999999999997E-3</c:v>
                </c:pt>
                <c:pt idx="139">
                  <c:v>4.9109999999999996E-3</c:v>
                </c:pt>
                <c:pt idx="140">
                  <c:v>4.6800000000000001E-3</c:v>
                </c:pt>
                <c:pt idx="141">
                  <c:v>4.5209999999999998E-3</c:v>
                </c:pt>
                <c:pt idx="142">
                  <c:v>4.483E-3</c:v>
                </c:pt>
                <c:pt idx="143">
                  <c:v>4.3480000000000003E-3</c:v>
                </c:pt>
                <c:pt idx="144">
                  <c:v>4.1399999999999996E-3</c:v>
                </c:pt>
                <c:pt idx="145">
                  <c:v>3.8449999999999999E-3</c:v>
                </c:pt>
                <c:pt idx="146">
                  <c:v>3.5209999999999998E-3</c:v>
                </c:pt>
                <c:pt idx="147">
                  <c:v>3.3860000000000001E-3</c:v>
                </c:pt>
                <c:pt idx="148">
                  <c:v>3.2789999999999998E-3</c:v>
                </c:pt>
                <c:pt idx="149">
                  <c:v>3.2820000000000002E-3</c:v>
                </c:pt>
                <c:pt idx="150">
                  <c:v>3.261E-3</c:v>
                </c:pt>
                <c:pt idx="151">
                  <c:v>3.1840000000000002E-3</c:v>
                </c:pt>
                <c:pt idx="152">
                  <c:v>3.1310000000000001E-3</c:v>
                </c:pt>
                <c:pt idx="153">
                  <c:v>3.1050000000000001E-3</c:v>
                </c:pt>
                <c:pt idx="154">
                  <c:v>3.0249999999999999E-3</c:v>
                </c:pt>
                <c:pt idx="155">
                  <c:v>2.918E-3</c:v>
                </c:pt>
                <c:pt idx="156">
                  <c:v>2.944E-3</c:v>
                </c:pt>
                <c:pt idx="157">
                  <c:v>2.9810000000000001E-3</c:v>
                </c:pt>
                <c:pt idx="158">
                  <c:v>2.7569999999999999E-3</c:v>
                </c:pt>
                <c:pt idx="159">
                  <c:v>2.5690000000000001E-3</c:v>
                </c:pt>
                <c:pt idx="160">
                  <c:v>2.5010000000000002E-3</c:v>
                </c:pt>
                <c:pt idx="161">
                  <c:v>2.454E-3</c:v>
                </c:pt>
                <c:pt idx="162">
                  <c:v>2.4359999999999998E-3</c:v>
                </c:pt>
                <c:pt idx="163">
                  <c:v>2.454E-3</c:v>
                </c:pt>
                <c:pt idx="164">
                  <c:v>2.493E-3</c:v>
                </c:pt>
                <c:pt idx="165">
                  <c:v>2.0149999999999999E-3</c:v>
                </c:pt>
                <c:pt idx="166">
                  <c:v>2.1310000000000001E-3</c:v>
                </c:pt>
                <c:pt idx="167">
                  <c:v>2.1480000000000002E-3</c:v>
                </c:pt>
                <c:pt idx="168">
                  <c:v>2.0739999999999999E-3</c:v>
                </c:pt>
                <c:pt idx="169">
                  <c:v>1.65E-3</c:v>
                </c:pt>
                <c:pt idx="170">
                  <c:v>1.482E-3</c:v>
                </c:pt>
                <c:pt idx="171">
                  <c:v>1.6800000000000001E-3</c:v>
                </c:pt>
                <c:pt idx="172">
                  <c:v>1.7750000000000001E-3</c:v>
                </c:pt>
                <c:pt idx="173">
                  <c:v>1.802E-3</c:v>
                </c:pt>
                <c:pt idx="174">
                  <c:v>1.8060000000000001E-3</c:v>
                </c:pt>
                <c:pt idx="175">
                  <c:v>1.807E-3</c:v>
                </c:pt>
                <c:pt idx="176">
                  <c:v>1.946E-3</c:v>
                </c:pt>
                <c:pt idx="177">
                  <c:v>2.075E-3</c:v>
                </c:pt>
                <c:pt idx="178">
                  <c:v>2.1710000000000002E-3</c:v>
                </c:pt>
                <c:pt idx="179">
                  <c:v>2.1800000000000001E-3</c:v>
                </c:pt>
                <c:pt idx="180">
                  <c:v>2.0769999999999999E-3</c:v>
                </c:pt>
                <c:pt idx="181">
                  <c:v>2.0839999999999999E-3</c:v>
                </c:pt>
                <c:pt idx="182">
                  <c:v>2.1510000000000001E-3</c:v>
                </c:pt>
                <c:pt idx="183">
                  <c:v>2.2430000000000002E-3</c:v>
                </c:pt>
                <c:pt idx="184">
                  <c:v>2.323E-3</c:v>
                </c:pt>
                <c:pt idx="185">
                  <c:v>2.2000000000000001E-3</c:v>
                </c:pt>
                <c:pt idx="186">
                  <c:v>2.2070000000000002E-3</c:v>
                </c:pt>
                <c:pt idx="187">
                  <c:v>2.5370000000000002E-3</c:v>
                </c:pt>
                <c:pt idx="188">
                  <c:v>2.8969999999999998E-3</c:v>
                </c:pt>
                <c:pt idx="189">
                  <c:v>3.2850000000000002E-3</c:v>
                </c:pt>
                <c:pt idx="190">
                  <c:v>3.7009999999999999E-3</c:v>
                </c:pt>
                <c:pt idx="191">
                  <c:v>4.1269999999999996E-3</c:v>
                </c:pt>
                <c:pt idx="192">
                  <c:v>4.2700000000000004E-3</c:v>
                </c:pt>
                <c:pt idx="193">
                  <c:v>4.3800000000000002E-3</c:v>
                </c:pt>
                <c:pt idx="194">
                  <c:v>4.4099999999999999E-3</c:v>
                </c:pt>
                <c:pt idx="195">
                  <c:v>4.542E-3</c:v>
                </c:pt>
                <c:pt idx="196">
                  <c:v>4.8320000000000004E-3</c:v>
                </c:pt>
                <c:pt idx="197">
                  <c:v>5.4089999999999997E-3</c:v>
                </c:pt>
                <c:pt idx="198">
                  <c:v>6.1640000000000002E-3</c:v>
                </c:pt>
                <c:pt idx="199">
                  <c:v>6.79E-3</c:v>
                </c:pt>
                <c:pt idx="200">
                  <c:v>7.404E-3</c:v>
                </c:pt>
                <c:pt idx="201">
                  <c:v>8.1410000000000007E-3</c:v>
                </c:pt>
                <c:pt idx="202">
                  <c:v>8.9829999999999997E-3</c:v>
                </c:pt>
                <c:pt idx="203">
                  <c:v>1.0063000000000001E-2</c:v>
                </c:pt>
                <c:pt idx="204">
                  <c:v>1.0907E-2</c:v>
                </c:pt>
                <c:pt idx="205">
                  <c:v>1.1552E-2</c:v>
                </c:pt>
                <c:pt idx="206">
                  <c:v>1.2566000000000001E-2</c:v>
                </c:pt>
                <c:pt idx="207">
                  <c:v>1.3691999999999999E-2</c:v>
                </c:pt>
                <c:pt idx="208">
                  <c:v>1.5235E-2</c:v>
                </c:pt>
                <c:pt idx="209">
                  <c:v>1.6905E-2</c:v>
                </c:pt>
                <c:pt idx="210">
                  <c:v>1.8953000000000001E-2</c:v>
                </c:pt>
                <c:pt idx="211">
                  <c:v>2.1187000000000001E-2</c:v>
                </c:pt>
                <c:pt idx="212">
                  <c:v>2.3612000000000001E-2</c:v>
                </c:pt>
                <c:pt idx="213">
                  <c:v>2.6196000000000001E-2</c:v>
                </c:pt>
                <c:pt idx="214">
                  <c:v>2.8837000000000002E-2</c:v>
                </c:pt>
                <c:pt idx="215">
                  <c:v>3.1981000000000002E-2</c:v>
                </c:pt>
                <c:pt idx="216">
                  <c:v>3.5256000000000003E-2</c:v>
                </c:pt>
                <c:pt idx="217">
                  <c:v>3.8942999999999998E-2</c:v>
                </c:pt>
                <c:pt idx="218">
                  <c:v>4.2913E-2</c:v>
                </c:pt>
                <c:pt idx="219">
                  <c:v>4.7197999999999997E-2</c:v>
                </c:pt>
                <c:pt idx="220">
                  <c:v>5.2333999999999999E-2</c:v>
                </c:pt>
                <c:pt idx="221">
                  <c:v>5.7793999999999998E-2</c:v>
                </c:pt>
                <c:pt idx="222">
                  <c:v>6.4249000000000001E-2</c:v>
                </c:pt>
                <c:pt idx="223">
                  <c:v>7.1049000000000001E-2</c:v>
                </c:pt>
                <c:pt idx="224">
                  <c:v>7.8920000000000004E-2</c:v>
                </c:pt>
                <c:pt idx="225">
                  <c:v>8.7540000000000007E-2</c:v>
                </c:pt>
                <c:pt idx="226">
                  <c:v>9.6953999999999999E-2</c:v>
                </c:pt>
                <c:pt idx="227">
                  <c:v>0.10738399999999999</c:v>
                </c:pt>
                <c:pt idx="228">
                  <c:v>0.118173</c:v>
                </c:pt>
                <c:pt idx="229">
                  <c:v>0.131632</c:v>
                </c:pt>
                <c:pt idx="230">
                  <c:v>0.14568700000000001</c:v>
                </c:pt>
                <c:pt idx="231">
                  <c:v>0.16139800000000001</c:v>
                </c:pt>
                <c:pt idx="232">
                  <c:v>0.178734</c:v>
                </c:pt>
                <c:pt idx="233">
                  <c:v>0.197523</c:v>
                </c:pt>
                <c:pt idx="234">
                  <c:v>0.21892400000000001</c:v>
                </c:pt>
                <c:pt idx="235">
                  <c:v>0.24127299999999999</c:v>
                </c:pt>
                <c:pt idx="236">
                  <c:v>0.26774199999999998</c:v>
                </c:pt>
                <c:pt idx="237">
                  <c:v>0.29530299999999998</c:v>
                </c:pt>
                <c:pt idx="238">
                  <c:v>0.325077</c:v>
                </c:pt>
                <c:pt idx="239">
                  <c:v>0.35772500000000002</c:v>
                </c:pt>
                <c:pt idx="240">
                  <c:v>0.39227600000000001</c:v>
                </c:pt>
                <c:pt idx="241">
                  <c:v>0.430645</c:v>
                </c:pt>
                <c:pt idx="242">
                  <c:v>0.47021200000000002</c:v>
                </c:pt>
                <c:pt idx="243">
                  <c:v>0.51346400000000003</c:v>
                </c:pt>
                <c:pt idx="244">
                  <c:v>0.55875699999999995</c:v>
                </c:pt>
                <c:pt idx="245">
                  <c:v>0.60677899999999996</c:v>
                </c:pt>
                <c:pt idx="246">
                  <c:v>0.65732800000000002</c:v>
                </c:pt>
                <c:pt idx="247">
                  <c:v>0.70892100000000002</c:v>
                </c:pt>
                <c:pt idx="248">
                  <c:v>0.75968100000000005</c:v>
                </c:pt>
                <c:pt idx="249">
                  <c:v>0.81039399999999995</c:v>
                </c:pt>
                <c:pt idx="250">
                  <c:v>0.86101099999999997</c:v>
                </c:pt>
                <c:pt idx="251">
                  <c:v>0.90609200000000001</c:v>
                </c:pt>
                <c:pt idx="252">
                  <c:v>0.94733599999999996</c:v>
                </c:pt>
                <c:pt idx="253">
                  <c:v>0.97436100000000003</c:v>
                </c:pt>
                <c:pt idx="254">
                  <c:v>0.99541500000000005</c:v>
                </c:pt>
                <c:pt idx="255">
                  <c:v>1</c:v>
                </c:pt>
                <c:pt idx="256">
                  <c:v>0.99226700000000001</c:v>
                </c:pt>
                <c:pt idx="257">
                  <c:v>0.97329100000000002</c:v>
                </c:pt>
                <c:pt idx="258">
                  <c:v>0.93514699999999995</c:v>
                </c:pt>
                <c:pt idx="259">
                  <c:v>0.89065499999999997</c:v>
                </c:pt>
                <c:pt idx="260">
                  <c:v>0.83177400000000001</c:v>
                </c:pt>
                <c:pt idx="261">
                  <c:v>0.76716099999999998</c:v>
                </c:pt>
                <c:pt idx="262">
                  <c:v>0.69617200000000001</c:v>
                </c:pt>
                <c:pt idx="263">
                  <c:v>0.62299400000000005</c:v>
                </c:pt>
                <c:pt idx="264">
                  <c:v>0.54966899999999996</c:v>
                </c:pt>
                <c:pt idx="265">
                  <c:v>0.47949599999999998</c:v>
                </c:pt>
                <c:pt idx="266">
                  <c:v>0.41322799999999998</c:v>
                </c:pt>
                <c:pt idx="267">
                  <c:v>0.35187299999999999</c:v>
                </c:pt>
                <c:pt idx="268">
                  <c:v>0.29989500000000002</c:v>
                </c:pt>
                <c:pt idx="269">
                  <c:v>0.25186700000000001</c:v>
                </c:pt>
                <c:pt idx="270">
                  <c:v>0.214256</c:v>
                </c:pt>
                <c:pt idx="271">
                  <c:v>0.180399</c:v>
                </c:pt>
                <c:pt idx="272">
                  <c:v>0.151502</c:v>
                </c:pt>
                <c:pt idx="273">
                  <c:v>0.1283</c:v>
                </c:pt>
                <c:pt idx="274">
                  <c:v>0.107377</c:v>
                </c:pt>
                <c:pt idx="275">
                  <c:v>9.1153999999999999E-2</c:v>
                </c:pt>
                <c:pt idx="276">
                  <c:v>7.6716999999999994E-2</c:v>
                </c:pt>
                <c:pt idx="277">
                  <c:v>6.4568E-2</c:v>
                </c:pt>
                <c:pt idx="278">
                  <c:v>5.4475999999999997E-2</c:v>
                </c:pt>
                <c:pt idx="279">
                  <c:v>4.5308000000000001E-2</c:v>
                </c:pt>
                <c:pt idx="280">
                  <c:v>3.8609999999999998E-2</c:v>
                </c:pt>
                <c:pt idx="281">
                  <c:v>3.2682000000000003E-2</c:v>
                </c:pt>
                <c:pt idx="282">
                  <c:v>2.7640999999999999E-2</c:v>
                </c:pt>
                <c:pt idx="283">
                  <c:v>2.3851000000000001E-2</c:v>
                </c:pt>
                <c:pt idx="284">
                  <c:v>2.052E-2</c:v>
                </c:pt>
                <c:pt idx="285">
                  <c:v>1.8065999999999999E-2</c:v>
                </c:pt>
                <c:pt idx="286">
                  <c:v>1.5866999999999999E-2</c:v>
                </c:pt>
                <c:pt idx="287">
                  <c:v>1.3913999999999999E-2</c:v>
                </c:pt>
                <c:pt idx="288">
                  <c:v>1.2326E-2</c:v>
                </c:pt>
                <c:pt idx="289">
                  <c:v>1.0829999999999999E-2</c:v>
                </c:pt>
                <c:pt idx="290">
                  <c:v>9.4509999999999993E-3</c:v>
                </c:pt>
                <c:pt idx="291">
                  <c:v>8.2249999999999997E-3</c:v>
                </c:pt>
                <c:pt idx="292">
                  <c:v>7.11E-3</c:v>
                </c:pt>
                <c:pt idx="293">
                  <c:v>6.6899999999999998E-3</c:v>
                </c:pt>
                <c:pt idx="294">
                  <c:v>6.2950000000000002E-3</c:v>
                </c:pt>
                <c:pt idx="295">
                  <c:v>5.8450000000000004E-3</c:v>
                </c:pt>
                <c:pt idx="296">
                  <c:v>5.3410000000000003E-3</c:v>
                </c:pt>
                <c:pt idx="297">
                  <c:v>4.8139999999999997E-3</c:v>
                </c:pt>
                <c:pt idx="298">
                  <c:v>4.4869999999999997E-3</c:v>
                </c:pt>
                <c:pt idx="299">
                  <c:v>4.2040000000000003E-3</c:v>
                </c:pt>
                <c:pt idx="300">
                  <c:v>3.9890000000000004E-3</c:v>
                </c:pt>
                <c:pt idx="301">
                  <c:v>3.4870000000000001E-3</c:v>
                </c:pt>
                <c:pt idx="302">
                  <c:v>2.957E-3</c:v>
                </c:pt>
                <c:pt idx="303">
                  <c:v>2.7759999999999998E-3</c:v>
                </c:pt>
                <c:pt idx="304">
                  <c:v>2.6319999999999998E-3</c:v>
                </c:pt>
                <c:pt idx="305">
                  <c:v>2.5230000000000001E-3</c:v>
                </c:pt>
                <c:pt idx="306">
                  <c:v>2.4109999999999999E-3</c:v>
                </c:pt>
                <c:pt idx="307">
                  <c:v>2.4329999999999998E-3</c:v>
                </c:pt>
                <c:pt idx="308">
                  <c:v>2.8040000000000001E-3</c:v>
                </c:pt>
                <c:pt idx="309">
                  <c:v>2.908E-3</c:v>
                </c:pt>
                <c:pt idx="310">
                  <c:v>2.8660000000000001E-3</c:v>
                </c:pt>
                <c:pt idx="311">
                  <c:v>2.699E-3</c:v>
                </c:pt>
                <c:pt idx="312">
                  <c:v>2.519E-3</c:v>
                </c:pt>
                <c:pt idx="313">
                  <c:v>2.3219999999999998E-3</c:v>
                </c:pt>
                <c:pt idx="314">
                  <c:v>1.882E-3</c:v>
                </c:pt>
                <c:pt idx="315">
                  <c:v>1.5740000000000001E-3</c:v>
                </c:pt>
                <c:pt idx="316">
                  <c:v>1.957E-3</c:v>
                </c:pt>
                <c:pt idx="317">
                  <c:v>2.1310000000000001E-3</c:v>
                </c:pt>
                <c:pt idx="318">
                  <c:v>2.1700000000000001E-3</c:v>
                </c:pt>
                <c:pt idx="319">
                  <c:v>2.3180000000000002E-3</c:v>
                </c:pt>
                <c:pt idx="320">
                  <c:v>2.3679999999999999E-3</c:v>
                </c:pt>
                <c:pt idx="321">
                  <c:v>2.271E-3</c:v>
                </c:pt>
                <c:pt idx="322">
                  <c:v>1.926E-3</c:v>
                </c:pt>
                <c:pt idx="323">
                  <c:v>1.653E-3</c:v>
                </c:pt>
                <c:pt idx="324">
                  <c:v>1.887E-3</c:v>
                </c:pt>
                <c:pt idx="325">
                  <c:v>1.81E-3</c:v>
                </c:pt>
                <c:pt idx="326">
                  <c:v>1.544E-3</c:v>
                </c:pt>
                <c:pt idx="327">
                  <c:v>1.5820000000000001E-3</c:v>
                </c:pt>
                <c:pt idx="328">
                  <c:v>1.7719999999999999E-3</c:v>
                </c:pt>
                <c:pt idx="329">
                  <c:v>2.16E-3</c:v>
                </c:pt>
                <c:pt idx="330">
                  <c:v>2.3319999999999999E-3</c:v>
                </c:pt>
                <c:pt idx="331">
                  <c:v>2.5200000000000001E-3</c:v>
                </c:pt>
                <c:pt idx="332">
                  <c:v>2.862E-3</c:v>
                </c:pt>
                <c:pt idx="333">
                  <c:v>2.7369999999999998E-3</c:v>
                </c:pt>
                <c:pt idx="334">
                  <c:v>2.3739999999999998E-3</c:v>
                </c:pt>
                <c:pt idx="335">
                  <c:v>1.8389999999999999E-3</c:v>
                </c:pt>
                <c:pt idx="336">
                  <c:v>1.5590000000000001E-3</c:v>
                </c:pt>
                <c:pt idx="337">
                  <c:v>1.506E-3</c:v>
                </c:pt>
                <c:pt idx="338">
                  <c:v>1.838E-3</c:v>
                </c:pt>
                <c:pt idx="339">
                  <c:v>2.0349999999999999E-3</c:v>
                </c:pt>
                <c:pt idx="340">
                  <c:v>1.9849999999999998E-3</c:v>
                </c:pt>
                <c:pt idx="341">
                  <c:v>2.323E-3</c:v>
                </c:pt>
                <c:pt idx="342">
                  <c:v>2.6329999999999999E-3</c:v>
                </c:pt>
                <c:pt idx="343">
                  <c:v>2.5860000000000002E-3</c:v>
                </c:pt>
                <c:pt idx="344">
                  <c:v>2.248E-3</c:v>
                </c:pt>
                <c:pt idx="345">
                  <c:v>1.836E-3</c:v>
                </c:pt>
                <c:pt idx="346">
                  <c:v>1.848E-3</c:v>
                </c:pt>
                <c:pt idx="347">
                  <c:v>1.634E-3</c:v>
                </c:pt>
                <c:pt idx="348">
                  <c:v>1.2509999999999999E-3</c:v>
                </c:pt>
                <c:pt idx="349">
                  <c:v>1.4289999999999999E-3</c:v>
                </c:pt>
                <c:pt idx="350">
                  <c:v>1.6869999999999999E-3</c:v>
                </c:pt>
                <c:pt idx="351">
                  <c:v>2.0409999999999998E-3</c:v>
                </c:pt>
                <c:pt idx="352">
                  <c:v>2.5609999999999999E-3</c:v>
                </c:pt>
                <c:pt idx="353">
                  <c:v>2.761E-3</c:v>
                </c:pt>
                <c:pt idx="354">
                  <c:v>2.362E-3</c:v>
                </c:pt>
                <c:pt idx="355">
                  <c:v>2.624E-3</c:v>
                </c:pt>
                <c:pt idx="356">
                  <c:v>2.7239999999999999E-3</c:v>
                </c:pt>
                <c:pt idx="357">
                  <c:v>1.9870000000000001E-3</c:v>
                </c:pt>
                <c:pt idx="358">
                  <c:v>1.748E-3</c:v>
                </c:pt>
                <c:pt idx="359">
                  <c:v>1.8010000000000001E-3</c:v>
                </c:pt>
                <c:pt idx="360">
                  <c:v>2.3050000000000002E-3</c:v>
                </c:pt>
                <c:pt idx="361">
                  <c:v>2.4910000000000002E-3</c:v>
                </c:pt>
                <c:pt idx="362">
                  <c:v>2.5609999999999999E-3</c:v>
                </c:pt>
                <c:pt idx="363">
                  <c:v>2.9350000000000001E-3</c:v>
                </c:pt>
                <c:pt idx="364">
                  <c:v>3.1489999999999999E-3</c:v>
                </c:pt>
                <c:pt idx="365">
                  <c:v>3.2699999999999999E-3</c:v>
                </c:pt>
                <c:pt idx="366">
                  <c:v>3.5430000000000001E-3</c:v>
                </c:pt>
                <c:pt idx="367">
                  <c:v>3.5720000000000001E-3</c:v>
                </c:pt>
                <c:pt idx="368">
                  <c:v>3.4129999999999998E-3</c:v>
                </c:pt>
                <c:pt idx="369">
                  <c:v>3.4889999999999999E-3</c:v>
                </c:pt>
                <c:pt idx="370">
                  <c:v>3.6110000000000001E-3</c:v>
                </c:pt>
                <c:pt idx="371">
                  <c:v>3.7750000000000001E-3</c:v>
                </c:pt>
                <c:pt idx="372">
                  <c:v>3.8149999999999998E-3</c:v>
                </c:pt>
                <c:pt idx="373">
                  <c:v>3.617E-3</c:v>
                </c:pt>
                <c:pt idx="374">
                  <c:v>3.176E-3</c:v>
                </c:pt>
                <c:pt idx="375">
                  <c:v>3.8170000000000001E-3</c:v>
                </c:pt>
                <c:pt idx="376">
                  <c:v>3.9839999999999997E-3</c:v>
                </c:pt>
                <c:pt idx="377">
                  <c:v>3.6180000000000001E-3</c:v>
                </c:pt>
                <c:pt idx="378">
                  <c:v>3.3739999999999998E-3</c:v>
                </c:pt>
                <c:pt idx="379">
                  <c:v>3.2650000000000001E-3</c:v>
                </c:pt>
                <c:pt idx="380">
                  <c:v>3.2980000000000002E-3</c:v>
                </c:pt>
                <c:pt idx="381">
                  <c:v>4.0790000000000002E-3</c:v>
                </c:pt>
                <c:pt idx="382">
                  <c:v>4.4159999999999998E-3</c:v>
                </c:pt>
                <c:pt idx="383">
                  <c:v>4.2700000000000004E-3</c:v>
                </c:pt>
                <c:pt idx="384">
                  <c:v>4.6129999999999999E-3</c:v>
                </c:pt>
                <c:pt idx="385">
                  <c:v>4.7840000000000001E-3</c:v>
                </c:pt>
                <c:pt idx="386">
                  <c:v>4.7739999999999996E-3</c:v>
                </c:pt>
                <c:pt idx="387">
                  <c:v>4.261E-3</c:v>
                </c:pt>
                <c:pt idx="388">
                  <c:v>3.9649999999999998E-3</c:v>
                </c:pt>
                <c:pt idx="389">
                  <c:v>3.8400000000000001E-3</c:v>
                </c:pt>
                <c:pt idx="390">
                  <c:v>3.5620000000000001E-3</c:v>
                </c:pt>
                <c:pt idx="391">
                  <c:v>3.1189999999999998E-3</c:v>
                </c:pt>
                <c:pt idx="392">
                  <c:v>2.7659999999999998E-3</c:v>
                </c:pt>
                <c:pt idx="393">
                  <c:v>3.9500000000000004E-3</c:v>
                </c:pt>
                <c:pt idx="394">
                  <c:v>4.5430000000000002E-3</c:v>
                </c:pt>
                <c:pt idx="395">
                  <c:v>4.8279999999999998E-3</c:v>
                </c:pt>
                <c:pt idx="396">
                  <c:v>5.1640000000000002E-3</c:v>
                </c:pt>
                <c:pt idx="397">
                  <c:v>4.6730000000000001E-3</c:v>
                </c:pt>
                <c:pt idx="398">
                  <c:v>3.9919999999999999E-3</c:v>
                </c:pt>
                <c:pt idx="399">
                  <c:v>3.6830000000000001E-3</c:v>
                </c:pt>
                <c:pt idx="400">
                  <c:v>2.8289999999999999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B13-4F5C-94F8-6E736E16EA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9757391"/>
        <c:axId val="849754895"/>
      </c:scatterChart>
      <c:valAx>
        <c:axId val="849757391"/>
        <c:scaling>
          <c:orientation val="minMax"/>
          <c:max val="780"/>
          <c:min val="3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Wavelength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4895"/>
        <c:crosses val="autoZero"/>
        <c:crossBetween val="midCat"/>
      </c:valAx>
      <c:valAx>
        <c:axId val="849754895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0" i="0" baseline="0" dirty="0" err="1">
                    <a:effectLst/>
                  </a:rPr>
                  <a:t>Relativ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spectral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irradianc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composition</a:t>
                </a:r>
                <a:endParaRPr lang="es-ES" sz="10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7391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>
                <a:solidFill>
                  <a:schemeClr val="tx1"/>
                </a:solidFill>
              </a:rPr>
              <a:t>R7B3-52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Hoja2!$A$7:$A$407</c:f>
              <c:numCache>
                <c:formatCode>General</c:formatCode>
                <c:ptCount val="401"/>
                <c:pt idx="0">
                  <c:v>380</c:v>
                </c:pt>
                <c:pt idx="1">
                  <c:v>381</c:v>
                </c:pt>
                <c:pt idx="2">
                  <c:v>382</c:v>
                </c:pt>
                <c:pt idx="3">
                  <c:v>383</c:v>
                </c:pt>
                <c:pt idx="4">
                  <c:v>384</c:v>
                </c:pt>
                <c:pt idx="5">
                  <c:v>385</c:v>
                </c:pt>
                <c:pt idx="6">
                  <c:v>386</c:v>
                </c:pt>
                <c:pt idx="7">
                  <c:v>387</c:v>
                </c:pt>
                <c:pt idx="8">
                  <c:v>388</c:v>
                </c:pt>
                <c:pt idx="9">
                  <c:v>389</c:v>
                </c:pt>
                <c:pt idx="10">
                  <c:v>390</c:v>
                </c:pt>
                <c:pt idx="11">
                  <c:v>391</c:v>
                </c:pt>
                <c:pt idx="12">
                  <c:v>392</c:v>
                </c:pt>
                <c:pt idx="13">
                  <c:v>393</c:v>
                </c:pt>
                <c:pt idx="14">
                  <c:v>394</c:v>
                </c:pt>
                <c:pt idx="15">
                  <c:v>395</c:v>
                </c:pt>
                <c:pt idx="16">
                  <c:v>396</c:v>
                </c:pt>
                <c:pt idx="17">
                  <c:v>397</c:v>
                </c:pt>
                <c:pt idx="18">
                  <c:v>398</c:v>
                </c:pt>
                <c:pt idx="19">
                  <c:v>399</c:v>
                </c:pt>
                <c:pt idx="20">
                  <c:v>400</c:v>
                </c:pt>
                <c:pt idx="21">
                  <c:v>401</c:v>
                </c:pt>
                <c:pt idx="22">
                  <c:v>402</c:v>
                </c:pt>
                <c:pt idx="23">
                  <c:v>403</c:v>
                </c:pt>
                <c:pt idx="24">
                  <c:v>404</c:v>
                </c:pt>
                <c:pt idx="25">
                  <c:v>405</c:v>
                </c:pt>
                <c:pt idx="26">
                  <c:v>406</c:v>
                </c:pt>
                <c:pt idx="27">
                  <c:v>407</c:v>
                </c:pt>
                <c:pt idx="28">
                  <c:v>408</c:v>
                </c:pt>
                <c:pt idx="29">
                  <c:v>409</c:v>
                </c:pt>
                <c:pt idx="30">
                  <c:v>410</c:v>
                </c:pt>
                <c:pt idx="31">
                  <c:v>411</c:v>
                </c:pt>
                <c:pt idx="32">
                  <c:v>412</c:v>
                </c:pt>
                <c:pt idx="33">
                  <c:v>413</c:v>
                </c:pt>
                <c:pt idx="34">
                  <c:v>414</c:v>
                </c:pt>
                <c:pt idx="35">
                  <c:v>415</c:v>
                </c:pt>
                <c:pt idx="36">
                  <c:v>416</c:v>
                </c:pt>
                <c:pt idx="37">
                  <c:v>417</c:v>
                </c:pt>
                <c:pt idx="38">
                  <c:v>418</c:v>
                </c:pt>
                <c:pt idx="39">
                  <c:v>419</c:v>
                </c:pt>
                <c:pt idx="40">
                  <c:v>420</c:v>
                </c:pt>
                <c:pt idx="41">
                  <c:v>421</c:v>
                </c:pt>
                <c:pt idx="42">
                  <c:v>422</c:v>
                </c:pt>
                <c:pt idx="43">
                  <c:v>423</c:v>
                </c:pt>
                <c:pt idx="44">
                  <c:v>424</c:v>
                </c:pt>
                <c:pt idx="45">
                  <c:v>425</c:v>
                </c:pt>
                <c:pt idx="46">
                  <c:v>426</c:v>
                </c:pt>
                <c:pt idx="47">
                  <c:v>427</c:v>
                </c:pt>
                <c:pt idx="48">
                  <c:v>428</c:v>
                </c:pt>
                <c:pt idx="49">
                  <c:v>429</c:v>
                </c:pt>
                <c:pt idx="50">
                  <c:v>430</c:v>
                </c:pt>
                <c:pt idx="51">
                  <c:v>431</c:v>
                </c:pt>
                <c:pt idx="52">
                  <c:v>432</c:v>
                </c:pt>
                <c:pt idx="53">
                  <c:v>433</c:v>
                </c:pt>
                <c:pt idx="54">
                  <c:v>434</c:v>
                </c:pt>
                <c:pt idx="55">
                  <c:v>435</c:v>
                </c:pt>
                <c:pt idx="56">
                  <c:v>436</c:v>
                </c:pt>
                <c:pt idx="57">
                  <c:v>437</c:v>
                </c:pt>
                <c:pt idx="58">
                  <c:v>438</c:v>
                </c:pt>
                <c:pt idx="59">
                  <c:v>439</c:v>
                </c:pt>
                <c:pt idx="60">
                  <c:v>440</c:v>
                </c:pt>
                <c:pt idx="61">
                  <c:v>441</c:v>
                </c:pt>
                <c:pt idx="62">
                  <c:v>442</c:v>
                </c:pt>
                <c:pt idx="63">
                  <c:v>443</c:v>
                </c:pt>
                <c:pt idx="64">
                  <c:v>444</c:v>
                </c:pt>
                <c:pt idx="65">
                  <c:v>445</c:v>
                </c:pt>
                <c:pt idx="66">
                  <c:v>446</c:v>
                </c:pt>
                <c:pt idx="67">
                  <c:v>447</c:v>
                </c:pt>
                <c:pt idx="68">
                  <c:v>448</c:v>
                </c:pt>
                <c:pt idx="69">
                  <c:v>449</c:v>
                </c:pt>
                <c:pt idx="70">
                  <c:v>450</c:v>
                </c:pt>
                <c:pt idx="71">
                  <c:v>451</c:v>
                </c:pt>
                <c:pt idx="72">
                  <c:v>452</c:v>
                </c:pt>
                <c:pt idx="73">
                  <c:v>453</c:v>
                </c:pt>
                <c:pt idx="74">
                  <c:v>454</c:v>
                </c:pt>
                <c:pt idx="75">
                  <c:v>455</c:v>
                </c:pt>
                <c:pt idx="76">
                  <c:v>456</c:v>
                </c:pt>
                <c:pt idx="77">
                  <c:v>457</c:v>
                </c:pt>
                <c:pt idx="78">
                  <c:v>458</c:v>
                </c:pt>
                <c:pt idx="79">
                  <c:v>459</c:v>
                </c:pt>
                <c:pt idx="80">
                  <c:v>460</c:v>
                </c:pt>
                <c:pt idx="81">
                  <c:v>461</c:v>
                </c:pt>
                <c:pt idx="82">
                  <c:v>462</c:v>
                </c:pt>
                <c:pt idx="83">
                  <c:v>463</c:v>
                </c:pt>
                <c:pt idx="84">
                  <c:v>464</c:v>
                </c:pt>
                <c:pt idx="85">
                  <c:v>465</c:v>
                </c:pt>
                <c:pt idx="86">
                  <c:v>466</c:v>
                </c:pt>
                <c:pt idx="87">
                  <c:v>467</c:v>
                </c:pt>
                <c:pt idx="88">
                  <c:v>468</c:v>
                </c:pt>
                <c:pt idx="89">
                  <c:v>469</c:v>
                </c:pt>
                <c:pt idx="90">
                  <c:v>470</c:v>
                </c:pt>
                <c:pt idx="91">
                  <c:v>471</c:v>
                </c:pt>
                <c:pt idx="92">
                  <c:v>472</c:v>
                </c:pt>
                <c:pt idx="93">
                  <c:v>473</c:v>
                </c:pt>
                <c:pt idx="94">
                  <c:v>474</c:v>
                </c:pt>
                <c:pt idx="95">
                  <c:v>475</c:v>
                </c:pt>
                <c:pt idx="96">
                  <c:v>476</c:v>
                </c:pt>
                <c:pt idx="97">
                  <c:v>477</c:v>
                </c:pt>
                <c:pt idx="98">
                  <c:v>478</c:v>
                </c:pt>
                <c:pt idx="99">
                  <c:v>479</c:v>
                </c:pt>
                <c:pt idx="100">
                  <c:v>480</c:v>
                </c:pt>
                <c:pt idx="101">
                  <c:v>481</c:v>
                </c:pt>
                <c:pt idx="102">
                  <c:v>482</c:v>
                </c:pt>
                <c:pt idx="103">
                  <c:v>483</c:v>
                </c:pt>
                <c:pt idx="104">
                  <c:v>484</c:v>
                </c:pt>
                <c:pt idx="105">
                  <c:v>485</c:v>
                </c:pt>
                <c:pt idx="106">
                  <c:v>486</c:v>
                </c:pt>
                <c:pt idx="107">
                  <c:v>487</c:v>
                </c:pt>
                <c:pt idx="108">
                  <c:v>488</c:v>
                </c:pt>
                <c:pt idx="109">
                  <c:v>489</c:v>
                </c:pt>
                <c:pt idx="110">
                  <c:v>490</c:v>
                </c:pt>
                <c:pt idx="111">
                  <c:v>491</c:v>
                </c:pt>
                <c:pt idx="112">
                  <c:v>492</c:v>
                </c:pt>
                <c:pt idx="113">
                  <c:v>493</c:v>
                </c:pt>
                <c:pt idx="114">
                  <c:v>494</c:v>
                </c:pt>
                <c:pt idx="115">
                  <c:v>495</c:v>
                </c:pt>
                <c:pt idx="116">
                  <c:v>496</c:v>
                </c:pt>
                <c:pt idx="117">
                  <c:v>497</c:v>
                </c:pt>
                <c:pt idx="118">
                  <c:v>498</c:v>
                </c:pt>
                <c:pt idx="119">
                  <c:v>499</c:v>
                </c:pt>
                <c:pt idx="120">
                  <c:v>500</c:v>
                </c:pt>
                <c:pt idx="121">
                  <c:v>501</c:v>
                </c:pt>
                <c:pt idx="122">
                  <c:v>502</c:v>
                </c:pt>
                <c:pt idx="123">
                  <c:v>503</c:v>
                </c:pt>
                <c:pt idx="124">
                  <c:v>504</c:v>
                </c:pt>
                <c:pt idx="125">
                  <c:v>505</c:v>
                </c:pt>
                <c:pt idx="126">
                  <c:v>506</c:v>
                </c:pt>
                <c:pt idx="127">
                  <c:v>507</c:v>
                </c:pt>
                <c:pt idx="128">
                  <c:v>508</c:v>
                </c:pt>
                <c:pt idx="129">
                  <c:v>509</c:v>
                </c:pt>
                <c:pt idx="130">
                  <c:v>510</c:v>
                </c:pt>
                <c:pt idx="131">
                  <c:v>511</c:v>
                </c:pt>
                <c:pt idx="132">
                  <c:v>512</c:v>
                </c:pt>
                <c:pt idx="133">
                  <c:v>513</c:v>
                </c:pt>
                <c:pt idx="134">
                  <c:v>514</c:v>
                </c:pt>
                <c:pt idx="135">
                  <c:v>515</c:v>
                </c:pt>
                <c:pt idx="136">
                  <c:v>516</c:v>
                </c:pt>
                <c:pt idx="137">
                  <c:v>517</c:v>
                </c:pt>
                <c:pt idx="138">
                  <c:v>518</c:v>
                </c:pt>
                <c:pt idx="139">
                  <c:v>519</c:v>
                </c:pt>
                <c:pt idx="140">
                  <c:v>520</c:v>
                </c:pt>
                <c:pt idx="141">
                  <c:v>521</c:v>
                </c:pt>
                <c:pt idx="142">
                  <c:v>522</c:v>
                </c:pt>
                <c:pt idx="143">
                  <c:v>523</c:v>
                </c:pt>
                <c:pt idx="144">
                  <c:v>524</c:v>
                </c:pt>
                <c:pt idx="145">
                  <c:v>525</c:v>
                </c:pt>
                <c:pt idx="146">
                  <c:v>526</c:v>
                </c:pt>
                <c:pt idx="147">
                  <c:v>527</c:v>
                </c:pt>
                <c:pt idx="148">
                  <c:v>528</c:v>
                </c:pt>
                <c:pt idx="149">
                  <c:v>529</c:v>
                </c:pt>
                <c:pt idx="150">
                  <c:v>530</c:v>
                </c:pt>
                <c:pt idx="151">
                  <c:v>531</c:v>
                </c:pt>
                <c:pt idx="152">
                  <c:v>532</c:v>
                </c:pt>
                <c:pt idx="153">
                  <c:v>533</c:v>
                </c:pt>
                <c:pt idx="154">
                  <c:v>534</c:v>
                </c:pt>
                <c:pt idx="155">
                  <c:v>535</c:v>
                </c:pt>
                <c:pt idx="156">
                  <c:v>536</c:v>
                </c:pt>
                <c:pt idx="157">
                  <c:v>537</c:v>
                </c:pt>
                <c:pt idx="158">
                  <c:v>538</c:v>
                </c:pt>
                <c:pt idx="159">
                  <c:v>539</c:v>
                </c:pt>
                <c:pt idx="160">
                  <c:v>540</c:v>
                </c:pt>
                <c:pt idx="161">
                  <c:v>541</c:v>
                </c:pt>
                <c:pt idx="162">
                  <c:v>542</c:v>
                </c:pt>
                <c:pt idx="163">
                  <c:v>543</c:v>
                </c:pt>
                <c:pt idx="164">
                  <c:v>544</c:v>
                </c:pt>
                <c:pt idx="165">
                  <c:v>545</c:v>
                </c:pt>
                <c:pt idx="166">
                  <c:v>546</c:v>
                </c:pt>
                <c:pt idx="167">
                  <c:v>547</c:v>
                </c:pt>
                <c:pt idx="168">
                  <c:v>548</c:v>
                </c:pt>
                <c:pt idx="169">
                  <c:v>549</c:v>
                </c:pt>
                <c:pt idx="170">
                  <c:v>550</c:v>
                </c:pt>
                <c:pt idx="171">
                  <c:v>551</c:v>
                </c:pt>
                <c:pt idx="172">
                  <c:v>552</c:v>
                </c:pt>
                <c:pt idx="173">
                  <c:v>553</c:v>
                </c:pt>
                <c:pt idx="174">
                  <c:v>554</c:v>
                </c:pt>
                <c:pt idx="175">
                  <c:v>555</c:v>
                </c:pt>
                <c:pt idx="176">
                  <c:v>556</c:v>
                </c:pt>
                <c:pt idx="177">
                  <c:v>557</c:v>
                </c:pt>
                <c:pt idx="178">
                  <c:v>558</c:v>
                </c:pt>
                <c:pt idx="179">
                  <c:v>559</c:v>
                </c:pt>
                <c:pt idx="180">
                  <c:v>560</c:v>
                </c:pt>
                <c:pt idx="181">
                  <c:v>561</c:v>
                </c:pt>
                <c:pt idx="182">
                  <c:v>562</c:v>
                </c:pt>
                <c:pt idx="183">
                  <c:v>563</c:v>
                </c:pt>
                <c:pt idx="184">
                  <c:v>564</c:v>
                </c:pt>
                <c:pt idx="185">
                  <c:v>565</c:v>
                </c:pt>
                <c:pt idx="186">
                  <c:v>566</c:v>
                </c:pt>
                <c:pt idx="187">
                  <c:v>567</c:v>
                </c:pt>
                <c:pt idx="188">
                  <c:v>568</c:v>
                </c:pt>
                <c:pt idx="189">
                  <c:v>569</c:v>
                </c:pt>
                <c:pt idx="190">
                  <c:v>570</c:v>
                </c:pt>
                <c:pt idx="191">
                  <c:v>571</c:v>
                </c:pt>
                <c:pt idx="192">
                  <c:v>572</c:v>
                </c:pt>
                <c:pt idx="193">
                  <c:v>573</c:v>
                </c:pt>
                <c:pt idx="194">
                  <c:v>574</c:v>
                </c:pt>
                <c:pt idx="195">
                  <c:v>575</c:v>
                </c:pt>
                <c:pt idx="196">
                  <c:v>576</c:v>
                </c:pt>
                <c:pt idx="197">
                  <c:v>577</c:v>
                </c:pt>
                <c:pt idx="198">
                  <c:v>578</c:v>
                </c:pt>
                <c:pt idx="199">
                  <c:v>579</c:v>
                </c:pt>
                <c:pt idx="200">
                  <c:v>580</c:v>
                </c:pt>
                <c:pt idx="201">
                  <c:v>581</c:v>
                </c:pt>
                <c:pt idx="202">
                  <c:v>582</c:v>
                </c:pt>
                <c:pt idx="203">
                  <c:v>583</c:v>
                </c:pt>
                <c:pt idx="204">
                  <c:v>584</c:v>
                </c:pt>
                <c:pt idx="205">
                  <c:v>585</c:v>
                </c:pt>
                <c:pt idx="206">
                  <c:v>586</c:v>
                </c:pt>
                <c:pt idx="207">
                  <c:v>587</c:v>
                </c:pt>
                <c:pt idx="208">
                  <c:v>588</c:v>
                </c:pt>
                <c:pt idx="209">
                  <c:v>589</c:v>
                </c:pt>
                <c:pt idx="210">
                  <c:v>590</c:v>
                </c:pt>
                <c:pt idx="211">
                  <c:v>591</c:v>
                </c:pt>
                <c:pt idx="212">
                  <c:v>592</c:v>
                </c:pt>
                <c:pt idx="213">
                  <c:v>593</c:v>
                </c:pt>
                <c:pt idx="214">
                  <c:v>594</c:v>
                </c:pt>
                <c:pt idx="215">
                  <c:v>595</c:v>
                </c:pt>
                <c:pt idx="216">
                  <c:v>596</c:v>
                </c:pt>
                <c:pt idx="217">
                  <c:v>597</c:v>
                </c:pt>
                <c:pt idx="218">
                  <c:v>598</c:v>
                </c:pt>
                <c:pt idx="219">
                  <c:v>599</c:v>
                </c:pt>
                <c:pt idx="220">
                  <c:v>600</c:v>
                </c:pt>
                <c:pt idx="221">
                  <c:v>601</c:v>
                </c:pt>
                <c:pt idx="222">
                  <c:v>602</c:v>
                </c:pt>
                <c:pt idx="223">
                  <c:v>603</c:v>
                </c:pt>
                <c:pt idx="224">
                  <c:v>604</c:v>
                </c:pt>
                <c:pt idx="225">
                  <c:v>605</c:v>
                </c:pt>
                <c:pt idx="226">
                  <c:v>606</c:v>
                </c:pt>
                <c:pt idx="227">
                  <c:v>607</c:v>
                </c:pt>
                <c:pt idx="228">
                  <c:v>608</c:v>
                </c:pt>
                <c:pt idx="229">
                  <c:v>609</c:v>
                </c:pt>
                <c:pt idx="230">
                  <c:v>610</c:v>
                </c:pt>
                <c:pt idx="231">
                  <c:v>611</c:v>
                </c:pt>
                <c:pt idx="232">
                  <c:v>612</c:v>
                </c:pt>
                <c:pt idx="233">
                  <c:v>613</c:v>
                </c:pt>
                <c:pt idx="234">
                  <c:v>614</c:v>
                </c:pt>
                <c:pt idx="235">
                  <c:v>615</c:v>
                </c:pt>
                <c:pt idx="236">
                  <c:v>616</c:v>
                </c:pt>
                <c:pt idx="237">
                  <c:v>617</c:v>
                </c:pt>
                <c:pt idx="238">
                  <c:v>618</c:v>
                </c:pt>
                <c:pt idx="239">
                  <c:v>619</c:v>
                </c:pt>
                <c:pt idx="240">
                  <c:v>620</c:v>
                </c:pt>
                <c:pt idx="241">
                  <c:v>621</c:v>
                </c:pt>
                <c:pt idx="242">
                  <c:v>622</c:v>
                </c:pt>
                <c:pt idx="243">
                  <c:v>623</c:v>
                </c:pt>
                <c:pt idx="244">
                  <c:v>624</c:v>
                </c:pt>
                <c:pt idx="245">
                  <c:v>625</c:v>
                </c:pt>
                <c:pt idx="246">
                  <c:v>626</c:v>
                </c:pt>
                <c:pt idx="247">
                  <c:v>627</c:v>
                </c:pt>
                <c:pt idx="248">
                  <c:v>628</c:v>
                </c:pt>
                <c:pt idx="249">
                  <c:v>629</c:v>
                </c:pt>
                <c:pt idx="250">
                  <c:v>630</c:v>
                </c:pt>
                <c:pt idx="251">
                  <c:v>631</c:v>
                </c:pt>
                <c:pt idx="252">
                  <c:v>632</c:v>
                </c:pt>
                <c:pt idx="253">
                  <c:v>633</c:v>
                </c:pt>
                <c:pt idx="254">
                  <c:v>634</c:v>
                </c:pt>
                <c:pt idx="255">
                  <c:v>635</c:v>
                </c:pt>
                <c:pt idx="256">
                  <c:v>636</c:v>
                </c:pt>
                <c:pt idx="257">
                  <c:v>637</c:v>
                </c:pt>
                <c:pt idx="258">
                  <c:v>638</c:v>
                </c:pt>
                <c:pt idx="259">
                  <c:v>639</c:v>
                </c:pt>
                <c:pt idx="260">
                  <c:v>640</c:v>
                </c:pt>
                <c:pt idx="261">
                  <c:v>641</c:v>
                </c:pt>
                <c:pt idx="262">
                  <c:v>642</c:v>
                </c:pt>
                <c:pt idx="263">
                  <c:v>643</c:v>
                </c:pt>
                <c:pt idx="264">
                  <c:v>644</c:v>
                </c:pt>
                <c:pt idx="265">
                  <c:v>645</c:v>
                </c:pt>
                <c:pt idx="266">
                  <c:v>646</c:v>
                </c:pt>
                <c:pt idx="267">
                  <c:v>647</c:v>
                </c:pt>
                <c:pt idx="268">
                  <c:v>648</c:v>
                </c:pt>
                <c:pt idx="269">
                  <c:v>649</c:v>
                </c:pt>
                <c:pt idx="270">
                  <c:v>650</c:v>
                </c:pt>
                <c:pt idx="271">
                  <c:v>651</c:v>
                </c:pt>
                <c:pt idx="272">
                  <c:v>652</c:v>
                </c:pt>
                <c:pt idx="273">
                  <c:v>653</c:v>
                </c:pt>
                <c:pt idx="274">
                  <c:v>654</c:v>
                </c:pt>
                <c:pt idx="275">
                  <c:v>655</c:v>
                </c:pt>
                <c:pt idx="276">
                  <c:v>656</c:v>
                </c:pt>
                <c:pt idx="277">
                  <c:v>657</c:v>
                </c:pt>
                <c:pt idx="278">
                  <c:v>658</c:v>
                </c:pt>
                <c:pt idx="279">
                  <c:v>659</c:v>
                </c:pt>
                <c:pt idx="280">
                  <c:v>660</c:v>
                </c:pt>
                <c:pt idx="281">
                  <c:v>661</c:v>
                </c:pt>
                <c:pt idx="282">
                  <c:v>662</c:v>
                </c:pt>
                <c:pt idx="283">
                  <c:v>663</c:v>
                </c:pt>
                <c:pt idx="284">
                  <c:v>664</c:v>
                </c:pt>
                <c:pt idx="285">
                  <c:v>665</c:v>
                </c:pt>
                <c:pt idx="286">
                  <c:v>666</c:v>
                </c:pt>
                <c:pt idx="287">
                  <c:v>667</c:v>
                </c:pt>
                <c:pt idx="288">
                  <c:v>668</c:v>
                </c:pt>
                <c:pt idx="289">
                  <c:v>669</c:v>
                </c:pt>
                <c:pt idx="290">
                  <c:v>670</c:v>
                </c:pt>
                <c:pt idx="291">
                  <c:v>671</c:v>
                </c:pt>
                <c:pt idx="292">
                  <c:v>672</c:v>
                </c:pt>
                <c:pt idx="293">
                  <c:v>673</c:v>
                </c:pt>
                <c:pt idx="294">
                  <c:v>674</c:v>
                </c:pt>
                <c:pt idx="295">
                  <c:v>675</c:v>
                </c:pt>
                <c:pt idx="296">
                  <c:v>676</c:v>
                </c:pt>
                <c:pt idx="297">
                  <c:v>677</c:v>
                </c:pt>
                <c:pt idx="298">
                  <c:v>678</c:v>
                </c:pt>
                <c:pt idx="299">
                  <c:v>679</c:v>
                </c:pt>
                <c:pt idx="300">
                  <c:v>680</c:v>
                </c:pt>
                <c:pt idx="301">
                  <c:v>681</c:v>
                </c:pt>
                <c:pt idx="302">
                  <c:v>682</c:v>
                </c:pt>
                <c:pt idx="303">
                  <c:v>683</c:v>
                </c:pt>
                <c:pt idx="304">
                  <c:v>684</c:v>
                </c:pt>
                <c:pt idx="305">
                  <c:v>685</c:v>
                </c:pt>
                <c:pt idx="306">
                  <c:v>686</c:v>
                </c:pt>
                <c:pt idx="307">
                  <c:v>687</c:v>
                </c:pt>
                <c:pt idx="308">
                  <c:v>688</c:v>
                </c:pt>
                <c:pt idx="309">
                  <c:v>689</c:v>
                </c:pt>
                <c:pt idx="310">
                  <c:v>690</c:v>
                </c:pt>
                <c:pt idx="311">
                  <c:v>691</c:v>
                </c:pt>
                <c:pt idx="312">
                  <c:v>692</c:v>
                </c:pt>
                <c:pt idx="313">
                  <c:v>693</c:v>
                </c:pt>
                <c:pt idx="314">
                  <c:v>694</c:v>
                </c:pt>
                <c:pt idx="315">
                  <c:v>695</c:v>
                </c:pt>
                <c:pt idx="316">
                  <c:v>696</c:v>
                </c:pt>
                <c:pt idx="317">
                  <c:v>697</c:v>
                </c:pt>
                <c:pt idx="318">
                  <c:v>698</c:v>
                </c:pt>
                <c:pt idx="319">
                  <c:v>699</c:v>
                </c:pt>
                <c:pt idx="320">
                  <c:v>700</c:v>
                </c:pt>
                <c:pt idx="321">
                  <c:v>701</c:v>
                </c:pt>
                <c:pt idx="322">
                  <c:v>702</c:v>
                </c:pt>
                <c:pt idx="323">
                  <c:v>703</c:v>
                </c:pt>
                <c:pt idx="324">
                  <c:v>704</c:v>
                </c:pt>
                <c:pt idx="325">
                  <c:v>705</c:v>
                </c:pt>
                <c:pt idx="326">
                  <c:v>706</c:v>
                </c:pt>
                <c:pt idx="327">
                  <c:v>707</c:v>
                </c:pt>
                <c:pt idx="328">
                  <c:v>708</c:v>
                </c:pt>
                <c:pt idx="329">
                  <c:v>709</c:v>
                </c:pt>
                <c:pt idx="330">
                  <c:v>710</c:v>
                </c:pt>
                <c:pt idx="331">
                  <c:v>711</c:v>
                </c:pt>
                <c:pt idx="332">
                  <c:v>712</c:v>
                </c:pt>
                <c:pt idx="333">
                  <c:v>713</c:v>
                </c:pt>
                <c:pt idx="334">
                  <c:v>714</c:v>
                </c:pt>
                <c:pt idx="335">
                  <c:v>715</c:v>
                </c:pt>
                <c:pt idx="336">
                  <c:v>716</c:v>
                </c:pt>
                <c:pt idx="337">
                  <c:v>717</c:v>
                </c:pt>
                <c:pt idx="338">
                  <c:v>718</c:v>
                </c:pt>
                <c:pt idx="339">
                  <c:v>719</c:v>
                </c:pt>
                <c:pt idx="340">
                  <c:v>720</c:v>
                </c:pt>
                <c:pt idx="341">
                  <c:v>721</c:v>
                </c:pt>
                <c:pt idx="342">
                  <c:v>722</c:v>
                </c:pt>
                <c:pt idx="343">
                  <c:v>723</c:v>
                </c:pt>
                <c:pt idx="344">
                  <c:v>724</c:v>
                </c:pt>
                <c:pt idx="345">
                  <c:v>725</c:v>
                </c:pt>
                <c:pt idx="346">
                  <c:v>726</c:v>
                </c:pt>
                <c:pt idx="347">
                  <c:v>727</c:v>
                </c:pt>
                <c:pt idx="348">
                  <c:v>728</c:v>
                </c:pt>
                <c:pt idx="349">
                  <c:v>729</c:v>
                </c:pt>
                <c:pt idx="350">
                  <c:v>730</c:v>
                </c:pt>
                <c:pt idx="351">
                  <c:v>731</c:v>
                </c:pt>
                <c:pt idx="352">
                  <c:v>732</c:v>
                </c:pt>
                <c:pt idx="353">
                  <c:v>733</c:v>
                </c:pt>
                <c:pt idx="354">
                  <c:v>734</c:v>
                </c:pt>
                <c:pt idx="355">
                  <c:v>735</c:v>
                </c:pt>
                <c:pt idx="356">
                  <c:v>736</c:v>
                </c:pt>
                <c:pt idx="357">
                  <c:v>737</c:v>
                </c:pt>
                <c:pt idx="358">
                  <c:v>738</c:v>
                </c:pt>
                <c:pt idx="359">
                  <c:v>739</c:v>
                </c:pt>
                <c:pt idx="360">
                  <c:v>740</c:v>
                </c:pt>
                <c:pt idx="361">
                  <c:v>741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6</c:v>
                </c:pt>
                <c:pt idx="367">
                  <c:v>747</c:v>
                </c:pt>
                <c:pt idx="368">
                  <c:v>748</c:v>
                </c:pt>
                <c:pt idx="369">
                  <c:v>749</c:v>
                </c:pt>
                <c:pt idx="370">
                  <c:v>750</c:v>
                </c:pt>
                <c:pt idx="371">
                  <c:v>751</c:v>
                </c:pt>
                <c:pt idx="372">
                  <c:v>752</c:v>
                </c:pt>
                <c:pt idx="373">
                  <c:v>753</c:v>
                </c:pt>
                <c:pt idx="374">
                  <c:v>754</c:v>
                </c:pt>
                <c:pt idx="375">
                  <c:v>755</c:v>
                </c:pt>
                <c:pt idx="376">
                  <c:v>756</c:v>
                </c:pt>
                <c:pt idx="377">
                  <c:v>757</c:v>
                </c:pt>
                <c:pt idx="378">
                  <c:v>758</c:v>
                </c:pt>
                <c:pt idx="379">
                  <c:v>759</c:v>
                </c:pt>
                <c:pt idx="380">
                  <c:v>760</c:v>
                </c:pt>
                <c:pt idx="381">
                  <c:v>761</c:v>
                </c:pt>
                <c:pt idx="382">
                  <c:v>762</c:v>
                </c:pt>
                <c:pt idx="383">
                  <c:v>763</c:v>
                </c:pt>
                <c:pt idx="384">
                  <c:v>764</c:v>
                </c:pt>
                <c:pt idx="385">
                  <c:v>765</c:v>
                </c:pt>
                <c:pt idx="386">
                  <c:v>766</c:v>
                </c:pt>
                <c:pt idx="387">
                  <c:v>767</c:v>
                </c:pt>
                <c:pt idx="388">
                  <c:v>768</c:v>
                </c:pt>
                <c:pt idx="389">
                  <c:v>769</c:v>
                </c:pt>
                <c:pt idx="390">
                  <c:v>770</c:v>
                </c:pt>
                <c:pt idx="391">
                  <c:v>771</c:v>
                </c:pt>
                <c:pt idx="392">
                  <c:v>772</c:v>
                </c:pt>
                <c:pt idx="393">
                  <c:v>773</c:v>
                </c:pt>
                <c:pt idx="394">
                  <c:v>774</c:v>
                </c:pt>
                <c:pt idx="395">
                  <c:v>775</c:v>
                </c:pt>
                <c:pt idx="396">
                  <c:v>776</c:v>
                </c:pt>
                <c:pt idx="397">
                  <c:v>777</c:v>
                </c:pt>
                <c:pt idx="398">
                  <c:v>778</c:v>
                </c:pt>
                <c:pt idx="399">
                  <c:v>779</c:v>
                </c:pt>
                <c:pt idx="400">
                  <c:v>780</c:v>
                </c:pt>
              </c:numCache>
            </c:numRef>
          </c:xVal>
          <c:yVal>
            <c:numRef>
              <c:f>Hoja2!$E$7:$E$407</c:f>
              <c:numCache>
                <c:formatCode>General</c:formatCode>
                <c:ptCount val="401"/>
                <c:pt idx="0">
                  <c:v>4.6950000000000004E-3</c:v>
                </c:pt>
                <c:pt idx="1">
                  <c:v>4.5700000000000003E-3</c:v>
                </c:pt>
                <c:pt idx="2">
                  <c:v>4.4029999999999998E-3</c:v>
                </c:pt>
                <c:pt idx="3">
                  <c:v>4.0070000000000001E-3</c:v>
                </c:pt>
                <c:pt idx="4">
                  <c:v>3.5000000000000001E-3</c:v>
                </c:pt>
                <c:pt idx="5">
                  <c:v>3.5530000000000002E-3</c:v>
                </c:pt>
                <c:pt idx="6">
                  <c:v>3.741E-3</c:v>
                </c:pt>
                <c:pt idx="7">
                  <c:v>3.5330000000000001E-3</c:v>
                </c:pt>
                <c:pt idx="8">
                  <c:v>3.3270000000000001E-3</c:v>
                </c:pt>
                <c:pt idx="9">
                  <c:v>3.457E-3</c:v>
                </c:pt>
                <c:pt idx="10">
                  <c:v>3.5149999999999999E-3</c:v>
                </c:pt>
                <c:pt idx="11">
                  <c:v>3.3E-3</c:v>
                </c:pt>
                <c:pt idx="12">
                  <c:v>3.2330000000000002E-3</c:v>
                </c:pt>
                <c:pt idx="13">
                  <c:v>3.4510000000000001E-3</c:v>
                </c:pt>
                <c:pt idx="14">
                  <c:v>3.552E-3</c:v>
                </c:pt>
                <c:pt idx="15">
                  <c:v>3.5260000000000001E-3</c:v>
                </c:pt>
                <c:pt idx="16">
                  <c:v>3.3470000000000001E-3</c:v>
                </c:pt>
                <c:pt idx="17">
                  <c:v>3.0709999999999999E-3</c:v>
                </c:pt>
                <c:pt idx="18">
                  <c:v>2.8960000000000001E-3</c:v>
                </c:pt>
                <c:pt idx="19">
                  <c:v>2.7539999999999999E-3</c:v>
                </c:pt>
                <c:pt idx="20">
                  <c:v>2.807E-3</c:v>
                </c:pt>
                <c:pt idx="21">
                  <c:v>2.8909999999999999E-3</c:v>
                </c:pt>
                <c:pt idx="22">
                  <c:v>3.2490000000000002E-3</c:v>
                </c:pt>
                <c:pt idx="23">
                  <c:v>3.516E-3</c:v>
                </c:pt>
                <c:pt idx="24">
                  <c:v>3.277E-3</c:v>
                </c:pt>
                <c:pt idx="25">
                  <c:v>3.1110000000000001E-3</c:v>
                </c:pt>
                <c:pt idx="26">
                  <c:v>3.124E-3</c:v>
                </c:pt>
                <c:pt idx="27">
                  <c:v>3.1700000000000001E-3</c:v>
                </c:pt>
                <c:pt idx="28">
                  <c:v>3.2590000000000002E-3</c:v>
                </c:pt>
                <c:pt idx="29">
                  <c:v>3.2439999999999999E-3</c:v>
                </c:pt>
                <c:pt idx="30">
                  <c:v>3.1489999999999999E-3</c:v>
                </c:pt>
                <c:pt idx="31">
                  <c:v>3.0530000000000002E-3</c:v>
                </c:pt>
                <c:pt idx="32">
                  <c:v>2.9589999999999998E-3</c:v>
                </c:pt>
                <c:pt idx="33">
                  <c:v>2.9870000000000001E-3</c:v>
                </c:pt>
                <c:pt idx="34">
                  <c:v>3.039E-3</c:v>
                </c:pt>
                <c:pt idx="35">
                  <c:v>3.1949999999999999E-3</c:v>
                </c:pt>
                <c:pt idx="36">
                  <c:v>3.3609999999999998E-3</c:v>
                </c:pt>
                <c:pt idx="37">
                  <c:v>3.5869999999999999E-3</c:v>
                </c:pt>
                <c:pt idx="38">
                  <c:v>3.813E-3</c:v>
                </c:pt>
                <c:pt idx="39">
                  <c:v>4.0379999999999999E-3</c:v>
                </c:pt>
                <c:pt idx="40">
                  <c:v>4.3709999999999999E-3</c:v>
                </c:pt>
                <c:pt idx="41">
                  <c:v>4.8700000000000002E-3</c:v>
                </c:pt>
                <c:pt idx="42">
                  <c:v>5.28E-3</c:v>
                </c:pt>
                <c:pt idx="43">
                  <c:v>5.6129999999999999E-3</c:v>
                </c:pt>
                <c:pt idx="44">
                  <c:v>6.1349999999999998E-3</c:v>
                </c:pt>
                <c:pt idx="45">
                  <c:v>6.7479999999999997E-3</c:v>
                </c:pt>
                <c:pt idx="46">
                  <c:v>7.7330000000000003E-3</c:v>
                </c:pt>
                <c:pt idx="47">
                  <c:v>8.8030000000000001E-3</c:v>
                </c:pt>
                <c:pt idx="48">
                  <c:v>1.0199E-2</c:v>
                </c:pt>
                <c:pt idx="49">
                  <c:v>1.1650000000000001E-2</c:v>
                </c:pt>
                <c:pt idx="50">
                  <c:v>1.3459E-2</c:v>
                </c:pt>
                <c:pt idx="51">
                  <c:v>1.5355000000000001E-2</c:v>
                </c:pt>
                <c:pt idx="52">
                  <c:v>1.7519E-2</c:v>
                </c:pt>
                <c:pt idx="53">
                  <c:v>2.0102999999999999E-2</c:v>
                </c:pt>
                <c:pt idx="54">
                  <c:v>2.3351E-2</c:v>
                </c:pt>
                <c:pt idx="55">
                  <c:v>2.6808999999999999E-2</c:v>
                </c:pt>
                <c:pt idx="56">
                  <c:v>3.0450999999999999E-2</c:v>
                </c:pt>
                <c:pt idx="57">
                  <c:v>3.4911999999999999E-2</c:v>
                </c:pt>
                <c:pt idx="58">
                  <c:v>3.9760999999999998E-2</c:v>
                </c:pt>
                <c:pt idx="59">
                  <c:v>4.5516000000000001E-2</c:v>
                </c:pt>
                <c:pt idx="60">
                  <c:v>5.1464999999999997E-2</c:v>
                </c:pt>
                <c:pt idx="61">
                  <c:v>5.9072E-2</c:v>
                </c:pt>
                <c:pt idx="62">
                  <c:v>6.6911999999999999E-2</c:v>
                </c:pt>
                <c:pt idx="63">
                  <c:v>7.6118000000000005E-2</c:v>
                </c:pt>
                <c:pt idx="64">
                  <c:v>8.5819999999999994E-2</c:v>
                </c:pt>
                <c:pt idx="65">
                  <c:v>9.6879000000000007E-2</c:v>
                </c:pt>
                <c:pt idx="66">
                  <c:v>0.108944</c:v>
                </c:pt>
                <c:pt idx="67">
                  <c:v>0.122414</c:v>
                </c:pt>
                <c:pt idx="68">
                  <c:v>0.13687299999999999</c:v>
                </c:pt>
                <c:pt idx="69">
                  <c:v>0.152086</c:v>
                </c:pt>
                <c:pt idx="70">
                  <c:v>0.168269</c:v>
                </c:pt>
                <c:pt idx="71">
                  <c:v>0.184838</c:v>
                </c:pt>
                <c:pt idx="72">
                  <c:v>0.202018</c:v>
                </c:pt>
                <c:pt idx="73">
                  <c:v>0.219282</c:v>
                </c:pt>
                <c:pt idx="74">
                  <c:v>0.23579900000000001</c:v>
                </c:pt>
                <c:pt idx="75">
                  <c:v>0.25190800000000002</c:v>
                </c:pt>
                <c:pt idx="76">
                  <c:v>0.26598300000000002</c:v>
                </c:pt>
                <c:pt idx="77">
                  <c:v>0.27873900000000001</c:v>
                </c:pt>
                <c:pt idx="78">
                  <c:v>0.28868100000000002</c:v>
                </c:pt>
                <c:pt idx="79">
                  <c:v>0.29630400000000001</c:v>
                </c:pt>
                <c:pt idx="80">
                  <c:v>0.30134</c:v>
                </c:pt>
                <c:pt idx="81">
                  <c:v>0.30308499999999999</c:v>
                </c:pt>
                <c:pt idx="82">
                  <c:v>0.30287199999999997</c:v>
                </c:pt>
                <c:pt idx="83">
                  <c:v>0.29811199999999999</c:v>
                </c:pt>
                <c:pt idx="84">
                  <c:v>0.29208600000000001</c:v>
                </c:pt>
                <c:pt idx="85">
                  <c:v>0.28173199999999998</c:v>
                </c:pt>
                <c:pt idx="86">
                  <c:v>0.27085500000000001</c:v>
                </c:pt>
                <c:pt idx="87">
                  <c:v>0.25772600000000001</c:v>
                </c:pt>
                <c:pt idx="88">
                  <c:v>0.24430299999999999</c:v>
                </c:pt>
                <c:pt idx="89">
                  <c:v>0.23002</c:v>
                </c:pt>
                <c:pt idx="90">
                  <c:v>0.21568100000000001</c:v>
                </c:pt>
                <c:pt idx="91">
                  <c:v>0.201261</c:v>
                </c:pt>
                <c:pt idx="92">
                  <c:v>0.187365</c:v>
                </c:pt>
                <c:pt idx="93">
                  <c:v>0.17385900000000001</c:v>
                </c:pt>
                <c:pt idx="94">
                  <c:v>0.161273</c:v>
                </c:pt>
                <c:pt idx="95">
                  <c:v>0.14901900000000001</c:v>
                </c:pt>
                <c:pt idx="96">
                  <c:v>0.138321</c:v>
                </c:pt>
                <c:pt idx="97">
                  <c:v>0.12787399999999999</c:v>
                </c:pt>
                <c:pt idx="98">
                  <c:v>0.11855400000000001</c:v>
                </c:pt>
                <c:pt idx="99">
                  <c:v>0.109497</c:v>
                </c:pt>
                <c:pt idx="100">
                  <c:v>0.10133499999999999</c:v>
                </c:pt>
                <c:pt idx="101">
                  <c:v>9.3614000000000003E-2</c:v>
                </c:pt>
                <c:pt idx="102">
                  <c:v>8.6573999999999998E-2</c:v>
                </c:pt>
                <c:pt idx="103">
                  <c:v>7.979E-2</c:v>
                </c:pt>
                <c:pt idx="104">
                  <c:v>7.3206999999999994E-2</c:v>
                </c:pt>
                <c:pt idx="105">
                  <c:v>6.7479999999999998E-2</c:v>
                </c:pt>
                <c:pt idx="106">
                  <c:v>6.2068999999999999E-2</c:v>
                </c:pt>
                <c:pt idx="107">
                  <c:v>5.6868000000000002E-2</c:v>
                </c:pt>
                <c:pt idx="108">
                  <c:v>5.1764999999999999E-2</c:v>
                </c:pt>
                <c:pt idx="109">
                  <c:v>4.7632000000000001E-2</c:v>
                </c:pt>
                <c:pt idx="110">
                  <c:v>4.3633999999999999E-2</c:v>
                </c:pt>
                <c:pt idx="111">
                  <c:v>4.0058000000000003E-2</c:v>
                </c:pt>
                <c:pt idx="112">
                  <c:v>3.6804000000000003E-2</c:v>
                </c:pt>
                <c:pt idx="113">
                  <c:v>3.4001000000000003E-2</c:v>
                </c:pt>
                <c:pt idx="114">
                  <c:v>3.1467000000000002E-2</c:v>
                </c:pt>
                <c:pt idx="115">
                  <c:v>2.9118999999999999E-2</c:v>
                </c:pt>
                <c:pt idx="116">
                  <c:v>2.6877000000000002E-2</c:v>
                </c:pt>
                <c:pt idx="117">
                  <c:v>2.4667999999999999E-2</c:v>
                </c:pt>
                <c:pt idx="118">
                  <c:v>2.2884000000000002E-2</c:v>
                </c:pt>
                <c:pt idx="119">
                  <c:v>2.1114999999999998E-2</c:v>
                </c:pt>
                <c:pt idx="120">
                  <c:v>1.9278E-2</c:v>
                </c:pt>
                <c:pt idx="121">
                  <c:v>1.7593000000000001E-2</c:v>
                </c:pt>
                <c:pt idx="122">
                  <c:v>1.6258000000000002E-2</c:v>
                </c:pt>
                <c:pt idx="123">
                  <c:v>1.4964E-2</c:v>
                </c:pt>
                <c:pt idx="124">
                  <c:v>1.3712999999999999E-2</c:v>
                </c:pt>
                <c:pt idx="125">
                  <c:v>1.2743000000000001E-2</c:v>
                </c:pt>
                <c:pt idx="126">
                  <c:v>1.1915E-2</c:v>
                </c:pt>
                <c:pt idx="127">
                  <c:v>1.1074000000000001E-2</c:v>
                </c:pt>
                <c:pt idx="128">
                  <c:v>1.0237E-2</c:v>
                </c:pt>
                <c:pt idx="129">
                  <c:v>9.5809999999999992E-3</c:v>
                </c:pt>
                <c:pt idx="130">
                  <c:v>8.9490000000000004E-3</c:v>
                </c:pt>
                <c:pt idx="131">
                  <c:v>8.4019999999999997E-3</c:v>
                </c:pt>
                <c:pt idx="132">
                  <c:v>7.8050000000000003E-3</c:v>
                </c:pt>
                <c:pt idx="133">
                  <c:v>7.1370000000000001E-3</c:v>
                </c:pt>
                <c:pt idx="134">
                  <c:v>6.6059999999999999E-3</c:v>
                </c:pt>
                <c:pt idx="135">
                  <c:v>6.1659999999999996E-3</c:v>
                </c:pt>
                <c:pt idx="136">
                  <c:v>5.8589999999999996E-3</c:v>
                </c:pt>
                <c:pt idx="137">
                  <c:v>5.5859999999999998E-3</c:v>
                </c:pt>
                <c:pt idx="138">
                  <c:v>5.2389999999999997E-3</c:v>
                </c:pt>
                <c:pt idx="139">
                  <c:v>4.9109999999999996E-3</c:v>
                </c:pt>
                <c:pt idx="140">
                  <c:v>4.6800000000000001E-3</c:v>
                </c:pt>
                <c:pt idx="141">
                  <c:v>4.5209999999999998E-3</c:v>
                </c:pt>
                <c:pt idx="142">
                  <c:v>4.483E-3</c:v>
                </c:pt>
                <c:pt idx="143">
                  <c:v>4.3480000000000003E-3</c:v>
                </c:pt>
                <c:pt idx="144">
                  <c:v>4.1399999999999996E-3</c:v>
                </c:pt>
                <c:pt idx="145">
                  <c:v>3.8449999999999999E-3</c:v>
                </c:pt>
                <c:pt idx="146">
                  <c:v>3.5209999999999998E-3</c:v>
                </c:pt>
                <c:pt idx="147">
                  <c:v>3.3860000000000001E-3</c:v>
                </c:pt>
                <c:pt idx="148">
                  <c:v>3.2789999999999998E-3</c:v>
                </c:pt>
                <c:pt idx="149">
                  <c:v>3.2820000000000002E-3</c:v>
                </c:pt>
                <c:pt idx="150">
                  <c:v>3.261E-3</c:v>
                </c:pt>
                <c:pt idx="151">
                  <c:v>3.1840000000000002E-3</c:v>
                </c:pt>
                <c:pt idx="152">
                  <c:v>3.1310000000000001E-3</c:v>
                </c:pt>
                <c:pt idx="153">
                  <c:v>3.1050000000000001E-3</c:v>
                </c:pt>
                <c:pt idx="154">
                  <c:v>3.0249999999999999E-3</c:v>
                </c:pt>
                <c:pt idx="155">
                  <c:v>2.918E-3</c:v>
                </c:pt>
                <c:pt idx="156">
                  <c:v>2.944E-3</c:v>
                </c:pt>
                <c:pt idx="157">
                  <c:v>2.9810000000000001E-3</c:v>
                </c:pt>
                <c:pt idx="158">
                  <c:v>2.7569999999999999E-3</c:v>
                </c:pt>
                <c:pt idx="159">
                  <c:v>2.5690000000000001E-3</c:v>
                </c:pt>
                <c:pt idx="160">
                  <c:v>2.5010000000000002E-3</c:v>
                </c:pt>
                <c:pt idx="161">
                  <c:v>2.454E-3</c:v>
                </c:pt>
                <c:pt idx="162">
                  <c:v>2.4359999999999998E-3</c:v>
                </c:pt>
                <c:pt idx="163">
                  <c:v>2.454E-3</c:v>
                </c:pt>
                <c:pt idx="164">
                  <c:v>2.493E-3</c:v>
                </c:pt>
                <c:pt idx="165">
                  <c:v>2.526E-3</c:v>
                </c:pt>
                <c:pt idx="166">
                  <c:v>2.5560000000000001E-3</c:v>
                </c:pt>
                <c:pt idx="167">
                  <c:v>2.5690000000000001E-3</c:v>
                </c:pt>
                <c:pt idx="168">
                  <c:v>2.5799999999999998E-3</c:v>
                </c:pt>
                <c:pt idx="169">
                  <c:v>2.5899999999999999E-3</c:v>
                </c:pt>
                <c:pt idx="170">
                  <c:v>2.5370000000000002E-3</c:v>
                </c:pt>
                <c:pt idx="171">
                  <c:v>2.3939999999999999E-3</c:v>
                </c:pt>
                <c:pt idx="172">
                  <c:v>2.3579999999999999E-3</c:v>
                </c:pt>
                <c:pt idx="173">
                  <c:v>2.3909999999999999E-3</c:v>
                </c:pt>
                <c:pt idx="174">
                  <c:v>2.3739999999999998E-3</c:v>
                </c:pt>
                <c:pt idx="175">
                  <c:v>2.3519999999999999E-3</c:v>
                </c:pt>
                <c:pt idx="176">
                  <c:v>2.6120000000000002E-3</c:v>
                </c:pt>
                <c:pt idx="177">
                  <c:v>2.8270000000000001E-3</c:v>
                </c:pt>
                <c:pt idx="178">
                  <c:v>2.8909999999999999E-3</c:v>
                </c:pt>
                <c:pt idx="179">
                  <c:v>2.9169999999999999E-3</c:v>
                </c:pt>
                <c:pt idx="180">
                  <c:v>2.895E-3</c:v>
                </c:pt>
                <c:pt idx="181">
                  <c:v>2.8890000000000001E-3</c:v>
                </c:pt>
                <c:pt idx="182">
                  <c:v>2.8930000000000002E-3</c:v>
                </c:pt>
                <c:pt idx="183">
                  <c:v>2.8760000000000001E-3</c:v>
                </c:pt>
                <c:pt idx="184">
                  <c:v>2.8649999999999999E-3</c:v>
                </c:pt>
                <c:pt idx="185">
                  <c:v>2.9710000000000001E-3</c:v>
                </c:pt>
                <c:pt idx="186">
                  <c:v>3.1120000000000002E-3</c:v>
                </c:pt>
                <c:pt idx="187">
                  <c:v>3.339E-3</c:v>
                </c:pt>
                <c:pt idx="188">
                  <c:v>3.5149999999999999E-3</c:v>
                </c:pt>
                <c:pt idx="189">
                  <c:v>3.64E-3</c:v>
                </c:pt>
                <c:pt idx="190">
                  <c:v>3.9319999999999997E-3</c:v>
                </c:pt>
                <c:pt idx="191">
                  <c:v>4.2880000000000001E-3</c:v>
                </c:pt>
                <c:pt idx="192">
                  <c:v>4.6690000000000004E-3</c:v>
                </c:pt>
                <c:pt idx="193">
                  <c:v>5.0470000000000003E-3</c:v>
                </c:pt>
                <c:pt idx="194">
                  <c:v>5.4039999999999999E-3</c:v>
                </c:pt>
                <c:pt idx="195">
                  <c:v>5.6959999999999997E-3</c:v>
                </c:pt>
                <c:pt idx="196">
                  <c:v>5.888E-3</c:v>
                </c:pt>
                <c:pt idx="197">
                  <c:v>6.3239999999999998E-3</c:v>
                </c:pt>
                <c:pt idx="198">
                  <c:v>6.9119999999999997E-3</c:v>
                </c:pt>
                <c:pt idx="199">
                  <c:v>7.4999999999999997E-3</c:v>
                </c:pt>
                <c:pt idx="200">
                  <c:v>8.097E-3</c:v>
                </c:pt>
                <c:pt idx="201">
                  <c:v>8.8070000000000006E-3</c:v>
                </c:pt>
                <c:pt idx="202">
                  <c:v>9.6450000000000008E-3</c:v>
                </c:pt>
                <c:pt idx="203">
                  <c:v>1.0773E-2</c:v>
                </c:pt>
                <c:pt idx="204">
                  <c:v>1.1849E-2</c:v>
                </c:pt>
                <c:pt idx="205">
                  <c:v>1.2880000000000001E-2</c:v>
                </c:pt>
                <c:pt idx="206">
                  <c:v>1.4237E-2</c:v>
                </c:pt>
                <c:pt idx="207">
                  <c:v>1.5688000000000001E-2</c:v>
                </c:pt>
                <c:pt idx="208">
                  <c:v>1.7180999999999998E-2</c:v>
                </c:pt>
                <c:pt idx="209">
                  <c:v>1.8748999999999998E-2</c:v>
                </c:pt>
                <c:pt idx="210">
                  <c:v>2.0541E-2</c:v>
                </c:pt>
                <c:pt idx="211">
                  <c:v>2.2727000000000001E-2</c:v>
                </c:pt>
                <c:pt idx="212">
                  <c:v>2.5321E-2</c:v>
                </c:pt>
                <c:pt idx="213">
                  <c:v>2.8088999999999999E-2</c:v>
                </c:pt>
                <c:pt idx="214">
                  <c:v>3.0918999999999999E-2</c:v>
                </c:pt>
                <c:pt idx="215">
                  <c:v>3.4329999999999999E-2</c:v>
                </c:pt>
                <c:pt idx="216">
                  <c:v>3.7891000000000001E-2</c:v>
                </c:pt>
                <c:pt idx="217">
                  <c:v>4.1924000000000003E-2</c:v>
                </c:pt>
                <c:pt idx="218">
                  <c:v>4.6363000000000001E-2</c:v>
                </c:pt>
                <c:pt idx="219">
                  <c:v>5.1253E-2</c:v>
                </c:pt>
                <c:pt idx="220">
                  <c:v>5.6454999999999998E-2</c:v>
                </c:pt>
                <c:pt idx="221">
                  <c:v>6.1776999999999999E-2</c:v>
                </c:pt>
                <c:pt idx="222">
                  <c:v>6.8679000000000004E-2</c:v>
                </c:pt>
                <c:pt idx="223">
                  <c:v>7.5866000000000003E-2</c:v>
                </c:pt>
                <c:pt idx="224">
                  <c:v>8.3878999999999995E-2</c:v>
                </c:pt>
                <c:pt idx="225">
                  <c:v>9.2839000000000005E-2</c:v>
                </c:pt>
                <c:pt idx="226">
                  <c:v>0.10280300000000001</c:v>
                </c:pt>
                <c:pt idx="227">
                  <c:v>0.11423800000000001</c:v>
                </c:pt>
                <c:pt idx="228">
                  <c:v>0.12618699999999999</c:v>
                </c:pt>
                <c:pt idx="229">
                  <c:v>0.14049500000000001</c:v>
                </c:pt>
                <c:pt idx="230">
                  <c:v>0.15545400000000001</c:v>
                </c:pt>
                <c:pt idx="231">
                  <c:v>0.17222999999999999</c:v>
                </c:pt>
                <c:pt idx="232">
                  <c:v>0.19044700000000001</c:v>
                </c:pt>
                <c:pt idx="233">
                  <c:v>0.209953</c:v>
                </c:pt>
                <c:pt idx="234">
                  <c:v>0.23264799999999999</c:v>
                </c:pt>
                <c:pt idx="235">
                  <c:v>0.25639699999999999</c:v>
                </c:pt>
                <c:pt idx="236">
                  <c:v>0.283609</c:v>
                </c:pt>
                <c:pt idx="237">
                  <c:v>0.31223499999999998</c:v>
                </c:pt>
                <c:pt idx="238">
                  <c:v>0.34372599999999998</c:v>
                </c:pt>
                <c:pt idx="239">
                  <c:v>0.37785600000000003</c:v>
                </c:pt>
                <c:pt idx="240">
                  <c:v>0.41373199999999999</c:v>
                </c:pt>
                <c:pt idx="241">
                  <c:v>0.454044</c:v>
                </c:pt>
                <c:pt idx="242">
                  <c:v>0.49567</c:v>
                </c:pt>
                <c:pt idx="243">
                  <c:v>0.54113</c:v>
                </c:pt>
                <c:pt idx="244">
                  <c:v>0.58849300000000004</c:v>
                </c:pt>
                <c:pt idx="245">
                  <c:v>0.63839599999999996</c:v>
                </c:pt>
                <c:pt idx="246">
                  <c:v>0.69089</c:v>
                </c:pt>
                <c:pt idx="247">
                  <c:v>0.74445499999999998</c:v>
                </c:pt>
                <c:pt idx="248">
                  <c:v>0.79763600000000001</c:v>
                </c:pt>
                <c:pt idx="249">
                  <c:v>0.85067700000000002</c:v>
                </c:pt>
                <c:pt idx="250">
                  <c:v>0.90337599999999996</c:v>
                </c:pt>
                <c:pt idx="251">
                  <c:v>0.94496000000000002</c:v>
                </c:pt>
                <c:pt idx="252">
                  <c:v>0.97883900000000001</c:v>
                </c:pt>
                <c:pt idx="253">
                  <c:v>0.98563900000000004</c:v>
                </c:pt>
                <c:pt idx="254">
                  <c:v>0.98933499999999996</c:v>
                </c:pt>
                <c:pt idx="255">
                  <c:v>0.99276799999999998</c:v>
                </c:pt>
                <c:pt idx="256">
                  <c:v>0.99632699999999996</c:v>
                </c:pt>
                <c:pt idx="257">
                  <c:v>1</c:v>
                </c:pt>
                <c:pt idx="258">
                  <c:v>0.97889999999999999</c:v>
                </c:pt>
                <c:pt idx="259">
                  <c:v>0.94770500000000002</c:v>
                </c:pt>
                <c:pt idx="260">
                  <c:v>0.88755899999999999</c:v>
                </c:pt>
                <c:pt idx="261">
                  <c:v>0.82137099999999996</c:v>
                </c:pt>
                <c:pt idx="262">
                  <c:v>0.74846400000000002</c:v>
                </c:pt>
                <c:pt idx="263">
                  <c:v>0.67205999999999999</c:v>
                </c:pt>
                <c:pt idx="264">
                  <c:v>0.59509900000000004</c:v>
                </c:pt>
                <c:pt idx="265">
                  <c:v>0.52075000000000005</c:v>
                </c:pt>
                <c:pt idx="266">
                  <c:v>0.45053900000000002</c:v>
                </c:pt>
                <c:pt idx="267">
                  <c:v>0.38553799999999999</c:v>
                </c:pt>
                <c:pt idx="268">
                  <c:v>0.329345</c:v>
                </c:pt>
                <c:pt idx="269">
                  <c:v>0.27698200000000001</c:v>
                </c:pt>
                <c:pt idx="270">
                  <c:v>0.23549999999999999</c:v>
                </c:pt>
                <c:pt idx="271">
                  <c:v>0.19833899999999999</c:v>
                </c:pt>
                <c:pt idx="272">
                  <c:v>0.16688600000000001</c:v>
                </c:pt>
                <c:pt idx="273">
                  <c:v>0.14141999999999999</c:v>
                </c:pt>
                <c:pt idx="274">
                  <c:v>0.11837</c:v>
                </c:pt>
                <c:pt idx="275">
                  <c:v>0.10044699999999999</c:v>
                </c:pt>
                <c:pt idx="276">
                  <c:v>8.4568000000000004E-2</c:v>
                </c:pt>
                <c:pt idx="277">
                  <c:v>7.1310999999999999E-2</c:v>
                </c:pt>
                <c:pt idx="278">
                  <c:v>6.0576999999999999E-2</c:v>
                </c:pt>
                <c:pt idx="279">
                  <c:v>5.0838000000000001E-2</c:v>
                </c:pt>
                <c:pt idx="280">
                  <c:v>4.3110000000000002E-2</c:v>
                </c:pt>
                <c:pt idx="281">
                  <c:v>3.6552000000000001E-2</c:v>
                </c:pt>
                <c:pt idx="282">
                  <c:v>3.1345999999999999E-2</c:v>
                </c:pt>
                <c:pt idx="283">
                  <c:v>2.7014E-2</c:v>
                </c:pt>
                <c:pt idx="284">
                  <c:v>2.3098E-2</c:v>
                </c:pt>
                <c:pt idx="285">
                  <c:v>2.0303000000000002E-2</c:v>
                </c:pt>
                <c:pt idx="286">
                  <c:v>1.7801000000000001E-2</c:v>
                </c:pt>
                <c:pt idx="287">
                  <c:v>1.5583E-2</c:v>
                </c:pt>
                <c:pt idx="288">
                  <c:v>1.3852E-2</c:v>
                </c:pt>
                <c:pt idx="289">
                  <c:v>1.2363000000000001E-2</c:v>
                </c:pt>
                <c:pt idx="290">
                  <c:v>1.1462999999999999E-2</c:v>
                </c:pt>
                <c:pt idx="291">
                  <c:v>1.0155000000000001E-2</c:v>
                </c:pt>
                <c:pt idx="292">
                  <c:v>8.5459999999999998E-3</c:v>
                </c:pt>
                <c:pt idx="293">
                  <c:v>7.7530000000000003E-3</c:v>
                </c:pt>
                <c:pt idx="294">
                  <c:v>7.1120000000000003E-3</c:v>
                </c:pt>
                <c:pt idx="295">
                  <c:v>6.6950000000000004E-3</c:v>
                </c:pt>
                <c:pt idx="296">
                  <c:v>6.2529999999999999E-3</c:v>
                </c:pt>
                <c:pt idx="297">
                  <c:v>5.8019999999999999E-3</c:v>
                </c:pt>
                <c:pt idx="298">
                  <c:v>5.5240000000000003E-3</c:v>
                </c:pt>
                <c:pt idx="299">
                  <c:v>5.2139999999999999E-3</c:v>
                </c:pt>
                <c:pt idx="300">
                  <c:v>4.8560000000000001E-3</c:v>
                </c:pt>
                <c:pt idx="301">
                  <c:v>4.5580000000000004E-3</c:v>
                </c:pt>
                <c:pt idx="302">
                  <c:v>4.2519999999999997E-3</c:v>
                </c:pt>
                <c:pt idx="303">
                  <c:v>3.787E-3</c:v>
                </c:pt>
                <c:pt idx="304">
                  <c:v>3.6120000000000002E-3</c:v>
                </c:pt>
                <c:pt idx="305">
                  <c:v>3.7069999999999998E-3</c:v>
                </c:pt>
                <c:pt idx="306">
                  <c:v>3.3700000000000002E-3</c:v>
                </c:pt>
                <c:pt idx="307">
                  <c:v>3.1029999999999999E-3</c:v>
                </c:pt>
                <c:pt idx="308">
                  <c:v>3.153E-3</c:v>
                </c:pt>
                <c:pt idx="309">
                  <c:v>3.313E-3</c:v>
                </c:pt>
                <c:pt idx="310">
                  <c:v>3.516E-3</c:v>
                </c:pt>
                <c:pt idx="311">
                  <c:v>3.3790000000000001E-3</c:v>
                </c:pt>
                <c:pt idx="312">
                  <c:v>3.2669999999999999E-3</c:v>
                </c:pt>
                <c:pt idx="313">
                  <c:v>3.1879999999999999E-3</c:v>
                </c:pt>
                <c:pt idx="314">
                  <c:v>2.9390000000000002E-3</c:v>
                </c:pt>
                <c:pt idx="315">
                  <c:v>2.7160000000000001E-3</c:v>
                </c:pt>
                <c:pt idx="316">
                  <c:v>2.7299999999999998E-3</c:v>
                </c:pt>
                <c:pt idx="317">
                  <c:v>2.774E-3</c:v>
                </c:pt>
                <c:pt idx="318">
                  <c:v>2.8370000000000001E-3</c:v>
                </c:pt>
                <c:pt idx="319">
                  <c:v>2.934E-3</c:v>
                </c:pt>
                <c:pt idx="320">
                  <c:v>2.9060000000000002E-3</c:v>
                </c:pt>
                <c:pt idx="321">
                  <c:v>2.6909999999999998E-3</c:v>
                </c:pt>
                <c:pt idx="322">
                  <c:v>2.8089999999999999E-3</c:v>
                </c:pt>
                <c:pt idx="323">
                  <c:v>2.98E-3</c:v>
                </c:pt>
                <c:pt idx="324">
                  <c:v>3.0479999999999999E-3</c:v>
                </c:pt>
                <c:pt idx="325">
                  <c:v>2.928E-3</c:v>
                </c:pt>
                <c:pt idx="326">
                  <c:v>2.6909999999999998E-3</c:v>
                </c:pt>
                <c:pt idx="327">
                  <c:v>2.4989999999999999E-3</c:v>
                </c:pt>
                <c:pt idx="328">
                  <c:v>2.4499999999999999E-3</c:v>
                </c:pt>
                <c:pt idx="329">
                  <c:v>2.5860000000000002E-3</c:v>
                </c:pt>
                <c:pt idx="330">
                  <c:v>2.6069999999999999E-3</c:v>
                </c:pt>
                <c:pt idx="331">
                  <c:v>2.7100000000000002E-3</c:v>
                </c:pt>
                <c:pt idx="332">
                  <c:v>3.101E-3</c:v>
                </c:pt>
                <c:pt idx="333">
                  <c:v>3.0409999999999999E-3</c:v>
                </c:pt>
                <c:pt idx="334">
                  <c:v>2.826E-3</c:v>
                </c:pt>
                <c:pt idx="335">
                  <c:v>3.081E-3</c:v>
                </c:pt>
                <c:pt idx="336">
                  <c:v>2.996E-3</c:v>
                </c:pt>
                <c:pt idx="337">
                  <c:v>2.6069999999999999E-3</c:v>
                </c:pt>
                <c:pt idx="338">
                  <c:v>2.6199999999999999E-3</c:v>
                </c:pt>
                <c:pt idx="339">
                  <c:v>2.7039999999999998E-3</c:v>
                </c:pt>
                <c:pt idx="340">
                  <c:v>2.872E-3</c:v>
                </c:pt>
                <c:pt idx="341">
                  <c:v>2.9190000000000002E-3</c:v>
                </c:pt>
                <c:pt idx="342">
                  <c:v>2.9520000000000002E-3</c:v>
                </c:pt>
                <c:pt idx="343">
                  <c:v>3.029E-3</c:v>
                </c:pt>
                <c:pt idx="344">
                  <c:v>3.055E-3</c:v>
                </c:pt>
                <c:pt idx="345">
                  <c:v>3.068E-3</c:v>
                </c:pt>
                <c:pt idx="346">
                  <c:v>3.1679999999999998E-3</c:v>
                </c:pt>
                <c:pt idx="347">
                  <c:v>3.065E-3</c:v>
                </c:pt>
                <c:pt idx="348">
                  <c:v>2.8080000000000002E-3</c:v>
                </c:pt>
                <c:pt idx="349">
                  <c:v>2.7260000000000001E-3</c:v>
                </c:pt>
                <c:pt idx="350">
                  <c:v>2.8410000000000002E-3</c:v>
                </c:pt>
                <c:pt idx="351">
                  <c:v>3.189E-3</c:v>
                </c:pt>
                <c:pt idx="352">
                  <c:v>3.2049999999999999E-3</c:v>
                </c:pt>
                <c:pt idx="353">
                  <c:v>3.1649999999999998E-3</c:v>
                </c:pt>
                <c:pt idx="354">
                  <c:v>3.0860000000000002E-3</c:v>
                </c:pt>
                <c:pt idx="355">
                  <c:v>3.2850000000000002E-3</c:v>
                </c:pt>
                <c:pt idx="356">
                  <c:v>3.5140000000000002E-3</c:v>
                </c:pt>
                <c:pt idx="357">
                  <c:v>3.6540000000000001E-3</c:v>
                </c:pt>
                <c:pt idx="358">
                  <c:v>3.326E-3</c:v>
                </c:pt>
                <c:pt idx="359">
                  <c:v>2.98E-3</c:v>
                </c:pt>
                <c:pt idx="360">
                  <c:v>3.2550000000000001E-3</c:v>
                </c:pt>
                <c:pt idx="361">
                  <c:v>3.3089999999999999E-3</c:v>
                </c:pt>
                <c:pt idx="362">
                  <c:v>3.2940000000000001E-3</c:v>
                </c:pt>
                <c:pt idx="363">
                  <c:v>3.558E-3</c:v>
                </c:pt>
                <c:pt idx="364">
                  <c:v>3.9979999999999998E-3</c:v>
                </c:pt>
                <c:pt idx="365">
                  <c:v>4.5129999999999997E-3</c:v>
                </c:pt>
                <c:pt idx="366">
                  <c:v>4.5329999999999997E-3</c:v>
                </c:pt>
                <c:pt idx="367">
                  <c:v>4.7039999999999998E-3</c:v>
                </c:pt>
                <c:pt idx="368">
                  <c:v>4.9569999999999996E-3</c:v>
                </c:pt>
                <c:pt idx="369">
                  <c:v>4.1859999999999996E-3</c:v>
                </c:pt>
                <c:pt idx="370">
                  <c:v>3.875E-3</c:v>
                </c:pt>
                <c:pt idx="371">
                  <c:v>3.9909999999999998E-3</c:v>
                </c:pt>
                <c:pt idx="372">
                  <c:v>4.0070000000000001E-3</c:v>
                </c:pt>
                <c:pt idx="373">
                  <c:v>3.9839999999999997E-3</c:v>
                </c:pt>
                <c:pt idx="374">
                  <c:v>3.921E-3</c:v>
                </c:pt>
                <c:pt idx="375">
                  <c:v>5.0410000000000003E-3</c:v>
                </c:pt>
                <c:pt idx="376">
                  <c:v>5.4000000000000003E-3</c:v>
                </c:pt>
                <c:pt idx="377">
                  <c:v>4.9129999999999998E-3</c:v>
                </c:pt>
                <c:pt idx="378">
                  <c:v>5.1650000000000003E-3</c:v>
                </c:pt>
                <c:pt idx="379">
                  <c:v>5.1310000000000001E-3</c:v>
                </c:pt>
                <c:pt idx="380">
                  <c:v>4.764E-3</c:v>
                </c:pt>
                <c:pt idx="381">
                  <c:v>4.8310000000000002E-3</c:v>
                </c:pt>
                <c:pt idx="382">
                  <c:v>4.7819999999999998E-3</c:v>
                </c:pt>
                <c:pt idx="383">
                  <c:v>4.6020000000000002E-3</c:v>
                </c:pt>
                <c:pt idx="384">
                  <c:v>5.2440000000000004E-3</c:v>
                </c:pt>
                <c:pt idx="385">
                  <c:v>5.7149999999999996E-3</c:v>
                </c:pt>
                <c:pt idx="386">
                  <c:v>6.0070000000000002E-3</c:v>
                </c:pt>
                <c:pt idx="387">
                  <c:v>5.8250000000000003E-3</c:v>
                </c:pt>
                <c:pt idx="388">
                  <c:v>5.6559999999999996E-3</c:v>
                </c:pt>
                <c:pt idx="389">
                  <c:v>5.4929999999999996E-3</c:v>
                </c:pt>
                <c:pt idx="390">
                  <c:v>5.2649999999999997E-3</c:v>
                </c:pt>
                <c:pt idx="391">
                  <c:v>5.012E-3</c:v>
                </c:pt>
                <c:pt idx="392">
                  <c:v>4.7879999999999997E-3</c:v>
                </c:pt>
                <c:pt idx="393">
                  <c:v>4.9049999999999996E-3</c:v>
                </c:pt>
                <c:pt idx="394">
                  <c:v>5.3749999999999996E-3</c:v>
                </c:pt>
                <c:pt idx="395">
                  <c:v>5.901E-3</c:v>
                </c:pt>
                <c:pt idx="396">
                  <c:v>5.8279999999999998E-3</c:v>
                </c:pt>
                <c:pt idx="397">
                  <c:v>5.6290000000000003E-3</c:v>
                </c:pt>
                <c:pt idx="398">
                  <c:v>5.555E-3</c:v>
                </c:pt>
                <c:pt idx="399">
                  <c:v>5.9719999999999999E-3</c:v>
                </c:pt>
                <c:pt idx="400">
                  <c:v>5.4380000000000001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989-4E94-A030-BC7D56AB6B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9757391"/>
        <c:axId val="849754895"/>
      </c:scatterChart>
      <c:valAx>
        <c:axId val="849757391"/>
        <c:scaling>
          <c:orientation val="minMax"/>
          <c:max val="780"/>
          <c:min val="3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Wavelength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4895"/>
        <c:crosses val="autoZero"/>
        <c:crossBetween val="midCat"/>
      </c:valAx>
      <c:valAx>
        <c:axId val="849754895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0" i="0" baseline="0" dirty="0" err="1">
                    <a:effectLst/>
                  </a:rPr>
                  <a:t>Relativ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spectral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irradianc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composition</a:t>
                </a:r>
                <a:endParaRPr lang="es-ES" sz="10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7391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>
                <a:solidFill>
                  <a:schemeClr val="tx1"/>
                </a:solidFill>
              </a:rPr>
              <a:t>R6B4-40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Hoja2!$A$7:$A$407</c:f>
              <c:numCache>
                <c:formatCode>General</c:formatCode>
                <c:ptCount val="401"/>
                <c:pt idx="0">
                  <c:v>380</c:v>
                </c:pt>
                <c:pt idx="1">
                  <c:v>381</c:v>
                </c:pt>
                <c:pt idx="2">
                  <c:v>382</c:v>
                </c:pt>
                <c:pt idx="3">
                  <c:v>383</c:v>
                </c:pt>
                <c:pt idx="4">
                  <c:v>384</c:v>
                </c:pt>
                <c:pt idx="5">
                  <c:v>385</c:v>
                </c:pt>
                <c:pt idx="6">
                  <c:v>386</c:v>
                </c:pt>
                <c:pt idx="7">
                  <c:v>387</c:v>
                </c:pt>
                <c:pt idx="8">
                  <c:v>388</c:v>
                </c:pt>
                <c:pt idx="9">
                  <c:v>389</c:v>
                </c:pt>
                <c:pt idx="10">
                  <c:v>390</c:v>
                </c:pt>
                <c:pt idx="11">
                  <c:v>391</c:v>
                </c:pt>
                <c:pt idx="12">
                  <c:v>392</c:v>
                </c:pt>
                <c:pt idx="13">
                  <c:v>393</c:v>
                </c:pt>
                <c:pt idx="14">
                  <c:v>394</c:v>
                </c:pt>
                <c:pt idx="15">
                  <c:v>395</c:v>
                </c:pt>
                <c:pt idx="16">
                  <c:v>396</c:v>
                </c:pt>
                <c:pt idx="17">
                  <c:v>397</c:v>
                </c:pt>
                <c:pt idx="18">
                  <c:v>398</c:v>
                </c:pt>
                <c:pt idx="19">
                  <c:v>399</c:v>
                </c:pt>
                <c:pt idx="20">
                  <c:v>400</c:v>
                </c:pt>
                <c:pt idx="21">
                  <c:v>401</c:v>
                </c:pt>
                <c:pt idx="22">
                  <c:v>402</c:v>
                </c:pt>
                <c:pt idx="23">
                  <c:v>403</c:v>
                </c:pt>
                <c:pt idx="24">
                  <c:v>404</c:v>
                </c:pt>
                <c:pt idx="25">
                  <c:v>405</c:v>
                </c:pt>
                <c:pt idx="26">
                  <c:v>406</c:v>
                </c:pt>
                <c:pt idx="27">
                  <c:v>407</c:v>
                </c:pt>
                <c:pt idx="28">
                  <c:v>408</c:v>
                </c:pt>
                <c:pt idx="29">
                  <c:v>409</c:v>
                </c:pt>
                <c:pt idx="30">
                  <c:v>410</c:v>
                </c:pt>
                <c:pt idx="31">
                  <c:v>411</c:v>
                </c:pt>
                <c:pt idx="32">
                  <c:v>412</c:v>
                </c:pt>
                <c:pt idx="33">
                  <c:v>413</c:v>
                </c:pt>
                <c:pt idx="34">
                  <c:v>414</c:v>
                </c:pt>
                <c:pt idx="35">
                  <c:v>415</c:v>
                </c:pt>
                <c:pt idx="36">
                  <c:v>416</c:v>
                </c:pt>
                <c:pt idx="37">
                  <c:v>417</c:v>
                </c:pt>
                <c:pt idx="38">
                  <c:v>418</c:v>
                </c:pt>
                <c:pt idx="39">
                  <c:v>419</c:v>
                </c:pt>
                <c:pt idx="40">
                  <c:v>420</c:v>
                </c:pt>
                <c:pt idx="41">
                  <c:v>421</c:v>
                </c:pt>
                <c:pt idx="42">
                  <c:v>422</c:v>
                </c:pt>
                <c:pt idx="43">
                  <c:v>423</c:v>
                </c:pt>
                <c:pt idx="44">
                  <c:v>424</c:v>
                </c:pt>
                <c:pt idx="45">
                  <c:v>425</c:v>
                </c:pt>
                <c:pt idx="46">
                  <c:v>426</c:v>
                </c:pt>
                <c:pt idx="47">
                  <c:v>427</c:v>
                </c:pt>
                <c:pt idx="48">
                  <c:v>428</c:v>
                </c:pt>
                <c:pt idx="49">
                  <c:v>429</c:v>
                </c:pt>
                <c:pt idx="50">
                  <c:v>430</c:v>
                </c:pt>
                <c:pt idx="51">
                  <c:v>431</c:v>
                </c:pt>
                <c:pt idx="52">
                  <c:v>432</c:v>
                </c:pt>
                <c:pt idx="53">
                  <c:v>433</c:v>
                </c:pt>
                <c:pt idx="54">
                  <c:v>434</c:v>
                </c:pt>
                <c:pt idx="55">
                  <c:v>435</c:v>
                </c:pt>
                <c:pt idx="56">
                  <c:v>436</c:v>
                </c:pt>
                <c:pt idx="57">
                  <c:v>437</c:v>
                </c:pt>
                <c:pt idx="58">
                  <c:v>438</c:v>
                </c:pt>
                <c:pt idx="59">
                  <c:v>439</c:v>
                </c:pt>
                <c:pt idx="60">
                  <c:v>440</c:v>
                </c:pt>
                <c:pt idx="61">
                  <c:v>441</c:v>
                </c:pt>
                <c:pt idx="62">
                  <c:v>442</c:v>
                </c:pt>
                <c:pt idx="63">
                  <c:v>443</c:v>
                </c:pt>
                <c:pt idx="64">
                  <c:v>444</c:v>
                </c:pt>
                <c:pt idx="65">
                  <c:v>445</c:v>
                </c:pt>
                <c:pt idx="66">
                  <c:v>446</c:v>
                </c:pt>
                <c:pt idx="67">
                  <c:v>447</c:v>
                </c:pt>
                <c:pt idx="68">
                  <c:v>448</c:v>
                </c:pt>
                <c:pt idx="69">
                  <c:v>449</c:v>
                </c:pt>
                <c:pt idx="70">
                  <c:v>450</c:v>
                </c:pt>
                <c:pt idx="71">
                  <c:v>451</c:v>
                </c:pt>
                <c:pt idx="72">
                  <c:v>452</c:v>
                </c:pt>
                <c:pt idx="73">
                  <c:v>453</c:v>
                </c:pt>
                <c:pt idx="74">
                  <c:v>454</c:v>
                </c:pt>
                <c:pt idx="75">
                  <c:v>455</c:v>
                </c:pt>
                <c:pt idx="76">
                  <c:v>456</c:v>
                </c:pt>
                <c:pt idx="77">
                  <c:v>457</c:v>
                </c:pt>
                <c:pt idx="78">
                  <c:v>458</c:v>
                </c:pt>
                <c:pt idx="79">
                  <c:v>459</c:v>
                </c:pt>
                <c:pt idx="80">
                  <c:v>460</c:v>
                </c:pt>
                <c:pt idx="81">
                  <c:v>461</c:v>
                </c:pt>
                <c:pt idx="82">
                  <c:v>462</c:v>
                </c:pt>
                <c:pt idx="83">
                  <c:v>463</c:v>
                </c:pt>
                <c:pt idx="84">
                  <c:v>464</c:v>
                </c:pt>
                <c:pt idx="85">
                  <c:v>465</c:v>
                </c:pt>
                <c:pt idx="86">
                  <c:v>466</c:v>
                </c:pt>
                <c:pt idx="87">
                  <c:v>467</c:v>
                </c:pt>
                <c:pt idx="88">
                  <c:v>468</c:v>
                </c:pt>
                <c:pt idx="89">
                  <c:v>469</c:v>
                </c:pt>
                <c:pt idx="90">
                  <c:v>470</c:v>
                </c:pt>
                <c:pt idx="91">
                  <c:v>471</c:v>
                </c:pt>
                <c:pt idx="92">
                  <c:v>472</c:v>
                </c:pt>
                <c:pt idx="93">
                  <c:v>473</c:v>
                </c:pt>
                <c:pt idx="94">
                  <c:v>474</c:v>
                </c:pt>
                <c:pt idx="95">
                  <c:v>475</c:v>
                </c:pt>
                <c:pt idx="96">
                  <c:v>476</c:v>
                </c:pt>
                <c:pt idx="97">
                  <c:v>477</c:v>
                </c:pt>
                <c:pt idx="98">
                  <c:v>478</c:v>
                </c:pt>
                <c:pt idx="99">
                  <c:v>479</c:v>
                </c:pt>
                <c:pt idx="100">
                  <c:v>480</c:v>
                </c:pt>
                <c:pt idx="101">
                  <c:v>481</c:v>
                </c:pt>
                <c:pt idx="102">
                  <c:v>482</c:v>
                </c:pt>
                <c:pt idx="103">
                  <c:v>483</c:v>
                </c:pt>
                <c:pt idx="104">
                  <c:v>484</c:v>
                </c:pt>
                <c:pt idx="105">
                  <c:v>485</c:v>
                </c:pt>
                <c:pt idx="106">
                  <c:v>486</c:v>
                </c:pt>
                <c:pt idx="107">
                  <c:v>487</c:v>
                </c:pt>
                <c:pt idx="108">
                  <c:v>488</c:v>
                </c:pt>
                <c:pt idx="109">
                  <c:v>489</c:v>
                </c:pt>
                <c:pt idx="110">
                  <c:v>490</c:v>
                </c:pt>
                <c:pt idx="111">
                  <c:v>491</c:v>
                </c:pt>
                <c:pt idx="112">
                  <c:v>492</c:v>
                </c:pt>
                <c:pt idx="113">
                  <c:v>493</c:v>
                </c:pt>
                <c:pt idx="114">
                  <c:v>494</c:v>
                </c:pt>
                <c:pt idx="115">
                  <c:v>495</c:v>
                </c:pt>
                <c:pt idx="116">
                  <c:v>496</c:v>
                </c:pt>
                <c:pt idx="117">
                  <c:v>497</c:v>
                </c:pt>
                <c:pt idx="118">
                  <c:v>498</c:v>
                </c:pt>
                <c:pt idx="119">
                  <c:v>499</c:v>
                </c:pt>
                <c:pt idx="120">
                  <c:v>500</c:v>
                </c:pt>
                <c:pt idx="121">
                  <c:v>501</c:v>
                </c:pt>
                <c:pt idx="122">
                  <c:v>502</c:v>
                </c:pt>
                <c:pt idx="123">
                  <c:v>503</c:v>
                </c:pt>
                <c:pt idx="124">
                  <c:v>504</c:v>
                </c:pt>
                <c:pt idx="125">
                  <c:v>505</c:v>
                </c:pt>
                <c:pt idx="126">
                  <c:v>506</c:v>
                </c:pt>
                <c:pt idx="127">
                  <c:v>507</c:v>
                </c:pt>
                <c:pt idx="128">
                  <c:v>508</c:v>
                </c:pt>
                <c:pt idx="129">
                  <c:v>509</c:v>
                </c:pt>
                <c:pt idx="130">
                  <c:v>510</c:v>
                </c:pt>
                <c:pt idx="131">
                  <c:v>511</c:v>
                </c:pt>
                <c:pt idx="132">
                  <c:v>512</c:v>
                </c:pt>
                <c:pt idx="133">
                  <c:v>513</c:v>
                </c:pt>
                <c:pt idx="134">
                  <c:v>514</c:v>
                </c:pt>
                <c:pt idx="135">
                  <c:v>515</c:v>
                </c:pt>
                <c:pt idx="136">
                  <c:v>516</c:v>
                </c:pt>
                <c:pt idx="137">
                  <c:v>517</c:v>
                </c:pt>
                <c:pt idx="138">
                  <c:v>518</c:v>
                </c:pt>
                <c:pt idx="139">
                  <c:v>519</c:v>
                </c:pt>
                <c:pt idx="140">
                  <c:v>520</c:v>
                </c:pt>
                <c:pt idx="141">
                  <c:v>521</c:v>
                </c:pt>
                <c:pt idx="142">
                  <c:v>522</c:v>
                </c:pt>
                <c:pt idx="143">
                  <c:v>523</c:v>
                </c:pt>
                <c:pt idx="144">
                  <c:v>524</c:v>
                </c:pt>
                <c:pt idx="145">
                  <c:v>525</c:v>
                </c:pt>
                <c:pt idx="146">
                  <c:v>526</c:v>
                </c:pt>
                <c:pt idx="147">
                  <c:v>527</c:v>
                </c:pt>
                <c:pt idx="148">
                  <c:v>528</c:v>
                </c:pt>
                <c:pt idx="149">
                  <c:v>529</c:v>
                </c:pt>
                <c:pt idx="150">
                  <c:v>530</c:v>
                </c:pt>
                <c:pt idx="151">
                  <c:v>531</c:v>
                </c:pt>
                <c:pt idx="152">
                  <c:v>532</c:v>
                </c:pt>
                <c:pt idx="153">
                  <c:v>533</c:v>
                </c:pt>
                <c:pt idx="154">
                  <c:v>534</c:v>
                </c:pt>
                <c:pt idx="155">
                  <c:v>535</c:v>
                </c:pt>
                <c:pt idx="156">
                  <c:v>536</c:v>
                </c:pt>
                <c:pt idx="157">
                  <c:v>537</c:v>
                </c:pt>
                <c:pt idx="158">
                  <c:v>538</c:v>
                </c:pt>
                <c:pt idx="159">
                  <c:v>539</c:v>
                </c:pt>
                <c:pt idx="160">
                  <c:v>540</c:v>
                </c:pt>
                <c:pt idx="161">
                  <c:v>541</c:v>
                </c:pt>
                <c:pt idx="162">
                  <c:v>542</c:v>
                </c:pt>
                <c:pt idx="163">
                  <c:v>543</c:v>
                </c:pt>
                <c:pt idx="164">
                  <c:v>544</c:v>
                </c:pt>
                <c:pt idx="165">
                  <c:v>545</c:v>
                </c:pt>
                <c:pt idx="166">
                  <c:v>546</c:v>
                </c:pt>
                <c:pt idx="167">
                  <c:v>547</c:v>
                </c:pt>
                <c:pt idx="168">
                  <c:v>548</c:v>
                </c:pt>
                <c:pt idx="169">
                  <c:v>549</c:v>
                </c:pt>
                <c:pt idx="170">
                  <c:v>550</c:v>
                </c:pt>
                <c:pt idx="171">
                  <c:v>551</c:v>
                </c:pt>
                <c:pt idx="172">
                  <c:v>552</c:v>
                </c:pt>
                <c:pt idx="173">
                  <c:v>553</c:v>
                </c:pt>
                <c:pt idx="174">
                  <c:v>554</c:v>
                </c:pt>
                <c:pt idx="175">
                  <c:v>555</c:v>
                </c:pt>
                <c:pt idx="176">
                  <c:v>556</c:v>
                </c:pt>
                <c:pt idx="177">
                  <c:v>557</c:v>
                </c:pt>
                <c:pt idx="178">
                  <c:v>558</c:v>
                </c:pt>
                <c:pt idx="179">
                  <c:v>559</c:v>
                </c:pt>
                <c:pt idx="180">
                  <c:v>560</c:v>
                </c:pt>
                <c:pt idx="181">
                  <c:v>561</c:v>
                </c:pt>
                <c:pt idx="182">
                  <c:v>562</c:v>
                </c:pt>
                <c:pt idx="183">
                  <c:v>563</c:v>
                </c:pt>
                <c:pt idx="184">
                  <c:v>564</c:v>
                </c:pt>
                <c:pt idx="185">
                  <c:v>565</c:v>
                </c:pt>
                <c:pt idx="186">
                  <c:v>566</c:v>
                </c:pt>
                <c:pt idx="187">
                  <c:v>567</c:v>
                </c:pt>
                <c:pt idx="188">
                  <c:v>568</c:v>
                </c:pt>
                <c:pt idx="189">
                  <c:v>569</c:v>
                </c:pt>
                <c:pt idx="190">
                  <c:v>570</c:v>
                </c:pt>
                <c:pt idx="191">
                  <c:v>571</c:v>
                </c:pt>
                <c:pt idx="192">
                  <c:v>572</c:v>
                </c:pt>
                <c:pt idx="193">
                  <c:v>573</c:v>
                </c:pt>
                <c:pt idx="194">
                  <c:v>574</c:v>
                </c:pt>
                <c:pt idx="195">
                  <c:v>575</c:v>
                </c:pt>
                <c:pt idx="196">
                  <c:v>576</c:v>
                </c:pt>
                <c:pt idx="197">
                  <c:v>577</c:v>
                </c:pt>
                <c:pt idx="198">
                  <c:v>578</c:v>
                </c:pt>
                <c:pt idx="199">
                  <c:v>579</c:v>
                </c:pt>
                <c:pt idx="200">
                  <c:v>580</c:v>
                </c:pt>
                <c:pt idx="201">
                  <c:v>581</c:v>
                </c:pt>
                <c:pt idx="202">
                  <c:v>582</c:v>
                </c:pt>
                <c:pt idx="203">
                  <c:v>583</c:v>
                </c:pt>
                <c:pt idx="204">
                  <c:v>584</c:v>
                </c:pt>
                <c:pt idx="205">
                  <c:v>585</c:v>
                </c:pt>
                <c:pt idx="206">
                  <c:v>586</c:v>
                </c:pt>
                <c:pt idx="207">
                  <c:v>587</c:v>
                </c:pt>
                <c:pt idx="208">
                  <c:v>588</c:v>
                </c:pt>
                <c:pt idx="209">
                  <c:v>589</c:v>
                </c:pt>
                <c:pt idx="210">
                  <c:v>590</c:v>
                </c:pt>
                <c:pt idx="211">
                  <c:v>591</c:v>
                </c:pt>
                <c:pt idx="212">
                  <c:v>592</c:v>
                </c:pt>
                <c:pt idx="213">
                  <c:v>593</c:v>
                </c:pt>
                <c:pt idx="214">
                  <c:v>594</c:v>
                </c:pt>
                <c:pt idx="215">
                  <c:v>595</c:v>
                </c:pt>
                <c:pt idx="216">
                  <c:v>596</c:v>
                </c:pt>
                <c:pt idx="217">
                  <c:v>597</c:v>
                </c:pt>
                <c:pt idx="218">
                  <c:v>598</c:v>
                </c:pt>
                <c:pt idx="219">
                  <c:v>599</c:v>
                </c:pt>
                <c:pt idx="220">
                  <c:v>600</c:v>
                </c:pt>
                <c:pt idx="221">
                  <c:v>601</c:v>
                </c:pt>
                <c:pt idx="222">
                  <c:v>602</c:v>
                </c:pt>
                <c:pt idx="223">
                  <c:v>603</c:v>
                </c:pt>
                <c:pt idx="224">
                  <c:v>604</c:v>
                </c:pt>
                <c:pt idx="225">
                  <c:v>605</c:v>
                </c:pt>
                <c:pt idx="226">
                  <c:v>606</c:v>
                </c:pt>
                <c:pt idx="227">
                  <c:v>607</c:v>
                </c:pt>
                <c:pt idx="228">
                  <c:v>608</c:v>
                </c:pt>
                <c:pt idx="229">
                  <c:v>609</c:v>
                </c:pt>
                <c:pt idx="230">
                  <c:v>610</c:v>
                </c:pt>
                <c:pt idx="231">
                  <c:v>611</c:v>
                </c:pt>
                <c:pt idx="232">
                  <c:v>612</c:v>
                </c:pt>
                <c:pt idx="233">
                  <c:v>613</c:v>
                </c:pt>
                <c:pt idx="234">
                  <c:v>614</c:v>
                </c:pt>
                <c:pt idx="235">
                  <c:v>615</c:v>
                </c:pt>
                <c:pt idx="236">
                  <c:v>616</c:v>
                </c:pt>
                <c:pt idx="237">
                  <c:v>617</c:v>
                </c:pt>
                <c:pt idx="238">
                  <c:v>618</c:v>
                </c:pt>
                <c:pt idx="239">
                  <c:v>619</c:v>
                </c:pt>
                <c:pt idx="240">
                  <c:v>620</c:v>
                </c:pt>
                <c:pt idx="241">
                  <c:v>621</c:v>
                </c:pt>
                <c:pt idx="242">
                  <c:v>622</c:v>
                </c:pt>
                <c:pt idx="243">
                  <c:v>623</c:v>
                </c:pt>
                <c:pt idx="244">
                  <c:v>624</c:v>
                </c:pt>
                <c:pt idx="245">
                  <c:v>625</c:v>
                </c:pt>
                <c:pt idx="246">
                  <c:v>626</c:v>
                </c:pt>
                <c:pt idx="247">
                  <c:v>627</c:v>
                </c:pt>
                <c:pt idx="248">
                  <c:v>628</c:v>
                </c:pt>
                <c:pt idx="249">
                  <c:v>629</c:v>
                </c:pt>
                <c:pt idx="250">
                  <c:v>630</c:v>
                </c:pt>
                <c:pt idx="251">
                  <c:v>631</c:v>
                </c:pt>
                <c:pt idx="252">
                  <c:v>632</c:v>
                </c:pt>
                <c:pt idx="253">
                  <c:v>633</c:v>
                </c:pt>
                <c:pt idx="254">
                  <c:v>634</c:v>
                </c:pt>
                <c:pt idx="255">
                  <c:v>635</c:v>
                </c:pt>
                <c:pt idx="256">
                  <c:v>636</c:v>
                </c:pt>
                <c:pt idx="257">
                  <c:v>637</c:v>
                </c:pt>
                <c:pt idx="258">
                  <c:v>638</c:v>
                </c:pt>
                <c:pt idx="259">
                  <c:v>639</c:v>
                </c:pt>
                <c:pt idx="260">
                  <c:v>640</c:v>
                </c:pt>
                <c:pt idx="261">
                  <c:v>641</c:v>
                </c:pt>
                <c:pt idx="262">
                  <c:v>642</c:v>
                </c:pt>
                <c:pt idx="263">
                  <c:v>643</c:v>
                </c:pt>
                <c:pt idx="264">
                  <c:v>644</c:v>
                </c:pt>
                <c:pt idx="265">
                  <c:v>645</c:v>
                </c:pt>
                <c:pt idx="266">
                  <c:v>646</c:v>
                </c:pt>
                <c:pt idx="267">
                  <c:v>647</c:v>
                </c:pt>
                <c:pt idx="268">
                  <c:v>648</c:v>
                </c:pt>
                <c:pt idx="269">
                  <c:v>649</c:v>
                </c:pt>
                <c:pt idx="270">
                  <c:v>650</c:v>
                </c:pt>
                <c:pt idx="271">
                  <c:v>651</c:v>
                </c:pt>
                <c:pt idx="272">
                  <c:v>652</c:v>
                </c:pt>
                <c:pt idx="273">
                  <c:v>653</c:v>
                </c:pt>
                <c:pt idx="274">
                  <c:v>654</c:v>
                </c:pt>
                <c:pt idx="275">
                  <c:v>655</c:v>
                </c:pt>
                <c:pt idx="276">
                  <c:v>656</c:v>
                </c:pt>
                <c:pt idx="277">
                  <c:v>657</c:v>
                </c:pt>
                <c:pt idx="278">
                  <c:v>658</c:v>
                </c:pt>
                <c:pt idx="279">
                  <c:v>659</c:v>
                </c:pt>
                <c:pt idx="280">
                  <c:v>660</c:v>
                </c:pt>
                <c:pt idx="281">
                  <c:v>661</c:v>
                </c:pt>
                <c:pt idx="282">
                  <c:v>662</c:v>
                </c:pt>
                <c:pt idx="283">
                  <c:v>663</c:v>
                </c:pt>
                <c:pt idx="284">
                  <c:v>664</c:v>
                </c:pt>
                <c:pt idx="285">
                  <c:v>665</c:v>
                </c:pt>
                <c:pt idx="286">
                  <c:v>666</c:v>
                </c:pt>
                <c:pt idx="287">
                  <c:v>667</c:v>
                </c:pt>
                <c:pt idx="288">
                  <c:v>668</c:v>
                </c:pt>
                <c:pt idx="289">
                  <c:v>669</c:v>
                </c:pt>
                <c:pt idx="290">
                  <c:v>670</c:v>
                </c:pt>
                <c:pt idx="291">
                  <c:v>671</c:v>
                </c:pt>
                <c:pt idx="292">
                  <c:v>672</c:v>
                </c:pt>
                <c:pt idx="293">
                  <c:v>673</c:v>
                </c:pt>
                <c:pt idx="294">
                  <c:v>674</c:v>
                </c:pt>
                <c:pt idx="295">
                  <c:v>675</c:v>
                </c:pt>
                <c:pt idx="296">
                  <c:v>676</c:v>
                </c:pt>
                <c:pt idx="297">
                  <c:v>677</c:v>
                </c:pt>
                <c:pt idx="298">
                  <c:v>678</c:v>
                </c:pt>
                <c:pt idx="299">
                  <c:v>679</c:v>
                </c:pt>
                <c:pt idx="300">
                  <c:v>680</c:v>
                </c:pt>
                <c:pt idx="301">
                  <c:v>681</c:v>
                </c:pt>
                <c:pt idx="302">
                  <c:v>682</c:v>
                </c:pt>
                <c:pt idx="303">
                  <c:v>683</c:v>
                </c:pt>
                <c:pt idx="304">
                  <c:v>684</c:v>
                </c:pt>
                <c:pt idx="305">
                  <c:v>685</c:v>
                </c:pt>
                <c:pt idx="306">
                  <c:v>686</c:v>
                </c:pt>
                <c:pt idx="307">
                  <c:v>687</c:v>
                </c:pt>
                <c:pt idx="308">
                  <c:v>688</c:v>
                </c:pt>
                <c:pt idx="309">
                  <c:v>689</c:v>
                </c:pt>
                <c:pt idx="310">
                  <c:v>690</c:v>
                </c:pt>
                <c:pt idx="311">
                  <c:v>691</c:v>
                </c:pt>
                <c:pt idx="312">
                  <c:v>692</c:v>
                </c:pt>
                <c:pt idx="313">
                  <c:v>693</c:v>
                </c:pt>
                <c:pt idx="314">
                  <c:v>694</c:v>
                </c:pt>
                <c:pt idx="315">
                  <c:v>695</c:v>
                </c:pt>
                <c:pt idx="316">
                  <c:v>696</c:v>
                </c:pt>
                <c:pt idx="317">
                  <c:v>697</c:v>
                </c:pt>
                <c:pt idx="318">
                  <c:v>698</c:v>
                </c:pt>
                <c:pt idx="319">
                  <c:v>699</c:v>
                </c:pt>
                <c:pt idx="320">
                  <c:v>700</c:v>
                </c:pt>
                <c:pt idx="321">
                  <c:v>701</c:v>
                </c:pt>
                <c:pt idx="322">
                  <c:v>702</c:v>
                </c:pt>
                <c:pt idx="323">
                  <c:v>703</c:v>
                </c:pt>
                <c:pt idx="324">
                  <c:v>704</c:v>
                </c:pt>
                <c:pt idx="325">
                  <c:v>705</c:v>
                </c:pt>
                <c:pt idx="326">
                  <c:v>706</c:v>
                </c:pt>
                <c:pt idx="327">
                  <c:v>707</c:v>
                </c:pt>
                <c:pt idx="328">
                  <c:v>708</c:v>
                </c:pt>
                <c:pt idx="329">
                  <c:v>709</c:v>
                </c:pt>
                <c:pt idx="330">
                  <c:v>710</c:v>
                </c:pt>
                <c:pt idx="331">
                  <c:v>711</c:v>
                </c:pt>
                <c:pt idx="332">
                  <c:v>712</c:v>
                </c:pt>
                <c:pt idx="333">
                  <c:v>713</c:v>
                </c:pt>
                <c:pt idx="334">
                  <c:v>714</c:v>
                </c:pt>
                <c:pt idx="335">
                  <c:v>715</c:v>
                </c:pt>
                <c:pt idx="336">
                  <c:v>716</c:v>
                </c:pt>
                <c:pt idx="337">
                  <c:v>717</c:v>
                </c:pt>
                <c:pt idx="338">
                  <c:v>718</c:v>
                </c:pt>
                <c:pt idx="339">
                  <c:v>719</c:v>
                </c:pt>
                <c:pt idx="340">
                  <c:v>720</c:v>
                </c:pt>
                <c:pt idx="341">
                  <c:v>721</c:v>
                </c:pt>
                <c:pt idx="342">
                  <c:v>722</c:v>
                </c:pt>
                <c:pt idx="343">
                  <c:v>723</c:v>
                </c:pt>
                <c:pt idx="344">
                  <c:v>724</c:v>
                </c:pt>
                <c:pt idx="345">
                  <c:v>725</c:v>
                </c:pt>
                <c:pt idx="346">
                  <c:v>726</c:v>
                </c:pt>
                <c:pt idx="347">
                  <c:v>727</c:v>
                </c:pt>
                <c:pt idx="348">
                  <c:v>728</c:v>
                </c:pt>
                <c:pt idx="349">
                  <c:v>729</c:v>
                </c:pt>
                <c:pt idx="350">
                  <c:v>730</c:v>
                </c:pt>
                <c:pt idx="351">
                  <c:v>731</c:v>
                </c:pt>
                <c:pt idx="352">
                  <c:v>732</c:v>
                </c:pt>
                <c:pt idx="353">
                  <c:v>733</c:v>
                </c:pt>
                <c:pt idx="354">
                  <c:v>734</c:v>
                </c:pt>
                <c:pt idx="355">
                  <c:v>735</c:v>
                </c:pt>
                <c:pt idx="356">
                  <c:v>736</c:v>
                </c:pt>
                <c:pt idx="357">
                  <c:v>737</c:v>
                </c:pt>
                <c:pt idx="358">
                  <c:v>738</c:v>
                </c:pt>
                <c:pt idx="359">
                  <c:v>739</c:v>
                </c:pt>
                <c:pt idx="360">
                  <c:v>740</c:v>
                </c:pt>
                <c:pt idx="361">
                  <c:v>741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6</c:v>
                </c:pt>
                <c:pt idx="367">
                  <c:v>747</c:v>
                </c:pt>
                <c:pt idx="368">
                  <c:v>748</c:v>
                </c:pt>
                <c:pt idx="369">
                  <c:v>749</c:v>
                </c:pt>
                <c:pt idx="370">
                  <c:v>750</c:v>
                </c:pt>
                <c:pt idx="371">
                  <c:v>751</c:v>
                </c:pt>
                <c:pt idx="372">
                  <c:v>752</c:v>
                </c:pt>
                <c:pt idx="373">
                  <c:v>753</c:v>
                </c:pt>
                <c:pt idx="374">
                  <c:v>754</c:v>
                </c:pt>
                <c:pt idx="375">
                  <c:v>755</c:v>
                </c:pt>
                <c:pt idx="376">
                  <c:v>756</c:v>
                </c:pt>
                <c:pt idx="377">
                  <c:v>757</c:v>
                </c:pt>
                <c:pt idx="378">
                  <c:v>758</c:v>
                </c:pt>
                <c:pt idx="379">
                  <c:v>759</c:v>
                </c:pt>
                <c:pt idx="380">
                  <c:v>760</c:v>
                </c:pt>
                <c:pt idx="381">
                  <c:v>761</c:v>
                </c:pt>
                <c:pt idx="382">
                  <c:v>762</c:v>
                </c:pt>
                <c:pt idx="383">
                  <c:v>763</c:v>
                </c:pt>
                <c:pt idx="384">
                  <c:v>764</c:v>
                </c:pt>
                <c:pt idx="385">
                  <c:v>765</c:v>
                </c:pt>
                <c:pt idx="386">
                  <c:v>766</c:v>
                </c:pt>
                <c:pt idx="387">
                  <c:v>767</c:v>
                </c:pt>
                <c:pt idx="388">
                  <c:v>768</c:v>
                </c:pt>
                <c:pt idx="389">
                  <c:v>769</c:v>
                </c:pt>
                <c:pt idx="390">
                  <c:v>770</c:v>
                </c:pt>
                <c:pt idx="391">
                  <c:v>771</c:v>
                </c:pt>
                <c:pt idx="392">
                  <c:v>772</c:v>
                </c:pt>
                <c:pt idx="393">
                  <c:v>773</c:v>
                </c:pt>
                <c:pt idx="394">
                  <c:v>774</c:v>
                </c:pt>
                <c:pt idx="395">
                  <c:v>775</c:v>
                </c:pt>
                <c:pt idx="396">
                  <c:v>776</c:v>
                </c:pt>
                <c:pt idx="397">
                  <c:v>777</c:v>
                </c:pt>
                <c:pt idx="398">
                  <c:v>778</c:v>
                </c:pt>
                <c:pt idx="399">
                  <c:v>779</c:v>
                </c:pt>
                <c:pt idx="400">
                  <c:v>780</c:v>
                </c:pt>
              </c:numCache>
            </c:numRef>
          </c:xVal>
          <c:yVal>
            <c:numRef>
              <c:f>Hoja2!$F$7:$F$407</c:f>
              <c:numCache>
                <c:formatCode>General</c:formatCode>
                <c:ptCount val="401"/>
                <c:pt idx="0">
                  <c:v>5.6519999999999999E-3</c:v>
                </c:pt>
                <c:pt idx="1">
                  <c:v>5.594E-3</c:v>
                </c:pt>
                <c:pt idx="2">
                  <c:v>5.6509999999999998E-3</c:v>
                </c:pt>
                <c:pt idx="3">
                  <c:v>5.352E-3</c:v>
                </c:pt>
                <c:pt idx="4">
                  <c:v>4.8799999999999998E-3</c:v>
                </c:pt>
                <c:pt idx="5">
                  <c:v>4.8219999999999999E-3</c:v>
                </c:pt>
                <c:pt idx="6">
                  <c:v>4.8640000000000003E-3</c:v>
                </c:pt>
                <c:pt idx="7">
                  <c:v>4.6499999999999996E-3</c:v>
                </c:pt>
                <c:pt idx="8">
                  <c:v>4.4320000000000002E-3</c:v>
                </c:pt>
                <c:pt idx="9">
                  <c:v>4.3730000000000002E-3</c:v>
                </c:pt>
                <c:pt idx="10">
                  <c:v>4.3210000000000002E-3</c:v>
                </c:pt>
                <c:pt idx="11">
                  <c:v>4.2950000000000002E-3</c:v>
                </c:pt>
                <c:pt idx="12">
                  <c:v>4.2779999999999997E-3</c:v>
                </c:pt>
                <c:pt idx="13">
                  <c:v>4.28E-3</c:v>
                </c:pt>
                <c:pt idx="14">
                  <c:v>4.2950000000000002E-3</c:v>
                </c:pt>
                <c:pt idx="15">
                  <c:v>4.3229999999999996E-3</c:v>
                </c:pt>
                <c:pt idx="16">
                  <c:v>4.1229999999999999E-3</c:v>
                </c:pt>
                <c:pt idx="17">
                  <c:v>3.7780000000000001E-3</c:v>
                </c:pt>
                <c:pt idx="18">
                  <c:v>3.8890000000000001E-3</c:v>
                </c:pt>
                <c:pt idx="19">
                  <c:v>4.1529999999999996E-3</c:v>
                </c:pt>
                <c:pt idx="20">
                  <c:v>3.9909999999999998E-3</c:v>
                </c:pt>
                <c:pt idx="21">
                  <c:v>3.7799999999999999E-3</c:v>
                </c:pt>
                <c:pt idx="22">
                  <c:v>3.9950000000000003E-3</c:v>
                </c:pt>
                <c:pt idx="23">
                  <c:v>4.1780000000000003E-3</c:v>
                </c:pt>
                <c:pt idx="24">
                  <c:v>4.1939999999999998E-3</c:v>
                </c:pt>
                <c:pt idx="25">
                  <c:v>4.2100000000000002E-3</c:v>
                </c:pt>
                <c:pt idx="26">
                  <c:v>4.2290000000000001E-3</c:v>
                </c:pt>
                <c:pt idx="27">
                  <c:v>4.1949999999999999E-3</c:v>
                </c:pt>
                <c:pt idx="28">
                  <c:v>4.0920000000000002E-3</c:v>
                </c:pt>
                <c:pt idx="29">
                  <c:v>3.9119999999999997E-3</c:v>
                </c:pt>
                <c:pt idx="30">
                  <c:v>3.6740000000000002E-3</c:v>
                </c:pt>
                <c:pt idx="31">
                  <c:v>3.6180000000000001E-3</c:v>
                </c:pt>
                <c:pt idx="32">
                  <c:v>3.6410000000000001E-3</c:v>
                </c:pt>
                <c:pt idx="33">
                  <c:v>3.7729999999999999E-3</c:v>
                </c:pt>
                <c:pt idx="34">
                  <c:v>3.9259999999999998E-3</c:v>
                </c:pt>
                <c:pt idx="35">
                  <c:v>4.0299999999999997E-3</c:v>
                </c:pt>
                <c:pt idx="36">
                  <c:v>4.15E-3</c:v>
                </c:pt>
                <c:pt idx="37">
                  <c:v>4.398E-3</c:v>
                </c:pt>
                <c:pt idx="38">
                  <c:v>4.6959999999999997E-3</c:v>
                </c:pt>
                <c:pt idx="39">
                  <c:v>5.1399999999999996E-3</c:v>
                </c:pt>
                <c:pt idx="40">
                  <c:v>5.6490000000000004E-3</c:v>
                </c:pt>
                <c:pt idx="41">
                  <c:v>6.2589999999999998E-3</c:v>
                </c:pt>
                <c:pt idx="42">
                  <c:v>6.7140000000000003E-3</c:v>
                </c:pt>
                <c:pt idx="43">
                  <c:v>7.0330000000000002E-3</c:v>
                </c:pt>
                <c:pt idx="44">
                  <c:v>7.8209999999999998E-3</c:v>
                </c:pt>
                <c:pt idx="45">
                  <c:v>8.8360000000000001E-3</c:v>
                </c:pt>
                <c:pt idx="46">
                  <c:v>9.9959999999999997E-3</c:v>
                </c:pt>
                <c:pt idx="47">
                  <c:v>1.1188E-2</c:v>
                </c:pt>
                <c:pt idx="48">
                  <c:v>1.2997999999999999E-2</c:v>
                </c:pt>
                <c:pt idx="49">
                  <c:v>1.4892000000000001E-2</c:v>
                </c:pt>
                <c:pt idx="50">
                  <c:v>1.7308E-2</c:v>
                </c:pt>
                <c:pt idx="51">
                  <c:v>1.9820999999999998E-2</c:v>
                </c:pt>
                <c:pt idx="52">
                  <c:v>2.2641999999999999E-2</c:v>
                </c:pt>
                <c:pt idx="53">
                  <c:v>2.5906999999999999E-2</c:v>
                </c:pt>
                <c:pt idx="54">
                  <c:v>2.9876E-2</c:v>
                </c:pt>
                <c:pt idx="55">
                  <c:v>3.4223000000000003E-2</c:v>
                </c:pt>
                <c:pt idx="56">
                  <c:v>3.8903E-2</c:v>
                </c:pt>
                <c:pt idx="57">
                  <c:v>4.4735999999999998E-2</c:v>
                </c:pt>
                <c:pt idx="58">
                  <c:v>5.1116000000000002E-2</c:v>
                </c:pt>
                <c:pt idx="59">
                  <c:v>5.8661999999999999E-2</c:v>
                </c:pt>
                <c:pt idx="60">
                  <c:v>6.6456000000000001E-2</c:v>
                </c:pt>
                <c:pt idx="61">
                  <c:v>7.6363E-2</c:v>
                </c:pt>
                <c:pt idx="62">
                  <c:v>8.6577000000000001E-2</c:v>
                </c:pt>
                <c:pt idx="63">
                  <c:v>9.8598000000000005E-2</c:v>
                </c:pt>
                <c:pt idx="64">
                  <c:v>0.111355</c:v>
                </c:pt>
                <c:pt idx="65">
                  <c:v>0.12612599999999999</c:v>
                </c:pt>
                <c:pt idx="66">
                  <c:v>0.14197699999999999</c:v>
                </c:pt>
                <c:pt idx="67">
                  <c:v>0.15934100000000001</c:v>
                </c:pt>
                <c:pt idx="68">
                  <c:v>0.178204</c:v>
                </c:pt>
                <c:pt idx="69">
                  <c:v>0.19821</c:v>
                </c:pt>
                <c:pt idx="70">
                  <c:v>0.219664</c:v>
                </c:pt>
                <c:pt idx="71">
                  <c:v>0.24169299999999999</c:v>
                </c:pt>
                <c:pt idx="72">
                  <c:v>0.26454299999999997</c:v>
                </c:pt>
                <c:pt idx="73">
                  <c:v>0.28750500000000001</c:v>
                </c:pt>
                <c:pt idx="74">
                  <c:v>0.30944300000000002</c:v>
                </c:pt>
                <c:pt idx="75">
                  <c:v>0.33089400000000002</c:v>
                </c:pt>
                <c:pt idx="76">
                  <c:v>0.349916</c:v>
                </c:pt>
                <c:pt idx="77">
                  <c:v>0.36724800000000002</c:v>
                </c:pt>
                <c:pt idx="78">
                  <c:v>0.38097799999999998</c:v>
                </c:pt>
                <c:pt idx="79">
                  <c:v>0.391679</c:v>
                </c:pt>
                <c:pt idx="80">
                  <c:v>0.39899899999999999</c:v>
                </c:pt>
                <c:pt idx="81">
                  <c:v>0.40187299999999998</c:v>
                </c:pt>
                <c:pt idx="82">
                  <c:v>0.40210099999999999</c:v>
                </c:pt>
                <c:pt idx="83">
                  <c:v>0.39646700000000001</c:v>
                </c:pt>
                <c:pt idx="84">
                  <c:v>0.38920100000000002</c:v>
                </c:pt>
                <c:pt idx="85">
                  <c:v>0.37587100000000001</c:v>
                </c:pt>
                <c:pt idx="86">
                  <c:v>0.361788</c:v>
                </c:pt>
                <c:pt idx="87">
                  <c:v>0.34435900000000003</c:v>
                </c:pt>
                <c:pt idx="88">
                  <c:v>0.326519</c:v>
                </c:pt>
                <c:pt idx="89">
                  <c:v>0.307479</c:v>
                </c:pt>
                <c:pt idx="90">
                  <c:v>0.28827599999999998</c:v>
                </c:pt>
                <c:pt idx="91">
                  <c:v>0.268843</c:v>
                </c:pt>
                <c:pt idx="92">
                  <c:v>0.25006499999999998</c:v>
                </c:pt>
                <c:pt idx="93">
                  <c:v>0.23177200000000001</c:v>
                </c:pt>
                <c:pt idx="94">
                  <c:v>0.21499599999999999</c:v>
                </c:pt>
                <c:pt idx="95">
                  <c:v>0.198766</c:v>
                </c:pt>
                <c:pt idx="96">
                  <c:v>0.18431700000000001</c:v>
                </c:pt>
                <c:pt idx="97">
                  <c:v>0.17018900000000001</c:v>
                </c:pt>
                <c:pt idx="98">
                  <c:v>0.157858</c:v>
                </c:pt>
                <c:pt idx="99">
                  <c:v>0.14582000000000001</c:v>
                </c:pt>
                <c:pt idx="100">
                  <c:v>0.13477500000000001</c:v>
                </c:pt>
                <c:pt idx="101">
                  <c:v>0.124352</c:v>
                </c:pt>
                <c:pt idx="102">
                  <c:v>0.114883</c:v>
                </c:pt>
                <c:pt idx="103">
                  <c:v>0.105869</c:v>
                </c:pt>
                <c:pt idx="104">
                  <c:v>9.7210000000000005E-2</c:v>
                </c:pt>
                <c:pt idx="105">
                  <c:v>8.9536000000000004E-2</c:v>
                </c:pt>
                <c:pt idx="106">
                  <c:v>8.2225999999999994E-2</c:v>
                </c:pt>
                <c:pt idx="107">
                  <c:v>7.5345999999999996E-2</c:v>
                </c:pt>
                <c:pt idx="108">
                  <c:v>6.8607000000000001E-2</c:v>
                </c:pt>
                <c:pt idx="109">
                  <c:v>6.3094999999999998E-2</c:v>
                </c:pt>
                <c:pt idx="110">
                  <c:v>5.7801999999999999E-2</c:v>
                </c:pt>
                <c:pt idx="111">
                  <c:v>5.3187999999999999E-2</c:v>
                </c:pt>
                <c:pt idx="112">
                  <c:v>4.8957000000000001E-2</c:v>
                </c:pt>
                <c:pt idx="113">
                  <c:v>4.5263999999999999E-2</c:v>
                </c:pt>
                <c:pt idx="114">
                  <c:v>4.1861000000000002E-2</c:v>
                </c:pt>
                <c:pt idx="115">
                  <c:v>3.8658999999999999E-2</c:v>
                </c:pt>
                <c:pt idx="116">
                  <c:v>3.5735999999999997E-2</c:v>
                </c:pt>
                <c:pt idx="117">
                  <c:v>3.2897000000000003E-2</c:v>
                </c:pt>
                <c:pt idx="118">
                  <c:v>3.0686000000000001E-2</c:v>
                </c:pt>
                <c:pt idx="119">
                  <c:v>2.8479000000000001E-2</c:v>
                </c:pt>
                <c:pt idx="120">
                  <c:v>2.6033000000000001E-2</c:v>
                </c:pt>
                <c:pt idx="121">
                  <c:v>2.376E-2</c:v>
                </c:pt>
                <c:pt idx="122">
                  <c:v>2.188E-2</c:v>
                </c:pt>
                <c:pt idx="123">
                  <c:v>2.0161999999999999E-2</c:v>
                </c:pt>
                <c:pt idx="124">
                  <c:v>1.8613999999999999E-2</c:v>
                </c:pt>
                <c:pt idx="125">
                  <c:v>1.7301E-2</c:v>
                </c:pt>
                <c:pt idx="126">
                  <c:v>1.6105000000000001E-2</c:v>
                </c:pt>
                <c:pt idx="127">
                  <c:v>1.4883E-2</c:v>
                </c:pt>
                <c:pt idx="128">
                  <c:v>1.3671000000000001E-2</c:v>
                </c:pt>
                <c:pt idx="129">
                  <c:v>1.2867999999999999E-2</c:v>
                </c:pt>
                <c:pt idx="130">
                  <c:v>1.2059E-2</c:v>
                </c:pt>
                <c:pt idx="131">
                  <c:v>1.1227000000000001E-2</c:v>
                </c:pt>
                <c:pt idx="132">
                  <c:v>1.0411999999999999E-2</c:v>
                </c:pt>
                <c:pt idx="133">
                  <c:v>9.6200000000000001E-3</c:v>
                </c:pt>
                <c:pt idx="134">
                  <c:v>9.0220000000000005E-3</c:v>
                </c:pt>
                <c:pt idx="135">
                  <c:v>8.5540000000000008E-3</c:v>
                </c:pt>
                <c:pt idx="136">
                  <c:v>8.1709999999999994E-3</c:v>
                </c:pt>
                <c:pt idx="137">
                  <c:v>7.8100000000000001E-3</c:v>
                </c:pt>
                <c:pt idx="138">
                  <c:v>7.4250000000000002E-3</c:v>
                </c:pt>
                <c:pt idx="139">
                  <c:v>7.0460000000000002E-3</c:v>
                </c:pt>
                <c:pt idx="140">
                  <c:v>6.692E-3</c:v>
                </c:pt>
                <c:pt idx="141">
                  <c:v>6.3769999999999999E-3</c:v>
                </c:pt>
                <c:pt idx="142">
                  <c:v>6.1279999999999998E-3</c:v>
                </c:pt>
                <c:pt idx="143">
                  <c:v>5.9300000000000004E-3</c:v>
                </c:pt>
                <c:pt idx="144">
                  <c:v>5.77E-3</c:v>
                </c:pt>
                <c:pt idx="145">
                  <c:v>5.4299999999999999E-3</c:v>
                </c:pt>
                <c:pt idx="146">
                  <c:v>5.0289999999999996E-3</c:v>
                </c:pt>
                <c:pt idx="147">
                  <c:v>4.8459999999999996E-3</c:v>
                </c:pt>
                <c:pt idx="148">
                  <c:v>4.6870000000000002E-3</c:v>
                </c:pt>
                <c:pt idx="149">
                  <c:v>4.5950000000000001E-3</c:v>
                </c:pt>
                <c:pt idx="150">
                  <c:v>4.5040000000000002E-3</c:v>
                </c:pt>
                <c:pt idx="151">
                  <c:v>4.4130000000000003E-3</c:v>
                </c:pt>
                <c:pt idx="152">
                  <c:v>4.3620000000000004E-3</c:v>
                </c:pt>
                <c:pt idx="153">
                  <c:v>4.3550000000000004E-3</c:v>
                </c:pt>
                <c:pt idx="154">
                  <c:v>4.3049999999999998E-3</c:v>
                </c:pt>
                <c:pt idx="155">
                  <c:v>4.235E-3</c:v>
                </c:pt>
                <c:pt idx="156">
                  <c:v>4.0689999999999997E-3</c:v>
                </c:pt>
                <c:pt idx="157">
                  <c:v>3.8899999999999998E-3</c:v>
                </c:pt>
                <c:pt idx="158">
                  <c:v>3.8180000000000002E-3</c:v>
                </c:pt>
                <c:pt idx="159">
                  <c:v>3.7550000000000001E-3</c:v>
                </c:pt>
                <c:pt idx="160">
                  <c:v>3.7230000000000002E-3</c:v>
                </c:pt>
                <c:pt idx="161">
                  <c:v>3.6389999999999999E-3</c:v>
                </c:pt>
                <c:pt idx="162">
                  <c:v>3.4849999999999998E-3</c:v>
                </c:pt>
                <c:pt idx="163">
                  <c:v>3.4629999999999999E-3</c:v>
                </c:pt>
                <c:pt idx="164">
                  <c:v>3.5209999999999998E-3</c:v>
                </c:pt>
                <c:pt idx="165">
                  <c:v>3.6189999999999998E-3</c:v>
                </c:pt>
                <c:pt idx="166">
                  <c:v>3.7260000000000001E-3</c:v>
                </c:pt>
                <c:pt idx="167">
                  <c:v>3.715E-3</c:v>
                </c:pt>
                <c:pt idx="168">
                  <c:v>3.6800000000000001E-3</c:v>
                </c:pt>
                <c:pt idx="169">
                  <c:v>3.5560000000000001E-3</c:v>
                </c:pt>
                <c:pt idx="170">
                  <c:v>3.4659999999999999E-3</c:v>
                </c:pt>
                <c:pt idx="171">
                  <c:v>3.4259999999999998E-3</c:v>
                </c:pt>
                <c:pt idx="172">
                  <c:v>3.4390000000000002E-3</c:v>
                </c:pt>
                <c:pt idx="173">
                  <c:v>3.4880000000000002E-3</c:v>
                </c:pt>
                <c:pt idx="174">
                  <c:v>3.5360000000000001E-3</c:v>
                </c:pt>
                <c:pt idx="175">
                  <c:v>3.5839999999999999E-3</c:v>
                </c:pt>
                <c:pt idx="176">
                  <c:v>3.6879999999999999E-3</c:v>
                </c:pt>
                <c:pt idx="177">
                  <c:v>3.8110000000000002E-3</c:v>
                </c:pt>
                <c:pt idx="178">
                  <c:v>3.9969999999999997E-3</c:v>
                </c:pt>
                <c:pt idx="179">
                  <c:v>4.1060000000000003E-3</c:v>
                </c:pt>
                <c:pt idx="180">
                  <c:v>4.1159999999999999E-3</c:v>
                </c:pt>
                <c:pt idx="181">
                  <c:v>4.1949999999999999E-3</c:v>
                </c:pt>
                <c:pt idx="182">
                  <c:v>4.313E-3</c:v>
                </c:pt>
                <c:pt idx="183">
                  <c:v>4.326E-3</c:v>
                </c:pt>
                <c:pt idx="184">
                  <c:v>4.3270000000000001E-3</c:v>
                </c:pt>
                <c:pt idx="185">
                  <c:v>4.4089999999999997E-3</c:v>
                </c:pt>
                <c:pt idx="186">
                  <c:v>4.555E-3</c:v>
                </c:pt>
                <c:pt idx="187">
                  <c:v>4.8570000000000002E-3</c:v>
                </c:pt>
                <c:pt idx="188">
                  <c:v>5.1180000000000002E-3</c:v>
                </c:pt>
                <c:pt idx="189">
                  <c:v>5.3359999999999996E-3</c:v>
                </c:pt>
                <c:pt idx="190">
                  <c:v>5.7229999999999998E-3</c:v>
                </c:pt>
                <c:pt idx="191">
                  <c:v>6.1739999999999998E-3</c:v>
                </c:pt>
                <c:pt idx="192">
                  <c:v>6.3749999999999996E-3</c:v>
                </c:pt>
                <c:pt idx="193">
                  <c:v>6.6290000000000003E-3</c:v>
                </c:pt>
                <c:pt idx="194">
                  <c:v>7.2189999999999997E-3</c:v>
                </c:pt>
                <c:pt idx="195">
                  <c:v>7.718E-3</c:v>
                </c:pt>
                <c:pt idx="196">
                  <c:v>8.0780000000000001E-3</c:v>
                </c:pt>
                <c:pt idx="197">
                  <c:v>8.6660000000000001E-3</c:v>
                </c:pt>
                <c:pt idx="198">
                  <c:v>9.3939999999999996E-3</c:v>
                </c:pt>
                <c:pt idx="199">
                  <c:v>1.0148000000000001E-2</c:v>
                </c:pt>
                <c:pt idx="200">
                  <c:v>1.0923E-2</c:v>
                </c:pt>
                <c:pt idx="201">
                  <c:v>1.1903E-2</c:v>
                </c:pt>
                <c:pt idx="202">
                  <c:v>1.3002E-2</c:v>
                </c:pt>
                <c:pt idx="203">
                  <c:v>1.4373E-2</c:v>
                </c:pt>
                <c:pt idx="204">
                  <c:v>1.5758000000000001E-2</c:v>
                </c:pt>
                <c:pt idx="205">
                  <c:v>1.7155E-2</c:v>
                </c:pt>
                <c:pt idx="206">
                  <c:v>1.8803E-2</c:v>
                </c:pt>
                <c:pt idx="207">
                  <c:v>2.0525000000000002E-2</c:v>
                </c:pt>
                <c:pt idx="208">
                  <c:v>2.2436999999999999E-2</c:v>
                </c:pt>
                <c:pt idx="209">
                  <c:v>2.4499E-2</c:v>
                </c:pt>
                <c:pt idx="210">
                  <c:v>2.7005000000000001E-2</c:v>
                </c:pt>
                <c:pt idx="211">
                  <c:v>2.9769E-2</c:v>
                </c:pt>
                <c:pt idx="212">
                  <c:v>3.2799000000000002E-2</c:v>
                </c:pt>
                <c:pt idx="213">
                  <c:v>3.6302000000000001E-2</c:v>
                </c:pt>
                <c:pt idx="214">
                  <c:v>3.9975999999999998E-2</c:v>
                </c:pt>
                <c:pt idx="215">
                  <c:v>4.4117000000000003E-2</c:v>
                </c:pt>
                <c:pt idx="216">
                  <c:v>4.8480000000000002E-2</c:v>
                </c:pt>
                <c:pt idx="217">
                  <c:v>5.3568999999999999E-2</c:v>
                </c:pt>
                <c:pt idx="218">
                  <c:v>5.9056999999999998E-2</c:v>
                </c:pt>
                <c:pt idx="219">
                  <c:v>6.4990000000000006E-2</c:v>
                </c:pt>
                <c:pt idx="220">
                  <c:v>7.1657999999999999E-2</c:v>
                </c:pt>
                <c:pt idx="221">
                  <c:v>7.8606999999999996E-2</c:v>
                </c:pt>
                <c:pt idx="222">
                  <c:v>8.7220000000000006E-2</c:v>
                </c:pt>
                <c:pt idx="223">
                  <c:v>9.6225000000000005E-2</c:v>
                </c:pt>
                <c:pt idx="224">
                  <c:v>0.10641100000000001</c:v>
                </c:pt>
                <c:pt idx="225">
                  <c:v>0.117692</c:v>
                </c:pt>
                <c:pt idx="226">
                  <c:v>0.130135</c:v>
                </c:pt>
                <c:pt idx="227">
                  <c:v>0.14433499999999999</c:v>
                </c:pt>
                <c:pt idx="228">
                  <c:v>0.15915099999999999</c:v>
                </c:pt>
                <c:pt idx="229">
                  <c:v>0.176786</c:v>
                </c:pt>
                <c:pt idx="230">
                  <c:v>0.195298</c:v>
                </c:pt>
                <c:pt idx="231">
                  <c:v>0.216249</c:v>
                </c:pt>
                <c:pt idx="232">
                  <c:v>0.23902200000000001</c:v>
                </c:pt>
                <c:pt idx="233">
                  <c:v>0.26342199999999999</c:v>
                </c:pt>
                <c:pt idx="234">
                  <c:v>0.29134599999999999</c:v>
                </c:pt>
                <c:pt idx="235">
                  <c:v>0.32049299999999997</c:v>
                </c:pt>
                <c:pt idx="236">
                  <c:v>0.35433900000000002</c:v>
                </c:pt>
                <c:pt idx="237">
                  <c:v>0.38979799999999998</c:v>
                </c:pt>
                <c:pt idx="238">
                  <c:v>0.42852899999999999</c:v>
                </c:pt>
                <c:pt idx="239">
                  <c:v>0.47047499999999998</c:v>
                </c:pt>
                <c:pt idx="240">
                  <c:v>0.51454800000000001</c:v>
                </c:pt>
                <c:pt idx="241">
                  <c:v>0.56385600000000002</c:v>
                </c:pt>
                <c:pt idx="242">
                  <c:v>0.61480599999999996</c:v>
                </c:pt>
                <c:pt idx="243">
                  <c:v>0.67081299999999999</c:v>
                </c:pt>
                <c:pt idx="244">
                  <c:v>0.72901199999999999</c:v>
                </c:pt>
                <c:pt idx="245">
                  <c:v>0.79014200000000001</c:v>
                </c:pt>
                <c:pt idx="246">
                  <c:v>0.85406599999999999</c:v>
                </c:pt>
                <c:pt idx="247">
                  <c:v>0.91914600000000002</c:v>
                </c:pt>
                <c:pt idx="248">
                  <c:v>0.94422600000000001</c:v>
                </c:pt>
                <c:pt idx="249">
                  <c:v>0.96252099999999996</c:v>
                </c:pt>
                <c:pt idx="250">
                  <c:v>0.96482000000000001</c:v>
                </c:pt>
                <c:pt idx="251">
                  <c:v>0.96778900000000001</c:v>
                </c:pt>
                <c:pt idx="252">
                  <c:v>0.97122399999999998</c:v>
                </c:pt>
                <c:pt idx="253">
                  <c:v>0.974329</c:v>
                </c:pt>
                <c:pt idx="254">
                  <c:v>0.97749699999999995</c:v>
                </c:pt>
                <c:pt idx="255">
                  <c:v>0.98103799999999997</c:v>
                </c:pt>
                <c:pt idx="256">
                  <c:v>0.98471500000000001</c:v>
                </c:pt>
                <c:pt idx="257">
                  <c:v>0.98851800000000001</c:v>
                </c:pt>
                <c:pt idx="258">
                  <c:v>0.99187800000000004</c:v>
                </c:pt>
                <c:pt idx="259">
                  <c:v>0.995363</c:v>
                </c:pt>
                <c:pt idx="260">
                  <c:v>1</c:v>
                </c:pt>
                <c:pt idx="261">
                  <c:v>0.98327500000000001</c:v>
                </c:pt>
                <c:pt idx="262">
                  <c:v>0.94279900000000005</c:v>
                </c:pt>
                <c:pt idx="263">
                  <c:v>0.85972499999999996</c:v>
                </c:pt>
                <c:pt idx="264">
                  <c:v>0.76592499999999997</c:v>
                </c:pt>
                <c:pt idx="265">
                  <c:v>0.67433100000000001</c:v>
                </c:pt>
                <c:pt idx="266">
                  <c:v>0.587086</c:v>
                </c:pt>
                <c:pt idx="267">
                  <c:v>0.50531400000000004</c:v>
                </c:pt>
                <c:pt idx="268">
                  <c:v>0.43405700000000003</c:v>
                </c:pt>
                <c:pt idx="269">
                  <c:v>0.36740099999999998</c:v>
                </c:pt>
                <c:pt idx="270">
                  <c:v>0.314002</c:v>
                </c:pt>
                <c:pt idx="271">
                  <c:v>0.265789</c:v>
                </c:pt>
                <c:pt idx="272">
                  <c:v>0.22442699999999999</c:v>
                </c:pt>
                <c:pt idx="273">
                  <c:v>0.19072600000000001</c:v>
                </c:pt>
                <c:pt idx="274">
                  <c:v>0.160132</c:v>
                </c:pt>
                <c:pt idx="275">
                  <c:v>0.13624700000000001</c:v>
                </c:pt>
                <c:pt idx="276">
                  <c:v>0.115039</c:v>
                </c:pt>
                <c:pt idx="277">
                  <c:v>9.7266000000000005E-2</c:v>
                </c:pt>
                <c:pt idx="278">
                  <c:v>8.2817000000000002E-2</c:v>
                </c:pt>
                <c:pt idx="279">
                  <c:v>6.9685999999999998E-2</c:v>
                </c:pt>
                <c:pt idx="280">
                  <c:v>5.9271999999999998E-2</c:v>
                </c:pt>
                <c:pt idx="281">
                  <c:v>5.0202999999999998E-2</c:v>
                </c:pt>
                <c:pt idx="282">
                  <c:v>4.2682999999999999E-2</c:v>
                </c:pt>
                <c:pt idx="283">
                  <c:v>3.6929999999999998E-2</c:v>
                </c:pt>
                <c:pt idx="284">
                  <c:v>3.1802999999999998E-2</c:v>
                </c:pt>
                <c:pt idx="285">
                  <c:v>2.7803000000000001E-2</c:v>
                </c:pt>
                <c:pt idx="286">
                  <c:v>2.4320999999999999E-2</c:v>
                </c:pt>
                <c:pt idx="287">
                  <c:v>2.1335E-2</c:v>
                </c:pt>
                <c:pt idx="288">
                  <c:v>1.8987E-2</c:v>
                </c:pt>
                <c:pt idx="289">
                  <c:v>1.6853E-2</c:v>
                </c:pt>
                <c:pt idx="290">
                  <c:v>1.5125E-2</c:v>
                </c:pt>
                <c:pt idx="291">
                  <c:v>1.3542E-2</c:v>
                </c:pt>
                <c:pt idx="292">
                  <c:v>1.2068000000000001E-2</c:v>
                </c:pt>
                <c:pt idx="293">
                  <c:v>1.0878000000000001E-2</c:v>
                </c:pt>
                <c:pt idx="294">
                  <c:v>9.861E-3</c:v>
                </c:pt>
                <c:pt idx="295">
                  <c:v>9.2049999999999996E-3</c:v>
                </c:pt>
                <c:pt idx="296">
                  <c:v>8.5749999999999993E-3</c:v>
                </c:pt>
                <c:pt idx="297">
                  <c:v>7.9559999999999995E-3</c:v>
                </c:pt>
                <c:pt idx="298">
                  <c:v>7.2420000000000002E-3</c:v>
                </c:pt>
                <c:pt idx="299">
                  <c:v>6.7609999999999996E-3</c:v>
                </c:pt>
                <c:pt idx="300">
                  <c:v>6.6319999999999999E-3</c:v>
                </c:pt>
                <c:pt idx="301">
                  <c:v>6.254E-3</c:v>
                </c:pt>
                <c:pt idx="302">
                  <c:v>5.7920000000000003E-3</c:v>
                </c:pt>
                <c:pt idx="303">
                  <c:v>5.2839999999999996E-3</c:v>
                </c:pt>
                <c:pt idx="304">
                  <c:v>4.8240000000000002E-3</c:v>
                </c:pt>
                <c:pt idx="305">
                  <c:v>4.4089999999999997E-3</c:v>
                </c:pt>
                <c:pt idx="306">
                  <c:v>4.4949999999999999E-3</c:v>
                </c:pt>
                <c:pt idx="307">
                  <c:v>4.5620000000000001E-3</c:v>
                </c:pt>
                <c:pt idx="308">
                  <c:v>4.424E-3</c:v>
                </c:pt>
                <c:pt idx="309">
                  <c:v>4.4429999999999999E-3</c:v>
                </c:pt>
                <c:pt idx="310">
                  <c:v>4.5339999999999998E-3</c:v>
                </c:pt>
                <c:pt idx="311">
                  <c:v>4.4349999999999997E-3</c:v>
                </c:pt>
                <c:pt idx="312">
                  <c:v>4.3410000000000002E-3</c:v>
                </c:pt>
                <c:pt idx="313">
                  <c:v>4.2529999999999998E-3</c:v>
                </c:pt>
                <c:pt idx="314">
                  <c:v>3.9709999999999997E-3</c:v>
                </c:pt>
                <c:pt idx="315">
                  <c:v>3.7060000000000001E-3</c:v>
                </c:pt>
                <c:pt idx="316">
                  <c:v>3.6610000000000002E-3</c:v>
                </c:pt>
                <c:pt idx="317">
                  <c:v>3.8110000000000002E-3</c:v>
                </c:pt>
                <c:pt idx="318">
                  <c:v>4.0850000000000001E-3</c:v>
                </c:pt>
                <c:pt idx="319">
                  <c:v>3.8800000000000002E-3</c:v>
                </c:pt>
                <c:pt idx="320">
                  <c:v>3.8059999999999999E-3</c:v>
                </c:pt>
                <c:pt idx="321">
                  <c:v>3.9259999999999998E-3</c:v>
                </c:pt>
                <c:pt idx="322">
                  <c:v>3.9269999999999999E-3</c:v>
                </c:pt>
                <c:pt idx="323">
                  <c:v>3.9170000000000003E-3</c:v>
                </c:pt>
                <c:pt idx="324">
                  <c:v>3.9719999999999998E-3</c:v>
                </c:pt>
                <c:pt idx="325">
                  <c:v>3.7390000000000001E-3</c:v>
                </c:pt>
                <c:pt idx="326">
                  <c:v>3.333E-3</c:v>
                </c:pt>
                <c:pt idx="327">
                  <c:v>3.336E-3</c:v>
                </c:pt>
                <c:pt idx="328">
                  <c:v>3.3760000000000001E-3</c:v>
                </c:pt>
                <c:pt idx="329">
                  <c:v>3.4650000000000002E-3</c:v>
                </c:pt>
                <c:pt idx="330">
                  <c:v>3.5270000000000002E-3</c:v>
                </c:pt>
                <c:pt idx="331">
                  <c:v>3.5799999999999998E-3</c:v>
                </c:pt>
                <c:pt idx="332">
                  <c:v>3.6189999999999998E-3</c:v>
                </c:pt>
                <c:pt idx="333">
                  <c:v>3.7200000000000002E-3</c:v>
                </c:pt>
                <c:pt idx="334">
                  <c:v>3.8709999999999999E-3</c:v>
                </c:pt>
                <c:pt idx="335">
                  <c:v>4.2009999999999999E-3</c:v>
                </c:pt>
                <c:pt idx="336">
                  <c:v>4.1190000000000003E-3</c:v>
                </c:pt>
                <c:pt idx="337">
                  <c:v>3.6679999999999998E-3</c:v>
                </c:pt>
                <c:pt idx="338">
                  <c:v>3.6310000000000001E-3</c:v>
                </c:pt>
                <c:pt idx="339">
                  <c:v>3.6219999999999998E-3</c:v>
                </c:pt>
                <c:pt idx="340">
                  <c:v>3.6259999999999999E-3</c:v>
                </c:pt>
                <c:pt idx="341">
                  <c:v>3.8E-3</c:v>
                </c:pt>
                <c:pt idx="342">
                  <c:v>4.0039999999999997E-3</c:v>
                </c:pt>
                <c:pt idx="343">
                  <c:v>4.1830000000000001E-3</c:v>
                </c:pt>
                <c:pt idx="344">
                  <c:v>3.9810000000000002E-3</c:v>
                </c:pt>
                <c:pt idx="345">
                  <c:v>3.6979999999999999E-3</c:v>
                </c:pt>
                <c:pt idx="346">
                  <c:v>4.0749999999999996E-3</c:v>
                </c:pt>
                <c:pt idx="347">
                  <c:v>4.0309999999999999E-3</c:v>
                </c:pt>
                <c:pt idx="348">
                  <c:v>3.6670000000000001E-3</c:v>
                </c:pt>
                <c:pt idx="349">
                  <c:v>3.6120000000000002E-3</c:v>
                </c:pt>
                <c:pt idx="350">
                  <c:v>3.6129999999999999E-3</c:v>
                </c:pt>
                <c:pt idx="351">
                  <c:v>3.6779999999999998E-3</c:v>
                </c:pt>
                <c:pt idx="352">
                  <c:v>3.8400000000000001E-3</c:v>
                </c:pt>
                <c:pt idx="353">
                  <c:v>4.052E-3</c:v>
                </c:pt>
                <c:pt idx="354">
                  <c:v>4.3359999999999996E-3</c:v>
                </c:pt>
                <c:pt idx="355">
                  <c:v>4.1590000000000004E-3</c:v>
                </c:pt>
                <c:pt idx="356">
                  <c:v>4.0350000000000004E-3</c:v>
                </c:pt>
                <c:pt idx="357">
                  <c:v>4.3290000000000004E-3</c:v>
                </c:pt>
                <c:pt idx="358">
                  <c:v>4.3559999999999996E-3</c:v>
                </c:pt>
                <c:pt idx="359">
                  <c:v>4.3200000000000001E-3</c:v>
                </c:pt>
                <c:pt idx="360">
                  <c:v>4.4279999999999996E-3</c:v>
                </c:pt>
                <c:pt idx="361">
                  <c:v>4.359E-3</c:v>
                </c:pt>
                <c:pt idx="362">
                  <c:v>4.2509999999999996E-3</c:v>
                </c:pt>
                <c:pt idx="363">
                  <c:v>4.4749999999999998E-3</c:v>
                </c:pt>
                <c:pt idx="364">
                  <c:v>4.718E-3</c:v>
                </c:pt>
                <c:pt idx="365">
                  <c:v>4.9940000000000002E-3</c:v>
                </c:pt>
                <c:pt idx="366">
                  <c:v>5.5180000000000003E-3</c:v>
                </c:pt>
                <c:pt idx="367">
                  <c:v>5.6090000000000003E-3</c:v>
                </c:pt>
                <c:pt idx="368">
                  <c:v>5.3530000000000001E-3</c:v>
                </c:pt>
                <c:pt idx="369">
                  <c:v>5.1130000000000004E-3</c:v>
                </c:pt>
                <c:pt idx="370">
                  <c:v>5.1149999999999998E-3</c:v>
                </c:pt>
                <c:pt idx="371">
                  <c:v>5.3420000000000004E-3</c:v>
                </c:pt>
                <c:pt idx="372">
                  <c:v>5.2709999999999996E-3</c:v>
                </c:pt>
                <c:pt idx="373">
                  <c:v>5.5820000000000002E-3</c:v>
                </c:pt>
                <c:pt idx="374">
                  <c:v>6.2839999999999997E-3</c:v>
                </c:pt>
                <c:pt idx="375">
                  <c:v>6.6220000000000003E-3</c:v>
                </c:pt>
                <c:pt idx="376">
                  <c:v>6.6470000000000001E-3</c:v>
                </c:pt>
                <c:pt idx="377">
                  <c:v>6.339E-3</c:v>
                </c:pt>
                <c:pt idx="378">
                  <c:v>6.8469999999999998E-3</c:v>
                </c:pt>
                <c:pt idx="379">
                  <c:v>6.7999999999999996E-3</c:v>
                </c:pt>
                <c:pt idx="380">
                  <c:v>6.123E-3</c:v>
                </c:pt>
                <c:pt idx="381">
                  <c:v>6.4469999999999996E-3</c:v>
                </c:pt>
                <c:pt idx="382">
                  <c:v>6.476E-3</c:v>
                </c:pt>
                <c:pt idx="383">
                  <c:v>6.1729999999999997E-3</c:v>
                </c:pt>
                <c:pt idx="384">
                  <c:v>6.8830000000000002E-3</c:v>
                </c:pt>
                <c:pt idx="385">
                  <c:v>7.2290000000000002E-3</c:v>
                </c:pt>
                <c:pt idx="386">
                  <c:v>7.2170000000000003E-3</c:v>
                </c:pt>
                <c:pt idx="387">
                  <c:v>7.0809999999999996E-3</c:v>
                </c:pt>
                <c:pt idx="388">
                  <c:v>7.2110000000000004E-3</c:v>
                </c:pt>
                <c:pt idx="389">
                  <c:v>7.4700000000000001E-3</c:v>
                </c:pt>
                <c:pt idx="390">
                  <c:v>6.3860000000000002E-3</c:v>
                </c:pt>
                <c:pt idx="391">
                  <c:v>5.8269999999999997E-3</c:v>
                </c:pt>
                <c:pt idx="392">
                  <c:v>5.7250000000000001E-3</c:v>
                </c:pt>
                <c:pt idx="393">
                  <c:v>6.3080000000000002E-3</c:v>
                </c:pt>
                <c:pt idx="394">
                  <c:v>6.7320000000000001E-3</c:v>
                </c:pt>
                <c:pt idx="395">
                  <c:v>7.0530000000000002E-3</c:v>
                </c:pt>
                <c:pt idx="396">
                  <c:v>7.2969999999999997E-3</c:v>
                </c:pt>
                <c:pt idx="397">
                  <c:v>7.5750000000000001E-3</c:v>
                </c:pt>
                <c:pt idx="398">
                  <c:v>7.7580000000000001E-3</c:v>
                </c:pt>
                <c:pt idx="399">
                  <c:v>7.6350000000000003E-3</c:v>
                </c:pt>
                <c:pt idx="400">
                  <c:v>7.1339999999999997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B75-4FFB-BCC9-87EE1299DA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9757391"/>
        <c:axId val="849754895"/>
      </c:scatterChart>
      <c:valAx>
        <c:axId val="849757391"/>
        <c:scaling>
          <c:orientation val="minMax"/>
          <c:max val="780"/>
          <c:min val="3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Wavelength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4895"/>
        <c:crosses val="autoZero"/>
        <c:crossBetween val="midCat"/>
      </c:valAx>
      <c:valAx>
        <c:axId val="849754895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0" i="0" baseline="0" dirty="0" err="1">
                    <a:effectLst/>
                  </a:rPr>
                  <a:t>Relativ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spectral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irradianc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composition</a:t>
                </a:r>
                <a:endParaRPr lang="es-ES" sz="10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>
                    <a:solidFill>
                      <a:prstClr val="black">
                        <a:lumMod val="65000"/>
                        <a:lumOff val="35000"/>
                      </a:prstClr>
                    </a:solidFill>
                  </a:defRPr>
                </a:pPr>
                <a:endParaRPr lang="es-ES" sz="10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7391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>
                <a:solidFill>
                  <a:schemeClr val="tx1"/>
                </a:solidFill>
              </a:rPr>
              <a:t>TFL-137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Hoja2!$A$7:$A$407</c:f>
              <c:numCache>
                <c:formatCode>General</c:formatCode>
                <c:ptCount val="401"/>
                <c:pt idx="0">
                  <c:v>380</c:v>
                </c:pt>
                <c:pt idx="1">
                  <c:v>381</c:v>
                </c:pt>
                <c:pt idx="2">
                  <c:v>382</c:v>
                </c:pt>
                <c:pt idx="3">
                  <c:v>383</c:v>
                </c:pt>
                <c:pt idx="4">
                  <c:v>384</c:v>
                </c:pt>
                <c:pt idx="5">
                  <c:v>385</c:v>
                </c:pt>
                <c:pt idx="6">
                  <c:v>386</c:v>
                </c:pt>
                <c:pt idx="7">
                  <c:v>387</c:v>
                </c:pt>
                <c:pt idx="8">
                  <c:v>388</c:v>
                </c:pt>
                <c:pt idx="9">
                  <c:v>389</c:v>
                </c:pt>
                <c:pt idx="10">
                  <c:v>390</c:v>
                </c:pt>
                <c:pt idx="11">
                  <c:v>391</c:v>
                </c:pt>
                <c:pt idx="12">
                  <c:v>392</c:v>
                </c:pt>
                <c:pt idx="13">
                  <c:v>393</c:v>
                </c:pt>
                <c:pt idx="14">
                  <c:v>394</c:v>
                </c:pt>
                <c:pt idx="15">
                  <c:v>395</c:v>
                </c:pt>
                <c:pt idx="16">
                  <c:v>396</c:v>
                </c:pt>
                <c:pt idx="17">
                  <c:v>397</c:v>
                </c:pt>
                <c:pt idx="18">
                  <c:v>398</c:v>
                </c:pt>
                <c:pt idx="19">
                  <c:v>399</c:v>
                </c:pt>
                <c:pt idx="20">
                  <c:v>400</c:v>
                </c:pt>
                <c:pt idx="21">
                  <c:v>401</c:v>
                </c:pt>
                <c:pt idx="22">
                  <c:v>402</c:v>
                </c:pt>
                <c:pt idx="23">
                  <c:v>403</c:v>
                </c:pt>
                <c:pt idx="24">
                  <c:v>404</c:v>
                </c:pt>
                <c:pt idx="25">
                  <c:v>405</c:v>
                </c:pt>
                <c:pt idx="26">
                  <c:v>406</c:v>
                </c:pt>
                <c:pt idx="27">
                  <c:v>407</c:v>
                </c:pt>
                <c:pt idx="28">
                  <c:v>408</c:v>
                </c:pt>
                <c:pt idx="29">
                  <c:v>409</c:v>
                </c:pt>
                <c:pt idx="30">
                  <c:v>410</c:v>
                </c:pt>
                <c:pt idx="31">
                  <c:v>411</c:v>
                </c:pt>
                <c:pt idx="32">
                  <c:v>412</c:v>
                </c:pt>
                <c:pt idx="33">
                  <c:v>413</c:v>
                </c:pt>
                <c:pt idx="34">
                  <c:v>414</c:v>
                </c:pt>
                <c:pt idx="35">
                  <c:v>415</c:v>
                </c:pt>
                <c:pt idx="36">
                  <c:v>416</c:v>
                </c:pt>
                <c:pt idx="37">
                  <c:v>417</c:v>
                </c:pt>
                <c:pt idx="38">
                  <c:v>418</c:v>
                </c:pt>
                <c:pt idx="39">
                  <c:v>419</c:v>
                </c:pt>
                <c:pt idx="40">
                  <c:v>420</c:v>
                </c:pt>
                <c:pt idx="41">
                  <c:v>421</c:v>
                </c:pt>
                <c:pt idx="42">
                  <c:v>422</c:v>
                </c:pt>
                <c:pt idx="43">
                  <c:v>423</c:v>
                </c:pt>
                <c:pt idx="44">
                  <c:v>424</c:v>
                </c:pt>
                <c:pt idx="45">
                  <c:v>425</c:v>
                </c:pt>
                <c:pt idx="46">
                  <c:v>426</c:v>
                </c:pt>
                <c:pt idx="47">
                  <c:v>427</c:v>
                </c:pt>
                <c:pt idx="48">
                  <c:v>428</c:v>
                </c:pt>
                <c:pt idx="49">
                  <c:v>429</c:v>
                </c:pt>
                <c:pt idx="50">
                  <c:v>430</c:v>
                </c:pt>
                <c:pt idx="51">
                  <c:v>431</c:v>
                </c:pt>
                <c:pt idx="52">
                  <c:v>432</c:v>
                </c:pt>
                <c:pt idx="53">
                  <c:v>433</c:v>
                </c:pt>
                <c:pt idx="54">
                  <c:v>434</c:v>
                </c:pt>
                <c:pt idx="55">
                  <c:v>435</c:v>
                </c:pt>
                <c:pt idx="56">
                  <c:v>436</c:v>
                </c:pt>
                <c:pt idx="57">
                  <c:v>437</c:v>
                </c:pt>
                <c:pt idx="58">
                  <c:v>438</c:v>
                </c:pt>
                <c:pt idx="59">
                  <c:v>439</c:v>
                </c:pt>
                <c:pt idx="60">
                  <c:v>440</c:v>
                </c:pt>
                <c:pt idx="61">
                  <c:v>441</c:v>
                </c:pt>
                <c:pt idx="62">
                  <c:v>442</c:v>
                </c:pt>
                <c:pt idx="63">
                  <c:v>443</c:v>
                </c:pt>
                <c:pt idx="64">
                  <c:v>444</c:v>
                </c:pt>
                <c:pt idx="65">
                  <c:v>445</c:v>
                </c:pt>
                <c:pt idx="66">
                  <c:v>446</c:v>
                </c:pt>
                <c:pt idx="67">
                  <c:v>447</c:v>
                </c:pt>
                <c:pt idx="68">
                  <c:v>448</c:v>
                </c:pt>
                <c:pt idx="69">
                  <c:v>449</c:v>
                </c:pt>
                <c:pt idx="70">
                  <c:v>450</c:v>
                </c:pt>
                <c:pt idx="71">
                  <c:v>451</c:v>
                </c:pt>
                <c:pt idx="72">
                  <c:v>452</c:v>
                </c:pt>
                <c:pt idx="73">
                  <c:v>453</c:v>
                </c:pt>
                <c:pt idx="74">
                  <c:v>454</c:v>
                </c:pt>
                <c:pt idx="75">
                  <c:v>455</c:v>
                </c:pt>
                <c:pt idx="76">
                  <c:v>456</c:v>
                </c:pt>
                <c:pt idx="77">
                  <c:v>457</c:v>
                </c:pt>
                <c:pt idx="78">
                  <c:v>458</c:v>
                </c:pt>
                <c:pt idx="79">
                  <c:v>459</c:v>
                </c:pt>
                <c:pt idx="80">
                  <c:v>460</c:v>
                </c:pt>
                <c:pt idx="81">
                  <c:v>461</c:v>
                </c:pt>
                <c:pt idx="82">
                  <c:v>462</c:v>
                </c:pt>
                <c:pt idx="83">
                  <c:v>463</c:v>
                </c:pt>
                <c:pt idx="84">
                  <c:v>464</c:v>
                </c:pt>
                <c:pt idx="85">
                  <c:v>465</c:v>
                </c:pt>
                <c:pt idx="86">
                  <c:v>466</c:v>
                </c:pt>
                <c:pt idx="87">
                  <c:v>467</c:v>
                </c:pt>
                <c:pt idx="88">
                  <c:v>468</c:v>
                </c:pt>
                <c:pt idx="89">
                  <c:v>469</c:v>
                </c:pt>
                <c:pt idx="90">
                  <c:v>470</c:v>
                </c:pt>
                <c:pt idx="91">
                  <c:v>471</c:v>
                </c:pt>
                <c:pt idx="92">
                  <c:v>472</c:v>
                </c:pt>
                <c:pt idx="93">
                  <c:v>473</c:v>
                </c:pt>
                <c:pt idx="94">
                  <c:v>474</c:v>
                </c:pt>
                <c:pt idx="95">
                  <c:v>475</c:v>
                </c:pt>
                <c:pt idx="96">
                  <c:v>476</c:v>
                </c:pt>
                <c:pt idx="97">
                  <c:v>477</c:v>
                </c:pt>
                <c:pt idx="98">
                  <c:v>478</c:v>
                </c:pt>
                <c:pt idx="99">
                  <c:v>479</c:v>
                </c:pt>
                <c:pt idx="100">
                  <c:v>480</c:v>
                </c:pt>
                <c:pt idx="101">
                  <c:v>481</c:v>
                </c:pt>
                <c:pt idx="102">
                  <c:v>482</c:v>
                </c:pt>
                <c:pt idx="103">
                  <c:v>483</c:v>
                </c:pt>
                <c:pt idx="104">
                  <c:v>484</c:v>
                </c:pt>
                <c:pt idx="105">
                  <c:v>485</c:v>
                </c:pt>
                <c:pt idx="106">
                  <c:v>486</c:v>
                </c:pt>
                <c:pt idx="107">
                  <c:v>487</c:v>
                </c:pt>
                <c:pt idx="108">
                  <c:v>488</c:v>
                </c:pt>
                <c:pt idx="109">
                  <c:v>489</c:v>
                </c:pt>
                <c:pt idx="110">
                  <c:v>490</c:v>
                </c:pt>
                <c:pt idx="111">
                  <c:v>491</c:v>
                </c:pt>
                <c:pt idx="112">
                  <c:v>492</c:v>
                </c:pt>
                <c:pt idx="113">
                  <c:v>493</c:v>
                </c:pt>
                <c:pt idx="114">
                  <c:v>494</c:v>
                </c:pt>
                <c:pt idx="115">
                  <c:v>495</c:v>
                </c:pt>
                <c:pt idx="116">
                  <c:v>496</c:v>
                </c:pt>
                <c:pt idx="117">
                  <c:v>497</c:v>
                </c:pt>
                <c:pt idx="118">
                  <c:v>498</c:v>
                </c:pt>
                <c:pt idx="119">
                  <c:v>499</c:v>
                </c:pt>
                <c:pt idx="120">
                  <c:v>500</c:v>
                </c:pt>
                <c:pt idx="121">
                  <c:v>501</c:v>
                </c:pt>
                <c:pt idx="122">
                  <c:v>502</c:v>
                </c:pt>
                <c:pt idx="123">
                  <c:v>503</c:v>
                </c:pt>
                <c:pt idx="124">
                  <c:v>504</c:v>
                </c:pt>
                <c:pt idx="125">
                  <c:v>505</c:v>
                </c:pt>
                <c:pt idx="126">
                  <c:v>506</c:v>
                </c:pt>
                <c:pt idx="127">
                  <c:v>507</c:v>
                </c:pt>
                <c:pt idx="128">
                  <c:v>508</c:v>
                </c:pt>
                <c:pt idx="129">
                  <c:v>509</c:v>
                </c:pt>
                <c:pt idx="130">
                  <c:v>510</c:v>
                </c:pt>
                <c:pt idx="131">
                  <c:v>511</c:v>
                </c:pt>
                <c:pt idx="132">
                  <c:v>512</c:v>
                </c:pt>
                <c:pt idx="133">
                  <c:v>513</c:v>
                </c:pt>
                <c:pt idx="134">
                  <c:v>514</c:v>
                </c:pt>
                <c:pt idx="135">
                  <c:v>515</c:v>
                </c:pt>
                <c:pt idx="136">
                  <c:v>516</c:v>
                </c:pt>
                <c:pt idx="137">
                  <c:v>517</c:v>
                </c:pt>
                <c:pt idx="138">
                  <c:v>518</c:v>
                </c:pt>
                <c:pt idx="139">
                  <c:v>519</c:v>
                </c:pt>
                <c:pt idx="140">
                  <c:v>520</c:v>
                </c:pt>
                <c:pt idx="141">
                  <c:v>521</c:v>
                </c:pt>
                <c:pt idx="142">
                  <c:v>522</c:v>
                </c:pt>
                <c:pt idx="143">
                  <c:v>523</c:v>
                </c:pt>
                <c:pt idx="144">
                  <c:v>524</c:v>
                </c:pt>
                <c:pt idx="145">
                  <c:v>525</c:v>
                </c:pt>
                <c:pt idx="146">
                  <c:v>526</c:v>
                </c:pt>
                <c:pt idx="147">
                  <c:v>527</c:v>
                </c:pt>
                <c:pt idx="148">
                  <c:v>528</c:v>
                </c:pt>
                <c:pt idx="149">
                  <c:v>529</c:v>
                </c:pt>
                <c:pt idx="150">
                  <c:v>530</c:v>
                </c:pt>
                <c:pt idx="151">
                  <c:v>531</c:v>
                </c:pt>
                <c:pt idx="152">
                  <c:v>532</c:v>
                </c:pt>
                <c:pt idx="153">
                  <c:v>533</c:v>
                </c:pt>
                <c:pt idx="154">
                  <c:v>534</c:v>
                </c:pt>
                <c:pt idx="155">
                  <c:v>535</c:v>
                </c:pt>
                <c:pt idx="156">
                  <c:v>536</c:v>
                </c:pt>
                <c:pt idx="157">
                  <c:v>537</c:v>
                </c:pt>
                <c:pt idx="158">
                  <c:v>538</c:v>
                </c:pt>
                <c:pt idx="159">
                  <c:v>539</c:v>
                </c:pt>
                <c:pt idx="160">
                  <c:v>540</c:v>
                </c:pt>
                <c:pt idx="161">
                  <c:v>541</c:v>
                </c:pt>
                <c:pt idx="162">
                  <c:v>542</c:v>
                </c:pt>
                <c:pt idx="163">
                  <c:v>543</c:v>
                </c:pt>
                <c:pt idx="164">
                  <c:v>544</c:v>
                </c:pt>
                <c:pt idx="165">
                  <c:v>545</c:v>
                </c:pt>
                <c:pt idx="166">
                  <c:v>546</c:v>
                </c:pt>
                <c:pt idx="167">
                  <c:v>547</c:v>
                </c:pt>
                <c:pt idx="168">
                  <c:v>548</c:v>
                </c:pt>
                <c:pt idx="169">
                  <c:v>549</c:v>
                </c:pt>
                <c:pt idx="170">
                  <c:v>550</c:v>
                </c:pt>
                <c:pt idx="171">
                  <c:v>551</c:v>
                </c:pt>
                <c:pt idx="172">
                  <c:v>552</c:v>
                </c:pt>
                <c:pt idx="173">
                  <c:v>553</c:v>
                </c:pt>
                <c:pt idx="174">
                  <c:v>554</c:v>
                </c:pt>
                <c:pt idx="175">
                  <c:v>555</c:v>
                </c:pt>
                <c:pt idx="176">
                  <c:v>556</c:v>
                </c:pt>
                <c:pt idx="177">
                  <c:v>557</c:v>
                </c:pt>
                <c:pt idx="178">
                  <c:v>558</c:v>
                </c:pt>
                <c:pt idx="179">
                  <c:v>559</c:v>
                </c:pt>
                <c:pt idx="180">
                  <c:v>560</c:v>
                </c:pt>
                <c:pt idx="181">
                  <c:v>561</c:v>
                </c:pt>
                <c:pt idx="182">
                  <c:v>562</c:v>
                </c:pt>
                <c:pt idx="183">
                  <c:v>563</c:v>
                </c:pt>
                <c:pt idx="184">
                  <c:v>564</c:v>
                </c:pt>
                <c:pt idx="185">
                  <c:v>565</c:v>
                </c:pt>
                <c:pt idx="186">
                  <c:v>566</c:v>
                </c:pt>
                <c:pt idx="187">
                  <c:v>567</c:v>
                </c:pt>
                <c:pt idx="188">
                  <c:v>568</c:v>
                </c:pt>
                <c:pt idx="189">
                  <c:v>569</c:v>
                </c:pt>
                <c:pt idx="190">
                  <c:v>570</c:v>
                </c:pt>
                <c:pt idx="191">
                  <c:v>571</c:v>
                </c:pt>
                <c:pt idx="192">
                  <c:v>572</c:v>
                </c:pt>
                <c:pt idx="193">
                  <c:v>573</c:v>
                </c:pt>
                <c:pt idx="194">
                  <c:v>574</c:v>
                </c:pt>
                <c:pt idx="195">
                  <c:v>575</c:v>
                </c:pt>
                <c:pt idx="196">
                  <c:v>576</c:v>
                </c:pt>
                <c:pt idx="197">
                  <c:v>577</c:v>
                </c:pt>
                <c:pt idx="198">
                  <c:v>578</c:v>
                </c:pt>
                <c:pt idx="199">
                  <c:v>579</c:v>
                </c:pt>
                <c:pt idx="200">
                  <c:v>580</c:v>
                </c:pt>
                <c:pt idx="201">
                  <c:v>581</c:v>
                </c:pt>
                <c:pt idx="202">
                  <c:v>582</c:v>
                </c:pt>
                <c:pt idx="203">
                  <c:v>583</c:v>
                </c:pt>
                <c:pt idx="204">
                  <c:v>584</c:v>
                </c:pt>
                <c:pt idx="205">
                  <c:v>585</c:v>
                </c:pt>
                <c:pt idx="206">
                  <c:v>586</c:v>
                </c:pt>
                <c:pt idx="207">
                  <c:v>587</c:v>
                </c:pt>
                <c:pt idx="208">
                  <c:v>588</c:v>
                </c:pt>
                <c:pt idx="209">
                  <c:v>589</c:v>
                </c:pt>
                <c:pt idx="210">
                  <c:v>590</c:v>
                </c:pt>
                <c:pt idx="211">
                  <c:v>591</c:v>
                </c:pt>
                <c:pt idx="212">
                  <c:v>592</c:v>
                </c:pt>
                <c:pt idx="213">
                  <c:v>593</c:v>
                </c:pt>
                <c:pt idx="214">
                  <c:v>594</c:v>
                </c:pt>
                <c:pt idx="215">
                  <c:v>595</c:v>
                </c:pt>
                <c:pt idx="216">
                  <c:v>596</c:v>
                </c:pt>
                <c:pt idx="217">
                  <c:v>597</c:v>
                </c:pt>
                <c:pt idx="218">
                  <c:v>598</c:v>
                </c:pt>
                <c:pt idx="219">
                  <c:v>599</c:v>
                </c:pt>
                <c:pt idx="220">
                  <c:v>600</c:v>
                </c:pt>
                <c:pt idx="221">
                  <c:v>601</c:v>
                </c:pt>
                <c:pt idx="222">
                  <c:v>602</c:v>
                </c:pt>
                <c:pt idx="223">
                  <c:v>603</c:v>
                </c:pt>
                <c:pt idx="224">
                  <c:v>604</c:v>
                </c:pt>
                <c:pt idx="225">
                  <c:v>605</c:v>
                </c:pt>
                <c:pt idx="226">
                  <c:v>606</c:v>
                </c:pt>
                <c:pt idx="227">
                  <c:v>607</c:v>
                </c:pt>
                <c:pt idx="228">
                  <c:v>608</c:v>
                </c:pt>
                <c:pt idx="229">
                  <c:v>609</c:v>
                </c:pt>
                <c:pt idx="230">
                  <c:v>610</c:v>
                </c:pt>
                <c:pt idx="231">
                  <c:v>611</c:v>
                </c:pt>
                <c:pt idx="232">
                  <c:v>612</c:v>
                </c:pt>
                <c:pt idx="233">
                  <c:v>613</c:v>
                </c:pt>
                <c:pt idx="234">
                  <c:v>614</c:v>
                </c:pt>
                <c:pt idx="235">
                  <c:v>615</c:v>
                </c:pt>
                <c:pt idx="236">
                  <c:v>616</c:v>
                </c:pt>
                <c:pt idx="237">
                  <c:v>617</c:v>
                </c:pt>
                <c:pt idx="238">
                  <c:v>618</c:v>
                </c:pt>
                <c:pt idx="239">
                  <c:v>619</c:v>
                </c:pt>
                <c:pt idx="240">
                  <c:v>620</c:v>
                </c:pt>
                <c:pt idx="241">
                  <c:v>621</c:v>
                </c:pt>
                <c:pt idx="242">
                  <c:v>622</c:v>
                </c:pt>
                <c:pt idx="243">
                  <c:v>623</c:v>
                </c:pt>
                <c:pt idx="244">
                  <c:v>624</c:v>
                </c:pt>
                <c:pt idx="245">
                  <c:v>625</c:v>
                </c:pt>
                <c:pt idx="246">
                  <c:v>626</c:v>
                </c:pt>
                <c:pt idx="247">
                  <c:v>627</c:v>
                </c:pt>
                <c:pt idx="248">
                  <c:v>628</c:v>
                </c:pt>
                <c:pt idx="249">
                  <c:v>629</c:v>
                </c:pt>
                <c:pt idx="250">
                  <c:v>630</c:v>
                </c:pt>
                <c:pt idx="251">
                  <c:v>631</c:v>
                </c:pt>
                <c:pt idx="252">
                  <c:v>632</c:v>
                </c:pt>
                <c:pt idx="253">
                  <c:v>633</c:v>
                </c:pt>
                <c:pt idx="254">
                  <c:v>634</c:v>
                </c:pt>
                <c:pt idx="255">
                  <c:v>635</c:v>
                </c:pt>
                <c:pt idx="256">
                  <c:v>636</c:v>
                </c:pt>
                <c:pt idx="257">
                  <c:v>637</c:v>
                </c:pt>
                <c:pt idx="258">
                  <c:v>638</c:v>
                </c:pt>
                <c:pt idx="259">
                  <c:v>639</c:v>
                </c:pt>
                <c:pt idx="260">
                  <c:v>640</c:v>
                </c:pt>
                <c:pt idx="261">
                  <c:v>641</c:v>
                </c:pt>
                <c:pt idx="262">
                  <c:v>642</c:v>
                </c:pt>
                <c:pt idx="263">
                  <c:v>643</c:v>
                </c:pt>
                <c:pt idx="264">
                  <c:v>644</c:v>
                </c:pt>
                <c:pt idx="265">
                  <c:v>645</c:v>
                </c:pt>
                <c:pt idx="266">
                  <c:v>646</c:v>
                </c:pt>
                <c:pt idx="267">
                  <c:v>647</c:v>
                </c:pt>
                <c:pt idx="268">
                  <c:v>648</c:v>
                </c:pt>
                <c:pt idx="269">
                  <c:v>649</c:v>
                </c:pt>
                <c:pt idx="270">
                  <c:v>650</c:v>
                </c:pt>
                <c:pt idx="271">
                  <c:v>651</c:v>
                </c:pt>
                <c:pt idx="272">
                  <c:v>652</c:v>
                </c:pt>
                <c:pt idx="273">
                  <c:v>653</c:v>
                </c:pt>
                <c:pt idx="274">
                  <c:v>654</c:v>
                </c:pt>
                <c:pt idx="275">
                  <c:v>655</c:v>
                </c:pt>
                <c:pt idx="276">
                  <c:v>656</c:v>
                </c:pt>
                <c:pt idx="277">
                  <c:v>657</c:v>
                </c:pt>
                <c:pt idx="278">
                  <c:v>658</c:v>
                </c:pt>
                <c:pt idx="279">
                  <c:v>659</c:v>
                </c:pt>
                <c:pt idx="280">
                  <c:v>660</c:v>
                </c:pt>
                <c:pt idx="281">
                  <c:v>661</c:v>
                </c:pt>
                <c:pt idx="282">
                  <c:v>662</c:v>
                </c:pt>
                <c:pt idx="283">
                  <c:v>663</c:v>
                </c:pt>
                <c:pt idx="284">
                  <c:v>664</c:v>
                </c:pt>
                <c:pt idx="285">
                  <c:v>665</c:v>
                </c:pt>
                <c:pt idx="286">
                  <c:v>666</c:v>
                </c:pt>
                <c:pt idx="287">
                  <c:v>667</c:v>
                </c:pt>
                <c:pt idx="288">
                  <c:v>668</c:v>
                </c:pt>
                <c:pt idx="289">
                  <c:v>669</c:v>
                </c:pt>
                <c:pt idx="290">
                  <c:v>670</c:v>
                </c:pt>
                <c:pt idx="291">
                  <c:v>671</c:v>
                </c:pt>
                <c:pt idx="292">
                  <c:v>672</c:v>
                </c:pt>
                <c:pt idx="293">
                  <c:v>673</c:v>
                </c:pt>
                <c:pt idx="294">
                  <c:v>674</c:v>
                </c:pt>
                <c:pt idx="295">
                  <c:v>675</c:v>
                </c:pt>
                <c:pt idx="296">
                  <c:v>676</c:v>
                </c:pt>
                <c:pt idx="297">
                  <c:v>677</c:v>
                </c:pt>
                <c:pt idx="298">
                  <c:v>678</c:v>
                </c:pt>
                <c:pt idx="299">
                  <c:v>679</c:v>
                </c:pt>
                <c:pt idx="300">
                  <c:v>680</c:v>
                </c:pt>
                <c:pt idx="301">
                  <c:v>681</c:v>
                </c:pt>
                <c:pt idx="302">
                  <c:v>682</c:v>
                </c:pt>
                <c:pt idx="303">
                  <c:v>683</c:v>
                </c:pt>
                <c:pt idx="304">
                  <c:v>684</c:v>
                </c:pt>
                <c:pt idx="305">
                  <c:v>685</c:v>
                </c:pt>
                <c:pt idx="306">
                  <c:v>686</c:v>
                </c:pt>
                <c:pt idx="307">
                  <c:v>687</c:v>
                </c:pt>
                <c:pt idx="308">
                  <c:v>688</c:v>
                </c:pt>
                <c:pt idx="309">
                  <c:v>689</c:v>
                </c:pt>
                <c:pt idx="310">
                  <c:v>690</c:v>
                </c:pt>
                <c:pt idx="311">
                  <c:v>691</c:v>
                </c:pt>
                <c:pt idx="312">
                  <c:v>692</c:v>
                </c:pt>
                <c:pt idx="313">
                  <c:v>693</c:v>
                </c:pt>
                <c:pt idx="314">
                  <c:v>694</c:v>
                </c:pt>
                <c:pt idx="315">
                  <c:v>695</c:v>
                </c:pt>
                <c:pt idx="316">
                  <c:v>696</c:v>
                </c:pt>
                <c:pt idx="317">
                  <c:v>697</c:v>
                </c:pt>
                <c:pt idx="318">
                  <c:v>698</c:v>
                </c:pt>
                <c:pt idx="319">
                  <c:v>699</c:v>
                </c:pt>
                <c:pt idx="320">
                  <c:v>700</c:v>
                </c:pt>
                <c:pt idx="321">
                  <c:v>701</c:v>
                </c:pt>
                <c:pt idx="322">
                  <c:v>702</c:v>
                </c:pt>
                <c:pt idx="323">
                  <c:v>703</c:v>
                </c:pt>
                <c:pt idx="324">
                  <c:v>704</c:v>
                </c:pt>
                <c:pt idx="325">
                  <c:v>705</c:v>
                </c:pt>
                <c:pt idx="326">
                  <c:v>706</c:v>
                </c:pt>
                <c:pt idx="327">
                  <c:v>707</c:v>
                </c:pt>
                <c:pt idx="328">
                  <c:v>708</c:v>
                </c:pt>
                <c:pt idx="329">
                  <c:v>709</c:v>
                </c:pt>
                <c:pt idx="330">
                  <c:v>710</c:v>
                </c:pt>
                <c:pt idx="331">
                  <c:v>711</c:v>
                </c:pt>
                <c:pt idx="332">
                  <c:v>712</c:v>
                </c:pt>
                <c:pt idx="333">
                  <c:v>713</c:v>
                </c:pt>
                <c:pt idx="334">
                  <c:v>714</c:v>
                </c:pt>
                <c:pt idx="335">
                  <c:v>715</c:v>
                </c:pt>
                <c:pt idx="336">
                  <c:v>716</c:v>
                </c:pt>
                <c:pt idx="337">
                  <c:v>717</c:v>
                </c:pt>
                <c:pt idx="338">
                  <c:v>718</c:v>
                </c:pt>
                <c:pt idx="339">
                  <c:v>719</c:v>
                </c:pt>
                <c:pt idx="340">
                  <c:v>720</c:v>
                </c:pt>
                <c:pt idx="341">
                  <c:v>721</c:v>
                </c:pt>
                <c:pt idx="342">
                  <c:v>722</c:v>
                </c:pt>
                <c:pt idx="343">
                  <c:v>723</c:v>
                </c:pt>
                <c:pt idx="344">
                  <c:v>724</c:v>
                </c:pt>
                <c:pt idx="345">
                  <c:v>725</c:v>
                </c:pt>
                <c:pt idx="346">
                  <c:v>726</c:v>
                </c:pt>
                <c:pt idx="347">
                  <c:v>727</c:v>
                </c:pt>
                <c:pt idx="348">
                  <c:v>728</c:v>
                </c:pt>
                <c:pt idx="349">
                  <c:v>729</c:v>
                </c:pt>
                <c:pt idx="350">
                  <c:v>730</c:v>
                </c:pt>
                <c:pt idx="351">
                  <c:v>731</c:v>
                </c:pt>
                <c:pt idx="352">
                  <c:v>732</c:v>
                </c:pt>
                <c:pt idx="353">
                  <c:v>733</c:v>
                </c:pt>
                <c:pt idx="354">
                  <c:v>734</c:v>
                </c:pt>
                <c:pt idx="355">
                  <c:v>735</c:v>
                </c:pt>
                <c:pt idx="356">
                  <c:v>736</c:v>
                </c:pt>
                <c:pt idx="357">
                  <c:v>737</c:v>
                </c:pt>
                <c:pt idx="358">
                  <c:v>738</c:v>
                </c:pt>
                <c:pt idx="359">
                  <c:v>739</c:v>
                </c:pt>
                <c:pt idx="360">
                  <c:v>740</c:v>
                </c:pt>
                <c:pt idx="361">
                  <c:v>741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6</c:v>
                </c:pt>
                <c:pt idx="367">
                  <c:v>747</c:v>
                </c:pt>
                <c:pt idx="368">
                  <c:v>748</c:v>
                </c:pt>
                <c:pt idx="369">
                  <c:v>749</c:v>
                </c:pt>
                <c:pt idx="370">
                  <c:v>750</c:v>
                </c:pt>
                <c:pt idx="371">
                  <c:v>751</c:v>
                </c:pt>
                <c:pt idx="372">
                  <c:v>752</c:v>
                </c:pt>
                <c:pt idx="373">
                  <c:v>753</c:v>
                </c:pt>
                <c:pt idx="374">
                  <c:v>754</c:v>
                </c:pt>
                <c:pt idx="375">
                  <c:v>755</c:v>
                </c:pt>
                <c:pt idx="376">
                  <c:v>756</c:v>
                </c:pt>
                <c:pt idx="377">
                  <c:v>757</c:v>
                </c:pt>
                <c:pt idx="378">
                  <c:v>758</c:v>
                </c:pt>
                <c:pt idx="379">
                  <c:v>759</c:v>
                </c:pt>
                <c:pt idx="380">
                  <c:v>760</c:v>
                </c:pt>
                <c:pt idx="381">
                  <c:v>761</c:v>
                </c:pt>
                <c:pt idx="382">
                  <c:v>762</c:v>
                </c:pt>
                <c:pt idx="383">
                  <c:v>763</c:v>
                </c:pt>
                <c:pt idx="384">
                  <c:v>764</c:v>
                </c:pt>
                <c:pt idx="385">
                  <c:v>765</c:v>
                </c:pt>
                <c:pt idx="386">
                  <c:v>766</c:v>
                </c:pt>
                <c:pt idx="387">
                  <c:v>767</c:v>
                </c:pt>
                <c:pt idx="388">
                  <c:v>768</c:v>
                </c:pt>
                <c:pt idx="389">
                  <c:v>769</c:v>
                </c:pt>
                <c:pt idx="390">
                  <c:v>770</c:v>
                </c:pt>
                <c:pt idx="391">
                  <c:v>771</c:v>
                </c:pt>
                <c:pt idx="392">
                  <c:v>772</c:v>
                </c:pt>
                <c:pt idx="393">
                  <c:v>773</c:v>
                </c:pt>
                <c:pt idx="394">
                  <c:v>774</c:v>
                </c:pt>
                <c:pt idx="395">
                  <c:v>775</c:v>
                </c:pt>
                <c:pt idx="396">
                  <c:v>776</c:v>
                </c:pt>
                <c:pt idx="397">
                  <c:v>777</c:v>
                </c:pt>
                <c:pt idx="398">
                  <c:v>778</c:v>
                </c:pt>
                <c:pt idx="399">
                  <c:v>779</c:v>
                </c:pt>
                <c:pt idx="400">
                  <c:v>780</c:v>
                </c:pt>
              </c:numCache>
            </c:numRef>
          </c:xVal>
          <c:yVal>
            <c:numRef>
              <c:f>Hoja2!$I$7:$I$407</c:f>
              <c:numCache>
                <c:formatCode>General</c:formatCode>
                <c:ptCount val="401"/>
                <c:pt idx="0">
                  <c:v>1.8185E-2</c:v>
                </c:pt>
                <c:pt idx="1">
                  <c:v>1.7571E-2</c:v>
                </c:pt>
                <c:pt idx="2">
                  <c:v>1.6562E-2</c:v>
                </c:pt>
                <c:pt idx="3">
                  <c:v>1.5731999999999999E-2</c:v>
                </c:pt>
                <c:pt idx="4">
                  <c:v>1.4989000000000001E-2</c:v>
                </c:pt>
                <c:pt idx="5">
                  <c:v>1.4675000000000001E-2</c:v>
                </c:pt>
                <c:pt idx="6">
                  <c:v>1.4463999999999999E-2</c:v>
                </c:pt>
                <c:pt idx="7">
                  <c:v>1.4007E-2</c:v>
                </c:pt>
                <c:pt idx="8">
                  <c:v>1.3554E-2</c:v>
                </c:pt>
                <c:pt idx="9">
                  <c:v>1.3336000000000001E-2</c:v>
                </c:pt>
                <c:pt idx="10">
                  <c:v>1.3183E-2</c:v>
                </c:pt>
                <c:pt idx="11">
                  <c:v>1.3278999999999999E-2</c:v>
                </c:pt>
                <c:pt idx="12">
                  <c:v>1.3396E-2</c:v>
                </c:pt>
                <c:pt idx="13">
                  <c:v>1.3552E-2</c:v>
                </c:pt>
                <c:pt idx="14">
                  <c:v>1.3632999999999999E-2</c:v>
                </c:pt>
                <c:pt idx="15">
                  <c:v>1.3632E-2</c:v>
                </c:pt>
                <c:pt idx="16">
                  <c:v>1.3252E-2</c:v>
                </c:pt>
                <c:pt idx="17">
                  <c:v>1.2631E-2</c:v>
                </c:pt>
                <c:pt idx="18">
                  <c:v>1.2524E-2</c:v>
                </c:pt>
                <c:pt idx="19">
                  <c:v>1.2591E-2</c:v>
                </c:pt>
                <c:pt idx="20">
                  <c:v>1.2730999999999999E-2</c:v>
                </c:pt>
                <c:pt idx="21">
                  <c:v>1.2891E-2</c:v>
                </c:pt>
                <c:pt idx="22">
                  <c:v>1.3565000000000001E-2</c:v>
                </c:pt>
                <c:pt idx="23">
                  <c:v>1.4172000000000001E-2</c:v>
                </c:pt>
                <c:pt idx="24">
                  <c:v>1.4411E-2</c:v>
                </c:pt>
                <c:pt idx="25">
                  <c:v>1.4765E-2</c:v>
                </c:pt>
                <c:pt idx="26">
                  <c:v>1.5403E-2</c:v>
                </c:pt>
                <c:pt idx="27">
                  <c:v>1.6063000000000001E-2</c:v>
                </c:pt>
                <c:pt idx="28">
                  <c:v>1.6752E-2</c:v>
                </c:pt>
                <c:pt idx="29">
                  <c:v>1.7232999999999998E-2</c:v>
                </c:pt>
                <c:pt idx="30">
                  <c:v>1.755E-2</c:v>
                </c:pt>
                <c:pt idx="31">
                  <c:v>1.8379E-2</c:v>
                </c:pt>
                <c:pt idx="32">
                  <c:v>1.9425999999999999E-2</c:v>
                </c:pt>
                <c:pt idx="33">
                  <c:v>2.0868000000000001E-2</c:v>
                </c:pt>
                <c:pt idx="34">
                  <c:v>2.2388000000000002E-2</c:v>
                </c:pt>
                <c:pt idx="35">
                  <c:v>2.4063000000000001E-2</c:v>
                </c:pt>
                <c:pt idx="36">
                  <c:v>2.5808999999999999E-2</c:v>
                </c:pt>
                <c:pt idx="37">
                  <c:v>2.8072E-2</c:v>
                </c:pt>
                <c:pt idx="38">
                  <c:v>3.0411000000000001E-2</c:v>
                </c:pt>
                <c:pt idx="39">
                  <c:v>3.2973000000000002E-2</c:v>
                </c:pt>
                <c:pt idx="40">
                  <c:v>3.5911999999999999E-2</c:v>
                </c:pt>
                <c:pt idx="41">
                  <c:v>3.9433000000000003E-2</c:v>
                </c:pt>
                <c:pt idx="42">
                  <c:v>4.2970000000000001E-2</c:v>
                </c:pt>
                <c:pt idx="43">
                  <c:v>4.6519999999999999E-2</c:v>
                </c:pt>
                <c:pt idx="44">
                  <c:v>5.0812000000000003E-2</c:v>
                </c:pt>
                <c:pt idx="45">
                  <c:v>5.5462999999999998E-2</c:v>
                </c:pt>
                <c:pt idx="46">
                  <c:v>6.1057E-2</c:v>
                </c:pt>
                <c:pt idx="47">
                  <c:v>6.6864000000000007E-2</c:v>
                </c:pt>
                <c:pt idx="48">
                  <c:v>7.4045E-2</c:v>
                </c:pt>
                <c:pt idx="49">
                  <c:v>8.1409999999999996E-2</c:v>
                </c:pt>
                <c:pt idx="50">
                  <c:v>8.9881000000000003E-2</c:v>
                </c:pt>
                <c:pt idx="51">
                  <c:v>9.8609000000000002E-2</c:v>
                </c:pt>
                <c:pt idx="52">
                  <c:v>0.108135</c:v>
                </c:pt>
                <c:pt idx="53">
                  <c:v>0.118494</c:v>
                </c:pt>
                <c:pt idx="54">
                  <c:v>0.13017100000000001</c:v>
                </c:pt>
                <c:pt idx="55">
                  <c:v>0.14288600000000001</c:v>
                </c:pt>
                <c:pt idx="56">
                  <c:v>0.15651399999999999</c:v>
                </c:pt>
                <c:pt idx="57">
                  <c:v>0.17228299999999999</c:v>
                </c:pt>
                <c:pt idx="58">
                  <c:v>0.18906999999999999</c:v>
                </c:pt>
                <c:pt idx="59">
                  <c:v>0.20825399999999999</c:v>
                </c:pt>
                <c:pt idx="60">
                  <c:v>0.22795000000000001</c:v>
                </c:pt>
                <c:pt idx="61">
                  <c:v>0.252077</c:v>
                </c:pt>
                <c:pt idx="62">
                  <c:v>0.27668300000000001</c:v>
                </c:pt>
                <c:pt idx="63">
                  <c:v>0.303869</c:v>
                </c:pt>
                <c:pt idx="64">
                  <c:v>0.331787</c:v>
                </c:pt>
                <c:pt idx="65">
                  <c:v>0.36171300000000001</c:v>
                </c:pt>
                <c:pt idx="66">
                  <c:v>0.39189000000000002</c:v>
                </c:pt>
                <c:pt idx="67">
                  <c:v>0.42241800000000002</c:v>
                </c:pt>
                <c:pt idx="68">
                  <c:v>0.45158300000000001</c:v>
                </c:pt>
                <c:pt idx="69">
                  <c:v>0.47970600000000002</c:v>
                </c:pt>
                <c:pt idx="70">
                  <c:v>0.50433600000000001</c:v>
                </c:pt>
                <c:pt idx="71">
                  <c:v>0.52757699999999996</c:v>
                </c:pt>
                <c:pt idx="72">
                  <c:v>0.54425500000000004</c:v>
                </c:pt>
                <c:pt idx="73">
                  <c:v>0.55976700000000001</c:v>
                </c:pt>
                <c:pt idx="74">
                  <c:v>0.56631900000000002</c:v>
                </c:pt>
                <c:pt idx="75">
                  <c:v>0.57147999999999999</c:v>
                </c:pt>
                <c:pt idx="76">
                  <c:v>0.56969499999999995</c:v>
                </c:pt>
                <c:pt idx="77">
                  <c:v>0.56574100000000005</c:v>
                </c:pt>
                <c:pt idx="78">
                  <c:v>0.55716600000000005</c:v>
                </c:pt>
                <c:pt idx="79">
                  <c:v>0.54656700000000003</c:v>
                </c:pt>
                <c:pt idx="80">
                  <c:v>0.53371000000000002</c:v>
                </c:pt>
                <c:pt idx="81">
                  <c:v>0.51985199999999998</c:v>
                </c:pt>
                <c:pt idx="82">
                  <c:v>0.50539800000000001</c:v>
                </c:pt>
                <c:pt idx="83">
                  <c:v>0.49102400000000002</c:v>
                </c:pt>
                <c:pt idx="84">
                  <c:v>0.47667100000000001</c:v>
                </c:pt>
                <c:pt idx="85">
                  <c:v>0.462893</c:v>
                </c:pt>
                <c:pt idx="86">
                  <c:v>0.44928400000000002</c:v>
                </c:pt>
                <c:pt idx="87">
                  <c:v>0.43691200000000002</c:v>
                </c:pt>
                <c:pt idx="88">
                  <c:v>0.42477900000000002</c:v>
                </c:pt>
                <c:pt idx="89">
                  <c:v>0.41334599999999999</c:v>
                </c:pt>
                <c:pt idx="90">
                  <c:v>0.40200399999999997</c:v>
                </c:pt>
                <c:pt idx="91">
                  <c:v>0.390789</c:v>
                </c:pt>
                <c:pt idx="92">
                  <c:v>0.37971500000000002</c:v>
                </c:pt>
                <c:pt idx="93">
                  <c:v>0.36874400000000002</c:v>
                </c:pt>
                <c:pt idx="94">
                  <c:v>0.35847299999999999</c:v>
                </c:pt>
                <c:pt idx="95">
                  <c:v>0.34845300000000001</c:v>
                </c:pt>
                <c:pt idx="96">
                  <c:v>0.34023900000000001</c:v>
                </c:pt>
                <c:pt idx="97">
                  <c:v>0.33234399999999997</c:v>
                </c:pt>
                <c:pt idx="98">
                  <c:v>0.32617699999999999</c:v>
                </c:pt>
                <c:pt idx="99">
                  <c:v>0.32042799999999999</c:v>
                </c:pt>
                <c:pt idx="100">
                  <c:v>0.31609599999999999</c:v>
                </c:pt>
                <c:pt idx="101">
                  <c:v>0.31276999999999999</c:v>
                </c:pt>
                <c:pt idx="102">
                  <c:v>0.31099100000000002</c:v>
                </c:pt>
                <c:pt idx="103">
                  <c:v>0.309975</c:v>
                </c:pt>
                <c:pt idx="104">
                  <c:v>0.309556</c:v>
                </c:pt>
                <c:pt idx="105">
                  <c:v>0.31037300000000001</c:v>
                </c:pt>
                <c:pt idx="106">
                  <c:v>0.31164700000000001</c:v>
                </c:pt>
                <c:pt idx="107">
                  <c:v>0.31330400000000003</c:v>
                </c:pt>
                <c:pt idx="108">
                  <c:v>0.31509599999999999</c:v>
                </c:pt>
                <c:pt idx="109">
                  <c:v>0.31808399999999998</c:v>
                </c:pt>
                <c:pt idx="110">
                  <c:v>0.32158500000000001</c:v>
                </c:pt>
                <c:pt idx="111">
                  <c:v>0.326685</c:v>
                </c:pt>
                <c:pt idx="112">
                  <c:v>0.332318</c:v>
                </c:pt>
                <c:pt idx="113">
                  <c:v>0.33869899999999997</c:v>
                </c:pt>
                <c:pt idx="114">
                  <c:v>0.345329</c:v>
                </c:pt>
                <c:pt idx="115">
                  <c:v>0.352132</c:v>
                </c:pt>
                <c:pt idx="116">
                  <c:v>0.358985</c:v>
                </c:pt>
                <c:pt idx="117">
                  <c:v>0.36585400000000001</c:v>
                </c:pt>
                <c:pt idx="118">
                  <c:v>0.37358000000000002</c:v>
                </c:pt>
                <c:pt idx="119">
                  <c:v>0.38092300000000001</c:v>
                </c:pt>
                <c:pt idx="120">
                  <c:v>0.38518400000000003</c:v>
                </c:pt>
                <c:pt idx="121">
                  <c:v>0.39007199999999997</c:v>
                </c:pt>
                <c:pt idx="122">
                  <c:v>0.39640399999999998</c:v>
                </c:pt>
                <c:pt idx="123">
                  <c:v>0.40275</c:v>
                </c:pt>
                <c:pt idx="124">
                  <c:v>0.40911199999999998</c:v>
                </c:pt>
                <c:pt idx="125">
                  <c:v>0.41553800000000002</c:v>
                </c:pt>
                <c:pt idx="126">
                  <c:v>0.42199500000000001</c:v>
                </c:pt>
                <c:pt idx="127">
                  <c:v>0.42797499999999999</c:v>
                </c:pt>
                <c:pt idx="128">
                  <c:v>0.43387999999999999</c:v>
                </c:pt>
                <c:pt idx="129">
                  <c:v>0.440023</c:v>
                </c:pt>
                <c:pt idx="130">
                  <c:v>0.446187</c:v>
                </c:pt>
                <c:pt idx="131">
                  <c:v>0.45242300000000002</c:v>
                </c:pt>
                <c:pt idx="132">
                  <c:v>0.45855699999999999</c:v>
                </c:pt>
                <c:pt idx="133">
                  <c:v>0.46454600000000001</c:v>
                </c:pt>
                <c:pt idx="134">
                  <c:v>0.47067199999999998</c:v>
                </c:pt>
                <c:pt idx="135">
                  <c:v>0.47688900000000001</c:v>
                </c:pt>
                <c:pt idx="136">
                  <c:v>0.48264299999999999</c:v>
                </c:pt>
                <c:pt idx="137">
                  <c:v>0.48827500000000001</c:v>
                </c:pt>
                <c:pt idx="138">
                  <c:v>0.49396299999999999</c:v>
                </c:pt>
                <c:pt idx="139">
                  <c:v>0.49971199999999999</c:v>
                </c:pt>
                <c:pt idx="140">
                  <c:v>0.50573599999999996</c:v>
                </c:pt>
                <c:pt idx="141">
                  <c:v>0.51176100000000002</c:v>
                </c:pt>
                <c:pt idx="142">
                  <c:v>0.51778500000000005</c:v>
                </c:pt>
                <c:pt idx="143">
                  <c:v>0.52406900000000001</c:v>
                </c:pt>
                <c:pt idx="144">
                  <c:v>0.53054800000000002</c:v>
                </c:pt>
                <c:pt idx="145">
                  <c:v>0.53634099999999996</c:v>
                </c:pt>
                <c:pt idx="146">
                  <c:v>0.54190700000000003</c:v>
                </c:pt>
                <c:pt idx="147">
                  <c:v>0.54744400000000004</c:v>
                </c:pt>
                <c:pt idx="148">
                  <c:v>0.55304600000000004</c:v>
                </c:pt>
                <c:pt idx="149">
                  <c:v>0.55918800000000002</c:v>
                </c:pt>
                <c:pt idx="150">
                  <c:v>0.56522300000000003</c:v>
                </c:pt>
                <c:pt idx="151">
                  <c:v>0.57099999999999995</c:v>
                </c:pt>
                <c:pt idx="152">
                  <c:v>0.57698000000000005</c:v>
                </c:pt>
                <c:pt idx="153">
                  <c:v>0.58318000000000003</c:v>
                </c:pt>
                <c:pt idx="154">
                  <c:v>0.58922600000000003</c:v>
                </c:pt>
                <c:pt idx="155">
                  <c:v>0.59519599999999995</c:v>
                </c:pt>
                <c:pt idx="156">
                  <c:v>0.60106300000000001</c:v>
                </c:pt>
                <c:pt idx="157">
                  <c:v>0.60690299999999997</c:v>
                </c:pt>
                <c:pt idx="158">
                  <c:v>0.61251500000000003</c:v>
                </c:pt>
                <c:pt idx="159">
                  <c:v>0.618232</c:v>
                </c:pt>
                <c:pt idx="160">
                  <c:v>0.62430099999999999</c:v>
                </c:pt>
                <c:pt idx="161">
                  <c:v>0.63036199999999998</c:v>
                </c:pt>
                <c:pt idx="162">
                  <c:v>0.63641099999999995</c:v>
                </c:pt>
                <c:pt idx="163">
                  <c:v>0.64296900000000001</c:v>
                </c:pt>
                <c:pt idx="164">
                  <c:v>0.64984200000000003</c:v>
                </c:pt>
                <c:pt idx="165">
                  <c:v>0.65665499999999999</c:v>
                </c:pt>
                <c:pt idx="166">
                  <c:v>0.66345399999999999</c:v>
                </c:pt>
                <c:pt idx="167">
                  <c:v>0.67028900000000002</c:v>
                </c:pt>
                <c:pt idx="168">
                  <c:v>0.67716500000000002</c:v>
                </c:pt>
                <c:pt idx="169">
                  <c:v>0.68420300000000001</c:v>
                </c:pt>
                <c:pt idx="170">
                  <c:v>0.69113199999999997</c:v>
                </c:pt>
                <c:pt idx="171">
                  <c:v>0.69790300000000005</c:v>
                </c:pt>
                <c:pt idx="172">
                  <c:v>0.70508899999999997</c:v>
                </c:pt>
                <c:pt idx="173">
                  <c:v>0.712538</c:v>
                </c:pt>
                <c:pt idx="174">
                  <c:v>0.72004999999999997</c:v>
                </c:pt>
                <c:pt idx="175">
                  <c:v>0.72758599999999996</c:v>
                </c:pt>
                <c:pt idx="176">
                  <c:v>0.73561399999999999</c:v>
                </c:pt>
                <c:pt idx="177">
                  <c:v>0.74365599999999998</c:v>
                </c:pt>
                <c:pt idx="178">
                  <c:v>0.75175099999999995</c:v>
                </c:pt>
                <c:pt idx="179">
                  <c:v>0.75975000000000004</c:v>
                </c:pt>
                <c:pt idx="180">
                  <c:v>0.767625</c:v>
                </c:pt>
                <c:pt idx="181">
                  <c:v>0.775841</c:v>
                </c:pt>
                <c:pt idx="182">
                  <c:v>0.78424300000000002</c:v>
                </c:pt>
                <c:pt idx="183">
                  <c:v>0.792659</c:v>
                </c:pt>
                <c:pt idx="184">
                  <c:v>0.80111100000000002</c:v>
                </c:pt>
                <c:pt idx="185">
                  <c:v>0.80999600000000005</c:v>
                </c:pt>
                <c:pt idx="186">
                  <c:v>0.81870799999999999</c:v>
                </c:pt>
                <c:pt idx="187">
                  <c:v>0.82699400000000001</c:v>
                </c:pt>
                <c:pt idx="188">
                  <c:v>0.83547099999999996</c:v>
                </c:pt>
                <c:pt idx="189">
                  <c:v>0.84413400000000005</c:v>
                </c:pt>
                <c:pt idx="190">
                  <c:v>0.85273900000000002</c:v>
                </c:pt>
                <c:pt idx="191">
                  <c:v>0.861321</c:v>
                </c:pt>
                <c:pt idx="192">
                  <c:v>0.86975499999999994</c:v>
                </c:pt>
                <c:pt idx="193">
                  <c:v>0.87816399999999994</c:v>
                </c:pt>
                <c:pt idx="194">
                  <c:v>0.886494</c:v>
                </c:pt>
                <c:pt idx="195">
                  <c:v>0.89438099999999998</c:v>
                </c:pt>
                <c:pt idx="196">
                  <c:v>0.90157699999999996</c:v>
                </c:pt>
                <c:pt idx="197">
                  <c:v>0.90909499999999999</c:v>
                </c:pt>
                <c:pt idx="198">
                  <c:v>0.91681199999999996</c:v>
                </c:pt>
                <c:pt idx="199">
                  <c:v>0.92397700000000005</c:v>
                </c:pt>
                <c:pt idx="200">
                  <c:v>0.93101299999999998</c:v>
                </c:pt>
                <c:pt idx="201">
                  <c:v>0.93770100000000001</c:v>
                </c:pt>
                <c:pt idx="202">
                  <c:v>0.94438299999999997</c:v>
                </c:pt>
                <c:pt idx="203">
                  <c:v>0.95104999999999995</c:v>
                </c:pt>
                <c:pt idx="204">
                  <c:v>0.95718499999999995</c:v>
                </c:pt>
                <c:pt idx="205">
                  <c:v>0.96286499999999997</c:v>
                </c:pt>
                <c:pt idx="206">
                  <c:v>0.96801199999999998</c:v>
                </c:pt>
                <c:pt idx="207">
                  <c:v>0.97299599999999997</c:v>
                </c:pt>
                <c:pt idx="208">
                  <c:v>0.97723499999999996</c:v>
                </c:pt>
                <c:pt idx="209">
                  <c:v>0.98120600000000002</c:v>
                </c:pt>
                <c:pt idx="210">
                  <c:v>0.98438199999999998</c:v>
                </c:pt>
                <c:pt idx="211">
                  <c:v>0.98740099999999997</c:v>
                </c:pt>
                <c:pt idx="212">
                  <c:v>0.990259</c:v>
                </c:pt>
                <c:pt idx="213">
                  <c:v>0.99282400000000004</c:v>
                </c:pt>
                <c:pt idx="214">
                  <c:v>0.995282</c:v>
                </c:pt>
                <c:pt idx="215">
                  <c:v>0.99702100000000005</c:v>
                </c:pt>
                <c:pt idx="216">
                  <c:v>0.99856900000000004</c:v>
                </c:pt>
                <c:pt idx="217">
                  <c:v>0.99951400000000001</c:v>
                </c:pt>
                <c:pt idx="218">
                  <c:v>1</c:v>
                </c:pt>
                <c:pt idx="219">
                  <c:v>0.99997599999999998</c:v>
                </c:pt>
                <c:pt idx="220">
                  <c:v>0.99889300000000003</c:v>
                </c:pt>
                <c:pt idx="221">
                  <c:v>0.99740600000000001</c:v>
                </c:pt>
                <c:pt idx="222">
                  <c:v>0.995417</c:v>
                </c:pt>
                <c:pt idx="223">
                  <c:v>0.99340899999999999</c:v>
                </c:pt>
                <c:pt idx="224">
                  <c:v>0.99137900000000001</c:v>
                </c:pt>
                <c:pt idx="225">
                  <c:v>0.98872400000000005</c:v>
                </c:pt>
                <c:pt idx="226">
                  <c:v>0.98540700000000003</c:v>
                </c:pt>
                <c:pt idx="227">
                  <c:v>0.98197599999999996</c:v>
                </c:pt>
                <c:pt idx="228">
                  <c:v>0.97850300000000001</c:v>
                </c:pt>
                <c:pt idx="229">
                  <c:v>0.97377499999999995</c:v>
                </c:pt>
                <c:pt idx="230">
                  <c:v>0.96866099999999999</c:v>
                </c:pt>
                <c:pt idx="231">
                  <c:v>0.96247400000000005</c:v>
                </c:pt>
                <c:pt idx="232">
                  <c:v>0.95571200000000001</c:v>
                </c:pt>
                <c:pt idx="233">
                  <c:v>0.94843699999999997</c:v>
                </c:pt>
                <c:pt idx="234">
                  <c:v>0.94057999999999997</c:v>
                </c:pt>
                <c:pt idx="235">
                  <c:v>0.93257800000000002</c:v>
                </c:pt>
                <c:pt idx="236">
                  <c:v>0.92469699999999999</c:v>
                </c:pt>
                <c:pt idx="237">
                  <c:v>0.91670600000000002</c:v>
                </c:pt>
                <c:pt idx="238">
                  <c:v>0.90849299999999999</c:v>
                </c:pt>
                <c:pt idx="239">
                  <c:v>0.89995499999999995</c:v>
                </c:pt>
                <c:pt idx="240">
                  <c:v>0.89120200000000005</c:v>
                </c:pt>
                <c:pt idx="241">
                  <c:v>0.882382</c:v>
                </c:pt>
                <c:pt idx="242">
                  <c:v>0.87352700000000005</c:v>
                </c:pt>
                <c:pt idx="243">
                  <c:v>0.86453500000000005</c:v>
                </c:pt>
                <c:pt idx="244">
                  <c:v>0.85555400000000004</c:v>
                </c:pt>
                <c:pt idx="245">
                  <c:v>0.84658900000000004</c:v>
                </c:pt>
                <c:pt idx="246">
                  <c:v>0.83685799999999999</c:v>
                </c:pt>
                <c:pt idx="247">
                  <c:v>0.82681099999999996</c:v>
                </c:pt>
                <c:pt idx="248">
                  <c:v>0.81455200000000005</c:v>
                </c:pt>
                <c:pt idx="249">
                  <c:v>0.80294100000000002</c:v>
                </c:pt>
                <c:pt idx="250">
                  <c:v>0.79302600000000001</c:v>
                </c:pt>
                <c:pt idx="251">
                  <c:v>0.782914</c:v>
                </c:pt>
                <c:pt idx="252">
                  <c:v>0.77266400000000002</c:v>
                </c:pt>
                <c:pt idx="253">
                  <c:v>0.76161699999999999</c:v>
                </c:pt>
                <c:pt idx="254">
                  <c:v>0.75047799999999998</c:v>
                </c:pt>
                <c:pt idx="255">
                  <c:v>0.73933099999999996</c:v>
                </c:pt>
                <c:pt idx="256">
                  <c:v>0.72745899999999997</c:v>
                </c:pt>
                <c:pt idx="257">
                  <c:v>0.71492699999999998</c:v>
                </c:pt>
                <c:pt idx="258">
                  <c:v>0.70277299999999998</c:v>
                </c:pt>
                <c:pt idx="259">
                  <c:v>0.69056099999999998</c:v>
                </c:pt>
                <c:pt idx="260">
                  <c:v>0.67763399999999996</c:v>
                </c:pt>
                <c:pt idx="261">
                  <c:v>0.66487700000000005</c:v>
                </c:pt>
                <c:pt idx="262">
                  <c:v>0.65230999999999995</c:v>
                </c:pt>
                <c:pt idx="263">
                  <c:v>0.63967600000000002</c:v>
                </c:pt>
                <c:pt idx="264">
                  <c:v>0.62702199999999997</c:v>
                </c:pt>
                <c:pt idx="265">
                  <c:v>0.61434800000000001</c:v>
                </c:pt>
                <c:pt idx="266">
                  <c:v>0.60166799999999998</c:v>
                </c:pt>
                <c:pt idx="267">
                  <c:v>0.58897999999999995</c:v>
                </c:pt>
                <c:pt idx="268">
                  <c:v>0.57634200000000002</c:v>
                </c:pt>
                <c:pt idx="269">
                  <c:v>0.56377900000000003</c:v>
                </c:pt>
                <c:pt idx="270">
                  <c:v>0.55176800000000004</c:v>
                </c:pt>
                <c:pt idx="271">
                  <c:v>0.53986699999999999</c:v>
                </c:pt>
                <c:pt idx="272">
                  <c:v>0.528111</c:v>
                </c:pt>
                <c:pt idx="273">
                  <c:v>0.51663999999999999</c:v>
                </c:pt>
                <c:pt idx="274">
                  <c:v>0.50531099999999995</c:v>
                </c:pt>
                <c:pt idx="275">
                  <c:v>0.49446899999999999</c:v>
                </c:pt>
                <c:pt idx="276">
                  <c:v>0.48352299999999998</c:v>
                </c:pt>
                <c:pt idx="277">
                  <c:v>0.472443</c:v>
                </c:pt>
                <c:pt idx="278">
                  <c:v>0.46194800000000003</c:v>
                </c:pt>
                <c:pt idx="279">
                  <c:v>0.45152100000000001</c:v>
                </c:pt>
                <c:pt idx="280">
                  <c:v>0.44037900000000002</c:v>
                </c:pt>
                <c:pt idx="281">
                  <c:v>0.42965700000000001</c:v>
                </c:pt>
                <c:pt idx="282">
                  <c:v>0.41941800000000001</c:v>
                </c:pt>
                <c:pt idx="283">
                  <c:v>0.40941100000000002</c:v>
                </c:pt>
                <c:pt idx="284">
                  <c:v>0.39954200000000001</c:v>
                </c:pt>
                <c:pt idx="285">
                  <c:v>0.39011499999999999</c:v>
                </c:pt>
                <c:pt idx="286">
                  <c:v>0.38053199999999998</c:v>
                </c:pt>
                <c:pt idx="287">
                  <c:v>0.37079800000000002</c:v>
                </c:pt>
                <c:pt idx="288">
                  <c:v>0.36168400000000001</c:v>
                </c:pt>
                <c:pt idx="289">
                  <c:v>0.352829</c:v>
                </c:pt>
                <c:pt idx="290">
                  <c:v>0.344553</c:v>
                </c:pt>
                <c:pt idx="291">
                  <c:v>0.33579999999999999</c:v>
                </c:pt>
                <c:pt idx="292">
                  <c:v>0.32669700000000002</c:v>
                </c:pt>
                <c:pt idx="293">
                  <c:v>0.31845400000000001</c:v>
                </c:pt>
                <c:pt idx="294">
                  <c:v>0.31041000000000002</c:v>
                </c:pt>
                <c:pt idx="295">
                  <c:v>0.30269499999999999</c:v>
                </c:pt>
                <c:pt idx="296">
                  <c:v>0.295211</c:v>
                </c:pt>
                <c:pt idx="297">
                  <c:v>0.28785500000000003</c:v>
                </c:pt>
                <c:pt idx="298">
                  <c:v>0.280804</c:v>
                </c:pt>
                <c:pt idx="299">
                  <c:v>0.27374500000000002</c:v>
                </c:pt>
                <c:pt idx="300">
                  <c:v>0.266677</c:v>
                </c:pt>
                <c:pt idx="301">
                  <c:v>0.26010299999999997</c:v>
                </c:pt>
                <c:pt idx="302">
                  <c:v>0.25355</c:v>
                </c:pt>
                <c:pt idx="303">
                  <c:v>0.246225</c:v>
                </c:pt>
                <c:pt idx="304">
                  <c:v>0.23960200000000001</c:v>
                </c:pt>
                <c:pt idx="305">
                  <c:v>0.23363500000000001</c:v>
                </c:pt>
                <c:pt idx="306">
                  <c:v>0.22753899999999999</c:v>
                </c:pt>
                <c:pt idx="307">
                  <c:v>0.22150300000000001</c:v>
                </c:pt>
                <c:pt idx="308">
                  <c:v>0.215666</c:v>
                </c:pt>
                <c:pt idx="309">
                  <c:v>0.21052499999999999</c:v>
                </c:pt>
                <c:pt idx="310">
                  <c:v>0.20571300000000001</c:v>
                </c:pt>
                <c:pt idx="311">
                  <c:v>0.20013800000000001</c:v>
                </c:pt>
                <c:pt idx="312">
                  <c:v>0.194909</c:v>
                </c:pt>
                <c:pt idx="313">
                  <c:v>0.190137</c:v>
                </c:pt>
                <c:pt idx="314">
                  <c:v>0.18496399999999999</c:v>
                </c:pt>
                <c:pt idx="315">
                  <c:v>0.17972199999999999</c:v>
                </c:pt>
                <c:pt idx="316">
                  <c:v>0.17455399999999999</c:v>
                </c:pt>
                <c:pt idx="317">
                  <c:v>0.16992399999999999</c:v>
                </c:pt>
                <c:pt idx="318">
                  <c:v>0.16564599999999999</c:v>
                </c:pt>
                <c:pt idx="319">
                  <c:v>0.16175300000000001</c:v>
                </c:pt>
                <c:pt idx="320">
                  <c:v>0.15792</c:v>
                </c:pt>
                <c:pt idx="321">
                  <c:v>0.15417800000000001</c:v>
                </c:pt>
                <c:pt idx="322">
                  <c:v>0.149949</c:v>
                </c:pt>
                <c:pt idx="323">
                  <c:v>0.145815</c:v>
                </c:pt>
                <c:pt idx="324">
                  <c:v>0.14250499999999999</c:v>
                </c:pt>
                <c:pt idx="325">
                  <c:v>0.138713</c:v>
                </c:pt>
                <c:pt idx="326">
                  <c:v>0.134626</c:v>
                </c:pt>
                <c:pt idx="327">
                  <c:v>0.13092699999999999</c:v>
                </c:pt>
                <c:pt idx="328">
                  <c:v>0.12748200000000001</c:v>
                </c:pt>
                <c:pt idx="329">
                  <c:v>0.124371</c:v>
                </c:pt>
                <c:pt idx="330">
                  <c:v>0.12155100000000001</c:v>
                </c:pt>
                <c:pt idx="331">
                  <c:v>0.11873499999999999</c:v>
                </c:pt>
                <c:pt idx="332">
                  <c:v>0.115782</c:v>
                </c:pt>
                <c:pt idx="333">
                  <c:v>0.112939</c:v>
                </c:pt>
                <c:pt idx="334">
                  <c:v>0.110164</c:v>
                </c:pt>
                <c:pt idx="335">
                  <c:v>0.107516</c:v>
                </c:pt>
                <c:pt idx="336">
                  <c:v>0.104452</c:v>
                </c:pt>
                <c:pt idx="337">
                  <c:v>0.10101599999999999</c:v>
                </c:pt>
                <c:pt idx="338">
                  <c:v>9.8665000000000003E-2</c:v>
                </c:pt>
                <c:pt idx="339">
                  <c:v>9.6279000000000003E-2</c:v>
                </c:pt>
                <c:pt idx="340">
                  <c:v>9.3751000000000001E-2</c:v>
                </c:pt>
                <c:pt idx="341">
                  <c:v>9.1472999999999999E-2</c:v>
                </c:pt>
                <c:pt idx="342">
                  <c:v>8.9363999999999999E-2</c:v>
                </c:pt>
                <c:pt idx="343">
                  <c:v>8.7596999999999994E-2</c:v>
                </c:pt>
                <c:pt idx="344">
                  <c:v>8.5497000000000004E-2</c:v>
                </c:pt>
                <c:pt idx="345">
                  <c:v>8.3323999999999995E-2</c:v>
                </c:pt>
                <c:pt idx="346">
                  <c:v>8.1728999999999996E-2</c:v>
                </c:pt>
                <c:pt idx="347">
                  <c:v>7.9464999999999994E-2</c:v>
                </c:pt>
                <c:pt idx="348">
                  <c:v>7.6700000000000004E-2</c:v>
                </c:pt>
                <c:pt idx="349">
                  <c:v>7.5282000000000002E-2</c:v>
                </c:pt>
                <c:pt idx="350">
                  <c:v>7.3633000000000004E-2</c:v>
                </c:pt>
                <c:pt idx="351">
                  <c:v>7.1709999999999996E-2</c:v>
                </c:pt>
                <c:pt idx="352">
                  <c:v>7.0430000000000006E-2</c:v>
                </c:pt>
                <c:pt idx="353">
                  <c:v>6.9018999999999997E-2</c:v>
                </c:pt>
                <c:pt idx="354">
                  <c:v>6.726E-2</c:v>
                </c:pt>
                <c:pt idx="355">
                  <c:v>6.5591999999999998E-2</c:v>
                </c:pt>
                <c:pt idx="356">
                  <c:v>6.4139000000000002E-2</c:v>
                </c:pt>
                <c:pt idx="357">
                  <c:v>6.3205999999999998E-2</c:v>
                </c:pt>
                <c:pt idx="358">
                  <c:v>6.1490999999999997E-2</c:v>
                </c:pt>
                <c:pt idx="359">
                  <c:v>5.9781000000000001E-2</c:v>
                </c:pt>
                <c:pt idx="360">
                  <c:v>5.9254000000000001E-2</c:v>
                </c:pt>
                <c:pt idx="361">
                  <c:v>5.7735000000000002E-2</c:v>
                </c:pt>
                <c:pt idx="362">
                  <c:v>5.5884999999999997E-2</c:v>
                </c:pt>
                <c:pt idx="363">
                  <c:v>5.5178999999999999E-2</c:v>
                </c:pt>
                <c:pt idx="364">
                  <c:v>5.4769999999999999E-2</c:v>
                </c:pt>
                <c:pt idx="365">
                  <c:v>5.4483999999999998E-2</c:v>
                </c:pt>
                <c:pt idx="366">
                  <c:v>5.3351000000000003E-2</c:v>
                </c:pt>
                <c:pt idx="367">
                  <c:v>5.2797999999999998E-2</c:v>
                </c:pt>
                <c:pt idx="368">
                  <c:v>5.2637000000000003E-2</c:v>
                </c:pt>
                <c:pt idx="369">
                  <c:v>5.0534999999999997E-2</c:v>
                </c:pt>
                <c:pt idx="370">
                  <c:v>4.9109E-2</c:v>
                </c:pt>
                <c:pt idx="371">
                  <c:v>4.8314999999999997E-2</c:v>
                </c:pt>
                <c:pt idx="372">
                  <c:v>4.8092000000000003E-2</c:v>
                </c:pt>
                <c:pt idx="373">
                  <c:v>4.7752999999999997E-2</c:v>
                </c:pt>
                <c:pt idx="374">
                  <c:v>4.7293000000000002E-2</c:v>
                </c:pt>
                <c:pt idx="375">
                  <c:v>4.7875000000000001E-2</c:v>
                </c:pt>
                <c:pt idx="376">
                  <c:v>4.7655000000000003E-2</c:v>
                </c:pt>
                <c:pt idx="377">
                  <c:v>4.6543000000000001E-2</c:v>
                </c:pt>
                <c:pt idx="378">
                  <c:v>4.6203000000000001E-2</c:v>
                </c:pt>
                <c:pt idx="379">
                  <c:v>4.5241999999999997E-2</c:v>
                </c:pt>
                <c:pt idx="380">
                  <c:v>4.3577999999999999E-2</c:v>
                </c:pt>
                <c:pt idx="381">
                  <c:v>4.2729000000000003E-2</c:v>
                </c:pt>
                <c:pt idx="382">
                  <c:v>4.2120999999999999E-2</c:v>
                </c:pt>
                <c:pt idx="383">
                  <c:v>4.1748E-2</c:v>
                </c:pt>
                <c:pt idx="384">
                  <c:v>4.0857999999999998E-2</c:v>
                </c:pt>
                <c:pt idx="385">
                  <c:v>4.0453999999999997E-2</c:v>
                </c:pt>
                <c:pt idx="386">
                  <c:v>4.0511999999999999E-2</c:v>
                </c:pt>
                <c:pt idx="387">
                  <c:v>4.0214E-2</c:v>
                </c:pt>
                <c:pt idx="388">
                  <c:v>3.9905000000000003E-2</c:v>
                </c:pt>
                <c:pt idx="389">
                  <c:v>3.9484999999999999E-2</c:v>
                </c:pt>
                <c:pt idx="390">
                  <c:v>3.7583999999999999E-2</c:v>
                </c:pt>
                <c:pt idx="391">
                  <c:v>3.6367999999999998E-2</c:v>
                </c:pt>
                <c:pt idx="392">
                  <c:v>3.5687000000000003E-2</c:v>
                </c:pt>
                <c:pt idx="393">
                  <c:v>3.5446999999999999E-2</c:v>
                </c:pt>
                <c:pt idx="394">
                  <c:v>3.5410999999999998E-2</c:v>
                </c:pt>
                <c:pt idx="395">
                  <c:v>3.5452999999999998E-2</c:v>
                </c:pt>
                <c:pt idx="396">
                  <c:v>3.5347000000000003E-2</c:v>
                </c:pt>
                <c:pt idx="397">
                  <c:v>3.4972999999999997E-2</c:v>
                </c:pt>
                <c:pt idx="398">
                  <c:v>3.4576000000000003E-2</c:v>
                </c:pt>
                <c:pt idx="399">
                  <c:v>3.4403999999999997E-2</c:v>
                </c:pt>
                <c:pt idx="400">
                  <c:v>3.2976999999999999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213-4057-8E1E-5FDD53AF66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9757391"/>
        <c:axId val="849754895"/>
      </c:scatterChart>
      <c:valAx>
        <c:axId val="849757391"/>
        <c:scaling>
          <c:orientation val="minMax"/>
          <c:max val="780"/>
          <c:min val="3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Wavelength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4895"/>
        <c:crosses val="autoZero"/>
        <c:crossBetween val="midCat"/>
      </c:valAx>
      <c:valAx>
        <c:axId val="849754895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0" i="0" baseline="0" dirty="0" err="1">
                    <a:effectLst/>
                  </a:rPr>
                  <a:t>Relativ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spectral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irradianc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composition</a:t>
                </a:r>
                <a:endParaRPr lang="es-ES" sz="10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7391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>
                <a:solidFill>
                  <a:schemeClr val="tx1"/>
                </a:solidFill>
              </a:rPr>
              <a:t>RW7B3-84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Hoja2!$A$7:$A$407</c:f>
              <c:numCache>
                <c:formatCode>General</c:formatCode>
                <c:ptCount val="401"/>
                <c:pt idx="0">
                  <c:v>380</c:v>
                </c:pt>
                <c:pt idx="1">
                  <c:v>381</c:v>
                </c:pt>
                <c:pt idx="2">
                  <c:v>382</c:v>
                </c:pt>
                <c:pt idx="3">
                  <c:v>383</c:v>
                </c:pt>
                <c:pt idx="4">
                  <c:v>384</c:v>
                </c:pt>
                <c:pt idx="5">
                  <c:v>385</c:v>
                </c:pt>
                <c:pt idx="6">
                  <c:v>386</c:v>
                </c:pt>
                <c:pt idx="7">
                  <c:v>387</c:v>
                </c:pt>
                <c:pt idx="8">
                  <c:v>388</c:v>
                </c:pt>
                <c:pt idx="9">
                  <c:v>389</c:v>
                </c:pt>
                <c:pt idx="10">
                  <c:v>390</c:v>
                </c:pt>
                <c:pt idx="11">
                  <c:v>391</c:v>
                </c:pt>
                <c:pt idx="12">
                  <c:v>392</c:v>
                </c:pt>
                <c:pt idx="13">
                  <c:v>393</c:v>
                </c:pt>
                <c:pt idx="14">
                  <c:v>394</c:v>
                </c:pt>
                <c:pt idx="15">
                  <c:v>395</c:v>
                </c:pt>
                <c:pt idx="16">
                  <c:v>396</c:v>
                </c:pt>
                <c:pt idx="17">
                  <c:v>397</c:v>
                </c:pt>
                <c:pt idx="18">
                  <c:v>398</c:v>
                </c:pt>
                <c:pt idx="19">
                  <c:v>399</c:v>
                </c:pt>
                <c:pt idx="20">
                  <c:v>400</c:v>
                </c:pt>
                <c:pt idx="21">
                  <c:v>401</c:v>
                </c:pt>
                <c:pt idx="22">
                  <c:v>402</c:v>
                </c:pt>
                <c:pt idx="23">
                  <c:v>403</c:v>
                </c:pt>
                <c:pt idx="24">
                  <c:v>404</c:v>
                </c:pt>
                <c:pt idx="25">
                  <c:v>405</c:v>
                </c:pt>
                <c:pt idx="26">
                  <c:v>406</c:v>
                </c:pt>
                <c:pt idx="27">
                  <c:v>407</c:v>
                </c:pt>
                <c:pt idx="28">
                  <c:v>408</c:v>
                </c:pt>
                <c:pt idx="29">
                  <c:v>409</c:v>
                </c:pt>
                <c:pt idx="30">
                  <c:v>410</c:v>
                </c:pt>
                <c:pt idx="31">
                  <c:v>411</c:v>
                </c:pt>
                <c:pt idx="32">
                  <c:v>412</c:v>
                </c:pt>
                <c:pt idx="33">
                  <c:v>413</c:v>
                </c:pt>
                <c:pt idx="34">
                  <c:v>414</c:v>
                </c:pt>
                <c:pt idx="35">
                  <c:v>415</c:v>
                </c:pt>
                <c:pt idx="36">
                  <c:v>416</c:v>
                </c:pt>
                <c:pt idx="37">
                  <c:v>417</c:v>
                </c:pt>
                <c:pt idx="38">
                  <c:v>418</c:v>
                </c:pt>
                <c:pt idx="39">
                  <c:v>419</c:v>
                </c:pt>
                <c:pt idx="40">
                  <c:v>420</c:v>
                </c:pt>
                <c:pt idx="41">
                  <c:v>421</c:v>
                </c:pt>
                <c:pt idx="42">
                  <c:v>422</c:v>
                </c:pt>
                <c:pt idx="43">
                  <c:v>423</c:v>
                </c:pt>
                <c:pt idx="44">
                  <c:v>424</c:v>
                </c:pt>
                <c:pt idx="45">
                  <c:v>425</c:v>
                </c:pt>
                <c:pt idx="46">
                  <c:v>426</c:v>
                </c:pt>
                <c:pt idx="47">
                  <c:v>427</c:v>
                </c:pt>
                <c:pt idx="48">
                  <c:v>428</c:v>
                </c:pt>
                <c:pt idx="49">
                  <c:v>429</c:v>
                </c:pt>
                <c:pt idx="50">
                  <c:v>430</c:v>
                </c:pt>
                <c:pt idx="51">
                  <c:v>431</c:v>
                </c:pt>
                <c:pt idx="52">
                  <c:v>432</c:v>
                </c:pt>
                <c:pt idx="53">
                  <c:v>433</c:v>
                </c:pt>
                <c:pt idx="54">
                  <c:v>434</c:v>
                </c:pt>
                <c:pt idx="55">
                  <c:v>435</c:v>
                </c:pt>
                <c:pt idx="56">
                  <c:v>436</c:v>
                </c:pt>
                <c:pt idx="57">
                  <c:v>437</c:v>
                </c:pt>
                <c:pt idx="58">
                  <c:v>438</c:v>
                </c:pt>
                <c:pt idx="59">
                  <c:v>439</c:v>
                </c:pt>
                <c:pt idx="60">
                  <c:v>440</c:v>
                </c:pt>
                <c:pt idx="61">
                  <c:v>441</c:v>
                </c:pt>
                <c:pt idx="62">
                  <c:v>442</c:v>
                </c:pt>
                <c:pt idx="63">
                  <c:v>443</c:v>
                </c:pt>
                <c:pt idx="64">
                  <c:v>444</c:v>
                </c:pt>
                <c:pt idx="65">
                  <c:v>445</c:v>
                </c:pt>
                <c:pt idx="66">
                  <c:v>446</c:v>
                </c:pt>
                <c:pt idx="67">
                  <c:v>447</c:v>
                </c:pt>
                <c:pt idx="68">
                  <c:v>448</c:v>
                </c:pt>
                <c:pt idx="69">
                  <c:v>449</c:v>
                </c:pt>
                <c:pt idx="70">
                  <c:v>450</c:v>
                </c:pt>
                <c:pt idx="71">
                  <c:v>451</c:v>
                </c:pt>
                <c:pt idx="72">
                  <c:v>452</c:v>
                </c:pt>
                <c:pt idx="73">
                  <c:v>453</c:v>
                </c:pt>
                <c:pt idx="74">
                  <c:v>454</c:v>
                </c:pt>
                <c:pt idx="75">
                  <c:v>455</c:v>
                </c:pt>
                <c:pt idx="76">
                  <c:v>456</c:v>
                </c:pt>
                <c:pt idx="77">
                  <c:v>457</c:v>
                </c:pt>
                <c:pt idx="78">
                  <c:v>458</c:v>
                </c:pt>
                <c:pt idx="79">
                  <c:v>459</c:v>
                </c:pt>
                <c:pt idx="80">
                  <c:v>460</c:v>
                </c:pt>
                <c:pt idx="81">
                  <c:v>461</c:v>
                </c:pt>
                <c:pt idx="82">
                  <c:v>462</c:v>
                </c:pt>
                <c:pt idx="83">
                  <c:v>463</c:v>
                </c:pt>
                <c:pt idx="84">
                  <c:v>464</c:v>
                </c:pt>
                <c:pt idx="85">
                  <c:v>465</c:v>
                </c:pt>
                <c:pt idx="86">
                  <c:v>466</c:v>
                </c:pt>
                <c:pt idx="87">
                  <c:v>467</c:v>
                </c:pt>
                <c:pt idx="88">
                  <c:v>468</c:v>
                </c:pt>
                <c:pt idx="89">
                  <c:v>469</c:v>
                </c:pt>
                <c:pt idx="90">
                  <c:v>470</c:v>
                </c:pt>
                <c:pt idx="91">
                  <c:v>471</c:v>
                </c:pt>
                <c:pt idx="92">
                  <c:v>472</c:v>
                </c:pt>
                <c:pt idx="93">
                  <c:v>473</c:v>
                </c:pt>
                <c:pt idx="94">
                  <c:v>474</c:v>
                </c:pt>
                <c:pt idx="95">
                  <c:v>475</c:v>
                </c:pt>
                <c:pt idx="96">
                  <c:v>476</c:v>
                </c:pt>
                <c:pt idx="97">
                  <c:v>477</c:v>
                </c:pt>
                <c:pt idx="98">
                  <c:v>478</c:v>
                </c:pt>
                <c:pt idx="99">
                  <c:v>479</c:v>
                </c:pt>
                <c:pt idx="100">
                  <c:v>480</c:v>
                </c:pt>
                <c:pt idx="101">
                  <c:v>481</c:v>
                </c:pt>
                <c:pt idx="102">
                  <c:v>482</c:v>
                </c:pt>
                <c:pt idx="103">
                  <c:v>483</c:v>
                </c:pt>
                <c:pt idx="104">
                  <c:v>484</c:v>
                </c:pt>
                <c:pt idx="105">
                  <c:v>485</c:v>
                </c:pt>
                <c:pt idx="106">
                  <c:v>486</c:v>
                </c:pt>
                <c:pt idx="107">
                  <c:v>487</c:v>
                </c:pt>
                <c:pt idx="108">
                  <c:v>488</c:v>
                </c:pt>
                <c:pt idx="109">
                  <c:v>489</c:v>
                </c:pt>
                <c:pt idx="110">
                  <c:v>490</c:v>
                </c:pt>
                <c:pt idx="111">
                  <c:v>491</c:v>
                </c:pt>
                <c:pt idx="112">
                  <c:v>492</c:v>
                </c:pt>
                <c:pt idx="113">
                  <c:v>493</c:v>
                </c:pt>
                <c:pt idx="114">
                  <c:v>494</c:v>
                </c:pt>
                <c:pt idx="115">
                  <c:v>495</c:v>
                </c:pt>
                <c:pt idx="116">
                  <c:v>496</c:v>
                </c:pt>
                <c:pt idx="117">
                  <c:v>497</c:v>
                </c:pt>
                <c:pt idx="118">
                  <c:v>498</c:v>
                </c:pt>
                <c:pt idx="119">
                  <c:v>499</c:v>
                </c:pt>
                <c:pt idx="120">
                  <c:v>500</c:v>
                </c:pt>
                <c:pt idx="121">
                  <c:v>501</c:v>
                </c:pt>
                <c:pt idx="122">
                  <c:v>502</c:v>
                </c:pt>
                <c:pt idx="123">
                  <c:v>503</c:v>
                </c:pt>
                <c:pt idx="124">
                  <c:v>504</c:v>
                </c:pt>
                <c:pt idx="125">
                  <c:v>505</c:v>
                </c:pt>
                <c:pt idx="126">
                  <c:v>506</c:v>
                </c:pt>
                <c:pt idx="127">
                  <c:v>507</c:v>
                </c:pt>
                <c:pt idx="128">
                  <c:v>508</c:v>
                </c:pt>
                <c:pt idx="129">
                  <c:v>509</c:v>
                </c:pt>
                <c:pt idx="130">
                  <c:v>510</c:v>
                </c:pt>
                <c:pt idx="131">
                  <c:v>511</c:v>
                </c:pt>
                <c:pt idx="132">
                  <c:v>512</c:v>
                </c:pt>
                <c:pt idx="133">
                  <c:v>513</c:v>
                </c:pt>
                <c:pt idx="134">
                  <c:v>514</c:v>
                </c:pt>
                <c:pt idx="135">
                  <c:v>515</c:v>
                </c:pt>
                <c:pt idx="136">
                  <c:v>516</c:v>
                </c:pt>
                <c:pt idx="137">
                  <c:v>517</c:v>
                </c:pt>
                <c:pt idx="138">
                  <c:v>518</c:v>
                </c:pt>
                <c:pt idx="139">
                  <c:v>519</c:v>
                </c:pt>
                <c:pt idx="140">
                  <c:v>520</c:v>
                </c:pt>
                <c:pt idx="141">
                  <c:v>521</c:v>
                </c:pt>
                <c:pt idx="142">
                  <c:v>522</c:v>
                </c:pt>
                <c:pt idx="143">
                  <c:v>523</c:v>
                </c:pt>
                <c:pt idx="144">
                  <c:v>524</c:v>
                </c:pt>
                <c:pt idx="145">
                  <c:v>525</c:v>
                </c:pt>
                <c:pt idx="146">
                  <c:v>526</c:v>
                </c:pt>
                <c:pt idx="147">
                  <c:v>527</c:v>
                </c:pt>
                <c:pt idx="148">
                  <c:v>528</c:v>
                </c:pt>
                <c:pt idx="149">
                  <c:v>529</c:v>
                </c:pt>
                <c:pt idx="150">
                  <c:v>530</c:v>
                </c:pt>
                <c:pt idx="151">
                  <c:v>531</c:v>
                </c:pt>
                <c:pt idx="152">
                  <c:v>532</c:v>
                </c:pt>
                <c:pt idx="153">
                  <c:v>533</c:v>
                </c:pt>
                <c:pt idx="154">
                  <c:v>534</c:v>
                </c:pt>
                <c:pt idx="155">
                  <c:v>535</c:v>
                </c:pt>
                <c:pt idx="156">
                  <c:v>536</c:v>
                </c:pt>
                <c:pt idx="157">
                  <c:v>537</c:v>
                </c:pt>
                <c:pt idx="158">
                  <c:v>538</c:v>
                </c:pt>
                <c:pt idx="159">
                  <c:v>539</c:v>
                </c:pt>
                <c:pt idx="160">
                  <c:v>540</c:v>
                </c:pt>
                <c:pt idx="161">
                  <c:v>541</c:v>
                </c:pt>
                <c:pt idx="162">
                  <c:v>542</c:v>
                </c:pt>
                <c:pt idx="163">
                  <c:v>543</c:v>
                </c:pt>
                <c:pt idx="164">
                  <c:v>544</c:v>
                </c:pt>
                <c:pt idx="165">
                  <c:v>545</c:v>
                </c:pt>
                <c:pt idx="166">
                  <c:v>546</c:v>
                </c:pt>
                <c:pt idx="167">
                  <c:v>547</c:v>
                </c:pt>
                <c:pt idx="168">
                  <c:v>548</c:v>
                </c:pt>
                <c:pt idx="169">
                  <c:v>549</c:v>
                </c:pt>
                <c:pt idx="170">
                  <c:v>550</c:v>
                </c:pt>
                <c:pt idx="171">
                  <c:v>551</c:v>
                </c:pt>
                <c:pt idx="172">
                  <c:v>552</c:v>
                </c:pt>
                <c:pt idx="173">
                  <c:v>553</c:v>
                </c:pt>
                <c:pt idx="174">
                  <c:v>554</c:v>
                </c:pt>
                <c:pt idx="175">
                  <c:v>555</c:v>
                </c:pt>
                <c:pt idx="176">
                  <c:v>556</c:v>
                </c:pt>
                <c:pt idx="177">
                  <c:v>557</c:v>
                </c:pt>
                <c:pt idx="178">
                  <c:v>558</c:v>
                </c:pt>
                <c:pt idx="179">
                  <c:v>559</c:v>
                </c:pt>
                <c:pt idx="180">
                  <c:v>560</c:v>
                </c:pt>
                <c:pt idx="181">
                  <c:v>561</c:v>
                </c:pt>
                <c:pt idx="182">
                  <c:v>562</c:v>
                </c:pt>
                <c:pt idx="183">
                  <c:v>563</c:v>
                </c:pt>
                <c:pt idx="184">
                  <c:v>564</c:v>
                </c:pt>
                <c:pt idx="185">
                  <c:v>565</c:v>
                </c:pt>
                <c:pt idx="186">
                  <c:v>566</c:v>
                </c:pt>
                <c:pt idx="187">
                  <c:v>567</c:v>
                </c:pt>
                <c:pt idx="188">
                  <c:v>568</c:v>
                </c:pt>
                <c:pt idx="189">
                  <c:v>569</c:v>
                </c:pt>
                <c:pt idx="190">
                  <c:v>570</c:v>
                </c:pt>
                <c:pt idx="191">
                  <c:v>571</c:v>
                </c:pt>
                <c:pt idx="192">
                  <c:v>572</c:v>
                </c:pt>
                <c:pt idx="193">
                  <c:v>573</c:v>
                </c:pt>
                <c:pt idx="194">
                  <c:v>574</c:v>
                </c:pt>
                <c:pt idx="195">
                  <c:v>575</c:v>
                </c:pt>
                <c:pt idx="196">
                  <c:v>576</c:v>
                </c:pt>
                <c:pt idx="197">
                  <c:v>577</c:v>
                </c:pt>
                <c:pt idx="198">
                  <c:v>578</c:v>
                </c:pt>
                <c:pt idx="199">
                  <c:v>579</c:v>
                </c:pt>
                <c:pt idx="200">
                  <c:v>580</c:v>
                </c:pt>
                <c:pt idx="201">
                  <c:v>581</c:v>
                </c:pt>
                <c:pt idx="202">
                  <c:v>582</c:v>
                </c:pt>
                <c:pt idx="203">
                  <c:v>583</c:v>
                </c:pt>
                <c:pt idx="204">
                  <c:v>584</c:v>
                </c:pt>
                <c:pt idx="205">
                  <c:v>585</c:v>
                </c:pt>
                <c:pt idx="206">
                  <c:v>586</c:v>
                </c:pt>
                <c:pt idx="207">
                  <c:v>587</c:v>
                </c:pt>
                <c:pt idx="208">
                  <c:v>588</c:v>
                </c:pt>
                <c:pt idx="209">
                  <c:v>589</c:v>
                </c:pt>
                <c:pt idx="210">
                  <c:v>590</c:v>
                </c:pt>
                <c:pt idx="211">
                  <c:v>591</c:v>
                </c:pt>
                <c:pt idx="212">
                  <c:v>592</c:v>
                </c:pt>
                <c:pt idx="213">
                  <c:v>593</c:v>
                </c:pt>
                <c:pt idx="214">
                  <c:v>594</c:v>
                </c:pt>
                <c:pt idx="215">
                  <c:v>595</c:v>
                </c:pt>
                <c:pt idx="216">
                  <c:v>596</c:v>
                </c:pt>
                <c:pt idx="217">
                  <c:v>597</c:v>
                </c:pt>
                <c:pt idx="218">
                  <c:v>598</c:v>
                </c:pt>
                <c:pt idx="219">
                  <c:v>599</c:v>
                </c:pt>
                <c:pt idx="220">
                  <c:v>600</c:v>
                </c:pt>
                <c:pt idx="221">
                  <c:v>601</c:v>
                </c:pt>
                <c:pt idx="222">
                  <c:v>602</c:v>
                </c:pt>
                <c:pt idx="223">
                  <c:v>603</c:v>
                </c:pt>
                <c:pt idx="224">
                  <c:v>604</c:v>
                </c:pt>
                <c:pt idx="225">
                  <c:v>605</c:v>
                </c:pt>
                <c:pt idx="226">
                  <c:v>606</c:v>
                </c:pt>
                <c:pt idx="227">
                  <c:v>607</c:v>
                </c:pt>
                <c:pt idx="228">
                  <c:v>608</c:v>
                </c:pt>
                <c:pt idx="229">
                  <c:v>609</c:v>
                </c:pt>
                <c:pt idx="230">
                  <c:v>610</c:v>
                </c:pt>
                <c:pt idx="231">
                  <c:v>611</c:v>
                </c:pt>
                <c:pt idx="232">
                  <c:v>612</c:v>
                </c:pt>
                <c:pt idx="233">
                  <c:v>613</c:v>
                </c:pt>
                <c:pt idx="234">
                  <c:v>614</c:v>
                </c:pt>
                <c:pt idx="235">
                  <c:v>615</c:v>
                </c:pt>
                <c:pt idx="236">
                  <c:v>616</c:v>
                </c:pt>
                <c:pt idx="237">
                  <c:v>617</c:v>
                </c:pt>
                <c:pt idx="238">
                  <c:v>618</c:v>
                </c:pt>
                <c:pt idx="239">
                  <c:v>619</c:v>
                </c:pt>
                <c:pt idx="240">
                  <c:v>620</c:v>
                </c:pt>
                <c:pt idx="241">
                  <c:v>621</c:v>
                </c:pt>
                <c:pt idx="242">
                  <c:v>622</c:v>
                </c:pt>
                <c:pt idx="243">
                  <c:v>623</c:v>
                </c:pt>
                <c:pt idx="244">
                  <c:v>624</c:v>
                </c:pt>
                <c:pt idx="245">
                  <c:v>625</c:v>
                </c:pt>
                <c:pt idx="246">
                  <c:v>626</c:v>
                </c:pt>
                <c:pt idx="247">
                  <c:v>627</c:v>
                </c:pt>
                <c:pt idx="248">
                  <c:v>628</c:v>
                </c:pt>
                <c:pt idx="249">
                  <c:v>629</c:v>
                </c:pt>
                <c:pt idx="250">
                  <c:v>630</c:v>
                </c:pt>
                <c:pt idx="251">
                  <c:v>631</c:v>
                </c:pt>
                <c:pt idx="252">
                  <c:v>632</c:v>
                </c:pt>
                <c:pt idx="253">
                  <c:v>633</c:v>
                </c:pt>
                <c:pt idx="254">
                  <c:v>634</c:v>
                </c:pt>
                <c:pt idx="255">
                  <c:v>635</c:v>
                </c:pt>
                <c:pt idx="256">
                  <c:v>636</c:v>
                </c:pt>
                <c:pt idx="257">
                  <c:v>637</c:v>
                </c:pt>
                <c:pt idx="258">
                  <c:v>638</c:v>
                </c:pt>
                <c:pt idx="259">
                  <c:v>639</c:v>
                </c:pt>
                <c:pt idx="260">
                  <c:v>640</c:v>
                </c:pt>
                <c:pt idx="261">
                  <c:v>641</c:v>
                </c:pt>
                <c:pt idx="262">
                  <c:v>642</c:v>
                </c:pt>
                <c:pt idx="263">
                  <c:v>643</c:v>
                </c:pt>
                <c:pt idx="264">
                  <c:v>644</c:v>
                </c:pt>
                <c:pt idx="265">
                  <c:v>645</c:v>
                </c:pt>
                <c:pt idx="266">
                  <c:v>646</c:v>
                </c:pt>
                <c:pt idx="267">
                  <c:v>647</c:v>
                </c:pt>
                <c:pt idx="268">
                  <c:v>648</c:v>
                </c:pt>
                <c:pt idx="269">
                  <c:v>649</c:v>
                </c:pt>
                <c:pt idx="270">
                  <c:v>650</c:v>
                </c:pt>
                <c:pt idx="271">
                  <c:v>651</c:v>
                </c:pt>
                <c:pt idx="272">
                  <c:v>652</c:v>
                </c:pt>
                <c:pt idx="273">
                  <c:v>653</c:v>
                </c:pt>
                <c:pt idx="274">
                  <c:v>654</c:v>
                </c:pt>
                <c:pt idx="275">
                  <c:v>655</c:v>
                </c:pt>
                <c:pt idx="276">
                  <c:v>656</c:v>
                </c:pt>
                <c:pt idx="277">
                  <c:v>657</c:v>
                </c:pt>
                <c:pt idx="278">
                  <c:v>658</c:v>
                </c:pt>
                <c:pt idx="279">
                  <c:v>659</c:v>
                </c:pt>
                <c:pt idx="280">
                  <c:v>660</c:v>
                </c:pt>
                <c:pt idx="281">
                  <c:v>661</c:v>
                </c:pt>
                <c:pt idx="282">
                  <c:v>662</c:v>
                </c:pt>
                <c:pt idx="283">
                  <c:v>663</c:v>
                </c:pt>
                <c:pt idx="284">
                  <c:v>664</c:v>
                </c:pt>
                <c:pt idx="285">
                  <c:v>665</c:v>
                </c:pt>
                <c:pt idx="286">
                  <c:v>666</c:v>
                </c:pt>
                <c:pt idx="287">
                  <c:v>667</c:v>
                </c:pt>
                <c:pt idx="288">
                  <c:v>668</c:v>
                </c:pt>
                <c:pt idx="289">
                  <c:v>669</c:v>
                </c:pt>
                <c:pt idx="290">
                  <c:v>670</c:v>
                </c:pt>
                <c:pt idx="291">
                  <c:v>671</c:v>
                </c:pt>
                <c:pt idx="292">
                  <c:v>672</c:v>
                </c:pt>
                <c:pt idx="293">
                  <c:v>673</c:v>
                </c:pt>
                <c:pt idx="294">
                  <c:v>674</c:v>
                </c:pt>
                <c:pt idx="295">
                  <c:v>675</c:v>
                </c:pt>
                <c:pt idx="296">
                  <c:v>676</c:v>
                </c:pt>
                <c:pt idx="297">
                  <c:v>677</c:v>
                </c:pt>
                <c:pt idx="298">
                  <c:v>678</c:v>
                </c:pt>
                <c:pt idx="299">
                  <c:v>679</c:v>
                </c:pt>
                <c:pt idx="300">
                  <c:v>680</c:v>
                </c:pt>
                <c:pt idx="301">
                  <c:v>681</c:v>
                </c:pt>
                <c:pt idx="302">
                  <c:v>682</c:v>
                </c:pt>
                <c:pt idx="303">
                  <c:v>683</c:v>
                </c:pt>
                <c:pt idx="304">
                  <c:v>684</c:v>
                </c:pt>
                <c:pt idx="305">
                  <c:v>685</c:v>
                </c:pt>
                <c:pt idx="306">
                  <c:v>686</c:v>
                </c:pt>
                <c:pt idx="307">
                  <c:v>687</c:v>
                </c:pt>
                <c:pt idx="308">
                  <c:v>688</c:v>
                </c:pt>
                <c:pt idx="309">
                  <c:v>689</c:v>
                </c:pt>
                <c:pt idx="310">
                  <c:v>690</c:v>
                </c:pt>
                <c:pt idx="311">
                  <c:v>691</c:v>
                </c:pt>
                <c:pt idx="312">
                  <c:v>692</c:v>
                </c:pt>
                <c:pt idx="313">
                  <c:v>693</c:v>
                </c:pt>
                <c:pt idx="314">
                  <c:v>694</c:v>
                </c:pt>
                <c:pt idx="315">
                  <c:v>695</c:v>
                </c:pt>
                <c:pt idx="316">
                  <c:v>696</c:v>
                </c:pt>
                <c:pt idx="317">
                  <c:v>697</c:v>
                </c:pt>
                <c:pt idx="318">
                  <c:v>698</c:v>
                </c:pt>
                <c:pt idx="319">
                  <c:v>699</c:v>
                </c:pt>
                <c:pt idx="320">
                  <c:v>700</c:v>
                </c:pt>
                <c:pt idx="321">
                  <c:v>701</c:v>
                </c:pt>
                <c:pt idx="322">
                  <c:v>702</c:v>
                </c:pt>
                <c:pt idx="323">
                  <c:v>703</c:v>
                </c:pt>
                <c:pt idx="324">
                  <c:v>704</c:v>
                </c:pt>
                <c:pt idx="325">
                  <c:v>705</c:v>
                </c:pt>
                <c:pt idx="326">
                  <c:v>706</c:v>
                </c:pt>
                <c:pt idx="327">
                  <c:v>707</c:v>
                </c:pt>
                <c:pt idx="328">
                  <c:v>708</c:v>
                </c:pt>
                <c:pt idx="329">
                  <c:v>709</c:v>
                </c:pt>
                <c:pt idx="330">
                  <c:v>710</c:v>
                </c:pt>
                <c:pt idx="331">
                  <c:v>711</c:v>
                </c:pt>
                <c:pt idx="332">
                  <c:v>712</c:v>
                </c:pt>
                <c:pt idx="333">
                  <c:v>713</c:v>
                </c:pt>
                <c:pt idx="334">
                  <c:v>714</c:v>
                </c:pt>
                <c:pt idx="335">
                  <c:v>715</c:v>
                </c:pt>
                <c:pt idx="336">
                  <c:v>716</c:v>
                </c:pt>
                <c:pt idx="337">
                  <c:v>717</c:v>
                </c:pt>
                <c:pt idx="338">
                  <c:v>718</c:v>
                </c:pt>
                <c:pt idx="339">
                  <c:v>719</c:v>
                </c:pt>
                <c:pt idx="340">
                  <c:v>720</c:v>
                </c:pt>
                <c:pt idx="341">
                  <c:v>721</c:v>
                </c:pt>
                <c:pt idx="342">
                  <c:v>722</c:v>
                </c:pt>
                <c:pt idx="343">
                  <c:v>723</c:v>
                </c:pt>
                <c:pt idx="344">
                  <c:v>724</c:v>
                </c:pt>
                <c:pt idx="345">
                  <c:v>725</c:v>
                </c:pt>
                <c:pt idx="346">
                  <c:v>726</c:v>
                </c:pt>
                <c:pt idx="347">
                  <c:v>727</c:v>
                </c:pt>
                <c:pt idx="348">
                  <c:v>728</c:v>
                </c:pt>
                <c:pt idx="349">
                  <c:v>729</c:v>
                </c:pt>
                <c:pt idx="350">
                  <c:v>730</c:v>
                </c:pt>
                <c:pt idx="351">
                  <c:v>731</c:v>
                </c:pt>
                <c:pt idx="352">
                  <c:v>732</c:v>
                </c:pt>
                <c:pt idx="353">
                  <c:v>733</c:v>
                </c:pt>
                <c:pt idx="354">
                  <c:v>734</c:v>
                </c:pt>
                <c:pt idx="355">
                  <c:v>735</c:v>
                </c:pt>
                <c:pt idx="356">
                  <c:v>736</c:v>
                </c:pt>
                <c:pt idx="357">
                  <c:v>737</c:v>
                </c:pt>
                <c:pt idx="358">
                  <c:v>738</c:v>
                </c:pt>
                <c:pt idx="359">
                  <c:v>739</c:v>
                </c:pt>
                <c:pt idx="360">
                  <c:v>740</c:v>
                </c:pt>
                <c:pt idx="361">
                  <c:v>741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6</c:v>
                </c:pt>
                <c:pt idx="367">
                  <c:v>747</c:v>
                </c:pt>
                <c:pt idx="368">
                  <c:v>748</c:v>
                </c:pt>
                <c:pt idx="369">
                  <c:v>749</c:v>
                </c:pt>
                <c:pt idx="370">
                  <c:v>750</c:v>
                </c:pt>
                <c:pt idx="371">
                  <c:v>751</c:v>
                </c:pt>
                <c:pt idx="372">
                  <c:v>752</c:v>
                </c:pt>
                <c:pt idx="373">
                  <c:v>753</c:v>
                </c:pt>
                <c:pt idx="374">
                  <c:v>754</c:v>
                </c:pt>
                <c:pt idx="375">
                  <c:v>755</c:v>
                </c:pt>
                <c:pt idx="376">
                  <c:v>756</c:v>
                </c:pt>
                <c:pt idx="377">
                  <c:v>757</c:v>
                </c:pt>
                <c:pt idx="378">
                  <c:v>758</c:v>
                </c:pt>
                <c:pt idx="379">
                  <c:v>759</c:v>
                </c:pt>
                <c:pt idx="380">
                  <c:v>760</c:v>
                </c:pt>
                <c:pt idx="381">
                  <c:v>761</c:v>
                </c:pt>
                <c:pt idx="382">
                  <c:v>762</c:v>
                </c:pt>
                <c:pt idx="383">
                  <c:v>763</c:v>
                </c:pt>
                <c:pt idx="384">
                  <c:v>764</c:v>
                </c:pt>
                <c:pt idx="385">
                  <c:v>765</c:v>
                </c:pt>
                <c:pt idx="386">
                  <c:v>766</c:v>
                </c:pt>
                <c:pt idx="387">
                  <c:v>767</c:v>
                </c:pt>
                <c:pt idx="388">
                  <c:v>768</c:v>
                </c:pt>
                <c:pt idx="389">
                  <c:v>769</c:v>
                </c:pt>
                <c:pt idx="390">
                  <c:v>770</c:v>
                </c:pt>
                <c:pt idx="391">
                  <c:v>771</c:v>
                </c:pt>
                <c:pt idx="392">
                  <c:v>772</c:v>
                </c:pt>
                <c:pt idx="393">
                  <c:v>773</c:v>
                </c:pt>
                <c:pt idx="394">
                  <c:v>774</c:v>
                </c:pt>
                <c:pt idx="395">
                  <c:v>775</c:v>
                </c:pt>
                <c:pt idx="396">
                  <c:v>776</c:v>
                </c:pt>
                <c:pt idx="397">
                  <c:v>777</c:v>
                </c:pt>
                <c:pt idx="398">
                  <c:v>778</c:v>
                </c:pt>
                <c:pt idx="399">
                  <c:v>779</c:v>
                </c:pt>
                <c:pt idx="400">
                  <c:v>780</c:v>
                </c:pt>
              </c:numCache>
            </c:numRef>
          </c:xVal>
          <c:yVal>
            <c:numRef>
              <c:f>Hoja2!$G$7:$G$407</c:f>
              <c:numCache>
                <c:formatCode>General</c:formatCode>
                <c:ptCount val="401"/>
                <c:pt idx="0">
                  <c:v>7.2896819154470403E-3</c:v>
                </c:pt>
                <c:pt idx="1">
                  <c:v>7.0728812459021784E-3</c:v>
                </c:pt>
                <c:pt idx="2">
                  <c:v>6.7502174568459059E-3</c:v>
                </c:pt>
                <c:pt idx="3">
                  <c:v>6.2585226372970301E-3</c:v>
                </c:pt>
                <c:pt idx="4">
                  <c:v>5.6849370079442834E-3</c:v>
                </c:pt>
                <c:pt idx="5">
                  <c:v>5.6763629701656743E-3</c:v>
                </c:pt>
                <c:pt idx="6">
                  <c:v>5.8039236546678554E-3</c:v>
                </c:pt>
                <c:pt idx="7">
                  <c:v>5.54197805151317E-3</c:v>
                </c:pt>
                <c:pt idx="8">
                  <c:v>5.2824821734380866E-3</c:v>
                </c:pt>
                <c:pt idx="9">
                  <c:v>5.3580736901801193E-3</c:v>
                </c:pt>
                <c:pt idx="10">
                  <c:v>5.3820459998876633E-3</c:v>
                </c:pt>
                <c:pt idx="11">
                  <c:v>5.2107402246782857E-3</c:v>
                </c:pt>
                <c:pt idx="12">
                  <c:v>5.1725945055816113E-3</c:v>
                </c:pt>
                <c:pt idx="13">
                  <c:v>5.3906200376662734E-3</c:v>
                </c:pt>
                <c:pt idx="14">
                  <c:v>5.4931585302839397E-3</c:v>
                </c:pt>
                <c:pt idx="15">
                  <c:v>5.470236102753369E-3</c:v>
                </c:pt>
                <c:pt idx="16">
                  <c:v>5.2471361401466724E-3</c:v>
                </c:pt>
                <c:pt idx="17">
                  <c:v>4.8970004341262804E-3</c:v>
                </c:pt>
                <c:pt idx="18">
                  <c:v>4.7251697178284178E-3</c:v>
                </c:pt>
                <c:pt idx="19">
                  <c:v>4.61265734452951E-3</c:v>
                </c:pt>
                <c:pt idx="20">
                  <c:v>4.6835243914751679E-3</c:v>
                </c:pt>
                <c:pt idx="21">
                  <c:v>4.785013001915861E-3</c:v>
                </c:pt>
                <c:pt idx="22">
                  <c:v>5.2161646159259783E-3</c:v>
                </c:pt>
                <c:pt idx="23">
                  <c:v>5.5559764805394726E-3</c:v>
                </c:pt>
                <c:pt idx="24">
                  <c:v>5.388695253675157E-3</c:v>
                </c:pt>
                <c:pt idx="25">
                  <c:v>5.3054046009686565E-3</c:v>
                </c:pt>
                <c:pt idx="26">
                  <c:v>5.4284157960372906E-3</c:v>
                </c:pt>
                <c:pt idx="27">
                  <c:v>5.5841483189549056E-3</c:v>
                </c:pt>
                <c:pt idx="28">
                  <c:v>5.7825760504027438E-3</c:v>
                </c:pt>
                <c:pt idx="29">
                  <c:v>5.8536180777112286E-3</c:v>
                </c:pt>
                <c:pt idx="30">
                  <c:v>5.8259711803842814E-3</c:v>
                </c:pt>
                <c:pt idx="31">
                  <c:v>5.8870393270115265E-3</c:v>
                </c:pt>
                <c:pt idx="32">
                  <c:v>5.9880029963637338E-3</c:v>
                </c:pt>
                <c:pt idx="33">
                  <c:v>6.2648219303588666E-3</c:v>
                </c:pt>
                <c:pt idx="34">
                  <c:v>6.5762869761940975E-3</c:v>
                </c:pt>
                <c:pt idx="35">
                  <c:v>7.0058637669387558E-3</c:v>
                </c:pt>
                <c:pt idx="36">
                  <c:v>7.4566131815856978E-3</c:v>
                </c:pt>
                <c:pt idx="37">
                  <c:v>8.0503215526637525E-3</c:v>
                </c:pt>
                <c:pt idx="38">
                  <c:v>8.6573284313167954E-3</c:v>
                </c:pt>
                <c:pt idx="39">
                  <c:v>9.3024810290665144E-3</c:v>
                </c:pt>
                <c:pt idx="40">
                  <c:v>1.0108090619530224E-2</c:v>
                </c:pt>
                <c:pt idx="41">
                  <c:v>1.1160772482308174E-2</c:v>
                </c:pt>
                <c:pt idx="42">
                  <c:v>1.2138387769432577E-2</c:v>
                </c:pt>
                <c:pt idx="43">
                  <c:v>1.3050910361584673E-2</c:v>
                </c:pt>
                <c:pt idx="44">
                  <c:v>1.4258624825828925E-2</c:v>
                </c:pt>
                <c:pt idx="45">
                  <c:v>1.5608773305415801E-2</c:v>
                </c:pt>
                <c:pt idx="46">
                  <c:v>1.7449391742011756E-2</c:v>
                </c:pt>
                <c:pt idx="47">
                  <c:v>1.940164765009247E-2</c:v>
                </c:pt>
                <c:pt idx="48">
                  <c:v>2.1879544568110847E-2</c:v>
                </c:pt>
                <c:pt idx="49">
                  <c:v>2.4437757472667632E-2</c:v>
                </c:pt>
                <c:pt idx="50">
                  <c:v>2.7502713507976572E-2</c:v>
                </c:pt>
                <c:pt idx="51">
                  <c:v>3.0688755954363028E-2</c:v>
                </c:pt>
                <c:pt idx="52">
                  <c:v>3.4248906416477411E-2</c:v>
                </c:pt>
                <c:pt idx="53">
                  <c:v>3.8322274282768617E-2</c:v>
                </c:pt>
                <c:pt idx="54">
                  <c:v>4.320720107185972E-2</c:v>
                </c:pt>
                <c:pt idx="55">
                  <c:v>4.8457486858537305E-2</c:v>
                </c:pt>
                <c:pt idx="56">
                  <c:v>5.4028511650280046E-2</c:v>
                </c:pt>
                <c:pt idx="57">
                  <c:v>6.0690713984623085E-2</c:v>
                </c:pt>
                <c:pt idx="58">
                  <c:v>6.7870508232213647E-2</c:v>
                </c:pt>
                <c:pt idx="59">
                  <c:v>7.626239145311918E-2</c:v>
                </c:pt>
                <c:pt idx="60">
                  <c:v>8.4913595571736972E-2</c:v>
                </c:pt>
                <c:pt idx="61">
                  <c:v>9.5790724885899681E-2</c:v>
                </c:pt>
                <c:pt idx="62">
                  <c:v>0.10695552191655293</c:v>
                </c:pt>
                <c:pt idx="63">
                  <c:v>0.119766884161425</c:v>
                </c:pt>
                <c:pt idx="64">
                  <c:v>0.13314028333170311</c:v>
                </c:pt>
                <c:pt idx="65">
                  <c:v>0.14805228483233474</c:v>
                </c:pt>
                <c:pt idx="66">
                  <c:v>0.16388835762906509</c:v>
                </c:pt>
                <c:pt idx="67">
                  <c:v>0.18101508558202059</c:v>
                </c:pt>
                <c:pt idx="68">
                  <c:v>0.19876859319462875</c:v>
                </c:pt>
                <c:pt idx="69">
                  <c:v>0.21699944723703385</c:v>
                </c:pt>
                <c:pt idx="70">
                  <c:v>0.23546774963179759</c:v>
                </c:pt>
                <c:pt idx="71">
                  <c:v>0.25403071640285169</c:v>
                </c:pt>
                <c:pt idx="72">
                  <c:v>0.27197985206110248</c:v>
                </c:pt>
                <c:pt idx="73">
                  <c:v>0.28979845236868296</c:v>
                </c:pt>
                <c:pt idx="74">
                  <c:v>0.30539567697015207</c:v>
                </c:pt>
                <c:pt idx="75">
                  <c:v>0.32039254394675565</c:v>
                </c:pt>
                <c:pt idx="76">
                  <c:v>0.33239444703318177</c:v>
                </c:pt>
                <c:pt idx="77">
                  <c:v>0.34286282221977643</c:v>
                </c:pt>
                <c:pt idx="78">
                  <c:v>0.35006063944473836</c:v>
                </c:pt>
                <c:pt idx="79">
                  <c:v>0.3548753991083351</c:v>
                </c:pt>
                <c:pt idx="80">
                  <c:v>0.35703168211947417</c:v>
                </c:pt>
                <c:pt idx="81">
                  <c:v>0.35613350791707404</c:v>
                </c:pt>
                <c:pt idx="82">
                  <c:v>0.35341798766633414</c:v>
                </c:pt>
                <c:pt idx="83">
                  <c:v>0.34673828729570827</c:v>
                </c:pt>
                <c:pt idx="84">
                  <c:v>0.33895463581599555</c:v>
                </c:pt>
                <c:pt idx="85">
                  <c:v>0.32748502299329457</c:v>
                </c:pt>
                <c:pt idx="86">
                  <c:v>0.31558740820311443</c:v>
                </c:pt>
                <c:pt idx="87">
                  <c:v>0.3019359652363014</c:v>
                </c:pt>
                <c:pt idx="88">
                  <c:v>0.28806912144284613</c:v>
                </c:pt>
                <c:pt idx="89">
                  <c:v>0.27357234834320721</c:v>
                </c:pt>
                <c:pt idx="90">
                  <c:v>0.25904250395499367</c:v>
                </c:pt>
                <c:pt idx="91">
                  <c:v>0.24446401502591369</c:v>
                </c:pt>
                <c:pt idx="92">
                  <c:v>0.23036864687860406</c:v>
                </c:pt>
                <c:pt idx="93">
                  <c:v>0.21663251341618189</c:v>
                </c:pt>
                <c:pt idx="94">
                  <c:v>0.20382377587675224</c:v>
                </c:pt>
                <c:pt idx="95">
                  <c:v>0.19134942581068842</c:v>
                </c:pt>
                <c:pt idx="96">
                  <c:v>0.18055243750270128</c:v>
                </c:pt>
                <c:pt idx="97">
                  <c:v>0.17003086828580663</c:v>
                </c:pt>
                <c:pt idx="98">
                  <c:v>0.16079767948042031</c:v>
                </c:pt>
                <c:pt idx="99">
                  <c:v>0.15186773164381628</c:v>
                </c:pt>
                <c:pt idx="100">
                  <c:v>0.14396876810499942</c:v>
                </c:pt>
                <c:pt idx="101">
                  <c:v>0.1366316665112258</c:v>
                </c:pt>
                <c:pt idx="102">
                  <c:v>0.13016106767418029</c:v>
                </c:pt>
                <c:pt idx="103">
                  <c:v>0.12404795371839396</c:v>
                </c:pt>
                <c:pt idx="104">
                  <c:v>0.11821515830385936</c:v>
                </c:pt>
                <c:pt idx="105">
                  <c:v>0.11334755457068833</c:v>
                </c:pt>
                <c:pt idx="106">
                  <c:v>0.10883638583659951</c:v>
                </c:pt>
                <c:pt idx="107">
                  <c:v>0.10457596396244433</c:v>
                </c:pt>
                <c:pt idx="108">
                  <c:v>0.10042490481505714</c:v>
                </c:pt>
                <c:pt idx="109">
                  <c:v>9.733177694133277E-2</c:v>
                </c:pt>
                <c:pt idx="110">
                  <c:v>9.4446525738648979E-2</c:v>
                </c:pt>
                <c:pt idx="111">
                  <c:v>9.2210276701697166E-2</c:v>
                </c:pt>
                <c:pt idx="112">
                  <c:v>9.0349010582287406E-2</c:v>
                </c:pt>
                <c:pt idx="113">
                  <c:v>8.9013210492452491E-2</c:v>
                </c:pt>
                <c:pt idx="114">
                  <c:v>8.7956329100966651E-2</c:v>
                </c:pt>
                <c:pt idx="115">
                  <c:v>8.7092451049680955E-2</c:v>
                </c:pt>
                <c:pt idx="116">
                  <c:v>8.6330061608835953E-2</c:v>
                </c:pt>
                <c:pt idx="117">
                  <c:v>8.5599343613662962E-2</c:v>
                </c:pt>
                <c:pt idx="118">
                  <c:v>8.5390417060445409E-2</c:v>
                </c:pt>
                <c:pt idx="119">
                  <c:v>8.5127596555476567E-2</c:v>
                </c:pt>
                <c:pt idx="120">
                  <c:v>8.426599324890767E-2</c:v>
                </c:pt>
                <c:pt idx="121">
                  <c:v>8.364708770558224E-2</c:v>
                </c:pt>
                <c:pt idx="122">
                  <c:v>8.3587069441131978E-2</c:v>
                </c:pt>
                <c:pt idx="123">
                  <c:v>8.3565371876141215E-2</c:v>
                </c:pt>
                <c:pt idx="124">
                  <c:v>8.3584094774963896E-2</c:v>
                </c:pt>
                <c:pt idx="125">
                  <c:v>8.3859863826782052E-2</c:v>
                </c:pt>
                <c:pt idx="126">
                  <c:v>8.4265293327456331E-2</c:v>
                </c:pt>
                <c:pt idx="127">
                  <c:v>8.4575883471477417E-2</c:v>
                </c:pt>
                <c:pt idx="128">
                  <c:v>8.4876849695542919E-2</c:v>
                </c:pt>
                <c:pt idx="129">
                  <c:v>8.5377818474321715E-2</c:v>
                </c:pt>
                <c:pt idx="130">
                  <c:v>8.5903459484259384E-2</c:v>
                </c:pt>
                <c:pt idx="131">
                  <c:v>8.6516065734522959E-2</c:v>
                </c:pt>
                <c:pt idx="132">
                  <c:v>8.7067078897070785E-2</c:v>
                </c:pt>
                <c:pt idx="133">
                  <c:v>8.7530601878204231E-2</c:v>
                </c:pt>
                <c:pt idx="134">
                  <c:v>8.8137958717582926E-2</c:v>
                </c:pt>
                <c:pt idx="135">
                  <c:v>8.8840854835066152E-2</c:v>
                </c:pt>
                <c:pt idx="136">
                  <c:v>8.9579096985840781E-2</c:v>
                </c:pt>
                <c:pt idx="137">
                  <c:v>9.0325738194031183E-2</c:v>
                </c:pt>
                <c:pt idx="138">
                  <c:v>9.1017435568293351E-2</c:v>
                </c:pt>
                <c:pt idx="139">
                  <c:v>9.1736429879156811E-2</c:v>
                </c:pt>
                <c:pt idx="140">
                  <c:v>9.2588409265770152E-2</c:v>
                </c:pt>
                <c:pt idx="141">
                  <c:v>9.350355656336469E-2</c:v>
                </c:pt>
                <c:pt idx="142">
                  <c:v>9.4524392000107801E-2</c:v>
                </c:pt>
                <c:pt idx="143">
                  <c:v>9.5505856855214441E-2</c:v>
                </c:pt>
                <c:pt idx="144">
                  <c:v>9.6457575048640193E-2</c:v>
                </c:pt>
                <c:pt idx="145">
                  <c:v>9.721314025533484E-2</c:v>
                </c:pt>
                <c:pt idx="146">
                  <c:v>9.7903612767057238E-2</c:v>
                </c:pt>
                <c:pt idx="147">
                  <c:v>9.8754367291130768E-2</c:v>
                </c:pt>
                <c:pt idx="148">
                  <c:v>9.9640992789584215E-2</c:v>
                </c:pt>
                <c:pt idx="149">
                  <c:v>0.10071834688352102</c:v>
                </c:pt>
                <c:pt idx="150">
                  <c:v>0.10175598043509569</c:v>
                </c:pt>
                <c:pt idx="151">
                  <c:v>0.10269947455146847</c:v>
                </c:pt>
                <c:pt idx="152">
                  <c:v>0.10369948732503496</c:v>
                </c:pt>
                <c:pt idx="153">
                  <c:v>0.10476161812740567</c:v>
                </c:pt>
                <c:pt idx="154">
                  <c:v>0.10574955725593697</c:v>
                </c:pt>
                <c:pt idx="155">
                  <c:v>0.10670057552791139</c:v>
                </c:pt>
                <c:pt idx="156">
                  <c:v>0.10774993276379559</c:v>
                </c:pt>
                <c:pt idx="157">
                  <c:v>0.10880418944983899</c:v>
                </c:pt>
                <c:pt idx="158">
                  <c:v>0.1095902012396659</c:v>
                </c:pt>
                <c:pt idx="159">
                  <c:v>0.11042608243289898</c:v>
                </c:pt>
                <c:pt idx="160">
                  <c:v>0.11142854493154507</c:v>
                </c:pt>
                <c:pt idx="161">
                  <c:v>0.11244798052538556</c:v>
                </c:pt>
                <c:pt idx="162">
                  <c:v>0.11349068850748223</c:v>
                </c:pt>
                <c:pt idx="163">
                  <c:v>0.11465395795956801</c:v>
                </c:pt>
                <c:pt idx="164">
                  <c:v>0.11589071916404182</c:v>
                </c:pt>
                <c:pt idx="165">
                  <c:v>0.11711173213586107</c:v>
                </c:pt>
                <c:pt idx="166">
                  <c:v>0.11832767067715827</c:v>
                </c:pt>
                <c:pt idx="167">
                  <c:v>0.11953503518067685</c:v>
                </c:pt>
                <c:pt idx="168">
                  <c:v>0.12074782407544314</c:v>
                </c:pt>
                <c:pt idx="169">
                  <c:v>0.12198808488717355</c:v>
                </c:pt>
                <c:pt idx="170">
                  <c:v>0.12315415402506455</c:v>
                </c:pt>
                <c:pt idx="171">
                  <c:v>0.12421383510235567</c:v>
                </c:pt>
                <c:pt idx="172">
                  <c:v>0.12543974752433409</c:v>
                </c:pt>
                <c:pt idx="173">
                  <c:v>0.12677204800691244</c:v>
                </c:pt>
                <c:pt idx="174">
                  <c:v>0.12807162716164178</c:v>
                </c:pt>
                <c:pt idx="175">
                  <c:v>0.1293710313360083</c:v>
                </c:pt>
                <c:pt idx="176">
                  <c:v>0.13100324816047521</c:v>
                </c:pt>
                <c:pt idx="177">
                  <c:v>0.1325985441283852</c:v>
                </c:pt>
                <c:pt idx="178">
                  <c:v>0.13407100388158938</c:v>
                </c:pt>
                <c:pt idx="179">
                  <c:v>0.13549341925102459</c:v>
                </c:pt>
                <c:pt idx="180">
                  <c:v>0.13685214176839008</c:v>
                </c:pt>
                <c:pt idx="181">
                  <c:v>0.13828453101850646</c:v>
                </c:pt>
                <c:pt idx="182">
                  <c:v>0.13975821563425048</c:v>
                </c:pt>
                <c:pt idx="183">
                  <c:v>0.14121597703697703</c:v>
                </c:pt>
                <c:pt idx="184">
                  <c:v>0.14268528714365034</c:v>
                </c:pt>
                <c:pt idx="185">
                  <c:v>0.1443327272596833</c:v>
                </c:pt>
                <c:pt idx="186">
                  <c:v>0.14598051733644193</c:v>
                </c:pt>
                <c:pt idx="187">
                  <c:v>0.1476290073346519</c:v>
                </c:pt>
                <c:pt idx="188">
                  <c:v>0.14926629858964077</c:v>
                </c:pt>
                <c:pt idx="189">
                  <c:v>0.15089151619959454</c:v>
                </c:pt>
                <c:pt idx="190">
                  <c:v>0.15265269355146621</c:v>
                </c:pt>
                <c:pt idx="191">
                  <c:v>0.15446584007109804</c:v>
                </c:pt>
                <c:pt idx="192">
                  <c:v>0.15627496204238481</c:v>
                </c:pt>
                <c:pt idx="193">
                  <c:v>0.15807708479915841</c:v>
                </c:pt>
                <c:pt idx="194">
                  <c:v>0.15984701116917155</c:v>
                </c:pt>
                <c:pt idx="195">
                  <c:v>0.16148255262053218</c:v>
                </c:pt>
                <c:pt idx="196">
                  <c:v>0.16290969245976372</c:v>
                </c:pt>
                <c:pt idx="197">
                  <c:v>0.16460665201847724</c:v>
                </c:pt>
                <c:pt idx="198">
                  <c:v>0.16647141774514357</c:v>
                </c:pt>
                <c:pt idx="199">
                  <c:v>0.16823959431152843</c:v>
                </c:pt>
                <c:pt idx="200">
                  <c:v>0.16999307252743562</c:v>
                </c:pt>
                <c:pt idx="201">
                  <c:v>0.17178452148207671</c:v>
                </c:pt>
                <c:pt idx="202">
                  <c:v>0.17368690798675121</c:v>
                </c:pt>
                <c:pt idx="203">
                  <c:v>0.17584039131208501</c:v>
                </c:pt>
                <c:pt idx="204">
                  <c:v>0.17785529019005844</c:v>
                </c:pt>
                <c:pt idx="205">
                  <c:v>0.17975120242130826</c:v>
                </c:pt>
                <c:pt idx="206">
                  <c:v>0.18183906811058131</c:v>
                </c:pt>
                <c:pt idx="207">
                  <c:v>0.18398065277124276</c:v>
                </c:pt>
                <c:pt idx="208">
                  <c:v>0.18602862293779082</c:v>
                </c:pt>
                <c:pt idx="209">
                  <c:v>0.18809531600316154</c:v>
                </c:pt>
                <c:pt idx="210">
                  <c:v>0.19021887768645165</c:v>
                </c:pt>
                <c:pt idx="211">
                  <c:v>0.19265967876755033</c:v>
                </c:pt>
                <c:pt idx="212">
                  <c:v>0.1954292679504043</c:v>
                </c:pt>
                <c:pt idx="213">
                  <c:v>0.19829982080261047</c:v>
                </c:pt>
                <c:pt idx="214">
                  <c:v>0.20120589466847086</c:v>
                </c:pt>
                <c:pt idx="215">
                  <c:v>0.204494475607475</c:v>
                </c:pt>
                <c:pt idx="216">
                  <c:v>0.20788087056930041</c:v>
                </c:pt>
                <c:pt idx="217">
                  <c:v>0.21157470602861597</c:v>
                </c:pt>
                <c:pt idx="218">
                  <c:v>0.21554343563793554</c:v>
                </c:pt>
                <c:pt idx="219">
                  <c:v>0.2198175059803914</c:v>
                </c:pt>
                <c:pt idx="220">
                  <c:v>0.2241792414846244</c:v>
                </c:pt>
                <c:pt idx="221">
                  <c:v>0.22857527313997189</c:v>
                </c:pt>
                <c:pt idx="222">
                  <c:v>0.23426580951952669</c:v>
                </c:pt>
                <c:pt idx="223">
                  <c:v>0.24020236828921876</c:v>
                </c:pt>
                <c:pt idx="224">
                  <c:v>0.24685774638941144</c:v>
                </c:pt>
                <c:pt idx="225">
                  <c:v>0.25423229378083051</c:v>
                </c:pt>
                <c:pt idx="226">
                  <c:v>0.26236940559345734</c:v>
                </c:pt>
                <c:pt idx="227">
                  <c:v>0.27177355021332733</c:v>
                </c:pt>
                <c:pt idx="228">
                  <c:v>0.28162004519042849</c:v>
                </c:pt>
                <c:pt idx="229">
                  <c:v>0.29331083319174511</c:v>
                </c:pt>
                <c:pt idx="230">
                  <c:v>0.30550363985401741</c:v>
                </c:pt>
                <c:pt idx="231">
                  <c:v>0.31909838918327393</c:v>
                </c:pt>
                <c:pt idx="232">
                  <c:v>0.33385325831808527</c:v>
                </c:pt>
                <c:pt idx="233">
                  <c:v>0.34964611096519693</c:v>
                </c:pt>
                <c:pt idx="234">
                  <c:v>0.36812718692644725</c:v>
                </c:pt>
                <c:pt idx="235">
                  <c:v>0.38750503724719493</c:v>
                </c:pt>
                <c:pt idx="236">
                  <c:v>0.40993384517422532</c:v>
                </c:pt>
                <c:pt idx="237">
                  <c:v>0.4335805164265441</c:v>
                </c:pt>
                <c:pt idx="238">
                  <c:v>0.45969493573583708</c:v>
                </c:pt>
                <c:pt idx="239">
                  <c:v>0.48806135231473652</c:v>
                </c:pt>
                <c:pt idx="240">
                  <c:v>0.51791772668312297</c:v>
                </c:pt>
                <c:pt idx="241">
                  <c:v>0.55164344181474234</c:v>
                </c:pt>
                <c:pt idx="242">
                  <c:v>0.58651265361744775</c:v>
                </c:pt>
                <c:pt idx="243">
                  <c:v>0.62471226666587354</c:v>
                </c:pt>
                <c:pt idx="244">
                  <c:v>0.66457874265060612</c:v>
                </c:pt>
                <c:pt idx="245">
                  <c:v>0.70667026892906937</c:v>
                </c:pt>
                <c:pt idx="246">
                  <c:v>0.75089463085005292</c:v>
                </c:pt>
                <c:pt idx="247">
                  <c:v>0.79600071881933054</c:v>
                </c:pt>
                <c:pt idx="248">
                  <c:v>0.84038378792939972</c:v>
                </c:pt>
                <c:pt idx="249">
                  <c:v>0.88475775806060164</c:v>
                </c:pt>
                <c:pt idx="250">
                  <c:v>0.92912927846672411</c:v>
                </c:pt>
                <c:pt idx="251">
                  <c:v>0.96374179407715976</c:v>
                </c:pt>
                <c:pt idx="252">
                  <c:v>0.99158904391954616</c:v>
                </c:pt>
                <c:pt idx="253">
                  <c:v>0.9956053681875553</c:v>
                </c:pt>
                <c:pt idx="254">
                  <c:v>0.99688989903108116</c:v>
                </c:pt>
                <c:pt idx="255">
                  <c:v>0.99794293085458496</c:v>
                </c:pt>
                <c:pt idx="256">
                  <c:v>0.99897933954361984</c:v>
                </c:pt>
                <c:pt idx="257">
                  <c:v>1</c:v>
                </c:pt>
                <c:pt idx="258">
                  <c:v>0.97941286039174269</c:v>
                </c:pt>
                <c:pt idx="259">
                  <c:v>0.94998343810865826</c:v>
                </c:pt>
                <c:pt idx="260">
                  <c:v>0.89509962244487118</c:v>
                </c:pt>
                <c:pt idx="261">
                  <c:v>0.83495939668170738</c:v>
                </c:pt>
                <c:pt idx="262">
                  <c:v>0.76897395189824824</c:v>
                </c:pt>
                <c:pt idx="263">
                  <c:v>0.69991725178641828</c:v>
                </c:pt>
                <c:pt idx="264">
                  <c:v>0.63036973175685362</c:v>
                </c:pt>
                <c:pt idx="265">
                  <c:v>0.56310395565857629</c:v>
                </c:pt>
                <c:pt idx="266">
                  <c:v>0.49945747338504942</c:v>
                </c:pt>
                <c:pt idx="267">
                  <c:v>0.44036782972030963</c:v>
                </c:pt>
                <c:pt idx="268">
                  <c:v>0.38899307025269092</c:v>
                </c:pt>
                <c:pt idx="269">
                  <c:v>0.3409823082604555</c:v>
                </c:pt>
                <c:pt idx="270">
                  <c:v>0.30258794206820139</c:v>
                </c:pt>
                <c:pt idx="271">
                  <c:v>0.26799327445477433</c:v>
                </c:pt>
                <c:pt idx="272">
                  <c:v>0.23841791854909083</c:v>
                </c:pt>
                <c:pt idx="273">
                  <c:v>0.21413046920809312</c:v>
                </c:pt>
                <c:pt idx="274">
                  <c:v>0.19198162986158879</c:v>
                </c:pt>
                <c:pt idx="275">
                  <c:v>0.17440362755289787</c:v>
                </c:pt>
                <c:pt idx="276">
                  <c:v>0.15859572659458293</c:v>
                </c:pt>
                <c:pt idx="277">
                  <c:v>0.14505837082433423</c:v>
                </c:pt>
                <c:pt idx="278">
                  <c:v>0.13383075584342549</c:v>
                </c:pt>
                <c:pt idx="279">
                  <c:v>0.12348556683226225</c:v>
                </c:pt>
                <c:pt idx="280">
                  <c:v>0.11477469440991987</c:v>
                </c:pt>
                <c:pt idx="281">
                  <c:v>0.10716094886251391</c:v>
                </c:pt>
                <c:pt idx="282">
                  <c:v>0.10081458608307683</c:v>
                </c:pt>
                <c:pt idx="283">
                  <c:v>9.5273482933377812E-2</c:v>
                </c:pt>
                <c:pt idx="284">
                  <c:v>9.0120486228433022E-2</c:v>
                </c:pt>
                <c:pt idx="285">
                  <c:v>8.6025595777513883E-2</c:v>
                </c:pt>
                <c:pt idx="286">
                  <c:v>8.2159754621537601E-2</c:v>
                </c:pt>
                <c:pt idx="287">
                  <c:v>7.8515963545991066E-2</c:v>
                </c:pt>
                <c:pt idx="288">
                  <c:v>7.5406737478886446E-2</c:v>
                </c:pt>
                <c:pt idx="289">
                  <c:v>7.25545575647773E-2</c:v>
                </c:pt>
                <c:pt idx="290">
                  <c:v>7.0319008449276785E-2</c:v>
                </c:pt>
                <c:pt idx="291">
                  <c:v>6.7643033760536223E-2</c:v>
                </c:pt>
                <c:pt idx="292">
                  <c:v>6.4642470498748286E-2</c:v>
                </c:pt>
                <c:pt idx="293">
                  <c:v>6.2506310229334519E-2</c:v>
                </c:pt>
                <c:pt idx="294">
                  <c:v>6.0537956127873556E-2</c:v>
                </c:pt>
                <c:pt idx="295">
                  <c:v>5.8823148572151499E-2</c:v>
                </c:pt>
                <c:pt idx="296">
                  <c:v>5.7126888934889285E-2</c:v>
                </c:pt>
                <c:pt idx="297">
                  <c:v>5.544515266774188E-2</c:v>
                </c:pt>
                <c:pt idx="298">
                  <c:v>5.3968143425104129E-2</c:v>
                </c:pt>
                <c:pt idx="299">
                  <c:v>5.2461737481511145E-2</c:v>
                </c:pt>
                <c:pt idx="300">
                  <c:v>5.0911761427573796E-2</c:v>
                </c:pt>
                <c:pt idx="301">
                  <c:v>4.9500719781722498E-2</c:v>
                </c:pt>
                <c:pt idx="302">
                  <c:v>4.8086353508977463E-2</c:v>
                </c:pt>
                <c:pt idx="303">
                  <c:v>4.6397793007679718E-2</c:v>
                </c:pt>
                <c:pt idx="304">
                  <c:v>4.5085790247189513E-2</c:v>
                </c:pt>
                <c:pt idx="305">
                  <c:v>4.4124798094533853E-2</c:v>
                </c:pt>
                <c:pt idx="306">
                  <c:v>4.2763275891363091E-2</c:v>
                </c:pt>
                <c:pt idx="307">
                  <c:v>4.147349563695215E-2</c:v>
                </c:pt>
                <c:pt idx="308">
                  <c:v>4.0495880349827748E-2</c:v>
                </c:pt>
                <c:pt idx="309">
                  <c:v>3.9736290594788004E-2</c:v>
                </c:pt>
                <c:pt idx="310">
                  <c:v>3.9071890157127122E-2</c:v>
                </c:pt>
                <c:pt idx="311">
                  <c:v>3.7976513085818953E-2</c:v>
                </c:pt>
                <c:pt idx="312">
                  <c:v>3.6963551765403134E-2</c:v>
                </c:pt>
                <c:pt idx="313">
                  <c:v>3.6059428230666817E-2</c:v>
                </c:pt>
                <c:pt idx="314">
                  <c:v>3.4936404262031692E-2</c:v>
                </c:pt>
                <c:pt idx="315">
                  <c:v>3.3824054095529132E-2</c:v>
                </c:pt>
                <c:pt idx="316">
                  <c:v>3.2932004205828001E-2</c:v>
                </c:pt>
                <c:pt idx="317">
                  <c:v>3.2160340805753078E-2</c:v>
                </c:pt>
                <c:pt idx="318">
                  <c:v>3.1466893627862612E-2</c:v>
                </c:pt>
                <c:pt idx="319">
                  <c:v>3.0870560551342126E-2</c:v>
                </c:pt>
                <c:pt idx="320">
                  <c:v>3.017536356982338E-2</c:v>
                </c:pt>
                <c:pt idx="321">
                  <c:v>2.9332483162077139E-2</c:v>
                </c:pt>
                <c:pt idx="322">
                  <c:v>2.8695729621743205E-2</c:v>
                </c:pt>
                <c:pt idx="323">
                  <c:v>2.8121969012027632E-2</c:v>
                </c:pt>
                <c:pt idx="324">
                  <c:v>2.7602277334426148E-2</c:v>
                </c:pt>
                <c:pt idx="325">
                  <c:v>2.6833763580882141E-2</c:v>
                </c:pt>
                <c:pt idx="326">
                  <c:v>2.5911267108048801E-2</c:v>
                </c:pt>
                <c:pt idx="327">
                  <c:v>2.5096033597629505E-2</c:v>
                </c:pt>
                <c:pt idx="328">
                  <c:v>2.4450356058791308E-2</c:v>
                </c:pt>
                <c:pt idx="329">
                  <c:v>2.4024978796754536E-2</c:v>
                </c:pt>
                <c:pt idx="330">
                  <c:v>2.3549907111674397E-2</c:v>
                </c:pt>
                <c:pt idx="331">
                  <c:v>2.3147277296805369E-2</c:v>
                </c:pt>
                <c:pt idx="332">
                  <c:v>2.2972646894702242E-2</c:v>
                </c:pt>
                <c:pt idx="333">
                  <c:v>2.2422683614331383E-2</c:v>
                </c:pt>
                <c:pt idx="334">
                  <c:v>2.1749009217440576E-2</c:v>
                </c:pt>
                <c:pt idx="335">
                  <c:v>2.1508761179276657E-2</c:v>
                </c:pt>
                <c:pt idx="336">
                  <c:v>2.0898254693367039E-2</c:v>
                </c:pt>
                <c:pt idx="337">
                  <c:v>1.9956685360985368E-2</c:v>
                </c:pt>
                <c:pt idx="338">
                  <c:v>1.955668025155877E-2</c:v>
                </c:pt>
                <c:pt idx="339">
                  <c:v>1.9212668858237386E-2</c:v>
                </c:pt>
                <c:pt idx="340">
                  <c:v>1.8917302005782403E-2</c:v>
                </c:pt>
                <c:pt idx="341">
                  <c:v>1.8559817124523204E-2</c:v>
                </c:pt>
                <c:pt idx="342">
                  <c:v>1.821965529918405E-2</c:v>
                </c:pt>
                <c:pt idx="343">
                  <c:v>1.7977832437754675E-2</c:v>
                </c:pt>
                <c:pt idx="344">
                  <c:v>1.7633121122981973E-2</c:v>
                </c:pt>
                <c:pt idx="345">
                  <c:v>1.7264262518138906E-2</c:v>
                </c:pt>
                <c:pt idx="346">
                  <c:v>1.7072659020841388E-2</c:v>
                </c:pt>
                <c:pt idx="347">
                  <c:v>1.6586388592540205E-2</c:v>
                </c:pt>
                <c:pt idx="348">
                  <c:v>1.587771812308364E-2</c:v>
                </c:pt>
                <c:pt idx="349">
                  <c:v>1.5557854019832626E-2</c:v>
                </c:pt>
                <c:pt idx="350">
                  <c:v>1.5369925110154517E-2</c:v>
                </c:pt>
                <c:pt idx="351">
                  <c:v>1.5337903703756848E-2</c:v>
                </c:pt>
                <c:pt idx="352">
                  <c:v>1.5127927268362309E-2</c:v>
                </c:pt>
                <c:pt idx="353">
                  <c:v>1.4846033903845141E-2</c:v>
                </c:pt>
                <c:pt idx="354">
                  <c:v>1.4469126202311947E-2</c:v>
                </c:pt>
                <c:pt idx="355">
                  <c:v>1.4351364418128178E-2</c:v>
                </c:pt>
                <c:pt idx="356">
                  <c:v>1.4297470466376912E-2</c:v>
                </c:pt>
                <c:pt idx="357">
                  <c:v>1.4256700041837805E-2</c:v>
                </c:pt>
                <c:pt idx="358">
                  <c:v>1.3669640924547245E-2</c:v>
                </c:pt>
                <c:pt idx="359">
                  <c:v>1.3067708476416235E-2</c:v>
                </c:pt>
                <c:pt idx="360">
                  <c:v>1.3216091824095043E-2</c:v>
                </c:pt>
                <c:pt idx="361">
                  <c:v>1.2997541350921895E-2</c:v>
                </c:pt>
                <c:pt idx="362">
                  <c:v>1.2660704152476488E-2</c:v>
                </c:pt>
                <c:pt idx="363">
                  <c:v>1.2768142095253362E-2</c:v>
                </c:pt>
                <c:pt idx="364">
                  <c:v>1.3081531925079709E-2</c:v>
                </c:pt>
                <c:pt idx="365">
                  <c:v>1.3482061975594789E-2</c:v>
                </c:pt>
                <c:pt idx="366">
                  <c:v>1.3301307260792658E-2</c:v>
                </c:pt>
                <c:pt idx="367">
                  <c:v>1.3354151330366951E-2</c:v>
                </c:pt>
                <c:pt idx="368">
                  <c:v>1.3547329650929927E-2</c:v>
                </c:pt>
                <c:pt idx="369">
                  <c:v>1.2504971629558874E-2</c:v>
                </c:pt>
                <c:pt idx="370">
                  <c:v>1.1983355167966276E-2</c:v>
                </c:pt>
                <c:pt idx="371">
                  <c:v>1.1945909370320916E-2</c:v>
                </c:pt>
                <c:pt idx="372">
                  <c:v>1.1920887178436401E-2</c:v>
                </c:pt>
                <c:pt idx="373">
                  <c:v>1.1841446093712134E-2</c:v>
                </c:pt>
                <c:pt idx="374">
                  <c:v>1.170583631251983E-2</c:v>
                </c:pt>
                <c:pt idx="375">
                  <c:v>1.2787564915527357E-2</c:v>
                </c:pt>
                <c:pt idx="376">
                  <c:v>1.3063158986982688E-2</c:v>
                </c:pt>
                <c:pt idx="377">
                  <c:v>1.2442503640028999E-2</c:v>
                </c:pt>
                <c:pt idx="378">
                  <c:v>1.2603485573831478E-2</c:v>
                </c:pt>
                <c:pt idx="379">
                  <c:v>1.2405582783472126E-2</c:v>
                </c:pt>
                <c:pt idx="380">
                  <c:v>1.179332649393422E-2</c:v>
                </c:pt>
                <c:pt idx="381">
                  <c:v>1.1703386587440226E-2</c:v>
                </c:pt>
                <c:pt idx="382">
                  <c:v>1.1554128337947275E-2</c:v>
                </c:pt>
                <c:pt idx="383">
                  <c:v>1.1331378336066237E-2</c:v>
                </c:pt>
                <c:pt idx="384">
                  <c:v>1.1737332777829009E-2</c:v>
                </c:pt>
                <c:pt idx="385">
                  <c:v>1.2078719465707962E-2</c:v>
                </c:pt>
                <c:pt idx="386">
                  <c:v>1.2344339656482054E-2</c:v>
                </c:pt>
                <c:pt idx="387">
                  <c:v>1.2132963378184885E-2</c:v>
                </c:pt>
                <c:pt idx="388">
                  <c:v>1.193103603948047E-2</c:v>
                </c:pt>
                <c:pt idx="389">
                  <c:v>1.1714935291386924E-2</c:v>
                </c:pt>
                <c:pt idx="390">
                  <c:v>1.11828200080246E-2</c:v>
                </c:pt>
                <c:pt idx="391">
                  <c:v>1.0748693727846394E-2</c:v>
                </c:pt>
                <c:pt idx="392">
                  <c:v>1.0433554094391758E-2</c:v>
                </c:pt>
                <c:pt idx="393">
                  <c:v>1.0493922319567686E-2</c:v>
                </c:pt>
                <c:pt idx="394">
                  <c:v>1.0898826879153488E-2</c:v>
                </c:pt>
                <c:pt idx="395">
                  <c:v>1.1366374408631991E-2</c:v>
                </c:pt>
                <c:pt idx="396">
                  <c:v>1.1283958657739636E-2</c:v>
                </c:pt>
                <c:pt idx="397">
                  <c:v>1.1044410541027035E-2</c:v>
                </c:pt>
                <c:pt idx="398">
                  <c:v>1.0910200602737358E-2</c:v>
                </c:pt>
                <c:pt idx="399">
                  <c:v>1.1244938036828817E-2</c:v>
                </c:pt>
                <c:pt idx="400">
                  <c:v>1.05280434903193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EA9-4877-ADD0-0850626389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9757391"/>
        <c:axId val="849754895"/>
      </c:scatterChart>
      <c:valAx>
        <c:axId val="849757391"/>
        <c:scaling>
          <c:orientation val="minMax"/>
          <c:max val="780"/>
          <c:min val="3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Wavelength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4895"/>
        <c:crosses val="autoZero"/>
        <c:crossBetween val="midCat"/>
      </c:valAx>
      <c:valAx>
        <c:axId val="849754895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0" i="0" baseline="0" dirty="0" err="1">
                    <a:effectLst/>
                  </a:rPr>
                  <a:t>Relativ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spectral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irradianc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composition</a:t>
                </a:r>
                <a:endParaRPr lang="es-ES" sz="10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7391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>
                <a:solidFill>
                  <a:schemeClr val="tx1"/>
                </a:solidFill>
              </a:rPr>
              <a:t>RW6B4-98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Hoja2!$A$7:$A$407</c:f>
              <c:numCache>
                <c:formatCode>General</c:formatCode>
                <c:ptCount val="401"/>
                <c:pt idx="0">
                  <c:v>380</c:v>
                </c:pt>
                <c:pt idx="1">
                  <c:v>381</c:v>
                </c:pt>
                <c:pt idx="2">
                  <c:v>382</c:v>
                </c:pt>
                <c:pt idx="3">
                  <c:v>383</c:v>
                </c:pt>
                <c:pt idx="4">
                  <c:v>384</c:v>
                </c:pt>
                <c:pt idx="5">
                  <c:v>385</c:v>
                </c:pt>
                <c:pt idx="6">
                  <c:v>386</c:v>
                </c:pt>
                <c:pt idx="7">
                  <c:v>387</c:v>
                </c:pt>
                <c:pt idx="8">
                  <c:v>388</c:v>
                </c:pt>
                <c:pt idx="9">
                  <c:v>389</c:v>
                </c:pt>
                <c:pt idx="10">
                  <c:v>390</c:v>
                </c:pt>
                <c:pt idx="11">
                  <c:v>391</c:v>
                </c:pt>
                <c:pt idx="12">
                  <c:v>392</c:v>
                </c:pt>
                <c:pt idx="13">
                  <c:v>393</c:v>
                </c:pt>
                <c:pt idx="14">
                  <c:v>394</c:v>
                </c:pt>
                <c:pt idx="15">
                  <c:v>395</c:v>
                </c:pt>
                <c:pt idx="16">
                  <c:v>396</c:v>
                </c:pt>
                <c:pt idx="17">
                  <c:v>397</c:v>
                </c:pt>
                <c:pt idx="18">
                  <c:v>398</c:v>
                </c:pt>
                <c:pt idx="19">
                  <c:v>399</c:v>
                </c:pt>
                <c:pt idx="20">
                  <c:v>400</c:v>
                </c:pt>
                <c:pt idx="21">
                  <c:v>401</c:v>
                </c:pt>
                <c:pt idx="22">
                  <c:v>402</c:v>
                </c:pt>
                <c:pt idx="23">
                  <c:v>403</c:v>
                </c:pt>
                <c:pt idx="24">
                  <c:v>404</c:v>
                </c:pt>
                <c:pt idx="25">
                  <c:v>405</c:v>
                </c:pt>
                <c:pt idx="26">
                  <c:v>406</c:v>
                </c:pt>
                <c:pt idx="27">
                  <c:v>407</c:v>
                </c:pt>
                <c:pt idx="28">
                  <c:v>408</c:v>
                </c:pt>
                <c:pt idx="29">
                  <c:v>409</c:v>
                </c:pt>
                <c:pt idx="30">
                  <c:v>410</c:v>
                </c:pt>
                <c:pt idx="31">
                  <c:v>411</c:v>
                </c:pt>
                <c:pt idx="32">
                  <c:v>412</c:v>
                </c:pt>
                <c:pt idx="33">
                  <c:v>413</c:v>
                </c:pt>
                <c:pt idx="34">
                  <c:v>414</c:v>
                </c:pt>
                <c:pt idx="35">
                  <c:v>415</c:v>
                </c:pt>
                <c:pt idx="36">
                  <c:v>416</c:v>
                </c:pt>
                <c:pt idx="37">
                  <c:v>417</c:v>
                </c:pt>
                <c:pt idx="38">
                  <c:v>418</c:v>
                </c:pt>
                <c:pt idx="39">
                  <c:v>419</c:v>
                </c:pt>
                <c:pt idx="40">
                  <c:v>420</c:v>
                </c:pt>
                <c:pt idx="41">
                  <c:v>421</c:v>
                </c:pt>
                <c:pt idx="42">
                  <c:v>422</c:v>
                </c:pt>
                <c:pt idx="43">
                  <c:v>423</c:v>
                </c:pt>
                <c:pt idx="44">
                  <c:v>424</c:v>
                </c:pt>
                <c:pt idx="45">
                  <c:v>425</c:v>
                </c:pt>
                <c:pt idx="46">
                  <c:v>426</c:v>
                </c:pt>
                <c:pt idx="47">
                  <c:v>427</c:v>
                </c:pt>
                <c:pt idx="48">
                  <c:v>428</c:v>
                </c:pt>
                <c:pt idx="49">
                  <c:v>429</c:v>
                </c:pt>
                <c:pt idx="50">
                  <c:v>430</c:v>
                </c:pt>
                <c:pt idx="51">
                  <c:v>431</c:v>
                </c:pt>
                <c:pt idx="52">
                  <c:v>432</c:v>
                </c:pt>
                <c:pt idx="53">
                  <c:v>433</c:v>
                </c:pt>
                <c:pt idx="54">
                  <c:v>434</c:v>
                </c:pt>
                <c:pt idx="55">
                  <c:v>435</c:v>
                </c:pt>
                <c:pt idx="56">
                  <c:v>436</c:v>
                </c:pt>
                <c:pt idx="57">
                  <c:v>437</c:v>
                </c:pt>
                <c:pt idx="58">
                  <c:v>438</c:v>
                </c:pt>
                <c:pt idx="59">
                  <c:v>439</c:v>
                </c:pt>
                <c:pt idx="60">
                  <c:v>440</c:v>
                </c:pt>
                <c:pt idx="61">
                  <c:v>441</c:v>
                </c:pt>
                <c:pt idx="62">
                  <c:v>442</c:v>
                </c:pt>
                <c:pt idx="63">
                  <c:v>443</c:v>
                </c:pt>
                <c:pt idx="64">
                  <c:v>444</c:v>
                </c:pt>
                <c:pt idx="65">
                  <c:v>445</c:v>
                </c:pt>
                <c:pt idx="66">
                  <c:v>446</c:v>
                </c:pt>
                <c:pt idx="67">
                  <c:v>447</c:v>
                </c:pt>
                <c:pt idx="68">
                  <c:v>448</c:v>
                </c:pt>
                <c:pt idx="69">
                  <c:v>449</c:v>
                </c:pt>
                <c:pt idx="70">
                  <c:v>450</c:v>
                </c:pt>
                <c:pt idx="71">
                  <c:v>451</c:v>
                </c:pt>
                <c:pt idx="72">
                  <c:v>452</c:v>
                </c:pt>
                <c:pt idx="73">
                  <c:v>453</c:v>
                </c:pt>
                <c:pt idx="74">
                  <c:v>454</c:v>
                </c:pt>
                <c:pt idx="75">
                  <c:v>455</c:v>
                </c:pt>
                <c:pt idx="76">
                  <c:v>456</c:v>
                </c:pt>
                <c:pt idx="77">
                  <c:v>457</c:v>
                </c:pt>
                <c:pt idx="78">
                  <c:v>458</c:v>
                </c:pt>
                <c:pt idx="79">
                  <c:v>459</c:v>
                </c:pt>
                <c:pt idx="80">
                  <c:v>460</c:v>
                </c:pt>
                <c:pt idx="81">
                  <c:v>461</c:v>
                </c:pt>
                <c:pt idx="82">
                  <c:v>462</c:v>
                </c:pt>
                <c:pt idx="83">
                  <c:v>463</c:v>
                </c:pt>
                <c:pt idx="84">
                  <c:v>464</c:v>
                </c:pt>
                <c:pt idx="85">
                  <c:v>465</c:v>
                </c:pt>
                <c:pt idx="86">
                  <c:v>466</c:v>
                </c:pt>
                <c:pt idx="87">
                  <c:v>467</c:v>
                </c:pt>
                <c:pt idx="88">
                  <c:v>468</c:v>
                </c:pt>
                <c:pt idx="89">
                  <c:v>469</c:v>
                </c:pt>
                <c:pt idx="90">
                  <c:v>470</c:v>
                </c:pt>
                <c:pt idx="91">
                  <c:v>471</c:v>
                </c:pt>
                <c:pt idx="92">
                  <c:v>472</c:v>
                </c:pt>
                <c:pt idx="93">
                  <c:v>473</c:v>
                </c:pt>
                <c:pt idx="94">
                  <c:v>474</c:v>
                </c:pt>
                <c:pt idx="95">
                  <c:v>475</c:v>
                </c:pt>
                <c:pt idx="96">
                  <c:v>476</c:v>
                </c:pt>
                <c:pt idx="97">
                  <c:v>477</c:v>
                </c:pt>
                <c:pt idx="98">
                  <c:v>478</c:v>
                </c:pt>
                <c:pt idx="99">
                  <c:v>479</c:v>
                </c:pt>
                <c:pt idx="100">
                  <c:v>480</c:v>
                </c:pt>
                <c:pt idx="101">
                  <c:v>481</c:v>
                </c:pt>
                <c:pt idx="102">
                  <c:v>482</c:v>
                </c:pt>
                <c:pt idx="103">
                  <c:v>483</c:v>
                </c:pt>
                <c:pt idx="104">
                  <c:v>484</c:v>
                </c:pt>
                <c:pt idx="105">
                  <c:v>485</c:v>
                </c:pt>
                <c:pt idx="106">
                  <c:v>486</c:v>
                </c:pt>
                <c:pt idx="107">
                  <c:v>487</c:v>
                </c:pt>
                <c:pt idx="108">
                  <c:v>488</c:v>
                </c:pt>
                <c:pt idx="109">
                  <c:v>489</c:v>
                </c:pt>
                <c:pt idx="110">
                  <c:v>490</c:v>
                </c:pt>
                <c:pt idx="111">
                  <c:v>491</c:v>
                </c:pt>
                <c:pt idx="112">
                  <c:v>492</c:v>
                </c:pt>
                <c:pt idx="113">
                  <c:v>493</c:v>
                </c:pt>
                <c:pt idx="114">
                  <c:v>494</c:v>
                </c:pt>
                <c:pt idx="115">
                  <c:v>495</c:v>
                </c:pt>
                <c:pt idx="116">
                  <c:v>496</c:v>
                </c:pt>
                <c:pt idx="117">
                  <c:v>497</c:v>
                </c:pt>
                <c:pt idx="118">
                  <c:v>498</c:v>
                </c:pt>
                <c:pt idx="119">
                  <c:v>499</c:v>
                </c:pt>
                <c:pt idx="120">
                  <c:v>500</c:v>
                </c:pt>
                <c:pt idx="121">
                  <c:v>501</c:v>
                </c:pt>
                <c:pt idx="122">
                  <c:v>502</c:v>
                </c:pt>
                <c:pt idx="123">
                  <c:v>503</c:v>
                </c:pt>
                <c:pt idx="124">
                  <c:v>504</c:v>
                </c:pt>
                <c:pt idx="125">
                  <c:v>505</c:v>
                </c:pt>
                <c:pt idx="126">
                  <c:v>506</c:v>
                </c:pt>
                <c:pt idx="127">
                  <c:v>507</c:v>
                </c:pt>
                <c:pt idx="128">
                  <c:v>508</c:v>
                </c:pt>
                <c:pt idx="129">
                  <c:v>509</c:v>
                </c:pt>
                <c:pt idx="130">
                  <c:v>510</c:v>
                </c:pt>
                <c:pt idx="131">
                  <c:v>511</c:v>
                </c:pt>
                <c:pt idx="132">
                  <c:v>512</c:v>
                </c:pt>
                <c:pt idx="133">
                  <c:v>513</c:v>
                </c:pt>
                <c:pt idx="134">
                  <c:v>514</c:v>
                </c:pt>
                <c:pt idx="135">
                  <c:v>515</c:v>
                </c:pt>
                <c:pt idx="136">
                  <c:v>516</c:v>
                </c:pt>
                <c:pt idx="137">
                  <c:v>517</c:v>
                </c:pt>
                <c:pt idx="138">
                  <c:v>518</c:v>
                </c:pt>
                <c:pt idx="139">
                  <c:v>519</c:v>
                </c:pt>
                <c:pt idx="140">
                  <c:v>520</c:v>
                </c:pt>
                <c:pt idx="141">
                  <c:v>521</c:v>
                </c:pt>
                <c:pt idx="142">
                  <c:v>522</c:v>
                </c:pt>
                <c:pt idx="143">
                  <c:v>523</c:v>
                </c:pt>
                <c:pt idx="144">
                  <c:v>524</c:v>
                </c:pt>
                <c:pt idx="145">
                  <c:v>525</c:v>
                </c:pt>
                <c:pt idx="146">
                  <c:v>526</c:v>
                </c:pt>
                <c:pt idx="147">
                  <c:v>527</c:v>
                </c:pt>
                <c:pt idx="148">
                  <c:v>528</c:v>
                </c:pt>
                <c:pt idx="149">
                  <c:v>529</c:v>
                </c:pt>
                <c:pt idx="150">
                  <c:v>530</c:v>
                </c:pt>
                <c:pt idx="151">
                  <c:v>531</c:v>
                </c:pt>
                <c:pt idx="152">
                  <c:v>532</c:v>
                </c:pt>
                <c:pt idx="153">
                  <c:v>533</c:v>
                </c:pt>
                <c:pt idx="154">
                  <c:v>534</c:v>
                </c:pt>
                <c:pt idx="155">
                  <c:v>535</c:v>
                </c:pt>
                <c:pt idx="156">
                  <c:v>536</c:v>
                </c:pt>
                <c:pt idx="157">
                  <c:v>537</c:v>
                </c:pt>
                <c:pt idx="158">
                  <c:v>538</c:v>
                </c:pt>
                <c:pt idx="159">
                  <c:v>539</c:v>
                </c:pt>
                <c:pt idx="160">
                  <c:v>540</c:v>
                </c:pt>
                <c:pt idx="161">
                  <c:v>541</c:v>
                </c:pt>
                <c:pt idx="162">
                  <c:v>542</c:v>
                </c:pt>
                <c:pt idx="163">
                  <c:v>543</c:v>
                </c:pt>
                <c:pt idx="164">
                  <c:v>544</c:v>
                </c:pt>
                <c:pt idx="165">
                  <c:v>545</c:v>
                </c:pt>
                <c:pt idx="166">
                  <c:v>546</c:v>
                </c:pt>
                <c:pt idx="167">
                  <c:v>547</c:v>
                </c:pt>
                <c:pt idx="168">
                  <c:v>548</c:v>
                </c:pt>
                <c:pt idx="169">
                  <c:v>549</c:v>
                </c:pt>
                <c:pt idx="170">
                  <c:v>550</c:v>
                </c:pt>
                <c:pt idx="171">
                  <c:v>551</c:v>
                </c:pt>
                <c:pt idx="172">
                  <c:v>552</c:v>
                </c:pt>
                <c:pt idx="173">
                  <c:v>553</c:v>
                </c:pt>
                <c:pt idx="174">
                  <c:v>554</c:v>
                </c:pt>
                <c:pt idx="175">
                  <c:v>555</c:v>
                </c:pt>
                <c:pt idx="176">
                  <c:v>556</c:v>
                </c:pt>
                <c:pt idx="177">
                  <c:v>557</c:v>
                </c:pt>
                <c:pt idx="178">
                  <c:v>558</c:v>
                </c:pt>
                <c:pt idx="179">
                  <c:v>559</c:v>
                </c:pt>
                <c:pt idx="180">
                  <c:v>560</c:v>
                </c:pt>
                <c:pt idx="181">
                  <c:v>561</c:v>
                </c:pt>
                <c:pt idx="182">
                  <c:v>562</c:v>
                </c:pt>
                <c:pt idx="183">
                  <c:v>563</c:v>
                </c:pt>
                <c:pt idx="184">
                  <c:v>564</c:v>
                </c:pt>
                <c:pt idx="185">
                  <c:v>565</c:v>
                </c:pt>
                <c:pt idx="186">
                  <c:v>566</c:v>
                </c:pt>
                <c:pt idx="187">
                  <c:v>567</c:v>
                </c:pt>
                <c:pt idx="188">
                  <c:v>568</c:v>
                </c:pt>
                <c:pt idx="189">
                  <c:v>569</c:v>
                </c:pt>
                <c:pt idx="190">
                  <c:v>570</c:v>
                </c:pt>
                <c:pt idx="191">
                  <c:v>571</c:v>
                </c:pt>
                <c:pt idx="192">
                  <c:v>572</c:v>
                </c:pt>
                <c:pt idx="193">
                  <c:v>573</c:v>
                </c:pt>
                <c:pt idx="194">
                  <c:v>574</c:v>
                </c:pt>
                <c:pt idx="195">
                  <c:v>575</c:v>
                </c:pt>
                <c:pt idx="196">
                  <c:v>576</c:v>
                </c:pt>
                <c:pt idx="197">
                  <c:v>577</c:v>
                </c:pt>
                <c:pt idx="198">
                  <c:v>578</c:v>
                </c:pt>
                <c:pt idx="199">
                  <c:v>579</c:v>
                </c:pt>
                <c:pt idx="200">
                  <c:v>580</c:v>
                </c:pt>
                <c:pt idx="201">
                  <c:v>581</c:v>
                </c:pt>
                <c:pt idx="202">
                  <c:v>582</c:v>
                </c:pt>
                <c:pt idx="203">
                  <c:v>583</c:v>
                </c:pt>
                <c:pt idx="204">
                  <c:v>584</c:v>
                </c:pt>
                <c:pt idx="205">
                  <c:v>585</c:v>
                </c:pt>
                <c:pt idx="206">
                  <c:v>586</c:v>
                </c:pt>
                <c:pt idx="207">
                  <c:v>587</c:v>
                </c:pt>
                <c:pt idx="208">
                  <c:v>588</c:v>
                </c:pt>
                <c:pt idx="209">
                  <c:v>589</c:v>
                </c:pt>
                <c:pt idx="210">
                  <c:v>590</c:v>
                </c:pt>
                <c:pt idx="211">
                  <c:v>591</c:v>
                </c:pt>
                <c:pt idx="212">
                  <c:v>592</c:v>
                </c:pt>
                <c:pt idx="213">
                  <c:v>593</c:v>
                </c:pt>
                <c:pt idx="214">
                  <c:v>594</c:v>
                </c:pt>
                <c:pt idx="215">
                  <c:v>595</c:v>
                </c:pt>
                <c:pt idx="216">
                  <c:v>596</c:v>
                </c:pt>
                <c:pt idx="217">
                  <c:v>597</c:v>
                </c:pt>
                <c:pt idx="218">
                  <c:v>598</c:v>
                </c:pt>
                <c:pt idx="219">
                  <c:v>599</c:v>
                </c:pt>
                <c:pt idx="220">
                  <c:v>600</c:v>
                </c:pt>
                <c:pt idx="221">
                  <c:v>601</c:v>
                </c:pt>
                <c:pt idx="222">
                  <c:v>602</c:v>
                </c:pt>
                <c:pt idx="223">
                  <c:v>603</c:v>
                </c:pt>
                <c:pt idx="224">
                  <c:v>604</c:v>
                </c:pt>
                <c:pt idx="225">
                  <c:v>605</c:v>
                </c:pt>
                <c:pt idx="226">
                  <c:v>606</c:v>
                </c:pt>
                <c:pt idx="227">
                  <c:v>607</c:v>
                </c:pt>
                <c:pt idx="228">
                  <c:v>608</c:v>
                </c:pt>
                <c:pt idx="229">
                  <c:v>609</c:v>
                </c:pt>
                <c:pt idx="230">
                  <c:v>610</c:v>
                </c:pt>
                <c:pt idx="231">
                  <c:v>611</c:v>
                </c:pt>
                <c:pt idx="232">
                  <c:v>612</c:v>
                </c:pt>
                <c:pt idx="233">
                  <c:v>613</c:v>
                </c:pt>
                <c:pt idx="234">
                  <c:v>614</c:v>
                </c:pt>
                <c:pt idx="235">
                  <c:v>615</c:v>
                </c:pt>
                <c:pt idx="236">
                  <c:v>616</c:v>
                </c:pt>
                <c:pt idx="237">
                  <c:v>617</c:v>
                </c:pt>
                <c:pt idx="238">
                  <c:v>618</c:v>
                </c:pt>
                <c:pt idx="239">
                  <c:v>619</c:v>
                </c:pt>
                <c:pt idx="240">
                  <c:v>620</c:v>
                </c:pt>
                <c:pt idx="241">
                  <c:v>621</c:v>
                </c:pt>
                <c:pt idx="242">
                  <c:v>622</c:v>
                </c:pt>
                <c:pt idx="243">
                  <c:v>623</c:v>
                </c:pt>
                <c:pt idx="244">
                  <c:v>624</c:v>
                </c:pt>
                <c:pt idx="245">
                  <c:v>625</c:v>
                </c:pt>
                <c:pt idx="246">
                  <c:v>626</c:v>
                </c:pt>
                <c:pt idx="247">
                  <c:v>627</c:v>
                </c:pt>
                <c:pt idx="248">
                  <c:v>628</c:v>
                </c:pt>
                <c:pt idx="249">
                  <c:v>629</c:v>
                </c:pt>
                <c:pt idx="250">
                  <c:v>630</c:v>
                </c:pt>
                <c:pt idx="251">
                  <c:v>631</c:v>
                </c:pt>
                <c:pt idx="252">
                  <c:v>632</c:v>
                </c:pt>
                <c:pt idx="253">
                  <c:v>633</c:v>
                </c:pt>
                <c:pt idx="254">
                  <c:v>634</c:v>
                </c:pt>
                <c:pt idx="255">
                  <c:v>635</c:v>
                </c:pt>
                <c:pt idx="256">
                  <c:v>636</c:v>
                </c:pt>
                <c:pt idx="257">
                  <c:v>637</c:v>
                </c:pt>
                <c:pt idx="258">
                  <c:v>638</c:v>
                </c:pt>
                <c:pt idx="259">
                  <c:v>639</c:v>
                </c:pt>
                <c:pt idx="260">
                  <c:v>640</c:v>
                </c:pt>
                <c:pt idx="261">
                  <c:v>641</c:v>
                </c:pt>
                <c:pt idx="262">
                  <c:v>642</c:v>
                </c:pt>
                <c:pt idx="263">
                  <c:v>643</c:v>
                </c:pt>
                <c:pt idx="264">
                  <c:v>644</c:v>
                </c:pt>
                <c:pt idx="265">
                  <c:v>645</c:v>
                </c:pt>
                <c:pt idx="266">
                  <c:v>646</c:v>
                </c:pt>
                <c:pt idx="267">
                  <c:v>647</c:v>
                </c:pt>
                <c:pt idx="268">
                  <c:v>648</c:v>
                </c:pt>
                <c:pt idx="269">
                  <c:v>649</c:v>
                </c:pt>
                <c:pt idx="270">
                  <c:v>650</c:v>
                </c:pt>
                <c:pt idx="271">
                  <c:v>651</c:v>
                </c:pt>
                <c:pt idx="272">
                  <c:v>652</c:v>
                </c:pt>
                <c:pt idx="273">
                  <c:v>653</c:v>
                </c:pt>
                <c:pt idx="274">
                  <c:v>654</c:v>
                </c:pt>
                <c:pt idx="275">
                  <c:v>655</c:v>
                </c:pt>
                <c:pt idx="276">
                  <c:v>656</c:v>
                </c:pt>
                <c:pt idx="277">
                  <c:v>657</c:v>
                </c:pt>
                <c:pt idx="278">
                  <c:v>658</c:v>
                </c:pt>
                <c:pt idx="279">
                  <c:v>659</c:v>
                </c:pt>
                <c:pt idx="280">
                  <c:v>660</c:v>
                </c:pt>
                <c:pt idx="281">
                  <c:v>661</c:v>
                </c:pt>
                <c:pt idx="282">
                  <c:v>662</c:v>
                </c:pt>
                <c:pt idx="283">
                  <c:v>663</c:v>
                </c:pt>
                <c:pt idx="284">
                  <c:v>664</c:v>
                </c:pt>
                <c:pt idx="285">
                  <c:v>665</c:v>
                </c:pt>
                <c:pt idx="286">
                  <c:v>666</c:v>
                </c:pt>
                <c:pt idx="287">
                  <c:v>667</c:v>
                </c:pt>
                <c:pt idx="288">
                  <c:v>668</c:v>
                </c:pt>
                <c:pt idx="289">
                  <c:v>669</c:v>
                </c:pt>
                <c:pt idx="290">
                  <c:v>670</c:v>
                </c:pt>
                <c:pt idx="291">
                  <c:v>671</c:v>
                </c:pt>
                <c:pt idx="292">
                  <c:v>672</c:v>
                </c:pt>
                <c:pt idx="293">
                  <c:v>673</c:v>
                </c:pt>
                <c:pt idx="294">
                  <c:v>674</c:v>
                </c:pt>
                <c:pt idx="295">
                  <c:v>675</c:v>
                </c:pt>
                <c:pt idx="296">
                  <c:v>676</c:v>
                </c:pt>
                <c:pt idx="297">
                  <c:v>677</c:v>
                </c:pt>
                <c:pt idx="298">
                  <c:v>678</c:v>
                </c:pt>
                <c:pt idx="299">
                  <c:v>679</c:v>
                </c:pt>
                <c:pt idx="300">
                  <c:v>680</c:v>
                </c:pt>
                <c:pt idx="301">
                  <c:v>681</c:v>
                </c:pt>
                <c:pt idx="302">
                  <c:v>682</c:v>
                </c:pt>
                <c:pt idx="303">
                  <c:v>683</c:v>
                </c:pt>
                <c:pt idx="304">
                  <c:v>684</c:v>
                </c:pt>
                <c:pt idx="305">
                  <c:v>685</c:v>
                </c:pt>
                <c:pt idx="306">
                  <c:v>686</c:v>
                </c:pt>
                <c:pt idx="307">
                  <c:v>687</c:v>
                </c:pt>
                <c:pt idx="308">
                  <c:v>688</c:v>
                </c:pt>
                <c:pt idx="309">
                  <c:v>689</c:v>
                </c:pt>
                <c:pt idx="310">
                  <c:v>690</c:v>
                </c:pt>
                <c:pt idx="311">
                  <c:v>691</c:v>
                </c:pt>
                <c:pt idx="312">
                  <c:v>692</c:v>
                </c:pt>
                <c:pt idx="313">
                  <c:v>693</c:v>
                </c:pt>
                <c:pt idx="314">
                  <c:v>694</c:v>
                </c:pt>
                <c:pt idx="315">
                  <c:v>695</c:v>
                </c:pt>
                <c:pt idx="316">
                  <c:v>696</c:v>
                </c:pt>
                <c:pt idx="317">
                  <c:v>697</c:v>
                </c:pt>
                <c:pt idx="318">
                  <c:v>698</c:v>
                </c:pt>
                <c:pt idx="319">
                  <c:v>699</c:v>
                </c:pt>
                <c:pt idx="320">
                  <c:v>700</c:v>
                </c:pt>
                <c:pt idx="321">
                  <c:v>701</c:v>
                </c:pt>
                <c:pt idx="322">
                  <c:v>702</c:v>
                </c:pt>
                <c:pt idx="323">
                  <c:v>703</c:v>
                </c:pt>
                <c:pt idx="324">
                  <c:v>704</c:v>
                </c:pt>
                <c:pt idx="325">
                  <c:v>705</c:v>
                </c:pt>
                <c:pt idx="326">
                  <c:v>706</c:v>
                </c:pt>
                <c:pt idx="327">
                  <c:v>707</c:v>
                </c:pt>
                <c:pt idx="328">
                  <c:v>708</c:v>
                </c:pt>
                <c:pt idx="329">
                  <c:v>709</c:v>
                </c:pt>
                <c:pt idx="330">
                  <c:v>710</c:v>
                </c:pt>
                <c:pt idx="331">
                  <c:v>711</c:v>
                </c:pt>
                <c:pt idx="332">
                  <c:v>712</c:v>
                </c:pt>
                <c:pt idx="333">
                  <c:v>713</c:v>
                </c:pt>
                <c:pt idx="334">
                  <c:v>714</c:v>
                </c:pt>
                <c:pt idx="335">
                  <c:v>715</c:v>
                </c:pt>
                <c:pt idx="336">
                  <c:v>716</c:v>
                </c:pt>
                <c:pt idx="337">
                  <c:v>717</c:v>
                </c:pt>
                <c:pt idx="338">
                  <c:v>718</c:v>
                </c:pt>
                <c:pt idx="339">
                  <c:v>719</c:v>
                </c:pt>
                <c:pt idx="340">
                  <c:v>720</c:v>
                </c:pt>
                <c:pt idx="341">
                  <c:v>721</c:v>
                </c:pt>
                <c:pt idx="342">
                  <c:v>722</c:v>
                </c:pt>
                <c:pt idx="343">
                  <c:v>723</c:v>
                </c:pt>
                <c:pt idx="344">
                  <c:v>724</c:v>
                </c:pt>
                <c:pt idx="345">
                  <c:v>725</c:v>
                </c:pt>
                <c:pt idx="346">
                  <c:v>726</c:v>
                </c:pt>
                <c:pt idx="347">
                  <c:v>727</c:v>
                </c:pt>
                <c:pt idx="348">
                  <c:v>728</c:v>
                </c:pt>
                <c:pt idx="349">
                  <c:v>729</c:v>
                </c:pt>
                <c:pt idx="350">
                  <c:v>730</c:v>
                </c:pt>
                <c:pt idx="351">
                  <c:v>731</c:v>
                </c:pt>
                <c:pt idx="352">
                  <c:v>732</c:v>
                </c:pt>
                <c:pt idx="353">
                  <c:v>733</c:v>
                </c:pt>
                <c:pt idx="354">
                  <c:v>734</c:v>
                </c:pt>
                <c:pt idx="355">
                  <c:v>735</c:v>
                </c:pt>
                <c:pt idx="356">
                  <c:v>736</c:v>
                </c:pt>
                <c:pt idx="357">
                  <c:v>737</c:v>
                </c:pt>
                <c:pt idx="358">
                  <c:v>738</c:v>
                </c:pt>
                <c:pt idx="359">
                  <c:v>739</c:v>
                </c:pt>
                <c:pt idx="360">
                  <c:v>740</c:v>
                </c:pt>
                <c:pt idx="361">
                  <c:v>741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6</c:v>
                </c:pt>
                <c:pt idx="367">
                  <c:v>747</c:v>
                </c:pt>
                <c:pt idx="368">
                  <c:v>748</c:v>
                </c:pt>
                <c:pt idx="369">
                  <c:v>749</c:v>
                </c:pt>
                <c:pt idx="370">
                  <c:v>750</c:v>
                </c:pt>
                <c:pt idx="371">
                  <c:v>751</c:v>
                </c:pt>
                <c:pt idx="372">
                  <c:v>752</c:v>
                </c:pt>
                <c:pt idx="373">
                  <c:v>753</c:v>
                </c:pt>
                <c:pt idx="374">
                  <c:v>754</c:v>
                </c:pt>
                <c:pt idx="375">
                  <c:v>755</c:v>
                </c:pt>
                <c:pt idx="376">
                  <c:v>756</c:v>
                </c:pt>
                <c:pt idx="377">
                  <c:v>757</c:v>
                </c:pt>
                <c:pt idx="378">
                  <c:v>758</c:v>
                </c:pt>
                <c:pt idx="379">
                  <c:v>759</c:v>
                </c:pt>
                <c:pt idx="380">
                  <c:v>760</c:v>
                </c:pt>
                <c:pt idx="381">
                  <c:v>761</c:v>
                </c:pt>
                <c:pt idx="382">
                  <c:v>762</c:v>
                </c:pt>
                <c:pt idx="383">
                  <c:v>763</c:v>
                </c:pt>
                <c:pt idx="384">
                  <c:v>764</c:v>
                </c:pt>
                <c:pt idx="385">
                  <c:v>765</c:v>
                </c:pt>
                <c:pt idx="386">
                  <c:v>766</c:v>
                </c:pt>
                <c:pt idx="387">
                  <c:v>767</c:v>
                </c:pt>
                <c:pt idx="388">
                  <c:v>768</c:v>
                </c:pt>
                <c:pt idx="389">
                  <c:v>769</c:v>
                </c:pt>
                <c:pt idx="390">
                  <c:v>770</c:v>
                </c:pt>
                <c:pt idx="391">
                  <c:v>771</c:v>
                </c:pt>
                <c:pt idx="392">
                  <c:v>772</c:v>
                </c:pt>
                <c:pt idx="393">
                  <c:v>773</c:v>
                </c:pt>
                <c:pt idx="394">
                  <c:v>774</c:v>
                </c:pt>
                <c:pt idx="395">
                  <c:v>775</c:v>
                </c:pt>
                <c:pt idx="396">
                  <c:v>776</c:v>
                </c:pt>
                <c:pt idx="397">
                  <c:v>777</c:v>
                </c:pt>
                <c:pt idx="398">
                  <c:v>778</c:v>
                </c:pt>
                <c:pt idx="399">
                  <c:v>779</c:v>
                </c:pt>
                <c:pt idx="400">
                  <c:v>780</c:v>
                </c:pt>
              </c:numCache>
            </c:numRef>
          </c:xVal>
          <c:yVal>
            <c:numRef>
              <c:f>Hoja2!$H$7:$H$407</c:f>
              <c:numCache>
                <c:formatCode>General</c:formatCode>
                <c:ptCount val="401"/>
                <c:pt idx="0">
                  <c:v>8.1803441363074835E-3</c:v>
                </c:pt>
                <c:pt idx="1">
                  <c:v>8.0211228832291759E-3</c:v>
                </c:pt>
                <c:pt idx="2">
                  <c:v>7.8936049770027446E-3</c:v>
                </c:pt>
                <c:pt idx="3">
                  <c:v>7.4841034134993552E-3</c:v>
                </c:pt>
                <c:pt idx="4">
                  <c:v>6.9375729397139728E-3</c:v>
                </c:pt>
                <c:pt idx="5">
                  <c:v>6.8311905980554576E-3</c:v>
                </c:pt>
                <c:pt idx="6">
                  <c:v>6.8310144683507252E-3</c:v>
                </c:pt>
                <c:pt idx="7">
                  <c:v>6.5620644092239831E-3</c:v>
                </c:pt>
                <c:pt idx="8">
                  <c:v>6.2902962748215187E-3</c:v>
                </c:pt>
                <c:pt idx="9">
                  <c:v>6.1999417362936741E-3</c:v>
                </c:pt>
                <c:pt idx="10">
                  <c:v>6.1272001682390938E-3</c:v>
                </c:pt>
                <c:pt idx="11">
                  <c:v>6.1212117582781838E-3</c:v>
                </c:pt>
                <c:pt idx="12">
                  <c:v>6.1268479088296282E-3</c:v>
                </c:pt>
                <c:pt idx="13">
                  <c:v>6.1560854398152462E-3</c:v>
                </c:pt>
                <c:pt idx="14">
                  <c:v>6.1835616737535388E-3</c:v>
                </c:pt>
                <c:pt idx="15">
                  <c:v>6.2080437027113751E-3</c:v>
                </c:pt>
                <c:pt idx="16">
                  <c:v>5.9649847101803325E-3</c:v>
                </c:pt>
                <c:pt idx="17">
                  <c:v>5.5517844228775573E-3</c:v>
                </c:pt>
                <c:pt idx="18">
                  <c:v>5.6306905305977799E-3</c:v>
                </c:pt>
                <c:pt idx="19">
                  <c:v>5.8749824310619526E-3</c:v>
                </c:pt>
                <c:pt idx="20">
                  <c:v>5.7569755288910838E-3</c:v>
                </c:pt>
                <c:pt idx="21">
                  <c:v>5.5993394431553701E-3</c:v>
                </c:pt>
                <c:pt idx="22">
                  <c:v>5.9073902967327592E-3</c:v>
                </c:pt>
                <c:pt idx="23">
                  <c:v>6.1754597073358369E-3</c:v>
                </c:pt>
                <c:pt idx="24">
                  <c:v>6.2316450831455487E-3</c:v>
                </c:pt>
                <c:pt idx="25">
                  <c:v>6.3080853749995164E-3</c:v>
                </c:pt>
                <c:pt idx="26">
                  <c:v>6.4371884485685408E-3</c:v>
                </c:pt>
                <c:pt idx="27">
                  <c:v>6.5234920038875349E-3</c:v>
                </c:pt>
                <c:pt idx="28">
                  <c:v>6.5541385725110136E-3</c:v>
                </c:pt>
                <c:pt idx="29">
                  <c:v>6.4803402262280374E-3</c:v>
                </c:pt>
                <c:pt idx="30">
                  <c:v>6.3265789939964427E-3</c:v>
                </c:pt>
                <c:pt idx="31">
                  <c:v>6.4232742018946621E-3</c:v>
                </c:pt>
                <c:pt idx="32">
                  <c:v>6.6279369187939906E-3</c:v>
                </c:pt>
                <c:pt idx="33">
                  <c:v>6.9981615581419998E-3</c:v>
                </c:pt>
                <c:pt idx="34">
                  <c:v>7.4006179334560841E-3</c:v>
                </c:pt>
                <c:pt idx="35">
                  <c:v>7.7872226353442285E-3</c:v>
                </c:pt>
                <c:pt idx="36">
                  <c:v>8.2004229226470046E-3</c:v>
                </c:pt>
                <c:pt idx="37">
                  <c:v>8.8174052783254447E-3</c:v>
                </c:pt>
                <c:pt idx="38">
                  <c:v>9.4918059177467231E-3</c:v>
                </c:pt>
                <c:pt idx="39">
                  <c:v>1.0334058165778211E-2</c:v>
                </c:pt>
                <c:pt idx="40">
                  <c:v>1.1299953466532009E-2</c:v>
                </c:pt>
                <c:pt idx="41">
                  <c:v>1.245730175633019E-2</c:v>
                </c:pt>
                <c:pt idx="42">
                  <c:v>1.3480967600236296E-2</c:v>
                </c:pt>
                <c:pt idx="43">
                  <c:v>1.438715493108573E-2</c:v>
                </c:pt>
                <c:pt idx="44">
                  <c:v>1.5837054660444827E-2</c:v>
                </c:pt>
                <c:pt idx="45">
                  <c:v>1.7550092168674487E-2</c:v>
                </c:pt>
                <c:pt idx="46">
                  <c:v>1.9556914024398193E-2</c:v>
                </c:pt>
                <c:pt idx="47">
                  <c:v>2.1629432259987171E-2</c:v>
                </c:pt>
                <c:pt idx="48">
                  <c:v>2.4488193497502656E-2</c:v>
                </c:pt>
                <c:pt idx="49">
                  <c:v>2.7453337076676656E-2</c:v>
                </c:pt>
                <c:pt idx="50">
                  <c:v>3.1072978638637151E-2</c:v>
                </c:pt>
                <c:pt idx="51">
                  <c:v>3.4823308441509264E-2</c:v>
                </c:pt>
                <c:pt idx="52">
                  <c:v>3.8985429494046285E-2</c:v>
                </c:pt>
                <c:pt idx="53">
                  <c:v>4.3685274535132067E-2</c:v>
                </c:pt>
                <c:pt idx="54">
                  <c:v>4.9237235087714361E-2</c:v>
                </c:pt>
                <c:pt idx="55">
                  <c:v>5.5304903415753816E-2</c:v>
                </c:pt>
                <c:pt idx="56">
                  <c:v>6.1826634122594017E-2</c:v>
                </c:pt>
                <c:pt idx="57">
                  <c:v>6.9740846275050491E-2</c:v>
                </c:pt>
                <c:pt idx="58">
                  <c:v>7.831607320936855E-2</c:v>
                </c:pt>
                <c:pt idx="59">
                  <c:v>8.8340319224522054E-2</c:v>
                </c:pt>
                <c:pt idx="60">
                  <c:v>9.8673144482367123E-2</c:v>
                </c:pt>
                <c:pt idx="61">
                  <c:v>0.11164721079238289</c:v>
                </c:pt>
                <c:pt idx="62">
                  <c:v>0.12497600232773017</c:v>
                </c:pt>
                <c:pt idx="63">
                  <c:v>0.14035054038354708</c:v>
                </c:pt>
                <c:pt idx="64">
                  <c:v>0.15650216269664441</c:v>
                </c:pt>
                <c:pt idx="65">
                  <c:v>0.17478107958350256</c:v>
                </c:pt>
                <c:pt idx="66">
                  <c:v>0.19405530543180485</c:v>
                </c:pt>
                <c:pt idx="67">
                  <c:v>0.21472377402277074</c:v>
                </c:pt>
                <c:pt idx="68">
                  <c:v>0.23647226996315718</c:v>
                </c:pt>
                <c:pt idx="69">
                  <c:v>0.25904382001375925</c:v>
                </c:pt>
                <c:pt idx="70">
                  <c:v>0.28227532806799455</c:v>
                </c:pt>
                <c:pt idx="71">
                  <c:v>0.30576856486346243</c:v>
                </c:pt>
                <c:pt idx="72">
                  <c:v>0.32882887484469764</c:v>
                </c:pt>
                <c:pt idx="73">
                  <c:v>0.35178245022486476</c:v>
                </c:pt>
                <c:pt idx="74">
                  <c:v>0.37225611936239639</c:v>
                </c:pt>
                <c:pt idx="75">
                  <c:v>0.39205591624962088</c:v>
                </c:pt>
                <c:pt idx="76">
                  <c:v>0.40849322094379453</c:v>
                </c:pt>
                <c:pt idx="77">
                  <c:v>0.42306020430341235</c:v>
                </c:pt>
                <c:pt idx="78">
                  <c:v>0.43364119631522563</c:v>
                </c:pt>
                <c:pt idx="79">
                  <c:v>0.4411982174264843</c:v>
                </c:pt>
                <c:pt idx="80">
                  <c:v>0.4453800650059514</c:v>
                </c:pt>
                <c:pt idx="81">
                  <c:v>0.44547024341477448</c:v>
                </c:pt>
                <c:pt idx="82">
                  <c:v>0.44312525252596413</c:v>
                </c:pt>
                <c:pt idx="83">
                  <c:v>0.43563199036781869</c:v>
                </c:pt>
                <c:pt idx="84">
                  <c:v>0.42670520854285432</c:v>
                </c:pt>
                <c:pt idx="85">
                  <c:v>0.41253944865061748</c:v>
                </c:pt>
                <c:pt idx="86">
                  <c:v>0.3977403263401621</c:v>
                </c:pt>
                <c:pt idx="87">
                  <c:v>0.380212426514284</c:v>
                </c:pt>
                <c:pt idx="88">
                  <c:v>0.36236467514461129</c:v>
                </c:pt>
                <c:pt idx="89">
                  <c:v>0.34358343633985561</c:v>
                </c:pt>
                <c:pt idx="90">
                  <c:v>0.32467467962887353</c:v>
                </c:pt>
                <c:pt idx="91">
                  <c:v>0.30558574222995</c:v>
                </c:pt>
                <c:pt idx="92">
                  <c:v>0.28709846390239308</c:v>
                </c:pt>
                <c:pt idx="93">
                  <c:v>0.26905644146840041</c:v>
                </c:pt>
                <c:pt idx="94">
                  <c:v>0.25247365363811758</c:v>
                </c:pt>
                <c:pt idx="95">
                  <c:v>0.23641590845764271</c:v>
                </c:pt>
                <c:pt idx="96">
                  <c:v>0.22224468854455923</c:v>
                </c:pt>
                <c:pt idx="97">
                  <c:v>0.20841234218338131</c:v>
                </c:pt>
                <c:pt idx="98">
                  <c:v>0.19646687334900417</c:v>
                </c:pt>
                <c:pt idx="99">
                  <c:v>0.18485305674863861</c:v>
                </c:pt>
                <c:pt idx="100">
                  <c:v>0.17436329992387675</c:v>
                </c:pt>
                <c:pt idx="101">
                  <c:v>0.16459849296379442</c:v>
                </c:pt>
                <c:pt idx="102">
                  <c:v>0.15594629734850818</c:v>
                </c:pt>
                <c:pt idx="103">
                  <c:v>0.14782918377619975</c:v>
                </c:pt>
                <c:pt idx="104">
                  <c:v>0.14012984986351709</c:v>
                </c:pt>
                <c:pt idx="105">
                  <c:v>0.13351565106169225</c:v>
                </c:pt>
                <c:pt idx="106">
                  <c:v>0.12730249959754361</c:v>
                </c:pt>
                <c:pt idx="107">
                  <c:v>0.12153548467548277</c:v>
                </c:pt>
                <c:pt idx="108">
                  <c:v>0.11591641870539734</c:v>
                </c:pt>
                <c:pt idx="109">
                  <c:v>0.11158855960070689</c:v>
                </c:pt>
                <c:pt idx="110">
                  <c:v>0.10754391706122655</c:v>
                </c:pt>
                <c:pt idx="111">
                  <c:v>0.10437886626718101</c:v>
                </c:pt>
                <c:pt idx="112">
                  <c:v>0.10164498099032096</c:v>
                </c:pt>
                <c:pt idx="113">
                  <c:v>9.9516629638331744E-2</c:v>
                </c:pt>
                <c:pt idx="114">
                  <c:v>9.7687522654683265E-2</c:v>
                </c:pt>
                <c:pt idx="115">
                  <c:v>9.6065896463209843E-2</c:v>
                </c:pt>
                <c:pt idx="116">
                  <c:v>9.4698777695075079E-2</c:v>
                </c:pt>
                <c:pt idx="117">
                  <c:v>9.3408451478203786E-2</c:v>
                </c:pt>
                <c:pt idx="118">
                  <c:v>9.2822115691148815E-2</c:v>
                </c:pt>
                <c:pt idx="119">
                  <c:v>9.2171844821275911E-2</c:v>
                </c:pt>
                <c:pt idx="120">
                  <c:v>9.076826720426151E-2</c:v>
                </c:pt>
                <c:pt idx="121">
                  <c:v>8.9627475106708182E-2</c:v>
                </c:pt>
                <c:pt idx="122">
                  <c:v>8.9087109172588427E-2</c:v>
                </c:pt>
                <c:pt idx="123">
                  <c:v>8.8691874115168406E-2</c:v>
                </c:pt>
                <c:pt idx="124">
                  <c:v>8.844916738204682E-2</c:v>
                </c:pt>
                <c:pt idx="125">
                  <c:v>8.8424685353088978E-2</c:v>
                </c:pt>
                <c:pt idx="126">
                  <c:v>8.8508699222246454E-2</c:v>
                </c:pt>
                <c:pt idx="127">
                  <c:v>8.8485802360631208E-2</c:v>
                </c:pt>
                <c:pt idx="128">
                  <c:v>8.8458502256397648E-2</c:v>
                </c:pt>
                <c:pt idx="129">
                  <c:v>8.8833306268068707E-2</c:v>
                </c:pt>
                <c:pt idx="130">
                  <c:v>8.920652511239717E-2</c:v>
                </c:pt>
                <c:pt idx="131">
                  <c:v>8.9572170379422139E-2</c:v>
                </c:pt>
                <c:pt idx="132">
                  <c:v>8.9934821441466639E-2</c:v>
                </c:pt>
                <c:pt idx="133">
                  <c:v>9.0292188612369179E-2</c:v>
                </c:pt>
                <c:pt idx="134">
                  <c:v>9.0844531366410727E-2</c:v>
                </c:pt>
                <c:pt idx="135">
                  <c:v>9.152738623165918E-2</c:v>
                </c:pt>
                <c:pt idx="136">
                  <c:v>9.2203548168127772E-2</c:v>
                </c:pt>
                <c:pt idx="137">
                  <c:v>9.2877596548139596E-2</c:v>
                </c:pt>
                <c:pt idx="138">
                  <c:v>9.3540372627048521E-2</c:v>
                </c:pt>
                <c:pt idx="139">
                  <c:v>9.4219176509088107E-2</c:v>
                </c:pt>
                <c:pt idx="140">
                  <c:v>9.4968432273020764E-2</c:v>
                </c:pt>
                <c:pt idx="141">
                  <c:v>9.5752209459081014E-2</c:v>
                </c:pt>
                <c:pt idx="142">
                  <c:v>9.6593933317998301E-2</c:v>
                </c:pt>
                <c:pt idx="143">
                  <c:v>9.7526363974852912E-2</c:v>
                </c:pt>
                <c:pt idx="144">
                  <c:v>9.8526604568029572E-2</c:v>
                </c:pt>
                <c:pt idx="145">
                  <c:v>9.9247503449500257E-2</c:v>
                </c:pt>
                <c:pt idx="146">
                  <c:v>9.987470132805322E-2</c:v>
                </c:pt>
                <c:pt idx="147">
                  <c:v>0.10068877282332747</c:v>
                </c:pt>
                <c:pt idx="148">
                  <c:v>0.10153542831397727</c:v>
                </c:pt>
                <c:pt idx="149">
                  <c:v>0.10253619729626813</c:v>
                </c:pt>
                <c:pt idx="150">
                  <c:v>0.10351900104867626</c:v>
                </c:pt>
                <c:pt idx="151">
                  <c:v>0.10445636333726337</c:v>
                </c:pt>
                <c:pt idx="152">
                  <c:v>0.10546470589685775</c:v>
                </c:pt>
                <c:pt idx="153">
                  <c:v>0.10655054552653448</c:v>
                </c:pt>
                <c:pt idx="154">
                  <c:v>0.10757139329516487</c:v>
                </c:pt>
                <c:pt idx="155">
                  <c:v>0.10856124223576229</c:v>
                </c:pt>
                <c:pt idx="156">
                  <c:v>0.1094484075585006</c:v>
                </c:pt>
                <c:pt idx="157">
                  <c:v>0.11031936894840351</c:v>
                </c:pt>
                <c:pt idx="158">
                  <c:v>0.11124440215765935</c:v>
                </c:pt>
                <c:pt idx="159">
                  <c:v>0.11219585482262505</c:v>
                </c:pt>
                <c:pt idx="160">
                  <c:v>0.11323660524789023</c:v>
                </c:pt>
                <c:pt idx="161">
                  <c:v>0.11423015291228705</c:v>
                </c:pt>
                <c:pt idx="162">
                  <c:v>0.11515994162357063</c:v>
                </c:pt>
                <c:pt idx="163">
                  <c:v>0.11629562595968672</c:v>
                </c:pt>
                <c:pt idx="164">
                  <c:v>0.11755724303468663</c:v>
                </c:pt>
                <c:pt idx="165">
                  <c:v>0.11884351826834912</c:v>
                </c:pt>
                <c:pt idx="166">
                  <c:v>0.12013525352285828</c:v>
                </c:pt>
                <c:pt idx="167">
                  <c:v>0.12132941292094558</c:v>
                </c:pt>
                <c:pt idx="168">
                  <c:v>0.122509658072359</c:v>
                </c:pt>
                <c:pt idx="169">
                  <c:v>0.1236400585173331</c:v>
                </c:pt>
                <c:pt idx="170">
                  <c:v>0.12478120287429587</c:v>
                </c:pt>
                <c:pt idx="171">
                  <c:v>0.12593855116409408</c:v>
                </c:pt>
                <c:pt idx="172">
                  <c:v>0.12721566765311043</c:v>
                </c:pt>
                <c:pt idx="173">
                  <c:v>0.12857080960132336</c:v>
                </c:pt>
                <c:pt idx="174">
                  <c:v>0.12993616707241079</c:v>
                </c:pt>
                <c:pt idx="175">
                  <c:v>0.13130575165641178</c:v>
                </c:pt>
                <c:pt idx="176">
                  <c:v>0.13281130837246641</c:v>
                </c:pt>
                <c:pt idx="177">
                  <c:v>0.1343360632263369</c:v>
                </c:pt>
                <c:pt idx="178">
                  <c:v>0.13592563381154896</c:v>
                </c:pt>
                <c:pt idx="179">
                  <c:v>0.13743048600878466</c:v>
                </c:pt>
                <c:pt idx="180">
                  <c:v>0.13882631391879083</c:v>
                </c:pt>
                <c:pt idx="181">
                  <c:v>0.14034296680624359</c:v>
                </c:pt>
                <c:pt idx="182">
                  <c:v>0.1419267251111995</c:v>
                </c:pt>
                <c:pt idx="183">
                  <c:v>0.14342048113703701</c:v>
                </c:pt>
                <c:pt idx="184">
                  <c:v>0.14491001004996096</c:v>
                </c:pt>
                <c:pt idx="185">
                  <c:v>0.14654713565545086</c:v>
                </c:pt>
                <c:pt idx="186">
                  <c:v>0.14821015232753645</c:v>
                </c:pt>
                <c:pt idx="187">
                  <c:v>0.14993551891509738</c:v>
                </c:pt>
                <c:pt idx="188">
                  <c:v>0.15165841968679206</c:v>
                </c:pt>
                <c:pt idx="189">
                  <c:v>0.15337621269704954</c:v>
                </c:pt>
                <c:pt idx="190">
                  <c:v>0.15523261978493155</c:v>
                </c:pt>
                <c:pt idx="191">
                  <c:v>0.15714133739511918</c:v>
                </c:pt>
                <c:pt idx="192">
                  <c:v>0.15880382567809054</c:v>
                </c:pt>
                <c:pt idx="193">
                  <c:v>0.16050858509019778</c:v>
                </c:pt>
                <c:pt idx="194">
                  <c:v>0.16249532815958195</c:v>
                </c:pt>
                <c:pt idx="195">
                  <c:v>0.16432390675411623</c:v>
                </c:pt>
                <c:pt idx="196">
                  <c:v>0.16590836957789107</c:v>
                </c:pt>
                <c:pt idx="197">
                  <c:v>0.16775033402998504</c:v>
                </c:pt>
                <c:pt idx="198">
                  <c:v>0.1697506390866336</c:v>
                </c:pt>
                <c:pt idx="199">
                  <c:v>0.17167661740788506</c:v>
                </c:pt>
                <c:pt idx="200">
                  <c:v>0.17359836861622285</c:v>
                </c:pt>
                <c:pt idx="201">
                  <c:v>0.17563935963466473</c:v>
                </c:pt>
                <c:pt idx="202">
                  <c:v>0.1777840910491941</c:v>
                </c:pt>
                <c:pt idx="203">
                  <c:v>0.18016571691658884</c:v>
                </c:pt>
                <c:pt idx="204">
                  <c:v>0.18246597086039712</c:v>
                </c:pt>
                <c:pt idx="205">
                  <c:v>0.18469665357083601</c:v>
                </c:pt>
                <c:pt idx="206">
                  <c:v>0.18705450192809189</c:v>
                </c:pt>
                <c:pt idx="207">
                  <c:v>0.18944880913422738</c:v>
                </c:pt>
                <c:pt idx="208">
                  <c:v>0.19187922292983312</c:v>
                </c:pt>
                <c:pt idx="209">
                  <c:v>0.19439453124311992</c:v>
                </c:pt>
                <c:pt idx="210">
                  <c:v>0.19716082438565077</c:v>
                </c:pt>
                <c:pt idx="211">
                  <c:v>0.20012667248364369</c:v>
                </c:pt>
                <c:pt idx="212">
                  <c:v>0.2032984162064691</c:v>
                </c:pt>
                <c:pt idx="213">
                  <c:v>0.20683510067750052</c:v>
                </c:pt>
                <c:pt idx="214">
                  <c:v>0.21050353016767198</c:v>
                </c:pt>
                <c:pt idx="215">
                  <c:v>0.21445658526069136</c:v>
                </c:pt>
                <c:pt idx="216">
                  <c:v>0.21857150355236002</c:v>
                </c:pt>
                <c:pt idx="217">
                  <c:v>0.2232195664602544</c:v>
                </c:pt>
                <c:pt idx="218">
                  <c:v>0.22813816459461808</c:v>
                </c:pt>
                <c:pt idx="219">
                  <c:v>0.23335882517259832</c:v>
                </c:pt>
                <c:pt idx="220">
                  <c:v>0.2390402410581591</c:v>
                </c:pt>
                <c:pt idx="221">
                  <c:v>0.24489796277815723</c:v>
                </c:pt>
                <c:pt idx="222">
                  <c:v>0.25213266652975519</c:v>
                </c:pt>
                <c:pt idx="223">
                  <c:v>0.2597092380382392</c:v>
                </c:pt>
                <c:pt idx="224">
                  <c:v>0.26832198059966528</c:v>
                </c:pt>
                <c:pt idx="225">
                  <c:v>0.27778895222904471</c:v>
                </c:pt>
                <c:pt idx="226">
                  <c:v>0.28816263957838778</c:v>
                </c:pt>
                <c:pt idx="227">
                  <c:v>0.30006354759746751</c:v>
                </c:pt>
                <c:pt idx="228">
                  <c:v>0.31249953765952504</c:v>
                </c:pt>
                <c:pt idx="229">
                  <c:v>0.3271970331303497</c:v>
                </c:pt>
                <c:pt idx="230">
                  <c:v>0.34259887129040018</c:v>
                </c:pt>
                <c:pt idx="231">
                  <c:v>0.35995962402648707</c:v>
                </c:pt>
                <c:pt idx="232">
                  <c:v>0.37882364379246708</c:v>
                </c:pt>
                <c:pt idx="233">
                  <c:v>0.39903012416791922</c:v>
                </c:pt>
                <c:pt idx="234">
                  <c:v>0.42223750245260611</c:v>
                </c:pt>
                <c:pt idx="235">
                  <c:v>0.44649637507454693</c:v>
                </c:pt>
                <c:pt idx="236">
                  <c:v>0.4749147268034537</c:v>
                </c:pt>
                <c:pt idx="237">
                  <c:v>0.50473419033350853</c:v>
                </c:pt>
                <c:pt idx="238">
                  <c:v>0.53739603503853894</c:v>
                </c:pt>
                <c:pt idx="239">
                  <c:v>0.57283192259310833</c:v>
                </c:pt>
                <c:pt idx="240">
                  <c:v>0.61010308167099181</c:v>
                </c:pt>
                <c:pt idx="241">
                  <c:v>0.65197263508003511</c:v>
                </c:pt>
                <c:pt idx="242">
                  <c:v>0.69528204882526767</c:v>
                </c:pt>
                <c:pt idx="243">
                  <c:v>0.74302077238511677</c:v>
                </c:pt>
                <c:pt idx="244">
                  <c:v>0.7926918149355876</c:v>
                </c:pt>
                <c:pt idx="245">
                  <c:v>0.84494685638419109</c:v>
                </c:pt>
                <c:pt idx="246">
                  <c:v>0.89952751445408419</c:v>
                </c:pt>
                <c:pt idx="247">
                  <c:v>0.95507054523063661</c:v>
                </c:pt>
                <c:pt idx="248">
                  <c:v>0.9749980361537921</c:v>
                </c:pt>
                <c:pt idx="249">
                  <c:v>0.98906445889255978</c:v>
                </c:pt>
                <c:pt idx="250">
                  <c:v>0.98934274382603737</c:v>
                </c:pt>
                <c:pt idx="251">
                  <c:v>0.99017636571853695</c:v>
                </c:pt>
                <c:pt idx="252">
                  <c:v>0.99139606392381052</c:v>
                </c:pt>
                <c:pt idx="253">
                  <c:v>0.99218477274160322</c:v>
                </c:pt>
                <c:pt idx="254">
                  <c:v>0.99301275848355119</c:v>
                </c:pt>
                <c:pt idx="255">
                  <c:v>0.99416781708718804</c:v>
                </c:pt>
                <c:pt idx="256">
                  <c:v>0.99531494985411173</c:v>
                </c:pt>
                <c:pt idx="257">
                  <c:v>0.99645679872989334</c:v>
                </c:pt>
                <c:pt idx="258">
                  <c:v>0.99727509733808128</c:v>
                </c:pt>
                <c:pt idx="259">
                  <c:v>0.99819326148885246</c:v>
                </c:pt>
                <c:pt idx="260">
                  <c:v>1</c:v>
                </c:pt>
                <c:pt idx="261">
                  <c:v>0.98302426679845856</c:v>
                </c:pt>
                <c:pt idx="262">
                  <c:v>0.9451657151552918</c:v>
                </c:pt>
                <c:pt idx="263">
                  <c:v>0.86978149701090268</c:v>
                </c:pt>
                <c:pt idx="264">
                  <c:v>0.78494792020760751</c:v>
                </c:pt>
                <c:pt idx="265">
                  <c:v>0.70205353145341876</c:v>
                </c:pt>
                <c:pt idx="266">
                  <c:v>0.62298802635041284</c:v>
                </c:pt>
                <c:pt idx="267">
                  <c:v>0.54874090157977784</c:v>
                </c:pt>
                <c:pt idx="268">
                  <c:v>0.48376260252069792</c:v>
                </c:pt>
                <c:pt idx="269">
                  <c:v>0.42284937704684733</c:v>
                </c:pt>
                <c:pt idx="270">
                  <c:v>0.37370813264821223</c:v>
                </c:pt>
                <c:pt idx="271">
                  <c:v>0.32915330576081514</c:v>
                </c:pt>
                <c:pt idx="272">
                  <c:v>0.29065734071622085</c:v>
                </c:pt>
                <c:pt idx="273">
                  <c:v>0.25895822097725923</c:v>
                </c:pt>
                <c:pt idx="274">
                  <c:v>0.23002028661939108</c:v>
                </c:pt>
                <c:pt idx="275">
                  <c:v>0.20707639837298425</c:v>
                </c:pt>
                <c:pt idx="276">
                  <c:v>0.18647168873513156</c:v>
                </c:pt>
                <c:pt idx="277">
                  <c:v>0.16886840539562781</c:v>
                </c:pt>
                <c:pt idx="278">
                  <c:v>0.15429543362604917</c:v>
                </c:pt>
                <c:pt idx="279">
                  <c:v>0.14089513343058041</c:v>
                </c:pt>
                <c:pt idx="280">
                  <c:v>0.12976162253502074</c:v>
                </c:pt>
                <c:pt idx="281">
                  <c:v>0.11988655837977578</c:v>
                </c:pt>
                <c:pt idx="282">
                  <c:v>0.11146068943507101</c:v>
                </c:pt>
                <c:pt idx="283">
                  <c:v>0.10463178852317709</c:v>
                </c:pt>
                <c:pt idx="284">
                  <c:v>9.837847948634941E-2</c:v>
                </c:pt>
                <c:pt idx="285">
                  <c:v>9.3195510665182002E-2</c:v>
                </c:pt>
                <c:pt idx="286">
                  <c:v>8.8441241545333837E-2</c:v>
                </c:pt>
                <c:pt idx="287">
                  <c:v>8.4097178507808013E-2</c:v>
                </c:pt>
                <c:pt idx="288">
                  <c:v>8.0424169645313529E-2</c:v>
                </c:pt>
                <c:pt idx="289">
                  <c:v>7.6985237160408712E-2</c:v>
                </c:pt>
                <c:pt idx="290">
                  <c:v>7.4005827075151367E-2</c:v>
                </c:pt>
                <c:pt idx="291">
                  <c:v>7.1070097156667719E-2</c:v>
                </c:pt>
                <c:pt idx="292">
                  <c:v>6.816871253060694E-2</c:v>
                </c:pt>
                <c:pt idx="293">
                  <c:v>6.5668903631336581E-2</c:v>
                </c:pt>
                <c:pt idx="294">
                  <c:v>6.3356496737901738E-2</c:v>
                </c:pt>
                <c:pt idx="295">
                  <c:v>6.1419950634366352E-2</c:v>
                </c:pt>
                <c:pt idx="296">
                  <c:v>5.954698735423946E-2</c:v>
                </c:pt>
                <c:pt idx="297">
                  <c:v>5.7706255810078648E-2</c:v>
                </c:pt>
                <c:pt idx="298">
                  <c:v>5.5835582216113268E-2</c:v>
                </c:pt>
                <c:pt idx="299">
                  <c:v>5.416869069052356E-2</c:v>
                </c:pt>
                <c:pt idx="300">
                  <c:v>5.2810202277920701E-2</c:v>
                </c:pt>
                <c:pt idx="301">
                  <c:v>5.1319440457063631E-2</c:v>
                </c:pt>
                <c:pt idx="302">
                  <c:v>4.9758402884018241E-2</c:v>
                </c:pt>
                <c:pt idx="303">
                  <c:v>4.8020883346830738E-2</c:v>
                </c:pt>
                <c:pt idx="304">
                  <c:v>4.6449277991501392E-2</c:v>
                </c:pt>
                <c:pt idx="305">
                  <c:v>4.5032842906041495E-2</c:v>
                </c:pt>
                <c:pt idx="306">
                  <c:v>4.4034891999026354E-2</c:v>
                </c:pt>
                <c:pt idx="307">
                  <c:v>4.3030776552345572E-2</c:v>
                </c:pt>
                <c:pt idx="308">
                  <c:v>4.1881177969555629E-2</c:v>
                </c:pt>
                <c:pt idx="309">
                  <c:v>4.0992427479474729E-2</c:v>
                </c:pt>
                <c:pt idx="310">
                  <c:v>4.0225030355954608E-2</c:v>
                </c:pt>
                <c:pt idx="311">
                  <c:v>3.9155923048227487E-2</c:v>
                </c:pt>
                <c:pt idx="312">
                  <c:v>3.8152159860956165E-2</c:v>
                </c:pt>
                <c:pt idx="313">
                  <c:v>3.7234171839889647E-2</c:v>
                </c:pt>
                <c:pt idx="314">
                  <c:v>3.6074709993634671E-2</c:v>
                </c:pt>
                <c:pt idx="315">
                  <c:v>3.4918066222655426E-2</c:v>
                </c:pt>
                <c:pt idx="316">
                  <c:v>3.3968198725032289E-2</c:v>
                </c:pt>
                <c:pt idx="317">
                  <c:v>3.3284815470669651E-2</c:v>
                </c:pt>
                <c:pt idx="318">
                  <c:v>3.2772630289307124E-2</c:v>
                </c:pt>
                <c:pt idx="319">
                  <c:v>3.1906424401432001E-2</c:v>
                </c:pt>
                <c:pt idx="320">
                  <c:v>3.1166151252440714E-2</c:v>
                </c:pt>
                <c:pt idx="321">
                  <c:v>3.0612751720170764E-2</c:v>
                </c:pt>
                <c:pt idx="322">
                  <c:v>2.9868779847380084E-2</c:v>
                </c:pt>
                <c:pt idx="323">
                  <c:v>2.9131853162778717E-2</c:v>
                </c:pt>
                <c:pt idx="324">
                  <c:v>2.8597299508915156E-2</c:v>
                </c:pt>
                <c:pt idx="325">
                  <c:v>2.7724224562555463E-2</c:v>
                </c:pt>
                <c:pt idx="326">
                  <c:v>2.6646839158705894E-2</c:v>
                </c:pt>
                <c:pt idx="327">
                  <c:v>2.5997977326470845E-2</c:v>
                </c:pt>
                <c:pt idx="328">
                  <c:v>2.5426436434613432E-2</c:v>
                </c:pt>
                <c:pt idx="329">
                  <c:v>2.495687464179621E-2</c:v>
                </c:pt>
                <c:pt idx="330">
                  <c:v>2.4514789082917286E-2</c:v>
                </c:pt>
                <c:pt idx="331">
                  <c:v>2.406548220614432E-2</c:v>
                </c:pt>
                <c:pt idx="332">
                  <c:v>2.3579716480491699E-2</c:v>
                </c:pt>
                <c:pt idx="333">
                  <c:v>2.3167925230826787E-2</c:v>
                </c:pt>
                <c:pt idx="334">
                  <c:v>2.2812143227266851E-2</c:v>
                </c:pt>
                <c:pt idx="335">
                  <c:v>2.2636365781943675E-2</c:v>
                </c:pt>
                <c:pt idx="336">
                  <c:v>2.2024491187702486E-2</c:v>
                </c:pt>
                <c:pt idx="337">
                  <c:v>2.1022137038069027E-2</c:v>
                </c:pt>
                <c:pt idx="338">
                  <c:v>2.0575472106867047E-2</c:v>
                </c:pt>
                <c:pt idx="339">
                  <c:v>2.0147300794662003E-2</c:v>
                </c:pt>
                <c:pt idx="340">
                  <c:v>1.970556749519254E-2</c:v>
                </c:pt>
                <c:pt idx="341">
                  <c:v>1.9457576870928982E-2</c:v>
                </c:pt>
                <c:pt idx="342">
                  <c:v>1.9265771622475138E-2</c:v>
                </c:pt>
                <c:pt idx="343">
                  <c:v>1.9112186519948272E-2</c:v>
                </c:pt>
                <c:pt idx="344">
                  <c:v>1.8564423138229761E-2</c:v>
                </c:pt>
                <c:pt idx="345">
                  <c:v>1.7932469757649047E-2</c:v>
                </c:pt>
                <c:pt idx="346">
                  <c:v>1.7983547372021513E-2</c:v>
                </c:pt>
                <c:pt idx="347">
                  <c:v>1.7546041185465634E-2</c:v>
                </c:pt>
                <c:pt idx="348">
                  <c:v>1.6738486489266482E-2</c:v>
                </c:pt>
                <c:pt idx="349">
                  <c:v>1.6440298899154122E-2</c:v>
                </c:pt>
                <c:pt idx="350">
                  <c:v>1.615074166457366E-2</c:v>
                </c:pt>
                <c:pt idx="351">
                  <c:v>1.58692863964109E-2</c:v>
                </c:pt>
                <c:pt idx="352">
                  <c:v>1.578650543518656E-2</c:v>
                </c:pt>
                <c:pt idx="353">
                  <c:v>1.57246839088254E-2</c:v>
                </c:pt>
                <c:pt idx="354">
                  <c:v>1.5664975938921036E-2</c:v>
                </c:pt>
                <c:pt idx="355">
                  <c:v>1.5215316802738606E-2</c:v>
                </c:pt>
                <c:pt idx="356">
                  <c:v>1.4850199924827842E-2</c:v>
                </c:pt>
                <c:pt idx="357">
                  <c:v>1.4944781576269271E-2</c:v>
                </c:pt>
                <c:pt idx="358">
                  <c:v>1.4666496642791698E-2</c:v>
                </c:pt>
                <c:pt idx="359">
                  <c:v>1.4333611500847008E-2</c:v>
                </c:pt>
                <c:pt idx="360">
                  <c:v>1.4335901187008534E-2</c:v>
                </c:pt>
                <c:pt idx="361">
                  <c:v>1.4007595417386894E-2</c:v>
                </c:pt>
                <c:pt idx="362">
                  <c:v>1.3586645423075878E-2</c:v>
                </c:pt>
                <c:pt idx="363">
                  <c:v>1.3659563120835192E-2</c:v>
                </c:pt>
                <c:pt idx="364">
                  <c:v>1.3801523662849698E-2</c:v>
                </c:pt>
                <c:pt idx="365">
                  <c:v>1.3994209559827209E-2</c:v>
                </c:pt>
                <c:pt idx="366">
                  <c:v>1.4256114430764645E-2</c:v>
                </c:pt>
                <c:pt idx="367">
                  <c:v>1.4238853719700848E-2</c:v>
                </c:pt>
                <c:pt idx="368">
                  <c:v>1.3985050815181114E-2</c:v>
                </c:pt>
                <c:pt idx="369">
                  <c:v>1.3403470530153934E-2</c:v>
                </c:pt>
                <c:pt idx="370">
                  <c:v>1.3154070868252514E-2</c:v>
                </c:pt>
                <c:pt idx="371">
                  <c:v>1.3214131097566346E-2</c:v>
                </c:pt>
                <c:pt idx="372">
                  <c:v>1.3112328128230879E-2</c:v>
                </c:pt>
                <c:pt idx="373">
                  <c:v>1.332650184918577E-2</c:v>
                </c:pt>
                <c:pt idx="374">
                  <c:v>1.3863697448620324E-2</c:v>
                </c:pt>
                <c:pt idx="375">
                  <c:v>1.4263864137772881E-2</c:v>
                </c:pt>
                <c:pt idx="376">
                  <c:v>1.4247131815823282E-2</c:v>
                </c:pt>
                <c:pt idx="377">
                  <c:v>1.378003583887232E-2</c:v>
                </c:pt>
                <c:pt idx="378">
                  <c:v>1.4167521189284127E-2</c:v>
                </c:pt>
                <c:pt idx="379">
                  <c:v>1.3956870062423889E-2</c:v>
                </c:pt>
                <c:pt idx="380">
                  <c:v>1.3067591183228788E-2</c:v>
                </c:pt>
                <c:pt idx="381">
                  <c:v>1.3203387185577654E-2</c:v>
                </c:pt>
                <c:pt idx="382">
                  <c:v>1.312183913228644E-2</c:v>
                </c:pt>
                <c:pt idx="383">
                  <c:v>1.2789306249751217E-2</c:v>
                </c:pt>
                <c:pt idx="384">
                  <c:v>1.3257811264340039E-2</c:v>
                </c:pt>
                <c:pt idx="385">
                  <c:v>1.3491359252815522E-2</c:v>
                </c:pt>
                <c:pt idx="386">
                  <c:v>1.3491006993406055E-2</c:v>
                </c:pt>
                <c:pt idx="387">
                  <c:v>1.3318752142177533E-2</c:v>
                </c:pt>
                <c:pt idx="388">
                  <c:v>1.3378812371491364E-2</c:v>
                </c:pt>
                <c:pt idx="389">
                  <c:v>1.3532925863132423E-2</c:v>
                </c:pt>
                <c:pt idx="390">
                  <c:v>1.2243480294784764E-2</c:v>
                </c:pt>
                <c:pt idx="391">
                  <c:v>1.1537024049102144E-2</c:v>
                </c:pt>
                <c:pt idx="392">
                  <c:v>1.1327253570765569E-2</c:v>
                </c:pt>
                <c:pt idx="393">
                  <c:v>1.1798400530925382E-2</c:v>
                </c:pt>
                <c:pt idx="394">
                  <c:v>1.2165454835588204E-2</c:v>
                </c:pt>
                <c:pt idx="395">
                  <c:v>1.2455540459282861E-2</c:v>
                </c:pt>
                <c:pt idx="396">
                  <c:v>1.2651748950355025E-2</c:v>
                </c:pt>
                <c:pt idx="397">
                  <c:v>1.2830696730363387E-2</c:v>
                </c:pt>
                <c:pt idx="398">
                  <c:v>1.2921931917414895E-2</c:v>
                </c:pt>
                <c:pt idx="399">
                  <c:v>1.2783317839790306E-2</c:v>
                </c:pt>
                <c:pt idx="400">
                  <c:v>1.2090775840781564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732-41DD-BBA7-2F61ABE698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9757391"/>
        <c:axId val="849754895"/>
      </c:scatterChart>
      <c:valAx>
        <c:axId val="849757391"/>
        <c:scaling>
          <c:orientation val="minMax"/>
          <c:max val="780"/>
          <c:min val="3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Wavelength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4895"/>
        <c:crosses val="autoZero"/>
        <c:crossBetween val="midCat"/>
      </c:valAx>
      <c:valAx>
        <c:axId val="849754895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0" i="0" baseline="0" dirty="0" err="1">
                    <a:effectLst/>
                  </a:rPr>
                  <a:t>Relativ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spectral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irradianc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composition</a:t>
                </a:r>
                <a:endParaRPr lang="es-ES" sz="10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9757391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MK34 FINAL'!$Q$1</c:f>
              <c:strCache>
                <c:ptCount val="1"/>
                <c:pt idx="0">
                  <c:v>Nº Nudos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605D-4606-8D8E-8DDADF4B903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605D-4606-8D8E-8DDADF4B903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605D-4606-8D8E-8DDADF4B903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605D-4606-8D8E-8DDADF4B903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605D-4606-8D8E-8DDADF4B9037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605D-4606-8D8E-8DDADF4B9037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605D-4606-8D8E-8DDADF4B9037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605D-4606-8D8E-8DDADF4B9037}"/>
              </c:ext>
            </c:extLst>
          </c:dPt>
          <c:errBars>
            <c:errBarType val="both"/>
            <c:errValType val="cust"/>
            <c:noEndCap val="0"/>
            <c:plus>
              <c:numRef>
                <c:f>'AMK34 FINAL'!$Q$11:$Q$18</c:f>
                <c:numCache>
                  <c:formatCode>General</c:formatCode>
                  <c:ptCount val="8"/>
                  <c:pt idx="0">
                    <c:v>0.60848001929750961</c:v>
                  </c:pt>
                  <c:pt idx="1">
                    <c:v>0.64108099994060697</c:v>
                  </c:pt>
                  <c:pt idx="2">
                    <c:v>0.8915285931046929</c:v>
                  </c:pt>
                  <c:pt idx="3">
                    <c:v>0.83899591263256001</c:v>
                  </c:pt>
                  <c:pt idx="4">
                    <c:v>0.73983003781171586</c:v>
                  </c:pt>
                  <c:pt idx="5">
                    <c:v>0.57075176369204139</c:v>
                  </c:pt>
                  <c:pt idx="6">
                    <c:v>0.61699418002264672</c:v>
                  </c:pt>
                  <c:pt idx="7">
                    <c:v>0.76993703008949388</c:v>
                  </c:pt>
                </c:numCache>
              </c:numRef>
            </c:plus>
            <c:minus>
              <c:numRef>
                <c:f>'AMK34 FINAL'!$Q$11:$Q$18</c:f>
                <c:numCache>
                  <c:formatCode>General</c:formatCode>
                  <c:ptCount val="8"/>
                  <c:pt idx="0">
                    <c:v>0.60848001929750961</c:v>
                  </c:pt>
                  <c:pt idx="1">
                    <c:v>0.64108099994060697</c:v>
                  </c:pt>
                  <c:pt idx="2">
                    <c:v>0.8915285931046929</c:v>
                  </c:pt>
                  <c:pt idx="3">
                    <c:v>0.83899591263256001</c:v>
                  </c:pt>
                  <c:pt idx="4">
                    <c:v>0.73983003781171586</c:v>
                  </c:pt>
                  <c:pt idx="5">
                    <c:v>0.57075176369204139</c:v>
                  </c:pt>
                  <c:pt idx="6">
                    <c:v>0.61699418002264672</c:v>
                  </c:pt>
                  <c:pt idx="7">
                    <c:v>0.76993703008949388</c:v>
                  </c:pt>
                </c:numCache>
              </c:numRef>
            </c:minus>
          </c:errBars>
          <c:cat>
            <c:strRef>
              <c:f>'AMK34 FINAL'!$N$2:$N$9</c:f>
              <c:strCache>
                <c:ptCount val="8"/>
                <c:pt idx="0">
                  <c:v>R9B1-56</c:v>
                </c:pt>
                <c:pt idx="1">
                  <c:v>R8B2-30</c:v>
                </c:pt>
                <c:pt idx="2">
                  <c:v>R7B3-34</c:v>
                </c:pt>
                <c:pt idx="3">
                  <c:v>R7B3-52</c:v>
                </c:pt>
                <c:pt idx="4">
                  <c:v>R6B4-40</c:v>
                </c:pt>
                <c:pt idx="5">
                  <c:v>R7B3W-84</c:v>
                </c:pt>
                <c:pt idx="6">
                  <c:v>R6B4W-98</c:v>
                </c:pt>
                <c:pt idx="7">
                  <c:v>TFL-137</c:v>
                </c:pt>
              </c:strCache>
            </c:strRef>
          </c:cat>
          <c:val>
            <c:numRef>
              <c:f>'AMK34 FINAL'!$Q$2:$Q$9</c:f>
              <c:numCache>
                <c:formatCode>General</c:formatCode>
                <c:ptCount val="8"/>
                <c:pt idx="0">
                  <c:v>11.454545454545455</c:v>
                </c:pt>
                <c:pt idx="1">
                  <c:v>10.25</c:v>
                </c:pt>
                <c:pt idx="2">
                  <c:v>10.916666666666666</c:v>
                </c:pt>
                <c:pt idx="3">
                  <c:v>11.583333333333334</c:v>
                </c:pt>
                <c:pt idx="4">
                  <c:v>10.75</c:v>
                </c:pt>
                <c:pt idx="5">
                  <c:v>12.5</c:v>
                </c:pt>
                <c:pt idx="6">
                  <c:v>11.75</c:v>
                </c:pt>
                <c:pt idx="7">
                  <c:v>11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05D-4606-8D8E-8DDADF4B90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8103168"/>
        <c:axId val="108104704"/>
      </c:barChart>
      <c:catAx>
        <c:axId val="1081031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100" b="1"/>
            </a:pPr>
            <a:endParaRPr lang="es-ES"/>
          </a:p>
        </c:txPr>
        <c:crossAx val="108104704"/>
        <c:crosses val="autoZero"/>
        <c:auto val="1"/>
        <c:lblAlgn val="ctr"/>
        <c:lblOffset val="100"/>
        <c:noMultiLvlLbl val="0"/>
      </c:catAx>
      <c:valAx>
        <c:axId val="1081047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s-ES" sz="1100" baseline="0" dirty="0" err="1"/>
                  <a:t>Number</a:t>
                </a:r>
                <a:r>
                  <a:rPr lang="es-ES" sz="1100" baseline="0" dirty="0"/>
                  <a:t> of </a:t>
                </a:r>
                <a:r>
                  <a:rPr lang="es-ES" sz="1100" baseline="0" dirty="0" err="1"/>
                  <a:t>nodes</a:t>
                </a:r>
                <a:endParaRPr lang="es-ES" sz="1100" dirty="0"/>
              </a:p>
            </c:rich>
          </c:tx>
          <c:layout>
            <c:manualLayout>
              <c:xMode val="edge"/>
              <c:yMode val="edge"/>
              <c:x val="5.2916666666666667E-2"/>
              <c:y val="7.7611111111111117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900" b="1"/>
            </a:pPr>
            <a:endParaRPr lang="es-ES"/>
          </a:p>
        </c:txPr>
        <c:crossAx val="108103168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MK34 FINAL'!$O$1</c:f>
              <c:strCache>
                <c:ptCount val="1"/>
                <c:pt idx="0">
                  <c:v>Nº brotes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0469-40E3-8AD0-CC80B782CFB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0469-40E3-8AD0-CC80B782CFB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0469-40E3-8AD0-CC80B782CFB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0469-40E3-8AD0-CC80B782CFB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0469-40E3-8AD0-CC80B782CFB7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0469-40E3-8AD0-CC80B782CFB7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0469-40E3-8AD0-CC80B782CFB7}"/>
              </c:ext>
            </c:extLst>
          </c:dPt>
          <c:errBars>
            <c:errBarType val="both"/>
            <c:errValType val="cust"/>
            <c:noEndCap val="0"/>
            <c:plus>
              <c:numRef>
                <c:f>'GUA7 FINAL'!$O$11:$O$1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.20719385350268699</c:v>
                  </c:pt>
                  <c:pt idx="3">
                    <c:v>0</c:v>
                  </c:pt>
                  <c:pt idx="4">
                    <c:v>0.21125363706585903</c:v>
                  </c:pt>
                  <c:pt idx="5">
                    <c:v>8.3333333333333232E-2</c:v>
                  </c:pt>
                  <c:pt idx="6">
                    <c:v>0</c:v>
                  </c:pt>
                  <c:pt idx="7">
                    <c:v>0.14864709750264074</c:v>
                  </c:pt>
                </c:numCache>
              </c:numRef>
            </c:plus>
            <c:minus>
              <c:numRef>
                <c:f>'GUA7 FINAL'!$O$11:$O$1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.20719385350268699</c:v>
                  </c:pt>
                  <c:pt idx="3">
                    <c:v>0</c:v>
                  </c:pt>
                  <c:pt idx="4">
                    <c:v>0.21125363706585903</c:v>
                  </c:pt>
                  <c:pt idx="5">
                    <c:v>8.3333333333333232E-2</c:v>
                  </c:pt>
                  <c:pt idx="6">
                    <c:v>0</c:v>
                  </c:pt>
                  <c:pt idx="7">
                    <c:v>0.14864709750264074</c:v>
                  </c:pt>
                </c:numCache>
              </c:numRef>
            </c:minus>
          </c:errBars>
          <c:cat>
            <c:strRef>
              <c:f>'AMK34 FINAL'!$N$2:$N$9</c:f>
              <c:strCache>
                <c:ptCount val="8"/>
                <c:pt idx="0">
                  <c:v>R9B1-56</c:v>
                </c:pt>
                <c:pt idx="1">
                  <c:v>R8B2-30</c:v>
                </c:pt>
                <c:pt idx="2">
                  <c:v>R7B3-34</c:v>
                </c:pt>
                <c:pt idx="3">
                  <c:v>R7B3-52</c:v>
                </c:pt>
                <c:pt idx="4">
                  <c:v>R6B4-40</c:v>
                </c:pt>
                <c:pt idx="5">
                  <c:v>R7B3W-84</c:v>
                </c:pt>
                <c:pt idx="6">
                  <c:v>R6B4W-98</c:v>
                </c:pt>
                <c:pt idx="7">
                  <c:v>TFL-137</c:v>
                </c:pt>
              </c:strCache>
            </c:strRef>
          </c:cat>
          <c:val>
            <c:numRef>
              <c:f>'GUA7 FINAL'!$O$2:$O$9</c:f>
              <c:numCache>
                <c:formatCode>General</c:formatCode>
                <c:ptCount val="8"/>
                <c:pt idx="0">
                  <c:v>2</c:v>
                </c:pt>
                <c:pt idx="1">
                  <c:v>2</c:v>
                </c:pt>
                <c:pt idx="2">
                  <c:v>2.1666666666666665</c:v>
                </c:pt>
                <c:pt idx="3">
                  <c:v>2</c:v>
                </c:pt>
                <c:pt idx="4">
                  <c:v>2.0909090909090908</c:v>
                </c:pt>
                <c:pt idx="5">
                  <c:v>2.0833333333333335</c:v>
                </c:pt>
                <c:pt idx="6">
                  <c:v>2</c:v>
                </c:pt>
                <c:pt idx="7">
                  <c:v>2.083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469-40E3-8AD0-CC80B782CF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570688"/>
        <c:axId val="41572224"/>
      </c:barChart>
      <c:catAx>
        <c:axId val="41570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100" b="1"/>
            </a:pPr>
            <a:endParaRPr lang="es-ES"/>
          </a:p>
        </c:txPr>
        <c:crossAx val="41572224"/>
        <c:crosses val="autoZero"/>
        <c:auto val="1"/>
        <c:lblAlgn val="ctr"/>
        <c:lblOffset val="100"/>
        <c:noMultiLvlLbl val="0"/>
      </c:catAx>
      <c:valAx>
        <c:axId val="4157222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s-ES" sz="1100"/>
                  <a:t>Number of shoot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900" b="1"/>
            </a:pPr>
            <a:endParaRPr lang="es-ES"/>
          </a:p>
        </c:txPr>
        <c:crossAx val="41570688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UA7 FINAL'!$Q$1</c:f>
              <c:strCache>
                <c:ptCount val="1"/>
                <c:pt idx="0">
                  <c:v>Nº Nudos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1B0-4CDB-89CC-8E5DE68C3698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31B0-4CDB-89CC-8E5DE68C3698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31B0-4CDB-89CC-8E5DE68C3698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31B0-4CDB-89CC-8E5DE68C3698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31B0-4CDB-89CC-8E5DE68C3698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31B0-4CDB-89CC-8E5DE68C3698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31B0-4CDB-89CC-8E5DE68C3698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31B0-4CDB-89CC-8E5DE68C3698}"/>
              </c:ext>
            </c:extLst>
          </c:dPt>
          <c:errBars>
            <c:errBarType val="both"/>
            <c:errValType val="cust"/>
            <c:noEndCap val="0"/>
            <c:plus>
              <c:numRef>
                <c:f>'AMK34 FINAL'!$Q$11:$Q$18</c:f>
                <c:numCache>
                  <c:formatCode>General</c:formatCode>
                  <c:ptCount val="8"/>
                  <c:pt idx="0">
                    <c:v>0.60848001929750961</c:v>
                  </c:pt>
                  <c:pt idx="1">
                    <c:v>0.64108099994060697</c:v>
                  </c:pt>
                  <c:pt idx="2">
                    <c:v>0.8915285931046929</c:v>
                  </c:pt>
                  <c:pt idx="3">
                    <c:v>0.83899591263256001</c:v>
                  </c:pt>
                  <c:pt idx="4">
                    <c:v>0.73983003781171586</c:v>
                  </c:pt>
                  <c:pt idx="5">
                    <c:v>0.57075176369204139</c:v>
                  </c:pt>
                  <c:pt idx="6">
                    <c:v>0.61699418002264672</c:v>
                  </c:pt>
                  <c:pt idx="7">
                    <c:v>0.76993703008949388</c:v>
                  </c:pt>
                </c:numCache>
              </c:numRef>
            </c:plus>
            <c:minus>
              <c:numRef>
                <c:f>'AMK34 FINAL'!$Q$11:$Q$18</c:f>
                <c:numCache>
                  <c:formatCode>General</c:formatCode>
                  <c:ptCount val="8"/>
                  <c:pt idx="0">
                    <c:v>0.60848001929750961</c:v>
                  </c:pt>
                  <c:pt idx="1">
                    <c:v>0.64108099994060697</c:v>
                  </c:pt>
                  <c:pt idx="2">
                    <c:v>0.8915285931046929</c:v>
                  </c:pt>
                  <c:pt idx="3">
                    <c:v>0.83899591263256001</c:v>
                  </c:pt>
                  <c:pt idx="4">
                    <c:v>0.73983003781171586</c:v>
                  </c:pt>
                  <c:pt idx="5">
                    <c:v>0.57075176369204139</c:v>
                  </c:pt>
                  <c:pt idx="6">
                    <c:v>0.61699418002264672</c:v>
                  </c:pt>
                  <c:pt idx="7">
                    <c:v>0.76993703008949388</c:v>
                  </c:pt>
                </c:numCache>
              </c:numRef>
            </c:minus>
          </c:errBars>
          <c:cat>
            <c:strRef>
              <c:f>'AMK34 FINAL'!$N$2:$N$9</c:f>
              <c:strCache>
                <c:ptCount val="8"/>
                <c:pt idx="0">
                  <c:v>R9B1-56</c:v>
                </c:pt>
                <c:pt idx="1">
                  <c:v>R8B2-30</c:v>
                </c:pt>
                <c:pt idx="2">
                  <c:v>R7B3-34</c:v>
                </c:pt>
                <c:pt idx="3">
                  <c:v>R7B3-52</c:v>
                </c:pt>
                <c:pt idx="4">
                  <c:v>R6B4-40</c:v>
                </c:pt>
                <c:pt idx="5">
                  <c:v>R7B3W-84</c:v>
                </c:pt>
                <c:pt idx="6">
                  <c:v>R6B4W-98</c:v>
                </c:pt>
                <c:pt idx="7">
                  <c:v>TFL-137</c:v>
                </c:pt>
              </c:strCache>
            </c:strRef>
          </c:cat>
          <c:val>
            <c:numRef>
              <c:f>'GUA7 FINAL'!$Q$2:$Q$9</c:f>
              <c:numCache>
                <c:formatCode>General</c:formatCode>
                <c:ptCount val="8"/>
                <c:pt idx="0">
                  <c:v>10.818181818181818</c:v>
                </c:pt>
                <c:pt idx="1">
                  <c:v>9.2727272727272734</c:v>
                </c:pt>
                <c:pt idx="2">
                  <c:v>9.8333333333333339</c:v>
                </c:pt>
                <c:pt idx="3">
                  <c:v>9.6363636363636367</c:v>
                </c:pt>
                <c:pt idx="4">
                  <c:v>9.7272727272727266</c:v>
                </c:pt>
                <c:pt idx="5">
                  <c:v>10.5</c:v>
                </c:pt>
                <c:pt idx="6">
                  <c:v>9.25</c:v>
                </c:pt>
                <c:pt idx="7">
                  <c:v>8.4166666666666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1B0-4CDB-89CC-8E5DE68C36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479552"/>
        <c:axId val="41366656"/>
      </c:barChart>
      <c:catAx>
        <c:axId val="414795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100" b="1"/>
            </a:pPr>
            <a:endParaRPr lang="es-ES"/>
          </a:p>
        </c:txPr>
        <c:crossAx val="41366656"/>
        <c:crosses val="autoZero"/>
        <c:auto val="1"/>
        <c:lblAlgn val="ctr"/>
        <c:lblOffset val="100"/>
        <c:noMultiLvlLbl val="0"/>
      </c:catAx>
      <c:valAx>
        <c:axId val="413666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s-ES" sz="1100"/>
                  <a:t>Number</a:t>
                </a:r>
                <a:r>
                  <a:rPr lang="es-ES" sz="1100" baseline="0"/>
                  <a:t> of nodes</a:t>
                </a:r>
                <a:endParaRPr lang="es-ES" sz="1100"/>
              </a:p>
            </c:rich>
          </c:tx>
          <c:layout>
            <c:manualLayout>
              <c:xMode val="edge"/>
              <c:yMode val="edge"/>
              <c:x val="4.8506978129845925E-2"/>
              <c:y val="8.4666666666666668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900" b="1"/>
            </a:pPr>
            <a:endParaRPr lang="es-ES"/>
          </a:p>
        </c:txPr>
        <c:crossAx val="41479552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616681249450162"/>
          <c:y val="4.6676350035879888E-2"/>
          <c:w val="0.8645211107102645"/>
          <c:h val="0.7787800594667789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GUA7'!$S$3</c:f>
              <c:strCache>
                <c:ptCount val="1"/>
                <c:pt idx="0">
                  <c:v>R9B1-56</c:v>
                </c:pt>
              </c:strCache>
            </c:strRef>
          </c:tx>
          <c:spPr>
            <a:ln w="44450">
              <a:solidFill>
                <a:schemeClr val="accent2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12;'GUA7'!$X$12;'GUA7'!$AC$12;'GUA7'!$AH$12)</c:f>
                <c:numCache>
                  <c:formatCode>General</c:formatCode>
                  <c:ptCount val="4"/>
                  <c:pt idx="1">
                    <c:v>0.40451991747794513</c:v>
                  </c:pt>
                  <c:pt idx="2">
                    <c:v>0.7240458716424153</c:v>
                  </c:pt>
                  <c:pt idx="3">
                    <c:v>0.79391626151819761</c:v>
                  </c:pt>
                </c:numCache>
              </c:numRef>
            </c:plus>
            <c:minus>
              <c:numRef>
                <c:f>('GUA7'!$AI$12;'GUA7'!$X$12;'GUA7'!$AC$12;'GUA7'!$AH$12)</c:f>
                <c:numCache>
                  <c:formatCode>General</c:formatCode>
                  <c:ptCount val="4"/>
                  <c:pt idx="1">
                    <c:v>0.40451991747794513</c:v>
                  </c:pt>
                  <c:pt idx="2">
                    <c:v>0.7240458716424153</c:v>
                  </c:pt>
                  <c:pt idx="3">
                    <c:v>0.79391626151819761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X$3;'GUA7'!$AC$3;'GUA7'!$AH$3)</c:f>
              <c:numCache>
                <c:formatCode>General</c:formatCode>
                <c:ptCount val="4"/>
                <c:pt idx="0">
                  <c:v>0</c:v>
                </c:pt>
                <c:pt idx="1">
                  <c:v>5.8181818181818183</c:v>
                </c:pt>
                <c:pt idx="2">
                  <c:v>9.9090909090909083</c:v>
                </c:pt>
                <c:pt idx="3">
                  <c:v>10.81818181818181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7CB-4789-862C-CEF4F0ABFE80}"/>
            </c:ext>
          </c:extLst>
        </c:ser>
        <c:ser>
          <c:idx val="1"/>
          <c:order val="1"/>
          <c:tx>
            <c:strRef>
              <c:f>'AMK34'!$S$4</c:f>
              <c:strCache>
                <c:ptCount val="1"/>
                <c:pt idx="0">
                  <c:v>R8B2-30</c:v>
                </c:pt>
              </c:strCache>
            </c:strRef>
          </c:tx>
          <c:spPr>
            <a:ln w="44450">
              <a:solidFill>
                <a:schemeClr val="accent2">
                  <a:lumMod val="7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X$13;'GUA7'!$AC$13;'GUA7'!$AH$13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6003246659132511</c:v>
                  </c:pt>
                  <c:pt idx="2">
                    <c:v>0.56675578621847433</c:v>
                  </c:pt>
                  <c:pt idx="3">
                    <c:v>0.63365223231292345</c:v>
                  </c:pt>
                </c:numCache>
              </c:numRef>
            </c:plus>
            <c:minus>
              <c:numRef>
                <c:f>('GUA7'!$AI$3;'GUA7'!$X$13;'GUA7'!$AC$13;'GUA7'!$AH$13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6003246659132511</c:v>
                  </c:pt>
                  <c:pt idx="2">
                    <c:v>0.56675578621847433</c:v>
                  </c:pt>
                  <c:pt idx="3">
                    <c:v>0.63365223231292345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X$4;'GUA7'!$AC$4;'GUA7'!$AH$4)</c:f>
              <c:numCache>
                <c:formatCode>General</c:formatCode>
                <c:ptCount val="4"/>
                <c:pt idx="0">
                  <c:v>0</c:v>
                </c:pt>
                <c:pt idx="1">
                  <c:v>4.8181818181818183</c:v>
                </c:pt>
                <c:pt idx="2">
                  <c:v>8.6363636363636367</c:v>
                </c:pt>
                <c:pt idx="3">
                  <c:v>9.272727272727273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7CB-4789-862C-CEF4F0ABFE80}"/>
            </c:ext>
          </c:extLst>
        </c:ser>
        <c:ser>
          <c:idx val="2"/>
          <c:order val="2"/>
          <c:tx>
            <c:strRef>
              <c:f>'AMK34'!$S$5</c:f>
              <c:strCache>
                <c:ptCount val="1"/>
                <c:pt idx="0">
                  <c:v>R7B3-34</c:v>
                </c:pt>
              </c:strCache>
            </c:strRef>
          </c:tx>
          <c:spPr>
            <a:ln w="44450"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X$14;'GUA7'!$AC$14;'GUA7'!$AH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3054828383614772</c:v>
                  </c:pt>
                  <c:pt idx="2">
                    <c:v>0.92030956583624457</c:v>
                  </c:pt>
                  <c:pt idx="3">
                    <c:v>0.98344888894731974</c:v>
                  </c:pt>
                </c:numCache>
              </c:numRef>
            </c:plus>
            <c:minus>
              <c:numRef>
                <c:f>('GUA7'!$AI$3;'GUA7'!$X$14;'GUA7'!$AC$14;'GUA7'!$AH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3054828383614772</c:v>
                  </c:pt>
                  <c:pt idx="2">
                    <c:v>0.92030956583624457</c:v>
                  </c:pt>
                  <c:pt idx="3">
                    <c:v>0.98344888894731974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X$5;'GUA7'!$AC$5;'GUA7'!$AH$5)</c:f>
              <c:numCache>
                <c:formatCode>General</c:formatCode>
                <c:ptCount val="4"/>
                <c:pt idx="0">
                  <c:v>0</c:v>
                </c:pt>
                <c:pt idx="1">
                  <c:v>4.4000000000000004</c:v>
                </c:pt>
                <c:pt idx="2">
                  <c:v>9.1818181818181817</c:v>
                </c:pt>
                <c:pt idx="3">
                  <c:v>9.833333333333333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7CB-4789-862C-CEF4F0ABFE80}"/>
            </c:ext>
          </c:extLst>
        </c:ser>
        <c:ser>
          <c:idx val="3"/>
          <c:order val="3"/>
          <c:tx>
            <c:strRef>
              <c:f>'AMK34'!$S$6</c:f>
              <c:strCache>
                <c:ptCount val="1"/>
                <c:pt idx="0">
                  <c:v>R7B3-52</c:v>
                </c:pt>
              </c:strCache>
            </c:strRef>
          </c:tx>
          <c:spPr>
            <a:ln w="44450"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X$15;'GUA7'!$AC$15;'GUA7'!$AH$15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1958873331764399</c:v>
                  </c:pt>
                  <c:pt idx="2">
                    <c:v>0.62983665729777338</c:v>
                  </c:pt>
                  <c:pt idx="3">
                    <c:v>0.70417879021953012</c:v>
                  </c:pt>
                </c:numCache>
              </c:numRef>
            </c:plus>
            <c:minus>
              <c:numRef>
                <c:f>('GUA7'!$AI$3;'GUA7'!$X$15;'GUA7'!$AC$15;'GUA7'!$AH$15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1958873331764399</c:v>
                  </c:pt>
                  <c:pt idx="2">
                    <c:v>0.62983665729777338</c:v>
                  </c:pt>
                  <c:pt idx="3">
                    <c:v>0.70417879021953012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X$6;'GUA7'!$AC$6;'GUA7'!$AH$6)</c:f>
              <c:numCache>
                <c:formatCode>General</c:formatCode>
                <c:ptCount val="4"/>
                <c:pt idx="0">
                  <c:v>0</c:v>
                </c:pt>
                <c:pt idx="1">
                  <c:v>5.333333333333333</c:v>
                </c:pt>
                <c:pt idx="2">
                  <c:v>9.1818181818181817</c:v>
                </c:pt>
                <c:pt idx="3">
                  <c:v>9.636363636363636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7CB-4789-862C-CEF4F0ABFE80}"/>
            </c:ext>
          </c:extLst>
        </c:ser>
        <c:ser>
          <c:idx val="4"/>
          <c:order val="4"/>
          <c:tx>
            <c:strRef>
              <c:f>'AMK34'!$S$7</c:f>
              <c:strCache>
                <c:ptCount val="1"/>
                <c:pt idx="0">
                  <c:v>R6B4-40</c:v>
                </c:pt>
              </c:strCache>
            </c:strRef>
          </c:tx>
          <c:spPr>
            <a:ln w="44450">
              <a:solidFill>
                <a:schemeClr val="accent2">
                  <a:lumMod val="20000"/>
                  <a:lumOff val="8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X$20;'GUA7'!$X$16;'GUA7'!$AC$16;'GUA7'!$AH$16)</c:f>
                <c:numCache>
                  <c:formatCode>General</c:formatCode>
                  <c:ptCount val="4"/>
                  <c:pt idx="1">
                    <c:v>0.226969494679685</c:v>
                  </c:pt>
                  <c:pt idx="2">
                    <c:v>0.36097511036500873</c:v>
                  </c:pt>
                  <c:pt idx="3">
                    <c:v>0.41009976613236288</c:v>
                  </c:pt>
                </c:numCache>
              </c:numRef>
            </c:plus>
            <c:minus>
              <c:numRef>
                <c:f>('GUA7'!$X$20;'GUA7'!$X$16;'GUA7'!$AC$16;'GUA7'!$AH$16)</c:f>
                <c:numCache>
                  <c:formatCode>General</c:formatCode>
                  <c:ptCount val="4"/>
                  <c:pt idx="1">
                    <c:v>0.226969494679685</c:v>
                  </c:pt>
                  <c:pt idx="2">
                    <c:v>0.36097511036500873</c:v>
                  </c:pt>
                  <c:pt idx="3">
                    <c:v>0.41009976613236288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X$7;'GUA7'!$AC$7;'GUA7'!$AH$7)</c:f>
              <c:numCache>
                <c:formatCode>General</c:formatCode>
                <c:ptCount val="4"/>
                <c:pt idx="0">
                  <c:v>0</c:v>
                </c:pt>
                <c:pt idx="1">
                  <c:v>4.7272727272727275</c:v>
                </c:pt>
                <c:pt idx="2">
                  <c:v>9.1818181818181817</c:v>
                </c:pt>
                <c:pt idx="3">
                  <c:v>9.727272727272726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B7CB-4789-862C-CEF4F0ABFE80}"/>
            </c:ext>
          </c:extLst>
        </c:ser>
        <c:ser>
          <c:idx val="5"/>
          <c:order val="5"/>
          <c:tx>
            <c:strRef>
              <c:f>'AMK34'!$S$8</c:f>
              <c:strCache>
                <c:ptCount val="1"/>
                <c:pt idx="0">
                  <c:v>RW7B3-84</c:v>
                </c:pt>
              </c:strCache>
            </c:strRef>
          </c:tx>
          <c:spPr>
            <a:ln w="444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X$17;'GUA7'!$AC$17;'GUA7'!$AH$17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7939345531966412</c:v>
                  </c:pt>
                  <c:pt idx="2">
                    <c:v>0.51431527492405138</c:v>
                  </c:pt>
                  <c:pt idx="3">
                    <c:v>0.65712874067277094</c:v>
                  </c:pt>
                </c:numCache>
              </c:numRef>
            </c:plus>
            <c:minus>
              <c:numRef>
                <c:f>('GUA7'!$AI$3;'GUA7'!$X$17;'GUA7'!$AC$17;'GUA7'!$AH$17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7939345531966412</c:v>
                  </c:pt>
                  <c:pt idx="2">
                    <c:v>0.51431527492405138</c:v>
                  </c:pt>
                  <c:pt idx="3">
                    <c:v>0.65712874067277094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X$8;'GUA7'!$AC$8;'GUA7'!$AH$8)</c:f>
              <c:numCache>
                <c:formatCode>General</c:formatCode>
                <c:ptCount val="4"/>
                <c:pt idx="0">
                  <c:v>0</c:v>
                </c:pt>
                <c:pt idx="1">
                  <c:v>5.5</c:v>
                </c:pt>
                <c:pt idx="2">
                  <c:v>10.083333333333334</c:v>
                </c:pt>
                <c:pt idx="3">
                  <c:v>10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B7CB-4789-862C-CEF4F0ABFE80}"/>
            </c:ext>
          </c:extLst>
        </c:ser>
        <c:ser>
          <c:idx val="6"/>
          <c:order val="6"/>
          <c:tx>
            <c:strRef>
              <c:f>'AMK34'!$S$9</c:f>
              <c:strCache>
                <c:ptCount val="1"/>
                <c:pt idx="0">
                  <c:v>RW6B4-98</c:v>
                </c:pt>
              </c:strCache>
            </c:strRef>
          </c:tx>
          <c:spPr>
            <a:ln w="44450">
              <a:solidFill>
                <a:schemeClr val="tx2">
                  <a:lumMod val="40000"/>
                  <a:lumOff val="6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X$18;'GUA7'!$AC$18;'GUA7'!$AH$18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4450960608794184</c:v>
                  </c:pt>
                  <c:pt idx="2">
                    <c:v>0.56853524361496099</c:v>
                  </c:pt>
                  <c:pt idx="3">
                    <c:v>0.60459102129481146</c:v>
                  </c:pt>
                </c:numCache>
              </c:numRef>
            </c:plus>
            <c:minus>
              <c:numRef>
                <c:f>('GUA7'!$AI$3;'GUA7'!$X$18;'GUA7'!$AC$18;'GUA7'!$AH$18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4450960608794184</c:v>
                  </c:pt>
                  <c:pt idx="2">
                    <c:v>0.56853524361496099</c:v>
                  </c:pt>
                  <c:pt idx="3">
                    <c:v>0.60459102129481146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X$9;'GUA7'!$AC$9;'GUA7'!$AH$9)</c:f>
              <c:numCache>
                <c:formatCode>General</c:formatCode>
                <c:ptCount val="4"/>
                <c:pt idx="0">
                  <c:v>0</c:v>
                </c:pt>
                <c:pt idx="1">
                  <c:v>5.166666666666667</c:v>
                </c:pt>
                <c:pt idx="2">
                  <c:v>8.6666666666666661</c:v>
                </c:pt>
                <c:pt idx="3">
                  <c:v>9.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B7CB-4789-862C-CEF4F0ABFE80}"/>
            </c:ext>
          </c:extLst>
        </c:ser>
        <c:ser>
          <c:idx val="7"/>
          <c:order val="7"/>
          <c:tx>
            <c:strRef>
              <c:f>'AMK34'!$S$10</c:f>
              <c:strCache>
                <c:ptCount val="1"/>
                <c:pt idx="0">
                  <c:v>TFL-137</c:v>
                </c:pt>
              </c:strCache>
            </c:strRef>
          </c:tx>
          <c:spPr>
            <a:ln w="44450"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19;'GUA7'!$X$19;'GUA7'!$AC$19;'GUA7'!$AH$19)</c:f>
                <c:numCache>
                  <c:formatCode>General</c:formatCode>
                  <c:ptCount val="4"/>
                  <c:pt idx="1">
                    <c:v>0.26111648393354681</c:v>
                  </c:pt>
                  <c:pt idx="2">
                    <c:v>0.551856371300952</c:v>
                  </c:pt>
                  <c:pt idx="3">
                    <c:v>0.41666666666666635</c:v>
                  </c:pt>
                </c:numCache>
              </c:numRef>
            </c:plus>
            <c:minus>
              <c:numRef>
                <c:f>('GUA7'!$AI$19;'GUA7'!$X$19;'GUA7'!$AC$19;'GUA7'!$AH$19)</c:f>
                <c:numCache>
                  <c:formatCode>General</c:formatCode>
                  <c:ptCount val="4"/>
                  <c:pt idx="1">
                    <c:v>0.26111648393354681</c:v>
                  </c:pt>
                  <c:pt idx="2">
                    <c:v>0.551856371300952</c:v>
                  </c:pt>
                  <c:pt idx="3">
                    <c:v>0.41666666666666635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X$10;'GUA7'!$AC$10;'GUA7'!$AH$10)</c:f>
              <c:numCache>
                <c:formatCode>General</c:formatCode>
                <c:ptCount val="4"/>
                <c:pt idx="0">
                  <c:v>0</c:v>
                </c:pt>
                <c:pt idx="1">
                  <c:v>4.5</c:v>
                </c:pt>
                <c:pt idx="2">
                  <c:v>8.3636363636363633</c:v>
                </c:pt>
                <c:pt idx="3">
                  <c:v>8.41666666666666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B7CB-4789-862C-CEF4F0ABFE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780736"/>
        <c:axId val="41782656"/>
      </c:scatterChart>
      <c:valAx>
        <c:axId val="41780736"/>
        <c:scaling>
          <c:orientation val="minMax"/>
          <c:max val="7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Time (day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41782656"/>
        <c:crosses val="autoZero"/>
        <c:crossBetween val="midCat"/>
      </c:valAx>
      <c:valAx>
        <c:axId val="417826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1"/>
                </a:pPr>
                <a:r>
                  <a:rPr lang="es-ES" sz="1200" b="1"/>
                  <a:t>Number of node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41780736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 w="25400">
      <a:noFill/>
    </a:ln>
  </c:sp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277751187583489"/>
          <c:y val="6.52787037037037E-2"/>
          <c:w val="0.8136017549641662"/>
          <c:h val="0.6627490740740741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GUA7'!$S$3</c:f>
              <c:strCache>
                <c:ptCount val="1"/>
                <c:pt idx="0">
                  <c:v>R9B1-56</c:v>
                </c:pt>
              </c:strCache>
            </c:strRef>
          </c:tx>
          <c:spPr>
            <a:ln w="44450">
              <a:solidFill>
                <a:schemeClr val="accent2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12;'GUA7'!$W$12;'GUA7'!$AB$12;'GUA7'!$AG$12)</c:f>
                <c:numCache>
                  <c:formatCode>General</c:formatCode>
                  <c:ptCount val="4"/>
                  <c:pt idx="1">
                    <c:v>3.8080854968757141</c:v>
                  </c:pt>
                  <c:pt idx="2">
                    <c:v>7.9057899764359538</c:v>
                  </c:pt>
                  <c:pt idx="3">
                    <c:v>8.0554893762520141</c:v>
                  </c:pt>
                </c:numCache>
              </c:numRef>
            </c:plus>
            <c:minus>
              <c:numRef>
                <c:f>('GUA7'!$AI$12;'GUA7'!$W$12;'GUA7'!$AB$12;'GUA7'!$AG$12)</c:f>
                <c:numCache>
                  <c:formatCode>General</c:formatCode>
                  <c:ptCount val="4"/>
                  <c:pt idx="1">
                    <c:v>3.8080854968757141</c:v>
                  </c:pt>
                  <c:pt idx="2">
                    <c:v>7.9057899764359538</c:v>
                  </c:pt>
                  <c:pt idx="3">
                    <c:v>8.0554893762520141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W$3;'GUA7'!$AB$3;'GUA7'!$AG$3)</c:f>
              <c:numCache>
                <c:formatCode>General</c:formatCode>
                <c:ptCount val="4"/>
                <c:pt idx="0">
                  <c:v>0</c:v>
                </c:pt>
                <c:pt idx="1">
                  <c:v>30.727272727272727</c:v>
                </c:pt>
                <c:pt idx="2">
                  <c:v>77.272727272727266</c:v>
                </c:pt>
                <c:pt idx="3">
                  <c:v>84.09090909090909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0E3-4D92-9DD2-3765C0F854DE}"/>
            </c:ext>
          </c:extLst>
        </c:ser>
        <c:ser>
          <c:idx val="1"/>
          <c:order val="1"/>
          <c:tx>
            <c:strRef>
              <c:f>'AMK34'!$S$4</c:f>
              <c:strCache>
                <c:ptCount val="1"/>
                <c:pt idx="0">
                  <c:v>R8B2-30</c:v>
                </c:pt>
              </c:strCache>
            </c:strRef>
          </c:tx>
          <c:spPr>
            <a:ln w="44450">
              <a:solidFill>
                <a:schemeClr val="accent2">
                  <a:lumMod val="7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W$13;'GUA7'!$AB$13;'GUA7'!$AG$13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061243557969886</c:v>
                  </c:pt>
                  <c:pt idx="2">
                    <c:v>4.5739711543922237</c:v>
                  </c:pt>
                  <c:pt idx="3">
                    <c:v>5.0839915122834016</c:v>
                  </c:pt>
                </c:numCache>
              </c:numRef>
            </c:plus>
            <c:minus>
              <c:numRef>
                <c:f>('GUA7'!$AI$3;'GUA7'!$W$13;'GUA7'!$AB$14;'GUA7'!$AB$14;'GUA7'!$AB$13;'GUA7'!$AG$13)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061243557969886</c:v>
                  </c:pt>
                  <c:pt idx="2">
                    <c:v>8.2858952809011903</c:v>
                  </c:pt>
                  <c:pt idx="3">
                    <c:v>8.2858952809011903</c:v>
                  </c:pt>
                  <c:pt idx="4">
                    <c:v>4.5739711543922237</c:v>
                  </c:pt>
                  <c:pt idx="5">
                    <c:v>5.0839915122834016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W$4;'GUA7'!$AB$4;'GUA7'!$AG$4)</c:f>
              <c:numCache>
                <c:formatCode>General</c:formatCode>
                <c:ptCount val="4"/>
                <c:pt idx="0">
                  <c:v>0</c:v>
                </c:pt>
                <c:pt idx="1">
                  <c:v>20.363636363636363</c:v>
                </c:pt>
                <c:pt idx="2">
                  <c:v>56.636363636363633</c:v>
                </c:pt>
                <c:pt idx="3">
                  <c:v>65.81818181818181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0E3-4D92-9DD2-3765C0F854DE}"/>
            </c:ext>
          </c:extLst>
        </c:ser>
        <c:ser>
          <c:idx val="2"/>
          <c:order val="2"/>
          <c:tx>
            <c:strRef>
              <c:f>'AMK34'!$S$5</c:f>
              <c:strCache>
                <c:ptCount val="1"/>
                <c:pt idx="0">
                  <c:v>R7B3-34</c:v>
                </c:pt>
              </c:strCache>
            </c:strRef>
          </c:tx>
          <c:spPr>
            <a:ln w="44450"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W$14;'GUA7'!$AB$14;'GUA7'!$AG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9044134571590186</c:v>
                  </c:pt>
                  <c:pt idx="2">
                    <c:v>8.2858952809011903</c:v>
                  </c:pt>
                  <c:pt idx="3">
                    <c:v>10.118115566955273</c:v>
                  </c:pt>
                </c:numCache>
              </c:numRef>
            </c:plus>
            <c:minus>
              <c:numRef>
                <c:f>('GUA7'!$AI$3;'GUA7'!$W$14;'GUA7'!$AB$14;'GUA7'!$AG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9044134571590186</c:v>
                  </c:pt>
                  <c:pt idx="2">
                    <c:v>8.2858952809011903</c:v>
                  </c:pt>
                  <c:pt idx="3">
                    <c:v>10.118115566955273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W$5;'GUA7'!$AB$5;'GUA7'!$AG$5)</c:f>
              <c:numCache>
                <c:formatCode>General</c:formatCode>
                <c:ptCount val="4"/>
                <c:pt idx="0">
                  <c:v>0</c:v>
                </c:pt>
                <c:pt idx="1">
                  <c:v>21.4</c:v>
                </c:pt>
                <c:pt idx="2">
                  <c:v>63.545454545454547</c:v>
                </c:pt>
                <c:pt idx="3">
                  <c:v>69.83333333333332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30E3-4D92-9DD2-3765C0F854DE}"/>
            </c:ext>
          </c:extLst>
        </c:ser>
        <c:ser>
          <c:idx val="3"/>
          <c:order val="3"/>
          <c:tx>
            <c:strRef>
              <c:f>'AMK34'!$S$6</c:f>
              <c:strCache>
                <c:ptCount val="1"/>
                <c:pt idx="0">
                  <c:v>R7B3-52</c:v>
                </c:pt>
              </c:strCache>
            </c:strRef>
          </c:tx>
          <c:spPr>
            <a:ln w="44450"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W$15;'GUA7'!$AB$15;'GUA7'!$AG$15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5291024393324504</c:v>
                  </c:pt>
                  <c:pt idx="2">
                    <c:v>2.2271799609623826</c:v>
                  </c:pt>
                  <c:pt idx="3">
                    <c:v>1.9344634295666026</c:v>
                  </c:pt>
                </c:numCache>
              </c:numRef>
            </c:plus>
            <c:minus>
              <c:numRef>
                <c:f>('GUA7'!$AI$3;'GUA7'!$W$15;'GUA7'!$AB$15;'GUA7'!$AG$15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5291024393324504</c:v>
                  </c:pt>
                  <c:pt idx="2">
                    <c:v>2.2271799609623826</c:v>
                  </c:pt>
                  <c:pt idx="3">
                    <c:v>1.9344634295666026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W$6;'GUA7'!$AB$6;'GUA7'!$AG$6)</c:f>
              <c:numCache>
                <c:formatCode>General</c:formatCode>
                <c:ptCount val="4"/>
                <c:pt idx="0">
                  <c:v>0</c:v>
                </c:pt>
                <c:pt idx="1">
                  <c:v>18.083333333333332</c:v>
                </c:pt>
                <c:pt idx="2">
                  <c:v>40.18181818181818</c:v>
                </c:pt>
                <c:pt idx="3">
                  <c:v>43.8181818181818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30E3-4D92-9DD2-3765C0F854DE}"/>
            </c:ext>
          </c:extLst>
        </c:ser>
        <c:ser>
          <c:idx val="4"/>
          <c:order val="4"/>
          <c:tx>
            <c:strRef>
              <c:f>'AMK34'!$S$7</c:f>
              <c:strCache>
                <c:ptCount val="1"/>
                <c:pt idx="0">
                  <c:v>R6B4-40</c:v>
                </c:pt>
              </c:strCache>
            </c:strRef>
          </c:tx>
          <c:spPr>
            <a:ln w="44450">
              <a:solidFill>
                <a:schemeClr val="accent2">
                  <a:lumMod val="20000"/>
                  <a:lumOff val="8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W$16;'GUA7'!$AB$16;'GUA7'!$AG$16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7311758134197983</c:v>
                  </c:pt>
                  <c:pt idx="2">
                    <c:v>3.715854646992502</c:v>
                  </c:pt>
                  <c:pt idx="3">
                    <c:v>3.0463589792247081</c:v>
                  </c:pt>
                </c:numCache>
              </c:numRef>
            </c:plus>
            <c:minus>
              <c:numRef>
                <c:f>('GUA7'!$AI$3;'GUA7'!$W$16;'GUA7'!$AB$16;'GUA7'!$AG$16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7311758134197983</c:v>
                  </c:pt>
                  <c:pt idx="2">
                    <c:v>3.715854646992502</c:v>
                  </c:pt>
                  <c:pt idx="3">
                    <c:v>3.0463589792247081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W$7;'GUA7'!$AB$7;'GUA7'!$AG$7)</c:f>
              <c:numCache>
                <c:formatCode>General</c:formatCode>
                <c:ptCount val="4"/>
                <c:pt idx="0">
                  <c:v>0</c:v>
                </c:pt>
                <c:pt idx="1">
                  <c:v>21.181818181818183</c:v>
                </c:pt>
                <c:pt idx="2">
                  <c:v>46.909090909090907</c:v>
                </c:pt>
                <c:pt idx="3">
                  <c:v>54.8181818181818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30E3-4D92-9DD2-3765C0F854DE}"/>
            </c:ext>
          </c:extLst>
        </c:ser>
        <c:ser>
          <c:idx val="5"/>
          <c:order val="5"/>
          <c:tx>
            <c:strRef>
              <c:f>'AMK34'!$S$8</c:f>
              <c:strCache>
                <c:ptCount val="1"/>
                <c:pt idx="0">
                  <c:v>RW7B3-84</c:v>
                </c:pt>
              </c:strCache>
            </c:strRef>
          </c:tx>
          <c:spPr>
            <a:ln w="444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W$17;'GUA7'!$AB$17;'GUA7'!$AG$17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2830070547681656</c:v>
                  </c:pt>
                  <c:pt idx="2">
                    <c:v>3.751767260339796</c:v>
                  </c:pt>
                  <c:pt idx="3">
                    <c:v>2.9476707119796535</c:v>
                  </c:pt>
                </c:numCache>
              </c:numRef>
            </c:plus>
            <c:minus>
              <c:numRef>
                <c:f>('GUA7'!$AI$3;'GUA7'!$W$17;'GUA7'!$AB$17;'GUA7'!$AG$17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2830070547681656</c:v>
                  </c:pt>
                  <c:pt idx="2">
                    <c:v>3.751767260339796</c:v>
                  </c:pt>
                  <c:pt idx="3">
                    <c:v>2.9476707119796535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W$8;'GUA7'!$AB$8;'GUA7'!$AG$8)</c:f>
              <c:numCache>
                <c:formatCode>General</c:formatCode>
                <c:ptCount val="4"/>
                <c:pt idx="0">
                  <c:v>0</c:v>
                </c:pt>
                <c:pt idx="1">
                  <c:v>19</c:v>
                </c:pt>
                <c:pt idx="2">
                  <c:v>43</c:v>
                </c:pt>
                <c:pt idx="3">
                  <c:v>50.4166666666666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30E3-4D92-9DD2-3765C0F854DE}"/>
            </c:ext>
          </c:extLst>
        </c:ser>
        <c:ser>
          <c:idx val="6"/>
          <c:order val="6"/>
          <c:tx>
            <c:strRef>
              <c:f>'AMK34'!$S$9</c:f>
              <c:strCache>
                <c:ptCount val="1"/>
                <c:pt idx="0">
                  <c:v>RW6B4-98</c:v>
                </c:pt>
              </c:strCache>
            </c:strRef>
          </c:tx>
          <c:spPr>
            <a:ln w="44450">
              <a:solidFill>
                <a:schemeClr val="tx2">
                  <a:lumMod val="40000"/>
                  <a:lumOff val="6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W$18;'GUA7'!$AB$18;'GUA7'!$AG$18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378038424351766</c:v>
                  </c:pt>
                  <c:pt idx="2">
                    <c:v>3.0437674356001967</c:v>
                  </c:pt>
                  <c:pt idx="3">
                    <c:v>3.5883509619688314</c:v>
                  </c:pt>
                </c:numCache>
              </c:numRef>
            </c:plus>
            <c:minus>
              <c:numRef>
                <c:f>('GUA7'!$AI$3;'GUA7'!$W$18;'GUA7'!$AB$18;'GUA7'!$AG$18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378038424351766</c:v>
                  </c:pt>
                  <c:pt idx="2">
                    <c:v>3.0437674356001967</c:v>
                  </c:pt>
                  <c:pt idx="3">
                    <c:v>3.5883509619688314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W$9;'GUA7'!$AB$9;'GUA7'!$AG$9)</c:f>
              <c:numCache>
                <c:formatCode>General</c:formatCode>
                <c:ptCount val="4"/>
                <c:pt idx="0">
                  <c:v>0</c:v>
                </c:pt>
                <c:pt idx="1">
                  <c:v>16.666666666666668</c:v>
                </c:pt>
                <c:pt idx="2">
                  <c:v>35.083333333333336</c:v>
                </c:pt>
                <c:pt idx="3">
                  <c:v>41.1666666666666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30E3-4D92-9DD2-3765C0F854DE}"/>
            </c:ext>
          </c:extLst>
        </c:ser>
        <c:ser>
          <c:idx val="7"/>
          <c:order val="7"/>
          <c:tx>
            <c:strRef>
              <c:f>'AMK34'!$S$10</c:f>
              <c:strCache>
                <c:ptCount val="1"/>
                <c:pt idx="0">
                  <c:v>TFL-137</c:v>
                </c:pt>
              </c:strCache>
            </c:strRef>
          </c:tx>
          <c:spPr>
            <a:ln w="44450"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GUA7'!$AI$3;'GUA7'!$W$19;'GUA7'!$AB$19;'GUA7'!$AG$19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77971439992765657</c:v>
                  </c:pt>
                  <c:pt idx="2">
                    <c:v>1.0022701504811238</c:v>
                  </c:pt>
                  <c:pt idx="3">
                    <c:v>1.2439246298906075</c:v>
                  </c:pt>
                </c:numCache>
              </c:numRef>
            </c:plus>
            <c:minus>
              <c:numRef>
                <c:f>('GUA7'!$AI$3;'GUA7'!$W$19;'GUA7'!$AB$19;'GUA7'!$AG$19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77971439992765657</c:v>
                  </c:pt>
                  <c:pt idx="2">
                    <c:v>1.0022701504811238</c:v>
                  </c:pt>
                  <c:pt idx="3">
                    <c:v>1.2439246298906075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GUA7'!$AI$3;'GUA7'!$W$10;'GUA7'!$AB$10;'GUA7'!$AG$10)</c:f>
              <c:numCache>
                <c:formatCode>General</c:formatCode>
                <c:ptCount val="4"/>
                <c:pt idx="0">
                  <c:v>0</c:v>
                </c:pt>
                <c:pt idx="1">
                  <c:v>8.75</c:v>
                </c:pt>
                <c:pt idx="2">
                  <c:v>18.636363636363637</c:v>
                </c:pt>
                <c:pt idx="3">
                  <c:v>23.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30E3-4D92-9DD2-3765C0F854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845120"/>
        <c:axId val="41847040"/>
      </c:scatterChart>
      <c:valAx>
        <c:axId val="41845120"/>
        <c:scaling>
          <c:orientation val="minMax"/>
          <c:max val="7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Time (day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41847040"/>
        <c:crosses val="autoZero"/>
        <c:crossBetween val="midCat"/>
      </c:valAx>
      <c:valAx>
        <c:axId val="418470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s-ES" sz="1200"/>
                  <a:t>Total stem length (m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41845120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 w="25400">
      <a:noFill/>
    </a:ln>
  </c:sp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21351131362352"/>
          <c:y val="9.1542017216942231E-2"/>
          <c:w val="0.87442521398093187"/>
          <c:h val="0.7003506344412909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AMK34'!$S$3</c:f>
              <c:strCache>
                <c:ptCount val="1"/>
                <c:pt idx="0">
                  <c:v>R9B1-56</c:v>
                </c:pt>
              </c:strCache>
            </c:strRef>
          </c:tx>
          <c:spPr>
            <a:ln w="44450">
              <a:solidFill>
                <a:schemeClr val="accent2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X$12;'AMK34'!$AC$12;'AMK34'!$AH$12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046358979224712</c:v>
                  </c:pt>
                  <c:pt idx="2">
                    <c:v>0.47407538930794046</c:v>
                  </c:pt>
                  <c:pt idx="3">
                    <c:v>0.60848001929750961</c:v>
                  </c:pt>
                </c:numCache>
              </c:numRef>
            </c:plus>
            <c:minus>
              <c:numRef>
                <c:f>('AMK34'!$AI$1;'AMK34'!$X$12;'AMK34'!$AC$12;'AMK34'!$AH$12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046358979224712</c:v>
                  </c:pt>
                  <c:pt idx="2">
                    <c:v>0.47407538930794046</c:v>
                  </c:pt>
                  <c:pt idx="3">
                    <c:v>0.60848001929750961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X$3;'AMK34'!$AC$3;'AMK34'!$AH$3)</c:f>
              <c:numCache>
                <c:formatCode>General</c:formatCode>
                <c:ptCount val="4"/>
                <c:pt idx="0">
                  <c:v>0</c:v>
                </c:pt>
                <c:pt idx="1">
                  <c:v>5.25</c:v>
                </c:pt>
                <c:pt idx="2">
                  <c:v>10.166666666666666</c:v>
                </c:pt>
                <c:pt idx="3">
                  <c:v>11.4545454545454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951-4BD8-8097-ED6F8843AA66}"/>
            </c:ext>
          </c:extLst>
        </c:ser>
        <c:ser>
          <c:idx val="1"/>
          <c:order val="1"/>
          <c:tx>
            <c:strRef>
              <c:f>'AMK34'!$S$4</c:f>
              <c:strCache>
                <c:ptCount val="1"/>
                <c:pt idx="0">
                  <c:v>R8B2-30</c:v>
                </c:pt>
              </c:strCache>
            </c:strRef>
          </c:tx>
          <c:spPr>
            <a:ln w="44450">
              <a:solidFill>
                <a:schemeClr val="accent2">
                  <a:lumMod val="7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X$13;'AMK34'!$AC$13;'AMK34'!$AH$13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2176909972114121</c:v>
                  </c:pt>
                  <c:pt idx="2">
                    <c:v>0.53830542192395503</c:v>
                  </c:pt>
                  <c:pt idx="3">
                    <c:v>0.64108099994060697</c:v>
                  </c:pt>
                </c:numCache>
              </c:numRef>
            </c:plus>
            <c:minus>
              <c:numRef>
                <c:f>('AMK34'!$AI$1;'AMK34'!$X$13;'AMK34'!$AC$13;'AMK34'!$AH$13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2176909972114121</c:v>
                  </c:pt>
                  <c:pt idx="2">
                    <c:v>0.53830542192395503</c:v>
                  </c:pt>
                  <c:pt idx="3">
                    <c:v>0.64108099994060697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X$4;'AMK34'!$AC$4;'AMK34'!$AH$4)</c:f>
              <c:numCache>
                <c:formatCode>General</c:formatCode>
                <c:ptCount val="4"/>
                <c:pt idx="0">
                  <c:v>0</c:v>
                </c:pt>
                <c:pt idx="1">
                  <c:v>5.166666666666667</c:v>
                </c:pt>
                <c:pt idx="2">
                  <c:v>8.75</c:v>
                </c:pt>
                <c:pt idx="3">
                  <c:v>10.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951-4BD8-8097-ED6F8843AA66}"/>
            </c:ext>
          </c:extLst>
        </c:ser>
        <c:ser>
          <c:idx val="2"/>
          <c:order val="2"/>
          <c:tx>
            <c:strRef>
              <c:f>'AMK34'!$S$5</c:f>
              <c:strCache>
                <c:ptCount val="1"/>
                <c:pt idx="0">
                  <c:v>R7B3-34</c:v>
                </c:pt>
              </c:strCache>
            </c:strRef>
          </c:tx>
          <c:spPr>
            <a:ln w="44450"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X$14;'AMK34'!$AC$14;'AMK34'!$AH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5061906821982216</c:v>
                  </c:pt>
                  <c:pt idx="2">
                    <c:v>0.63376091119757694</c:v>
                  </c:pt>
                  <c:pt idx="3">
                    <c:v>0.8915285931046929</c:v>
                  </c:pt>
                </c:numCache>
              </c:numRef>
            </c:plus>
            <c:minus>
              <c:numRef>
                <c:f>('AMK34'!$AI$1;'AMK34'!$X$14;'AMK34'!$AC$14;'AMK34'!$AH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5061906821982216</c:v>
                  </c:pt>
                  <c:pt idx="2">
                    <c:v>0.63376091119757694</c:v>
                  </c:pt>
                  <c:pt idx="3">
                    <c:v>0.8915285931046929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X$5;'AMK34'!$AC$5;'AMK34'!$AH$5)</c:f>
              <c:numCache>
                <c:formatCode>General</c:formatCode>
                <c:ptCount val="4"/>
                <c:pt idx="0">
                  <c:v>0</c:v>
                </c:pt>
                <c:pt idx="1">
                  <c:v>4.0909090909090908</c:v>
                </c:pt>
                <c:pt idx="2">
                  <c:v>9.2727272727272734</c:v>
                </c:pt>
                <c:pt idx="3">
                  <c:v>10.91666666666666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3951-4BD8-8097-ED6F8843AA66}"/>
            </c:ext>
          </c:extLst>
        </c:ser>
        <c:ser>
          <c:idx val="3"/>
          <c:order val="3"/>
          <c:tx>
            <c:strRef>
              <c:f>'AMK34'!$S$6</c:f>
              <c:strCache>
                <c:ptCount val="1"/>
                <c:pt idx="0">
                  <c:v>R7B3-52</c:v>
                </c:pt>
              </c:strCache>
            </c:strRef>
          </c:tx>
          <c:spPr>
            <a:ln w="44450"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X$15;'AMK34'!$AC$15;'AMK34'!$AH$15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0041300991900425</c:v>
                  </c:pt>
                  <c:pt idx="2">
                    <c:v>0.56040127299717934</c:v>
                  </c:pt>
                  <c:pt idx="3">
                    <c:v>0.70064904974537123</c:v>
                  </c:pt>
                </c:numCache>
              </c:numRef>
            </c:plus>
            <c:minus>
              <c:numRef>
                <c:f>('AMK34'!$AI$1;'AMK34'!$X$15;'AMK34'!$AC$15;'AMK34'!$AH$15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0041300991900425</c:v>
                  </c:pt>
                  <c:pt idx="2">
                    <c:v>0.56040127299717934</c:v>
                  </c:pt>
                  <c:pt idx="3">
                    <c:v>0.70064904974537123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X$6;'AMK34'!$AC$6;'AMK34'!$AH$6)</c:f>
              <c:numCache>
                <c:formatCode>General</c:formatCode>
                <c:ptCount val="4"/>
                <c:pt idx="0">
                  <c:v>0</c:v>
                </c:pt>
                <c:pt idx="1">
                  <c:v>5.1818181818181817</c:v>
                </c:pt>
                <c:pt idx="2">
                  <c:v>10.363636363636363</c:v>
                </c:pt>
                <c:pt idx="3">
                  <c:v>12.0909090909090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3951-4BD8-8097-ED6F8843AA66}"/>
            </c:ext>
          </c:extLst>
        </c:ser>
        <c:ser>
          <c:idx val="4"/>
          <c:order val="4"/>
          <c:tx>
            <c:strRef>
              <c:f>'AMK34'!$S$7</c:f>
              <c:strCache>
                <c:ptCount val="1"/>
                <c:pt idx="0">
                  <c:v>R6B4-40</c:v>
                </c:pt>
              </c:strCache>
            </c:strRef>
          </c:tx>
          <c:spPr>
            <a:ln w="44450">
              <a:solidFill>
                <a:schemeClr val="accent2">
                  <a:lumMod val="20000"/>
                  <a:lumOff val="8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X$16;'AMK34'!$AC$16;'AMK34'!$AH$16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0977345909486159</c:v>
                  </c:pt>
                  <c:pt idx="2">
                    <c:v>0.5143152749240506</c:v>
                  </c:pt>
                  <c:pt idx="3">
                    <c:v>0.73983003781171586</c:v>
                  </c:pt>
                </c:numCache>
              </c:numRef>
            </c:plus>
            <c:minus>
              <c:numRef>
                <c:f>('AMK34'!$AI$1;'AMK34'!$X$16;'AMK34'!$AC$16;'AMK34'!$AH$16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0977345909486159</c:v>
                  </c:pt>
                  <c:pt idx="2">
                    <c:v>0.5143152749240506</c:v>
                  </c:pt>
                  <c:pt idx="3">
                    <c:v>0.73983003781171586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X$7;'AMK34'!$AC$7;'AMK34'!$AH$7)</c:f>
              <c:numCache>
                <c:formatCode>General</c:formatCode>
                <c:ptCount val="4"/>
                <c:pt idx="0">
                  <c:v>0</c:v>
                </c:pt>
                <c:pt idx="1">
                  <c:v>4.333333333333333</c:v>
                </c:pt>
                <c:pt idx="2">
                  <c:v>9.0833333333333339</c:v>
                </c:pt>
                <c:pt idx="3">
                  <c:v>10.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3951-4BD8-8097-ED6F8843AA66}"/>
            </c:ext>
          </c:extLst>
        </c:ser>
        <c:ser>
          <c:idx val="5"/>
          <c:order val="5"/>
          <c:tx>
            <c:strRef>
              <c:f>'AMK34'!$S$8</c:f>
              <c:strCache>
                <c:ptCount val="1"/>
                <c:pt idx="0">
                  <c:v>RW7B3-84</c:v>
                </c:pt>
              </c:strCache>
            </c:strRef>
          </c:tx>
          <c:spPr>
            <a:ln w="444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X$17;'AMK34'!$AC$17;'AMK34'!$AH$17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9806983804301993</c:v>
                  </c:pt>
                  <c:pt idx="2">
                    <c:v>0.53654336998865981</c:v>
                  </c:pt>
                  <c:pt idx="3">
                    <c:v>0.57075176369204139</c:v>
                  </c:pt>
                </c:numCache>
              </c:numRef>
            </c:plus>
            <c:minus>
              <c:numRef>
                <c:f>('AMK34'!$AI$1;'AMK34'!$X$17;'AMK34'!$AC$17;'AMK34'!$AH$17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9806983804301993</c:v>
                  </c:pt>
                  <c:pt idx="2">
                    <c:v>0.53654336998865981</c:v>
                  </c:pt>
                  <c:pt idx="3">
                    <c:v>0.57075176369204139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X$8;'AMK34'!$AC$8;'AMK34'!$AH$8)</c:f>
              <c:numCache>
                <c:formatCode>General</c:formatCode>
                <c:ptCount val="4"/>
                <c:pt idx="0">
                  <c:v>0</c:v>
                </c:pt>
                <c:pt idx="1">
                  <c:v>5.416666666666667</c:v>
                </c:pt>
                <c:pt idx="2">
                  <c:v>11</c:v>
                </c:pt>
                <c:pt idx="3">
                  <c:v>12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3951-4BD8-8097-ED6F8843AA66}"/>
            </c:ext>
          </c:extLst>
        </c:ser>
        <c:ser>
          <c:idx val="6"/>
          <c:order val="6"/>
          <c:tx>
            <c:strRef>
              <c:f>'AMK34'!$S$9</c:f>
              <c:strCache>
                <c:ptCount val="1"/>
                <c:pt idx="0">
                  <c:v>RW6B4-98</c:v>
                </c:pt>
              </c:strCache>
            </c:strRef>
          </c:tx>
          <c:spPr>
            <a:ln w="44450">
              <a:solidFill>
                <a:schemeClr val="tx2">
                  <a:lumMod val="40000"/>
                  <a:lumOff val="6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X$18;'AMK34'!$AC$18;'AMK34'!$AH$18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046358979224712</c:v>
                  </c:pt>
                  <c:pt idx="2">
                    <c:v>0.51431527492405138</c:v>
                  </c:pt>
                  <c:pt idx="3">
                    <c:v>0.61699418002264672</c:v>
                  </c:pt>
                </c:numCache>
              </c:numRef>
            </c:plus>
            <c:minus>
              <c:numRef>
                <c:f>('AMK34'!$AI$1;'AMK34'!$X$18;'AMK34'!$AC$18;'AMK34'!$AH$18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046358979224712</c:v>
                  </c:pt>
                  <c:pt idx="2">
                    <c:v>0.51431527492405138</c:v>
                  </c:pt>
                  <c:pt idx="3">
                    <c:v>0.61699418002264672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X$9;'AMK34'!$AC$9;'AMK34'!$AH$9)</c:f>
              <c:numCache>
                <c:formatCode>General</c:formatCode>
                <c:ptCount val="4"/>
                <c:pt idx="0">
                  <c:v>0</c:v>
                </c:pt>
                <c:pt idx="1">
                  <c:v>5.25</c:v>
                </c:pt>
                <c:pt idx="2">
                  <c:v>10.583333333333334</c:v>
                </c:pt>
                <c:pt idx="3">
                  <c:v>11.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3951-4BD8-8097-ED6F8843AA66}"/>
            </c:ext>
          </c:extLst>
        </c:ser>
        <c:ser>
          <c:idx val="7"/>
          <c:order val="7"/>
          <c:tx>
            <c:strRef>
              <c:f>'AMK34'!$S$10</c:f>
              <c:strCache>
                <c:ptCount val="1"/>
                <c:pt idx="0">
                  <c:v>TFL-137</c:v>
                </c:pt>
              </c:strCache>
            </c:strRef>
          </c:tx>
          <c:spPr>
            <a:ln w="44450"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X$19;'AMK34'!$AC$19;'AMK34'!$AH$19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7856053783784799</c:v>
                  </c:pt>
                  <c:pt idx="2">
                    <c:v>0.63315388207278578</c:v>
                  </c:pt>
                  <c:pt idx="3">
                    <c:v>0.76993703008949388</c:v>
                  </c:pt>
                </c:numCache>
              </c:numRef>
            </c:plus>
            <c:minus>
              <c:numRef>
                <c:f>('AMK34'!$AI$1;'AMK34'!$X$19;'AMK34'!$AC$19;'AMK34'!$AH$19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7856053783784799</c:v>
                  </c:pt>
                  <c:pt idx="2">
                    <c:v>0.63315388207278578</c:v>
                  </c:pt>
                  <c:pt idx="3">
                    <c:v>0.76993703008949388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X$10;'AMK34'!$AC$10;'AMK34'!$AH$10)</c:f>
              <c:numCache>
                <c:formatCode>General</c:formatCode>
                <c:ptCount val="4"/>
                <c:pt idx="0">
                  <c:v>0</c:v>
                </c:pt>
                <c:pt idx="1">
                  <c:v>4.583333333333333</c:v>
                </c:pt>
                <c:pt idx="2">
                  <c:v>9.9166666666666661</c:v>
                </c:pt>
                <c:pt idx="3">
                  <c:v>11.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3951-4BD8-8097-ED6F8843AA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350272"/>
        <c:axId val="45356544"/>
      </c:scatterChart>
      <c:valAx>
        <c:axId val="45350272"/>
        <c:scaling>
          <c:orientation val="minMax"/>
          <c:max val="7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Time (day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45356544"/>
        <c:crosses val="autoZero"/>
        <c:crossBetween val="midCat"/>
      </c:valAx>
      <c:valAx>
        <c:axId val="453565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s-ES" sz="1200"/>
                  <a:t>Number of node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45350272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 w="25400">
      <a:noFill/>
    </a:ln>
  </c:sp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274817990065999"/>
          <c:y val="6.52787037037037E-2"/>
          <c:w val="0.83741358780703545"/>
          <c:h val="0.6627490740740741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AMK34'!$S$3</c:f>
              <c:strCache>
                <c:ptCount val="1"/>
                <c:pt idx="0">
                  <c:v>R9B1-56</c:v>
                </c:pt>
              </c:strCache>
            </c:strRef>
          </c:tx>
          <c:spPr>
            <a:ln>
              <a:solidFill>
                <a:schemeClr val="accent2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W$12;'AMK34'!$AB$12;'AMK34'!$AG$12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8185890875479607</c:v>
                  </c:pt>
                  <c:pt idx="2">
                    <c:v>8.4794761130340568</c:v>
                  </c:pt>
                  <c:pt idx="3">
                    <c:v>10.14563375534129</c:v>
                  </c:pt>
                </c:numCache>
              </c:numRef>
            </c:plus>
            <c:minus>
              <c:numRef>
                <c:f>('AMK34'!$AI$1;'AMK34'!$W$12;'AMK34'!$AB$12;'AMK34'!$AG$12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8185890875479607</c:v>
                  </c:pt>
                  <c:pt idx="2">
                    <c:v>8.4794761130340568</c:v>
                  </c:pt>
                  <c:pt idx="3">
                    <c:v>10.14563375534129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W$3;'AMK34'!$AB$3;'AMK34'!$AG$3)</c:f>
              <c:numCache>
                <c:formatCode>General</c:formatCode>
                <c:ptCount val="4"/>
                <c:pt idx="0">
                  <c:v>0</c:v>
                </c:pt>
                <c:pt idx="1">
                  <c:v>24.666666666666668</c:v>
                </c:pt>
                <c:pt idx="2">
                  <c:v>105.5</c:v>
                </c:pt>
                <c:pt idx="3">
                  <c:v>135.4545454545454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995-4A5F-B670-196B311079E8}"/>
            </c:ext>
          </c:extLst>
        </c:ser>
        <c:ser>
          <c:idx val="1"/>
          <c:order val="1"/>
          <c:tx>
            <c:strRef>
              <c:f>'AMK34'!$S$4</c:f>
              <c:strCache>
                <c:ptCount val="1"/>
                <c:pt idx="0">
                  <c:v>R8B2-30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W$13;'AMK34'!$AB$13;'AMK34'!$AG$13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220201101092631</c:v>
                  </c:pt>
                  <c:pt idx="2">
                    <c:v>8.8500413740972057</c:v>
                  </c:pt>
                  <c:pt idx="3">
                    <c:v>10.56569157148922</c:v>
                  </c:pt>
                </c:numCache>
              </c:numRef>
            </c:plus>
            <c:minus>
              <c:numRef>
                <c:f>('AMK34'!$AI$1;'AMK34'!$W$13;'AMK34'!$AB$13;'AMK34'!$AG$13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220201101092631</c:v>
                  </c:pt>
                  <c:pt idx="2">
                    <c:v>8.8500413740972057</c:v>
                  </c:pt>
                  <c:pt idx="3">
                    <c:v>10.56569157148922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W$4;'AMK34'!$AB$4;'AMK34'!$AG$4)</c:f>
              <c:numCache>
                <c:formatCode>General</c:formatCode>
                <c:ptCount val="4"/>
                <c:pt idx="0">
                  <c:v>0</c:v>
                </c:pt>
                <c:pt idx="1">
                  <c:v>20.666666666666668</c:v>
                </c:pt>
                <c:pt idx="2">
                  <c:v>87.333333333333329</c:v>
                </c:pt>
                <c:pt idx="3">
                  <c:v>110.8333333333333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995-4A5F-B670-196B311079E8}"/>
            </c:ext>
          </c:extLst>
        </c:ser>
        <c:ser>
          <c:idx val="2"/>
          <c:order val="2"/>
          <c:tx>
            <c:strRef>
              <c:f>'AMK34'!$S$5</c:f>
              <c:strCache>
                <c:ptCount val="1"/>
                <c:pt idx="0">
                  <c:v>R7B3-34</c:v>
                </c:pt>
              </c:strCache>
            </c:strRef>
          </c:tx>
          <c:spPr>
            <a:ln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W$14;'AMK34'!$AB$14;'AMK34'!$AG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5184811898627331</c:v>
                  </c:pt>
                  <c:pt idx="2">
                    <c:v>8.1809090403984275</c:v>
                  </c:pt>
                  <c:pt idx="3">
                    <c:v>11.715913377224423</c:v>
                  </c:pt>
                </c:numCache>
              </c:numRef>
            </c:plus>
            <c:minus>
              <c:numRef>
                <c:f>('AMK34'!$AI$1;'AMK34'!$W$14;'AMK34'!$AB$14;'AMK34'!$AG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5184811898627331</c:v>
                  </c:pt>
                  <c:pt idx="2">
                    <c:v>8.1809090403984275</c:v>
                  </c:pt>
                  <c:pt idx="3">
                    <c:v>11.715913377224423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W$5;'AMK34'!$AB$5;'AMK34'!$AG$5)</c:f>
              <c:numCache>
                <c:formatCode>General</c:formatCode>
                <c:ptCount val="4"/>
                <c:pt idx="0">
                  <c:v>0</c:v>
                </c:pt>
                <c:pt idx="1">
                  <c:v>14.181818181818182</c:v>
                </c:pt>
                <c:pt idx="2">
                  <c:v>94</c:v>
                </c:pt>
                <c:pt idx="3">
                  <c:v>120.6666666666666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F995-4A5F-B670-196B311079E8}"/>
            </c:ext>
          </c:extLst>
        </c:ser>
        <c:ser>
          <c:idx val="3"/>
          <c:order val="3"/>
          <c:tx>
            <c:strRef>
              <c:f>'AMK34'!$S$6</c:f>
              <c:strCache>
                <c:ptCount val="1"/>
                <c:pt idx="0">
                  <c:v>R7B3-52</c:v>
                </c:pt>
              </c:strCache>
            </c:strRef>
          </c:tx>
          <c:spPr>
            <a:ln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W$15;'AMK34'!$AB$15;'AMK34'!$AG$15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1578225939839069</c:v>
                  </c:pt>
                  <c:pt idx="2">
                    <c:v>6.42052493927621</c:v>
                  </c:pt>
                  <c:pt idx="3">
                    <c:v>6.3144855113245235</c:v>
                  </c:pt>
                </c:numCache>
              </c:numRef>
            </c:plus>
            <c:minus>
              <c:numRef>
                <c:f>('AMK34'!$AI$1;'AMK34'!$W$15;'AMK34'!$AB$15;'AMK34'!$AG$15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1578225939839069</c:v>
                  </c:pt>
                  <c:pt idx="2">
                    <c:v>6.42052493927621</c:v>
                  </c:pt>
                  <c:pt idx="3">
                    <c:v>6.3144855113245235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W$6;'AMK34'!$AB$6;'AMK34'!$AG$6)</c:f>
              <c:numCache>
                <c:formatCode>General</c:formatCode>
                <c:ptCount val="4"/>
                <c:pt idx="0">
                  <c:v>0</c:v>
                </c:pt>
                <c:pt idx="1">
                  <c:v>19.272727272727273</c:v>
                </c:pt>
                <c:pt idx="2">
                  <c:v>78.63636363636364</c:v>
                </c:pt>
                <c:pt idx="3">
                  <c:v>92.54545454545454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F995-4A5F-B670-196B311079E8}"/>
            </c:ext>
          </c:extLst>
        </c:ser>
        <c:ser>
          <c:idx val="4"/>
          <c:order val="4"/>
          <c:tx>
            <c:strRef>
              <c:f>'AMK34'!$S$7</c:f>
              <c:strCache>
                <c:ptCount val="1"/>
                <c:pt idx="0">
                  <c:v>R6B4-40</c:v>
                </c:pt>
              </c:strCache>
            </c:strRef>
          </c:tx>
          <c:spPr>
            <a:ln>
              <a:solidFill>
                <a:schemeClr val="accent2">
                  <a:lumMod val="20000"/>
                  <a:lumOff val="8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W$16;'AMK34'!$AB$16;'AMK34'!$AG$16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6182357271692118</c:v>
                  </c:pt>
                  <c:pt idx="2">
                    <c:v>6.6050179883375497</c:v>
                  </c:pt>
                  <c:pt idx="3">
                    <c:v>7.3704295887846571</c:v>
                  </c:pt>
                </c:numCache>
              </c:numRef>
            </c:plus>
            <c:minus>
              <c:numRef>
                <c:f>('AMK34'!$AI$1;'AMK34'!$W$16;'AMK34'!$AB$16;'AMK34'!$AG$16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6182357271692118</c:v>
                  </c:pt>
                  <c:pt idx="2">
                    <c:v>6.6050179883375497</c:v>
                  </c:pt>
                  <c:pt idx="3">
                    <c:v>7.3704295887846571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W$7;'AMK34'!$AB$7;'AMK34'!$AG$7)</c:f>
              <c:numCache>
                <c:formatCode>General</c:formatCode>
                <c:ptCount val="4"/>
                <c:pt idx="0">
                  <c:v>0</c:v>
                </c:pt>
                <c:pt idx="1">
                  <c:v>16.833333333333332</c:v>
                </c:pt>
                <c:pt idx="2">
                  <c:v>73.333333333333329</c:v>
                </c:pt>
                <c:pt idx="3">
                  <c:v>91.33333333333332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F995-4A5F-B670-196B311079E8}"/>
            </c:ext>
          </c:extLst>
        </c:ser>
        <c:ser>
          <c:idx val="5"/>
          <c:order val="5"/>
          <c:tx>
            <c:strRef>
              <c:f>'AMK34'!$S$8</c:f>
              <c:strCache>
                <c:ptCount val="1"/>
                <c:pt idx="0">
                  <c:v>RW7B3-84</c:v>
                </c:pt>
              </c:strCache>
            </c:strRef>
          </c:tx>
          <c:spPr>
            <a:ln>
              <a:solidFill>
                <a:schemeClr val="tx2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W$17;'AMK34'!$AB$17;'AMK34'!$AG$17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086778913041726</c:v>
                  </c:pt>
                  <c:pt idx="2">
                    <c:v>3.2427074359478554</c:v>
                  </c:pt>
                  <c:pt idx="3">
                    <c:v>4.182319085064286</c:v>
                  </c:pt>
                </c:numCache>
              </c:numRef>
            </c:plus>
            <c:minus>
              <c:numRef>
                <c:f>('AMK34'!$AI$1;'AMK34'!$W$17;'AMK34'!$AB$17;'AMK34'!$AG$17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086778913041726</c:v>
                  </c:pt>
                  <c:pt idx="2">
                    <c:v>3.2427074359478554</c:v>
                  </c:pt>
                  <c:pt idx="3">
                    <c:v>4.182319085064286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W$8;'AMK34'!$AB$8;'AMK34'!$AG$8)</c:f>
              <c:numCache>
                <c:formatCode>General</c:formatCode>
                <c:ptCount val="4"/>
                <c:pt idx="0">
                  <c:v>0</c:v>
                </c:pt>
                <c:pt idx="1">
                  <c:v>12.25</c:v>
                </c:pt>
                <c:pt idx="2">
                  <c:v>60</c:v>
                </c:pt>
                <c:pt idx="3">
                  <c:v>75.58333333333332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F995-4A5F-B670-196B311079E8}"/>
            </c:ext>
          </c:extLst>
        </c:ser>
        <c:ser>
          <c:idx val="6"/>
          <c:order val="6"/>
          <c:tx>
            <c:strRef>
              <c:f>'AMK34'!$S$9</c:f>
              <c:strCache>
                <c:ptCount val="1"/>
                <c:pt idx="0">
                  <c:v>RW6B4-98</c:v>
                </c:pt>
              </c:strCache>
            </c:strRef>
          </c:tx>
          <c:spPr>
            <a:ln>
              <a:solidFill>
                <a:schemeClr val="accent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W$18;'AMK34'!$AB$18;'AMK34'!$AG$18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97958968940876479</c:v>
                  </c:pt>
                  <c:pt idx="2">
                    <c:v>3.5823642100341133</c:v>
                  </c:pt>
                  <c:pt idx="3">
                    <c:v>4.4295837413025758</c:v>
                  </c:pt>
                </c:numCache>
              </c:numRef>
            </c:plus>
            <c:minus>
              <c:numRef>
                <c:f>('AMK34'!$AI$1;'AMK34'!$W$18;'AMK34'!$AB$18;'AMK34'!$AG$18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97958968940876479</c:v>
                  </c:pt>
                  <c:pt idx="2">
                    <c:v>3.5823642100341133</c:v>
                  </c:pt>
                  <c:pt idx="3">
                    <c:v>4.4295837413025758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W$9;'AMK34'!$AB$9;'AMK34'!$AG$9)</c:f>
              <c:numCache>
                <c:formatCode>General</c:formatCode>
                <c:ptCount val="4"/>
                <c:pt idx="0">
                  <c:v>0</c:v>
                </c:pt>
                <c:pt idx="1">
                  <c:v>9.6666666666666661</c:v>
                </c:pt>
                <c:pt idx="2">
                  <c:v>51</c:v>
                </c:pt>
                <c:pt idx="3">
                  <c:v>6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F995-4A5F-B670-196B311079E8}"/>
            </c:ext>
          </c:extLst>
        </c:ser>
        <c:ser>
          <c:idx val="7"/>
          <c:order val="7"/>
          <c:tx>
            <c:strRef>
              <c:f>'AMK34'!$S$10</c:f>
              <c:strCache>
                <c:ptCount val="1"/>
                <c:pt idx="0">
                  <c:v>TFL-137</c:v>
                </c:pt>
              </c:strCache>
            </c:strRef>
          </c:tx>
          <c:spPr>
            <a:ln>
              <a:solidFill>
                <a:schemeClr val="bg1">
                  <a:lumMod val="7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AMK34'!$AI$1;'AMK34'!$W$19;'AMK34'!$AB$19;'AMK34'!$AG$19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93844649191193541</c:v>
                  </c:pt>
                  <c:pt idx="2">
                    <c:v>2.3154073315749679</c:v>
                  </c:pt>
                  <c:pt idx="3">
                    <c:v>3.337119062359573</c:v>
                  </c:pt>
                </c:numCache>
              </c:numRef>
            </c:plus>
            <c:minus>
              <c:numRef>
                <c:f>('AMK34'!$AI$1;'AMK34'!$W$19;'AMK34'!$AB$19;'AMK34'!$AG$19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93844649191193541</c:v>
                  </c:pt>
                  <c:pt idx="2">
                    <c:v>2.3154073315749679</c:v>
                  </c:pt>
                  <c:pt idx="3">
                    <c:v>3.337119062359573</c:v>
                  </c:pt>
                </c:numCache>
              </c:numRef>
            </c:minus>
          </c:errBars>
          <c:xVal>
            <c:numRef>
              <c:f>'AMK34'!$AI$1:$AI$4</c:f>
              <c:numCache>
                <c:formatCode>General</c:formatCode>
                <c:ptCount val="4"/>
                <c:pt idx="0">
                  <c:v>0</c:v>
                </c:pt>
                <c:pt idx="1">
                  <c:v>26</c:v>
                </c:pt>
                <c:pt idx="2">
                  <c:v>54</c:v>
                </c:pt>
                <c:pt idx="3">
                  <c:v>69</c:v>
                </c:pt>
              </c:numCache>
            </c:numRef>
          </c:xVal>
          <c:yVal>
            <c:numRef>
              <c:f>('AMK34'!$AI$1;'AMK34'!$W$10;'AMK34'!$AB$10;'AMK34'!$AG$10)</c:f>
              <c:numCache>
                <c:formatCode>General</c:formatCode>
                <c:ptCount val="4"/>
                <c:pt idx="0">
                  <c:v>0</c:v>
                </c:pt>
                <c:pt idx="1">
                  <c:v>6.25</c:v>
                </c:pt>
                <c:pt idx="2">
                  <c:v>24.166666666666668</c:v>
                </c:pt>
                <c:pt idx="3">
                  <c:v>3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F995-4A5F-B670-196B311079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426944"/>
        <c:axId val="45429120"/>
      </c:scatterChart>
      <c:valAx>
        <c:axId val="45426944"/>
        <c:scaling>
          <c:orientation val="minMax"/>
          <c:max val="7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Time (day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45429120"/>
        <c:crosses val="autoZero"/>
        <c:crossBetween val="midCat"/>
      </c:valAx>
      <c:valAx>
        <c:axId val="454291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s-ES" sz="1200"/>
                  <a:t>Total stem lenght (m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45426944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 w="25400">
      <a:noFill/>
    </a:ln>
  </c:spPr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49876543209878"/>
          <c:y val="7.1428608064338303E-2"/>
          <c:w val="0.80957901234567897"/>
          <c:h val="0.718487763470696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ato Biométricos Cosecha 1'!$S$3</c:f>
              <c:strCache>
                <c:ptCount val="1"/>
                <c:pt idx="0">
                  <c:v>R7B3-34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Dato Biométricos Cosecha 1'!$U$11;'Dato Biométricos Cosecha 1'!$U$13;'Dato Biométricos Cosecha 1'!$U$15;'Dato Biométricos Cosecha 1'!$U$17)</c:f>
                <c:numCache>
                  <c:formatCode>General</c:formatCode>
                  <c:ptCount val="4"/>
                  <c:pt idx="0">
                    <c:v>2.2271057451320084</c:v>
                  </c:pt>
                  <c:pt idx="1">
                    <c:v>3.5309284361626165</c:v>
                  </c:pt>
                  <c:pt idx="2">
                    <c:v>2.5679868015661107</c:v>
                  </c:pt>
                  <c:pt idx="3">
                    <c:v>5.1867722438925083</c:v>
                  </c:pt>
                </c:numCache>
              </c:numRef>
            </c:plus>
            <c:minus>
              <c:numRef>
                <c:f>('Dato Biométricos Cosecha 1'!$U$11;'Dato Biométricos Cosecha 1'!$U$13;'Dato Biométricos Cosecha 1'!$U$15;'Dato Biométricos Cosecha 1'!$U$17)</c:f>
                <c:numCache>
                  <c:formatCode>General</c:formatCode>
                  <c:ptCount val="4"/>
                  <c:pt idx="0">
                    <c:v>2.2271057451320084</c:v>
                  </c:pt>
                  <c:pt idx="1">
                    <c:v>3.5309284361626165</c:v>
                  </c:pt>
                  <c:pt idx="2">
                    <c:v>2.5679868015661107</c:v>
                  </c:pt>
                  <c:pt idx="3">
                    <c:v>5.1867722438925083</c:v>
                  </c:pt>
                </c:numCache>
              </c:numRef>
            </c:minus>
          </c:errBars>
          <c:cat>
            <c:strRef>
              <c:f>'Dato Biométricos Cosecha 1'!$R$3:$R$6</c:f>
              <c:strCache>
                <c:ptCount val="4"/>
                <c:pt idx="0">
                  <c:v>ACZ1</c:v>
                </c:pt>
                <c:pt idx="1">
                  <c:v>ACZ4</c:v>
                </c:pt>
                <c:pt idx="2">
                  <c:v>AJA4</c:v>
                </c:pt>
                <c:pt idx="3">
                  <c:v>AJA6</c:v>
                </c:pt>
              </c:strCache>
            </c:strRef>
          </c:cat>
          <c:val>
            <c:numRef>
              <c:f>('Dato Biométricos Cosecha 1'!$U$3;'Dato Biométricos Cosecha 1'!$U$5;'Dato Biométricos Cosecha 1'!$U$7;'Dato Biométricos Cosecha 1'!$U$9)</c:f>
              <c:numCache>
                <c:formatCode>0.0000</c:formatCode>
                <c:ptCount val="4"/>
                <c:pt idx="0" formatCode="General">
                  <c:v>37</c:v>
                </c:pt>
                <c:pt idx="1">
                  <c:v>56.92307692307692</c:v>
                </c:pt>
                <c:pt idx="2">
                  <c:v>54.53846153846154</c:v>
                </c:pt>
                <c:pt idx="3">
                  <c:v>78.7037037037037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9E-4AB5-9402-664FDEB8FC01}"/>
            </c:ext>
          </c:extLst>
        </c:ser>
        <c:ser>
          <c:idx val="1"/>
          <c:order val="1"/>
          <c:tx>
            <c:strRef>
              <c:f>'Dato Biométricos Cosecha 1'!$S$4</c:f>
              <c:strCache>
                <c:ptCount val="1"/>
                <c:pt idx="0">
                  <c:v>TFL-137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Dato Biométricos Cosecha 1'!$U$12;'Dato Biométricos Cosecha 1'!$U$14;'Dato Biométricos Cosecha 1'!$U$16;'Dato Biométricos Cosecha 1'!$U$18)</c:f>
                <c:numCache>
                  <c:formatCode>General</c:formatCode>
                  <c:ptCount val="4"/>
                  <c:pt idx="0">
                    <c:v>2.1648710508172693</c:v>
                  </c:pt>
                  <c:pt idx="1">
                    <c:v>1.8559094805512468</c:v>
                  </c:pt>
                  <c:pt idx="2">
                    <c:v>1.0484138484554357</c:v>
                  </c:pt>
                  <c:pt idx="3">
                    <c:v>1.7861129388141814</c:v>
                  </c:pt>
                </c:numCache>
              </c:numRef>
            </c:plus>
            <c:minus>
              <c:numRef>
                <c:f>('Dato Biométricos Cosecha 1'!$U$12;'Dato Biométricos Cosecha 1'!$U$14;'Dato Biométricos Cosecha 1'!$U$16;'Dato Biométricos Cosecha 1'!$U$18)</c:f>
                <c:numCache>
                  <c:formatCode>General</c:formatCode>
                  <c:ptCount val="4"/>
                  <c:pt idx="0">
                    <c:v>2.1648710508172693</c:v>
                  </c:pt>
                  <c:pt idx="1">
                    <c:v>1.8559094805512468</c:v>
                  </c:pt>
                  <c:pt idx="2">
                    <c:v>1.0484138484554357</c:v>
                  </c:pt>
                  <c:pt idx="3">
                    <c:v>1.7861129388141814</c:v>
                  </c:pt>
                </c:numCache>
              </c:numRef>
            </c:minus>
          </c:errBars>
          <c:cat>
            <c:strRef>
              <c:f>'Dato Biométricos Cosecha 1'!$R$3:$R$6</c:f>
              <c:strCache>
                <c:ptCount val="4"/>
                <c:pt idx="0">
                  <c:v>ACZ1</c:v>
                </c:pt>
                <c:pt idx="1">
                  <c:v>ACZ4</c:v>
                </c:pt>
                <c:pt idx="2">
                  <c:v>AJA4</c:v>
                </c:pt>
                <c:pt idx="3">
                  <c:v>AJA6</c:v>
                </c:pt>
              </c:strCache>
            </c:strRef>
          </c:cat>
          <c:val>
            <c:numRef>
              <c:f>('Dato Biométricos Cosecha 1'!$U$4;'Dato Biométricos Cosecha 1'!$U$6;'Dato Biométricos Cosecha 1'!$U$8;'Dato Biométricos Cosecha 1'!$U$10)</c:f>
              <c:numCache>
                <c:formatCode>0.0000</c:formatCode>
                <c:ptCount val="4"/>
                <c:pt idx="0" formatCode="General">
                  <c:v>25.4</c:v>
                </c:pt>
                <c:pt idx="1">
                  <c:v>32.880000000000003</c:v>
                </c:pt>
                <c:pt idx="2">
                  <c:v>18.53846153846154</c:v>
                </c:pt>
                <c:pt idx="3">
                  <c:v>40.4814814814814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9E-4AB5-9402-664FDEB8FC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519616"/>
        <c:axId val="45521152"/>
      </c:barChart>
      <c:catAx>
        <c:axId val="45519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s-ES" sz="1200" b="1" baseline="0">
                <a:solidFill>
                  <a:schemeClr val="bg1"/>
                </a:solidFill>
              </a:defRPr>
            </a:pPr>
            <a:endParaRPr lang="es-ES"/>
          </a:p>
        </c:txPr>
        <c:crossAx val="45521152"/>
        <c:crosses val="autoZero"/>
        <c:auto val="1"/>
        <c:lblAlgn val="ctr"/>
        <c:lblOffset val="100"/>
        <c:noMultiLvlLbl val="0"/>
      </c:catAx>
      <c:valAx>
        <c:axId val="45521152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s-ES" sz="1200" b="1" i="0" baseline="0" dirty="0">
                    <a:effectLst/>
                  </a:rPr>
                  <a:t>Total </a:t>
                </a:r>
                <a:r>
                  <a:rPr lang="es-ES" sz="1200" b="1" i="0" baseline="0" dirty="0" err="1">
                    <a:effectLst/>
                  </a:rPr>
                  <a:t>stem</a:t>
                </a:r>
                <a:r>
                  <a:rPr lang="es-ES" sz="1200" b="1" i="0" baseline="0" dirty="0">
                    <a:effectLst/>
                  </a:rPr>
                  <a:t> </a:t>
                </a:r>
                <a:r>
                  <a:rPr lang="es-ES" sz="1200" b="1" i="0" baseline="0" dirty="0" err="1">
                    <a:effectLst/>
                  </a:rPr>
                  <a:t>lenght</a:t>
                </a:r>
                <a:r>
                  <a:rPr lang="es-ES" sz="1200" b="1" i="0" baseline="0" dirty="0">
                    <a:effectLst/>
                  </a:rPr>
                  <a:t> (mm)</a:t>
                </a:r>
                <a:endParaRPr lang="es-ES" sz="12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s-ES" sz="1200" b="1"/>
            </a:pPr>
            <a:endParaRPr lang="es-ES"/>
          </a:p>
        </c:txPr>
        <c:crossAx val="45519616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075475308641975"/>
          <c:y val="0"/>
          <c:w val="0.50249753086419757"/>
          <c:h val="9.6442592592592594E-2"/>
        </c:manualLayout>
      </c:layout>
      <c:overlay val="0"/>
      <c:txPr>
        <a:bodyPr/>
        <a:lstStyle/>
        <a:p>
          <a:pPr>
            <a:defRPr sz="1200" b="1"/>
          </a:pPr>
          <a:endParaRPr lang="es-ES"/>
        </a:p>
      </c:txPr>
    </c:legend>
    <c:plotVisOnly val="1"/>
    <c:dispBlanksAs val="gap"/>
    <c:showDLblsOverMax val="0"/>
  </c:chart>
  <c:spPr>
    <a:noFill/>
    <a:ln w="3175">
      <a:noFill/>
      <a:prstDash val="solid"/>
    </a:ln>
  </c:spPr>
  <c:externalData r:id="rId1">
    <c:autoUpdate val="0"/>
  </c:externalData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8932</cdr:x>
      <cdr:y>0.00116</cdr:y>
    </cdr:from>
    <cdr:to>
      <cdr:x>1</cdr:x>
      <cdr:y>0.09837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1909389" y="3132"/>
          <a:ext cx="1330611" cy="2624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000" b="1" dirty="0"/>
            <a:t>NS</a:t>
          </a: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14679</cdr:x>
      <cdr:y>0.10017</cdr:y>
    </cdr:from>
    <cdr:to>
      <cdr:x>0.9691</cdr:x>
      <cdr:y>0.15351</cdr:y>
    </cdr:to>
    <cdr:sp macro="" textlink="">
      <cdr:nvSpPr>
        <cdr:cNvPr id="6" name="1 CuadroTexto"/>
        <cdr:cNvSpPr txBox="1"/>
      </cdr:nvSpPr>
      <cdr:spPr>
        <a:xfrm xmlns:a="http://schemas.openxmlformats.org/drawingml/2006/main">
          <a:off x="475592" y="270454"/>
          <a:ext cx="2664296" cy="1440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400" b="1" dirty="0"/>
            <a:t>    ***          ***          ***           *** 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4719</cdr:x>
      <cdr:y>0</cdr:y>
    </cdr:from>
    <cdr:to>
      <cdr:x>1</cdr:x>
      <cdr:y>0.09721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2151907" y="-1910666"/>
          <a:ext cx="728093" cy="1749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000" b="1" dirty="0"/>
            <a:t>NS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56709</cdr:x>
      <cdr:y>0</cdr:y>
    </cdr:from>
    <cdr:to>
      <cdr:x>1</cdr:x>
      <cdr:y>0.09721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1633219" y="-5461172"/>
          <a:ext cx="1246781" cy="1749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000" b="1" dirty="0"/>
            <a:t>NS</a:t>
          </a:r>
          <a:endParaRPr lang="es-ES" sz="900" b="1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68102</cdr:x>
      <cdr:y>0</cdr:y>
    </cdr:from>
    <cdr:to>
      <cdr:x>0.9986</cdr:x>
      <cdr:y>0.09721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2206493" y="0"/>
          <a:ext cx="1028972" cy="2624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000" b="1" dirty="0"/>
            <a:t>NS</a:t>
          </a:r>
          <a:endParaRPr lang="es-ES" sz="1050" b="1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80146</cdr:x>
      <cdr:y>0.01129</cdr:y>
    </cdr:from>
    <cdr:to>
      <cdr:x>1</cdr:x>
      <cdr:y>0.1012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4700855" y="32090"/>
          <a:ext cx="1164509" cy="2555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800" b="1" dirty="0"/>
            <a:t>NS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81622</cdr:x>
      <cdr:y>0.0048</cdr:y>
    </cdr:from>
    <cdr:to>
      <cdr:x>0.95191</cdr:x>
      <cdr:y>0.10481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4797152" y="10363"/>
          <a:ext cx="797487" cy="2160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400" b="1" dirty="0"/>
            <a:t>***</a:t>
          </a:r>
        </a:p>
      </cdr:txBody>
    </cdr:sp>
  </cdr:relSizeAnchor>
  <cdr:relSizeAnchor xmlns:cdr="http://schemas.openxmlformats.org/drawingml/2006/chartDrawing">
    <cdr:from>
      <cdr:x>0.44128</cdr:x>
      <cdr:y>0</cdr:y>
    </cdr:from>
    <cdr:to>
      <cdr:x>0.64469</cdr:x>
      <cdr:y>0.10001</cdr:y>
    </cdr:to>
    <cdr:sp macro="" textlink="">
      <cdr:nvSpPr>
        <cdr:cNvPr id="3" name="1 CuadroTexto"/>
        <cdr:cNvSpPr txBox="1"/>
      </cdr:nvSpPr>
      <cdr:spPr>
        <a:xfrm xmlns:a="http://schemas.openxmlformats.org/drawingml/2006/main">
          <a:off x="2593522" y="0"/>
          <a:ext cx="1195518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s-ES" sz="1600" b="1" dirty="0"/>
            <a:t>***</a:t>
          </a:r>
        </a:p>
      </cdr:txBody>
    </cdr:sp>
  </cdr:relSizeAnchor>
  <cdr:relSizeAnchor xmlns:cdr="http://schemas.openxmlformats.org/drawingml/2006/chartDrawing">
    <cdr:from>
      <cdr:x>0.3629</cdr:x>
      <cdr:y>0.36671</cdr:y>
    </cdr:from>
    <cdr:to>
      <cdr:x>0.47539</cdr:x>
      <cdr:y>0.44427</cdr:y>
    </cdr:to>
    <cdr:sp macro="" textlink="">
      <cdr:nvSpPr>
        <cdr:cNvPr id="4" name="1 CuadroTexto"/>
        <cdr:cNvSpPr txBox="1"/>
      </cdr:nvSpPr>
      <cdr:spPr>
        <a:xfrm xmlns:a="http://schemas.openxmlformats.org/drawingml/2006/main">
          <a:off x="2132855" y="792088"/>
          <a:ext cx="661149" cy="1675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s-ES" sz="1400" b="1" dirty="0"/>
            <a:t>***</a:t>
          </a:r>
        </a:p>
      </cdr:txBody>
    </cdr:sp>
  </cdr:relSizeAnchor>
  <cdr:relSizeAnchor xmlns:cdr="http://schemas.openxmlformats.org/drawingml/2006/chartDrawing">
    <cdr:from>
      <cdr:x>0.6692</cdr:x>
      <cdr:y>0.04358</cdr:y>
    </cdr:from>
    <cdr:to>
      <cdr:x>0.80127</cdr:x>
      <cdr:y>0.13452</cdr:y>
    </cdr:to>
    <cdr:sp macro="" textlink="">
      <cdr:nvSpPr>
        <cdr:cNvPr id="5" name="1 CuadroTexto"/>
        <cdr:cNvSpPr txBox="1"/>
      </cdr:nvSpPr>
      <cdr:spPr>
        <a:xfrm xmlns:a="http://schemas.openxmlformats.org/drawingml/2006/main">
          <a:off x="3933056" y="94136"/>
          <a:ext cx="776212" cy="1964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s-ES" sz="1400" b="1" dirty="0"/>
            <a:t>***</a:t>
          </a:r>
        </a:p>
      </cdr:txBody>
    </cdr:sp>
  </cdr:relSizeAnchor>
  <cdr:relSizeAnchor xmlns:cdr="http://schemas.openxmlformats.org/drawingml/2006/chartDrawing">
    <cdr:from>
      <cdr:x>0.92649</cdr:x>
      <cdr:y>0.06667</cdr:y>
    </cdr:from>
    <cdr:to>
      <cdr:x>0.99309</cdr:x>
      <cdr:y>0.15934</cdr:y>
    </cdr:to>
    <cdr:sp macro="" textlink="">
      <cdr:nvSpPr>
        <cdr:cNvPr id="6" name="1 CuadroTexto"/>
        <cdr:cNvSpPr txBox="1"/>
      </cdr:nvSpPr>
      <cdr:spPr>
        <a:xfrm xmlns:a="http://schemas.openxmlformats.org/drawingml/2006/main">
          <a:off x="5445223" y="144016"/>
          <a:ext cx="391427" cy="2001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/>
            <a:t>a</a:t>
          </a:r>
        </a:p>
      </cdr:txBody>
    </cdr:sp>
  </cdr:relSizeAnchor>
  <cdr:relSizeAnchor xmlns:cdr="http://schemas.openxmlformats.org/drawingml/2006/chartDrawing">
    <cdr:from>
      <cdr:x>0.88973</cdr:x>
      <cdr:y>0.21027</cdr:y>
    </cdr:from>
    <cdr:to>
      <cdr:x>1</cdr:x>
      <cdr:y>0.30294</cdr:y>
    </cdr:to>
    <cdr:sp macro="" textlink="">
      <cdr:nvSpPr>
        <cdr:cNvPr id="7" name="1 CuadroTexto"/>
        <cdr:cNvSpPr txBox="1"/>
      </cdr:nvSpPr>
      <cdr:spPr>
        <a:xfrm xmlns:a="http://schemas.openxmlformats.org/drawingml/2006/main">
          <a:off x="5229200" y="454176"/>
          <a:ext cx="648071" cy="2001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 err="1"/>
            <a:t>abc</a:t>
          </a:r>
          <a:endParaRPr lang="es-ES" sz="1600" b="1" dirty="0"/>
        </a:p>
      </cdr:txBody>
    </cdr:sp>
  </cdr:relSizeAnchor>
  <cdr:relSizeAnchor xmlns:cdr="http://schemas.openxmlformats.org/drawingml/2006/chartDrawing">
    <cdr:from>
      <cdr:x>0.90198</cdr:x>
      <cdr:y>0.14359</cdr:y>
    </cdr:from>
    <cdr:to>
      <cdr:x>1</cdr:x>
      <cdr:y>0.23627</cdr:y>
    </cdr:to>
    <cdr:sp macro="" textlink="">
      <cdr:nvSpPr>
        <cdr:cNvPr id="8" name="1 CuadroTexto"/>
        <cdr:cNvSpPr txBox="1"/>
      </cdr:nvSpPr>
      <cdr:spPr>
        <a:xfrm xmlns:a="http://schemas.openxmlformats.org/drawingml/2006/main">
          <a:off x="5301208" y="310160"/>
          <a:ext cx="576063" cy="20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/>
            <a:t>ab</a:t>
          </a:r>
        </a:p>
      </cdr:txBody>
    </cdr:sp>
  </cdr:relSizeAnchor>
  <cdr:relSizeAnchor xmlns:cdr="http://schemas.openxmlformats.org/drawingml/2006/chartDrawing">
    <cdr:from>
      <cdr:x>0.88485</cdr:x>
      <cdr:y>0.41029</cdr:y>
    </cdr:from>
    <cdr:to>
      <cdr:x>1</cdr:x>
      <cdr:y>0.50296</cdr:y>
    </cdr:to>
    <cdr:sp macro="" textlink="">
      <cdr:nvSpPr>
        <cdr:cNvPr id="9" name="1 CuadroTexto"/>
        <cdr:cNvSpPr txBox="1"/>
      </cdr:nvSpPr>
      <cdr:spPr>
        <a:xfrm xmlns:a="http://schemas.openxmlformats.org/drawingml/2006/main">
          <a:off x="5200526" y="886224"/>
          <a:ext cx="676745" cy="2001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 err="1"/>
            <a:t>cde</a:t>
          </a:r>
          <a:endParaRPr lang="es-ES" sz="1600" b="1" dirty="0"/>
        </a:p>
      </cdr:txBody>
    </cdr:sp>
  </cdr:relSizeAnchor>
  <cdr:relSizeAnchor xmlns:cdr="http://schemas.openxmlformats.org/drawingml/2006/chartDrawing">
    <cdr:from>
      <cdr:x>0.90663</cdr:x>
      <cdr:y>0.28021</cdr:y>
    </cdr:from>
    <cdr:to>
      <cdr:x>1</cdr:x>
      <cdr:y>0.37288</cdr:y>
    </cdr:to>
    <cdr:sp macro="" textlink="">
      <cdr:nvSpPr>
        <cdr:cNvPr id="10" name="1 CuadroTexto"/>
        <cdr:cNvSpPr txBox="1"/>
      </cdr:nvSpPr>
      <cdr:spPr>
        <a:xfrm xmlns:a="http://schemas.openxmlformats.org/drawingml/2006/main">
          <a:off x="5328510" y="605255"/>
          <a:ext cx="548761" cy="2001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 err="1"/>
            <a:t>bcd</a:t>
          </a:r>
          <a:endParaRPr lang="es-ES" sz="1600" b="1" dirty="0"/>
        </a:p>
      </cdr:txBody>
    </cdr:sp>
  </cdr:relSizeAnchor>
  <cdr:relSizeAnchor xmlns:cdr="http://schemas.openxmlformats.org/drawingml/2006/chartDrawing">
    <cdr:from>
      <cdr:x>0.87802</cdr:x>
      <cdr:y>0.34361</cdr:y>
    </cdr:from>
    <cdr:to>
      <cdr:x>1</cdr:x>
      <cdr:y>0.43628</cdr:y>
    </cdr:to>
    <cdr:sp macro="" textlink="">
      <cdr:nvSpPr>
        <cdr:cNvPr id="11" name="1 CuadroTexto"/>
        <cdr:cNvSpPr txBox="1"/>
      </cdr:nvSpPr>
      <cdr:spPr>
        <a:xfrm xmlns:a="http://schemas.openxmlformats.org/drawingml/2006/main">
          <a:off x="5160384" y="742208"/>
          <a:ext cx="716887" cy="2001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 err="1"/>
            <a:t>bcd</a:t>
          </a:r>
          <a:endParaRPr lang="es-ES" sz="1600" b="1" dirty="0"/>
        </a:p>
      </cdr:txBody>
    </cdr:sp>
  </cdr:relSizeAnchor>
  <cdr:relSizeAnchor xmlns:cdr="http://schemas.openxmlformats.org/drawingml/2006/chartDrawing">
    <cdr:from>
      <cdr:x>0.9334</cdr:x>
      <cdr:y>0.54364</cdr:y>
    </cdr:from>
    <cdr:to>
      <cdr:x>1</cdr:x>
      <cdr:y>0.63632</cdr:y>
    </cdr:to>
    <cdr:sp macro="" textlink="">
      <cdr:nvSpPr>
        <cdr:cNvPr id="12" name="1 CuadroTexto"/>
        <cdr:cNvSpPr txBox="1"/>
      </cdr:nvSpPr>
      <cdr:spPr>
        <a:xfrm xmlns:a="http://schemas.openxmlformats.org/drawingml/2006/main">
          <a:off x="5485845" y="1174256"/>
          <a:ext cx="391426" cy="20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/>
            <a:t>e</a:t>
          </a:r>
        </a:p>
      </cdr:txBody>
    </cdr:sp>
  </cdr:relSizeAnchor>
  <cdr:relSizeAnchor xmlns:cdr="http://schemas.openxmlformats.org/drawingml/2006/chartDrawing">
    <cdr:from>
      <cdr:x>0.89711</cdr:x>
      <cdr:y>0.47696</cdr:y>
    </cdr:from>
    <cdr:to>
      <cdr:x>1</cdr:x>
      <cdr:y>0.56963</cdr:y>
    </cdr:to>
    <cdr:sp macro="" textlink="">
      <cdr:nvSpPr>
        <cdr:cNvPr id="13" name="1 CuadroTexto"/>
        <cdr:cNvSpPr txBox="1"/>
      </cdr:nvSpPr>
      <cdr:spPr>
        <a:xfrm xmlns:a="http://schemas.openxmlformats.org/drawingml/2006/main">
          <a:off x="5272533" y="1030240"/>
          <a:ext cx="604738" cy="2001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/>
            <a:t>de</a:t>
          </a:r>
          <a:endParaRPr lang="es-ES" sz="1400" b="1" dirty="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85027</cdr:x>
      <cdr:y>0</cdr:y>
    </cdr:from>
    <cdr:to>
      <cdr:x>0.99967</cdr:x>
      <cdr:y>0.11771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4906940" y="0"/>
          <a:ext cx="862210" cy="2119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800" b="1" dirty="0"/>
            <a:t>NS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90175</cdr:x>
      <cdr:y>0.06667</cdr:y>
    </cdr:from>
    <cdr:to>
      <cdr:x>0.99974</cdr:x>
      <cdr:y>0.16669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5301208" y="144016"/>
          <a:ext cx="576064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r"/>
          <a:r>
            <a:rPr lang="es-ES" sz="1200" b="1" dirty="0"/>
            <a:t>a</a:t>
          </a:r>
        </a:p>
      </cdr:txBody>
    </cdr:sp>
  </cdr:relSizeAnchor>
  <cdr:relSizeAnchor xmlns:cdr="http://schemas.openxmlformats.org/drawingml/2006/chartDrawing">
    <cdr:from>
      <cdr:x>0.92625</cdr:x>
      <cdr:y>0.20002</cdr:y>
    </cdr:from>
    <cdr:to>
      <cdr:x>0.99974</cdr:x>
      <cdr:y>0.26269</cdr:y>
    </cdr:to>
    <cdr:sp macro="" textlink="">
      <cdr:nvSpPr>
        <cdr:cNvPr id="3" name="1 CuadroTexto"/>
        <cdr:cNvSpPr txBox="1"/>
      </cdr:nvSpPr>
      <cdr:spPr>
        <a:xfrm xmlns:a="http://schemas.openxmlformats.org/drawingml/2006/main">
          <a:off x="5445224" y="432048"/>
          <a:ext cx="432048" cy="1353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/>
            <a:t>ab</a:t>
          </a:r>
        </a:p>
      </cdr:txBody>
    </cdr:sp>
  </cdr:relSizeAnchor>
  <cdr:relSizeAnchor xmlns:cdr="http://schemas.openxmlformats.org/drawingml/2006/chartDrawing">
    <cdr:from>
      <cdr:x>0.90175</cdr:x>
      <cdr:y>0.13335</cdr:y>
    </cdr:from>
    <cdr:to>
      <cdr:x>0.99974</cdr:x>
      <cdr:y>0.19602</cdr:y>
    </cdr:to>
    <cdr:sp macro="" textlink="">
      <cdr:nvSpPr>
        <cdr:cNvPr id="4" name="1 CuadroTexto"/>
        <cdr:cNvSpPr txBox="1"/>
      </cdr:nvSpPr>
      <cdr:spPr>
        <a:xfrm xmlns:a="http://schemas.openxmlformats.org/drawingml/2006/main">
          <a:off x="5301208" y="288032"/>
          <a:ext cx="576064" cy="1353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/>
            <a:t>ab</a:t>
          </a:r>
        </a:p>
      </cdr:txBody>
    </cdr:sp>
  </cdr:relSizeAnchor>
  <cdr:relSizeAnchor xmlns:cdr="http://schemas.openxmlformats.org/drawingml/2006/chartDrawing">
    <cdr:from>
      <cdr:x>0.94353</cdr:x>
      <cdr:y>0.20002</cdr:y>
    </cdr:from>
    <cdr:to>
      <cdr:x>1</cdr:x>
      <cdr:y>0.30003</cdr:y>
    </cdr:to>
    <cdr:sp macro="" textlink="">
      <cdr:nvSpPr>
        <cdr:cNvPr id="5" name="1 CuadroTexto"/>
        <cdr:cNvSpPr txBox="1"/>
      </cdr:nvSpPr>
      <cdr:spPr>
        <a:xfrm xmlns:a="http://schemas.openxmlformats.org/drawingml/2006/main">
          <a:off x="5546824" y="432048"/>
          <a:ext cx="331976" cy="2160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endParaRPr lang="es-ES" sz="800" b="1" dirty="0"/>
        </a:p>
        <a:p xmlns:a="http://schemas.openxmlformats.org/drawingml/2006/main">
          <a:pPr algn="r"/>
          <a:r>
            <a:rPr lang="es-ES" sz="1200" b="1" dirty="0" err="1"/>
            <a:t>bc</a:t>
          </a:r>
          <a:endParaRPr lang="es-ES" sz="1200" b="1" dirty="0"/>
        </a:p>
      </cdr:txBody>
    </cdr:sp>
  </cdr:relSizeAnchor>
  <cdr:relSizeAnchor xmlns:cdr="http://schemas.openxmlformats.org/drawingml/2006/chartDrawing">
    <cdr:from>
      <cdr:x>0.94327</cdr:x>
      <cdr:y>0.36671</cdr:y>
    </cdr:from>
    <cdr:to>
      <cdr:x>0.99974</cdr:x>
      <cdr:y>0.42938</cdr:y>
    </cdr:to>
    <cdr:sp macro="" textlink="">
      <cdr:nvSpPr>
        <cdr:cNvPr id="7" name="1 CuadroTexto"/>
        <cdr:cNvSpPr txBox="1"/>
      </cdr:nvSpPr>
      <cdr:spPr>
        <a:xfrm xmlns:a="http://schemas.openxmlformats.org/drawingml/2006/main">
          <a:off x="5545296" y="792088"/>
          <a:ext cx="331976" cy="1353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/>
            <a:t>c</a:t>
          </a:r>
        </a:p>
      </cdr:txBody>
    </cdr:sp>
  </cdr:relSizeAnchor>
  <cdr:relSizeAnchor xmlns:cdr="http://schemas.openxmlformats.org/drawingml/2006/chartDrawing">
    <cdr:from>
      <cdr:x>0.92868</cdr:x>
      <cdr:y>0.43338</cdr:y>
    </cdr:from>
    <cdr:to>
      <cdr:x>0.99974</cdr:x>
      <cdr:y>0.49605</cdr:y>
    </cdr:to>
    <cdr:sp macro="" textlink="">
      <cdr:nvSpPr>
        <cdr:cNvPr id="8" name="1 CuadroTexto"/>
        <cdr:cNvSpPr txBox="1"/>
      </cdr:nvSpPr>
      <cdr:spPr>
        <a:xfrm xmlns:a="http://schemas.openxmlformats.org/drawingml/2006/main">
          <a:off x="5459539" y="936104"/>
          <a:ext cx="417733" cy="1353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/>
            <a:t>cd</a:t>
          </a:r>
        </a:p>
      </cdr:txBody>
    </cdr:sp>
  </cdr:relSizeAnchor>
  <cdr:relSizeAnchor xmlns:cdr="http://schemas.openxmlformats.org/drawingml/2006/chartDrawing">
    <cdr:from>
      <cdr:x>0.94111</cdr:x>
      <cdr:y>0.50006</cdr:y>
    </cdr:from>
    <cdr:to>
      <cdr:x>0.99758</cdr:x>
      <cdr:y>0.56273</cdr:y>
    </cdr:to>
    <cdr:sp macro="" textlink="">
      <cdr:nvSpPr>
        <cdr:cNvPr id="9" name="1 CuadroTexto"/>
        <cdr:cNvSpPr txBox="1"/>
      </cdr:nvSpPr>
      <cdr:spPr>
        <a:xfrm xmlns:a="http://schemas.openxmlformats.org/drawingml/2006/main">
          <a:off x="5532575" y="1080120"/>
          <a:ext cx="331976" cy="1353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200" b="1" dirty="0"/>
            <a:t>d</a:t>
          </a:r>
        </a:p>
      </cdr:txBody>
    </cdr:sp>
  </cdr:relSizeAnchor>
  <cdr:relSizeAnchor xmlns:cdr="http://schemas.openxmlformats.org/drawingml/2006/chartDrawing">
    <cdr:from>
      <cdr:x>0.84051</cdr:x>
      <cdr:y>0</cdr:y>
    </cdr:from>
    <cdr:to>
      <cdr:x>0.97616</cdr:x>
      <cdr:y>0.10001</cdr:y>
    </cdr:to>
    <cdr:sp macro="" textlink="">
      <cdr:nvSpPr>
        <cdr:cNvPr id="11" name="1 CuadroTexto"/>
        <cdr:cNvSpPr txBox="1"/>
      </cdr:nvSpPr>
      <cdr:spPr>
        <a:xfrm xmlns:a="http://schemas.openxmlformats.org/drawingml/2006/main">
          <a:off x="4941168" y="-539552"/>
          <a:ext cx="797487" cy="2160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400" b="1" dirty="0"/>
            <a:t>***</a:t>
          </a:r>
        </a:p>
      </cdr:txBody>
    </cdr:sp>
  </cdr:relSizeAnchor>
  <cdr:relSizeAnchor xmlns:cdr="http://schemas.openxmlformats.org/drawingml/2006/chartDrawing">
    <cdr:from>
      <cdr:x>0.66902</cdr:x>
      <cdr:y>0.13335</cdr:y>
    </cdr:from>
    <cdr:to>
      <cdr:x>0.80468</cdr:x>
      <cdr:y>0.23336</cdr:y>
    </cdr:to>
    <cdr:sp macro="" textlink="">
      <cdr:nvSpPr>
        <cdr:cNvPr id="12" name="1 CuadroTexto"/>
        <cdr:cNvSpPr txBox="1"/>
      </cdr:nvSpPr>
      <cdr:spPr>
        <a:xfrm xmlns:a="http://schemas.openxmlformats.org/drawingml/2006/main">
          <a:off x="3933056" y="288032"/>
          <a:ext cx="797487" cy="2160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s-ES" sz="1400" b="1" dirty="0"/>
            <a:t>***</a:t>
          </a:r>
        </a:p>
      </cdr:txBody>
    </cdr:sp>
  </cdr:relSizeAnchor>
  <cdr:relSizeAnchor xmlns:cdr="http://schemas.openxmlformats.org/drawingml/2006/chartDrawing">
    <cdr:from>
      <cdr:x>0.35056</cdr:x>
      <cdr:y>0.46672</cdr:y>
    </cdr:from>
    <cdr:to>
      <cdr:x>0.48621</cdr:x>
      <cdr:y>0.56673</cdr:y>
    </cdr:to>
    <cdr:sp macro="" textlink="">
      <cdr:nvSpPr>
        <cdr:cNvPr id="13" name="1 CuadroTexto"/>
        <cdr:cNvSpPr txBox="1"/>
      </cdr:nvSpPr>
      <cdr:spPr>
        <a:xfrm xmlns:a="http://schemas.openxmlformats.org/drawingml/2006/main">
          <a:off x="2060848" y="1008112"/>
          <a:ext cx="797487" cy="2160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s-ES" sz="1400" b="1" dirty="0"/>
            <a:t>***</a:t>
          </a:r>
        </a:p>
      </cdr:txBody>
    </cdr:sp>
  </cdr:relSizeAnchor>
  <cdr:relSizeAnchor xmlns:cdr="http://schemas.openxmlformats.org/drawingml/2006/chartDrawing">
    <cdr:from>
      <cdr:x>0.44855</cdr:x>
      <cdr:y>0.03334</cdr:y>
    </cdr:from>
    <cdr:to>
      <cdr:x>0.5842</cdr:x>
      <cdr:y>0.13335</cdr:y>
    </cdr:to>
    <cdr:sp macro="" textlink="">
      <cdr:nvSpPr>
        <cdr:cNvPr id="14" name="1 CuadroTexto"/>
        <cdr:cNvSpPr txBox="1"/>
      </cdr:nvSpPr>
      <cdr:spPr>
        <a:xfrm xmlns:a="http://schemas.openxmlformats.org/drawingml/2006/main">
          <a:off x="2636912" y="72008"/>
          <a:ext cx="797487" cy="2160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s-ES" sz="1600" b="1" dirty="0"/>
            <a:t>***</a:t>
          </a:r>
        </a:p>
      </cdr:txBody>
    </cdr:sp>
  </cdr:relSizeAnchor>
  <cdr:relSizeAnchor xmlns:cdr="http://schemas.openxmlformats.org/drawingml/2006/chartDrawing">
    <cdr:from>
      <cdr:x>0.9385</cdr:x>
      <cdr:y>0.2667</cdr:y>
    </cdr:from>
    <cdr:to>
      <cdr:x>1</cdr:x>
      <cdr:y>0.36671</cdr:y>
    </cdr:to>
    <cdr:sp macro="" textlink="">
      <cdr:nvSpPr>
        <cdr:cNvPr id="15" name="1 CuadroTexto"/>
        <cdr:cNvSpPr txBox="1"/>
      </cdr:nvSpPr>
      <cdr:spPr>
        <a:xfrm xmlns:a="http://schemas.openxmlformats.org/drawingml/2006/main">
          <a:off x="5517232" y="576064"/>
          <a:ext cx="361568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endParaRPr lang="es-ES" sz="600" b="1" dirty="0"/>
        </a:p>
        <a:p xmlns:a="http://schemas.openxmlformats.org/drawingml/2006/main">
          <a:pPr algn="r"/>
          <a:r>
            <a:rPr lang="es-ES" sz="1200" b="1" dirty="0" err="1"/>
            <a:t>bc</a:t>
          </a:r>
          <a:endParaRPr lang="es-ES" sz="1200" b="1" dirty="0"/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15557</cdr:x>
      <cdr:y>0.10668</cdr:y>
    </cdr:from>
    <cdr:to>
      <cdr:x>0.97789</cdr:x>
      <cdr:y>0.16002</cdr:y>
    </cdr:to>
    <cdr:sp macro="" textlink="">
      <cdr:nvSpPr>
        <cdr:cNvPr id="5" name="1 CuadroTexto"/>
        <cdr:cNvSpPr txBox="1"/>
      </cdr:nvSpPr>
      <cdr:spPr>
        <a:xfrm xmlns:a="http://schemas.openxmlformats.org/drawingml/2006/main">
          <a:off x="504056" y="288033"/>
          <a:ext cx="2664296" cy="1440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400" b="1" dirty="0"/>
            <a:t>    ***          ***          ***           **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50475" cy="497046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56738" y="1"/>
            <a:ext cx="2950475" cy="497046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C84889A7-85B4-4E67-850D-772F1CF4F281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5588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0880" y="4721940"/>
            <a:ext cx="5447030" cy="4473416"/>
          </a:xfrm>
          <a:prstGeom prst="rect">
            <a:avLst/>
          </a:prstGeom>
        </p:spPr>
        <p:txBody>
          <a:bodyPr vert="horz" lIns="91431" tIns="45715" rIns="91431" bIns="45715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1" y="9442154"/>
            <a:ext cx="2950475" cy="497046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56738" y="9442154"/>
            <a:ext cx="2950475" cy="497046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82815970-C812-4593-92FF-870B8D6616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50753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815970-C812-4593-92FF-870B8D6616AF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95282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_tradnl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1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dirty="0"/>
              <a:t>Evolution of stem length and nodes number in AMK34 (A) and in GUA7 (B) along 69 days of in vitro culture in the different light treatments assayed (Levels of significance *P≤0.05; **P≤0.01; ***P≤0.001; Non-significant (NS)).</a:t>
            </a:r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815970-C812-4593-92FF-870B8D6616AF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4939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4306">
              <a:defRPr/>
            </a:pPr>
            <a:r>
              <a:rPr lang="es-ES_tradnl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2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dirty="0"/>
              <a:t> </a:t>
            </a:r>
            <a:r>
              <a:rPr lang="en-US" b="0" dirty="0">
                <a:solidFill>
                  <a:srgbClr val="FF0000"/>
                </a:solidFill>
              </a:rPr>
              <a:t>Total stem length and internodes space in</a:t>
            </a:r>
            <a:r>
              <a:rPr lang="en-US" b="0" baseline="0" dirty="0">
                <a:solidFill>
                  <a:srgbClr val="FF0000"/>
                </a:solidFill>
              </a:rPr>
              <a:t> four genotypes of </a:t>
            </a:r>
            <a:r>
              <a:rPr lang="en-US" i="1" dirty="0"/>
              <a:t>Olea </a:t>
            </a:r>
            <a:r>
              <a:rPr lang="en-US" i="1" dirty="0" err="1"/>
              <a:t>europea</a:t>
            </a:r>
            <a:r>
              <a:rPr lang="en-US" dirty="0"/>
              <a:t> </a:t>
            </a:r>
            <a:r>
              <a:rPr lang="en-US" dirty="0" err="1"/>
              <a:t>ssp</a:t>
            </a:r>
            <a:r>
              <a:rPr lang="en-US" dirty="0"/>
              <a:t> </a:t>
            </a:r>
            <a:r>
              <a:rPr lang="en-US" i="1" dirty="0" err="1"/>
              <a:t>europaea</a:t>
            </a:r>
            <a:r>
              <a:rPr lang="en-US" dirty="0"/>
              <a:t> (“ACZ” from Cadiz; “AJA” from Jaen ) along 69 days of in vitro culture in the treatments 70 % red plus 30% blue (R7B3-34) and TFL </a:t>
            </a:r>
            <a:r>
              <a:rPr lang="en-US" b="0" dirty="0"/>
              <a:t>(</a:t>
            </a:r>
            <a:r>
              <a:rPr lang="en-US" dirty="0"/>
              <a:t>Levels of significance *P≤0.05; **P≤0.01; ***P≤0.001; Non-significant (NS)).</a:t>
            </a:r>
            <a:endParaRPr lang="es-ES" dirty="0"/>
          </a:p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815970-C812-4593-92FF-870B8D6616AF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078704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815970-C812-4593-92FF-870B8D6616AF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738474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815970-C812-4593-92FF-870B8D6616AF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1960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6440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0122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148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1355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3707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5259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9339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1778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6778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6484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0941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6F3F17-EF3E-41D7-A709-9B56F837A0E3}" type="datetimeFigureOut">
              <a:rPr lang="es-ES" smtClean="0"/>
              <a:t>12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FB05A-B604-4BA6-B422-065102816F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3073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7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0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6.xml"/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10" Type="http://schemas.openxmlformats.org/officeDocument/2006/relationships/chart" Target="../charts/chart18.xml"/><Relationship Id="rId4" Type="http://schemas.openxmlformats.org/officeDocument/2006/relationships/chart" Target="../charts/chart12.xml"/><Relationship Id="rId9" Type="http://schemas.openxmlformats.org/officeDocument/2006/relationships/chart" Target="../charts/char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5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0745556"/>
              </p:ext>
            </p:extLst>
          </p:nvPr>
        </p:nvGraphicFramePr>
        <p:xfrm>
          <a:off x="730008" y="700470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6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5647653"/>
              </p:ext>
            </p:extLst>
          </p:nvPr>
        </p:nvGraphicFramePr>
        <p:xfrm>
          <a:off x="3717352" y="674318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7 CuadroTexto"/>
          <p:cNvSpPr txBox="1"/>
          <p:nvPr/>
        </p:nvSpPr>
        <p:spPr>
          <a:xfrm>
            <a:off x="581348" y="542939"/>
            <a:ext cx="5486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/>
              <a:t>A</a:t>
            </a:r>
          </a:p>
        </p:txBody>
      </p:sp>
      <p:sp>
        <p:nvSpPr>
          <p:cNvPr id="7" name="8 CuadroTexto"/>
          <p:cNvSpPr txBox="1"/>
          <p:nvPr/>
        </p:nvSpPr>
        <p:spPr>
          <a:xfrm>
            <a:off x="3619055" y="539552"/>
            <a:ext cx="5486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/>
              <a:t>B</a:t>
            </a:r>
          </a:p>
        </p:txBody>
      </p:sp>
      <p:graphicFrame>
        <p:nvGraphicFramePr>
          <p:cNvPr id="8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4816334"/>
              </p:ext>
            </p:extLst>
          </p:nvPr>
        </p:nvGraphicFramePr>
        <p:xfrm>
          <a:off x="730008" y="2699792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3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3329470"/>
              </p:ext>
            </p:extLst>
          </p:nvPr>
        </p:nvGraphicFramePr>
        <p:xfrm>
          <a:off x="3717354" y="2699792"/>
          <a:ext cx="2879998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0" name="7 CuadroTexto"/>
          <p:cNvSpPr txBox="1"/>
          <p:nvPr/>
        </p:nvSpPr>
        <p:spPr>
          <a:xfrm>
            <a:off x="584781" y="2491277"/>
            <a:ext cx="5486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/>
              <a:t>C</a:t>
            </a:r>
          </a:p>
        </p:txBody>
      </p:sp>
      <p:sp>
        <p:nvSpPr>
          <p:cNvPr id="11" name="8 CuadroTexto"/>
          <p:cNvSpPr txBox="1"/>
          <p:nvPr/>
        </p:nvSpPr>
        <p:spPr>
          <a:xfrm>
            <a:off x="3619055" y="2524495"/>
            <a:ext cx="5486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/>
              <a:t>D</a:t>
            </a:r>
          </a:p>
        </p:txBody>
      </p:sp>
      <p:sp>
        <p:nvSpPr>
          <p:cNvPr id="12" name="Rectángulo 11"/>
          <p:cNvSpPr/>
          <p:nvPr/>
        </p:nvSpPr>
        <p:spPr>
          <a:xfrm>
            <a:off x="324184" y="5004048"/>
            <a:ext cx="626469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914306">
              <a:defRPr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different illumination regimes from light-emitting diodes (LEDs) and fluorescent lighting (TFL-137) on: number of shoots (A, C) and number of nodes (B, D)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ea europae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s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ropae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 AMK34 (A, B)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ea europae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s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anchic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type GUA7 (C, D). Levels of significance: non-significant (NS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8 CuadroTexto">
            <a:extLst>
              <a:ext uri="{FF2B5EF4-FFF2-40B4-BE49-F238E27FC236}">
                <a16:creationId xmlns:a16="http://schemas.microsoft.com/office/drawing/2014/main" id="{17736CAF-503F-0441-9EA8-A7BF684AD3B3}"/>
              </a:ext>
            </a:extLst>
          </p:cNvPr>
          <p:cNvSpPr txBox="1"/>
          <p:nvPr/>
        </p:nvSpPr>
        <p:spPr>
          <a:xfrm>
            <a:off x="-38504" y="1155410"/>
            <a:ext cx="9603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AMK34</a:t>
            </a:r>
          </a:p>
        </p:txBody>
      </p:sp>
      <p:sp>
        <p:nvSpPr>
          <p:cNvPr id="14" name="8 CuadroTexto">
            <a:extLst>
              <a:ext uri="{FF2B5EF4-FFF2-40B4-BE49-F238E27FC236}">
                <a16:creationId xmlns:a16="http://schemas.microsoft.com/office/drawing/2014/main" id="{2DA9D26F-1A83-694A-A2E4-C1D1D2A6E3FE}"/>
              </a:ext>
            </a:extLst>
          </p:cNvPr>
          <p:cNvSpPr txBox="1"/>
          <p:nvPr/>
        </p:nvSpPr>
        <p:spPr>
          <a:xfrm>
            <a:off x="-38504" y="3155873"/>
            <a:ext cx="6722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GUA7</a:t>
            </a:r>
          </a:p>
        </p:txBody>
      </p:sp>
    </p:spTree>
    <p:extLst>
      <p:ext uri="{BB962C8B-B14F-4D97-AF65-F5344CB8AC3E}">
        <p14:creationId xmlns:p14="http://schemas.microsoft.com/office/powerpoint/2010/main" val="7956153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4566990"/>
              </p:ext>
            </p:extLst>
          </p:nvPr>
        </p:nvGraphicFramePr>
        <p:xfrm>
          <a:off x="221935" y="6015252"/>
          <a:ext cx="5865364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4752501"/>
              </p:ext>
            </p:extLst>
          </p:nvPr>
        </p:nvGraphicFramePr>
        <p:xfrm>
          <a:off x="221935" y="4292313"/>
          <a:ext cx="5877271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5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2797796"/>
              </p:ext>
            </p:extLst>
          </p:nvPr>
        </p:nvGraphicFramePr>
        <p:xfrm>
          <a:off x="278526" y="2132241"/>
          <a:ext cx="5843044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6 CuadroTexto"/>
          <p:cNvSpPr txBox="1"/>
          <p:nvPr/>
        </p:nvSpPr>
        <p:spPr>
          <a:xfrm>
            <a:off x="124598" y="3837047"/>
            <a:ext cx="580833" cy="369332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B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50535" y="105113"/>
            <a:ext cx="654896" cy="369332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A</a:t>
            </a:r>
          </a:p>
        </p:txBody>
      </p:sp>
      <p:graphicFrame>
        <p:nvGraphicFramePr>
          <p:cNvPr id="9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3077164"/>
              </p:ext>
            </p:extLst>
          </p:nvPr>
        </p:nvGraphicFramePr>
        <p:xfrm>
          <a:off x="260648" y="360361"/>
          <a:ext cx="58788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500" t="16693" r="8917" b="23430"/>
          <a:stretch/>
        </p:blipFill>
        <p:spPr bwMode="auto">
          <a:xfrm>
            <a:off x="6127626" y="204362"/>
            <a:ext cx="702374" cy="15850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ángulo 3"/>
          <p:cNvSpPr/>
          <p:nvPr/>
        </p:nvSpPr>
        <p:spPr>
          <a:xfrm>
            <a:off x="260648" y="8244408"/>
            <a:ext cx="633670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ffects of different illumination regimes from light-emitting diodes (LEDs) and fluorescent lighting (TFL-137) on the evolution of stem length and number of nodes in AMK34 (A) and GUA7 (B) along 69 day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 in the different light treatments assayed. Levels of significance: ***P≤0.001; Non-significant (NS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49645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2477901"/>
              </p:ext>
            </p:extLst>
          </p:nvPr>
        </p:nvGraphicFramePr>
        <p:xfrm>
          <a:off x="1655952" y="467544"/>
          <a:ext cx="324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Rectángulo 1"/>
          <p:cNvSpPr/>
          <p:nvPr/>
        </p:nvSpPr>
        <p:spPr>
          <a:xfrm>
            <a:off x="836713" y="5273354"/>
            <a:ext cx="511256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914306">
              <a:defRPr/>
            </a:pP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Total stem and internodal length in four different genotype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ea europae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p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ropae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]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ng 69 day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 under the LED illumination treatment R7B3-34 and the fluorescent illumination treatment TFL-137. Levels of significance: ***P≤0.001; Non-significant (NS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2420536"/>
              </p:ext>
            </p:extLst>
          </p:nvPr>
        </p:nvGraphicFramePr>
        <p:xfrm>
          <a:off x="1684416" y="2573354"/>
          <a:ext cx="324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6240595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0688" y="1259632"/>
            <a:ext cx="5400040" cy="292354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ángulo 2"/>
          <p:cNvSpPr/>
          <p:nvPr/>
        </p:nvSpPr>
        <p:spPr>
          <a:xfrm>
            <a:off x="620688" y="4427984"/>
            <a:ext cx="5400040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4.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ages of GUA7 and AMK34 genotypes one year after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-vitro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cclimatization.</a:t>
            </a:r>
            <a:endParaRPr lang="es-E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52356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4906839"/>
              </p:ext>
            </p:extLst>
          </p:nvPr>
        </p:nvGraphicFramePr>
        <p:xfrm>
          <a:off x="103015" y="251520"/>
          <a:ext cx="2314884" cy="1769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Gráfico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6339015"/>
              </p:ext>
            </p:extLst>
          </p:nvPr>
        </p:nvGraphicFramePr>
        <p:xfrm>
          <a:off x="2365380" y="251520"/>
          <a:ext cx="2314884" cy="1769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Grá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6560779"/>
              </p:ext>
            </p:extLst>
          </p:nvPr>
        </p:nvGraphicFramePr>
        <p:xfrm>
          <a:off x="4521719" y="251520"/>
          <a:ext cx="2314884" cy="1769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Gráfico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856310"/>
              </p:ext>
            </p:extLst>
          </p:nvPr>
        </p:nvGraphicFramePr>
        <p:xfrm>
          <a:off x="103015" y="2082812"/>
          <a:ext cx="2314884" cy="1769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Gráfico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3064246"/>
              </p:ext>
            </p:extLst>
          </p:nvPr>
        </p:nvGraphicFramePr>
        <p:xfrm>
          <a:off x="2414012" y="2079426"/>
          <a:ext cx="2314884" cy="1769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Gráfico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3015369"/>
              </p:ext>
            </p:extLst>
          </p:nvPr>
        </p:nvGraphicFramePr>
        <p:xfrm>
          <a:off x="2365380" y="3975510"/>
          <a:ext cx="2314884" cy="1769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" name="Gráfico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9697015"/>
              </p:ext>
            </p:extLst>
          </p:nvPr>
        </p:nvGraphicFramePr>
        <p:xfrm>
          <a:off x="4520346" y="2079426"/>
          <a:ext cx="2314884" cy="1769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9" name="Gráfico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3337736"/>
              </p:ext>
            </p:extLst>
          </p:nvPr>
        </p:nvGraphicFramePr>
        <p:xfrm>
          <a:off x="103015" y="3914104"/>
          <a:ext cx="2314884" cy="1769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0" name="CuadroTexto 9"/>
          <p:cNvSpPr txBox="1"/>
          <p:nvPr/>
        </p:nvSpPr>
        <p:spPr>
          <a:xfrm>
            <a:off x="103015" y="6012160"/>
            <a:ext cx="66468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Spectral patterns of the different illumination treatments used in this work (see Table 1), obtained with a spectrometer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350N PLUS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Rtek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huna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wnship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aoli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unty,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iwa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35921083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4</TotalTime>
  <Words>565</Words>
  <Application>Microsoft Office PowerPoint</Application>
  <PresentationFormat>Presentación en pantalla (4:3)</PresentationFormat>
  <Paragraphs>92</Paragraphs>
  <Slides>5</Slides>
  <Notes>5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AFICAS FINALES ARTICULO LED</dc:title>
  <dc:creator>chema</dc:creator>
  <cp:lastModifiedBy>Portatil</cp:lastModifiedBy>
  <cp:revision>201</cp:revision>
  <cp:lastPrinted>2021-10-01T07:03:04Z</cp:lastPrinted>
  <dcterms:created xsi:type="dcterms:W3CDTF">2018-04-02T09:47:39Z</dcterms:created>
  <dcterms:modified xsi:type="dcterms:W3CDTF">2021-10-12T11:16:12Z</dcterms:modified>
</cp:coreProperties>
</file>